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omments/modernComment_100_E0E6D698.xml" ContentType="application/vnd.ms-powerpoint.comment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omments/modernComment_105_A14FBA04.xml" ContentType="application/vnd.ms-powerpoint.comments+xml"/>
  <Override PartName="/ppt/notesSlides/notesSlide6.xml" ContentType="application/vnd.openxmlformats-officedocument.presentationml.notesSlide+xml"/>
  <Override PartName="/ppt/comments/modernComment_104_58A381D1.xml" ContentType="application/vnd.ms-powerpoint.comments+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comments/modernComment_106_27CEFE08.xml" ContentType="application/vnd.ms-powerpoint.comments+xml"/>
  <Override PartName="/ppt/notesSlides/notesSlide9.xml" ContentType="application/vnd.openxmlformats-officedocument.presentationml.notesSlide+xml"/>
  <Override PartName="/ppt/comments/modernComment_109_CE7327D8.xml" ContentType="application/vnd.ms-powerpoint.comment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21"/>
  </p:notesMasterIdLst>
  <p:sldIdLst>
    <p:sldId id="259" r:id="rId5"/>
    <p:sldId id="256" r:id="rId6"/>
    <p:sldId id="258" r:id="rId7"/>
    <p:sldId id="257" r:id="rId8"/>
    <p:sldId id="261" r:id="rId9"/>
    <p:sldId id="260" r:id="rId10"/>
    <p:sldId id="264" r:id="rId11"/>
    <p:sldId id="262" r:id="rId12"/>
    <p:sldId id="265" r:id="rId13"/>
    <p:sldId id="263" r:id="rId14"/>
    <p:sldId id="275" r:id="rId15"/>
    <p:sldId id="277" r:id="rId16"/>
    <p:sldId id="276" r:id="rId17"/>
    <p:sldId id="271" r:id="rId18"/>
    <p:sldId id="279" r:id="rId19"/>
    <p:sldId id="268"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BED92B5-DACF-4B5B-1439-DD3E3B41A5A3}" name="Karly M. Murphy" initials="KMM" userId="S::karmurph@wakehealth.edu::356800e2-27aa-4b4f-9e7a-e979cf0bfcd7"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80729" autoAdjust="0"/>
  </p:normalViewPr>
  <p:slideViewPr>
    <p:cSldViewPr snapToGrid="0">
      <p:cViewPr varScale="1">
        <p:scale>
          <a:sx n="86" d="100"/>
          <a:sy n="86" d="100"/>
        </p:scale>
        <p:origin x="141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microsoft.com/office/2016/11/relationships/changesInfo" Target="changesInfos/changesInfo1.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presProps" Target="presProps.xml"/><Relationship Id="rId27"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rly M. Murphy" userId="356800e2-27aa-4b4f-9e7a-e979cf0bfcd7" providerId="ADAL" clId="{4391D788-B3C3-4494-8C6B-DEF0886077D5}"/>
    <pc:docChg chg="undo custSel addSld modSld">
      <pc:chgData name="Karly M. Murphy" userId="356800e2-27aa-4b4f-9e7a-e979cf0bfcd7" providerId="ADAL" clId="{4391D788-B3C3-4494-8C6B-DEF0886077D5}" dt="2023-03-27T14:18:14.627" v="1287" actId="1076"/>
      <pc:docMkLst>
        <pc:docMk/>
      </pc:docMkLst>
      <pc:sldChg chg="modSp mod">
        <pc:chgData name="Karly M. Murphy" userId="356800e2-27aa-4b4f-9e7a-e979cf0bfcd7" providerId="ADAL" clId="{4391D788-B3C3-4494-8C6B-DEF0886077D5}" dt="2023-03-27T14:18:14.627" v="1287" actId="1076"/>
        <pc:sldMkLst>
          <pc:docMk/>
          <pc:sldMk cId="712715475" sldId="257"/>
        </pc:sldMkLst>
        <pc:picChg chg="mod">
          <ac:chgData name="Karly M. Murphy" userId="356800e2-27aa-4b4f-9e7a-e979cf0bfcd7" providerId="ADAL" clId="{4391D788-B3C3-4494-8C6B-DEF0886077D5}" dt="2023-03-27T14:18:14.627" v="1287" actId="1076"/>
          <ac:picMkLst>
            <pc:docMk/>
            <pc:sldMk cId="712715475" sldId="257"/>
            <ac:picMk id="5" creationId="{CB8B0D00-4A52-96D5-A36C-FF24884A223C}"/>
          </ac:picMkLst>
        </pc:picChg>
      </pc:sldChg>
      <pc:sldChg chg="addSp delSp modSp">
        <pc:chgData name="Karly M. Murphy" userId="356800e2-27aa-4b4f-9e7a-e979cf0bfcd7" providerId="ADAL" clId="{4391D788-B3C3-4494-8C6B-DEF0886077D5}" dt="2023-03-27T14:17:53.292" v="1286" actId="478"/>
        <pc:sldMkLst>
          <pc:docMk/>
          <pc:sldMk cId="2664980082" sldId="258"/>
        </pc:sldMkLst>
        <pc:picChg chg="add del mod">
          <ac:chgData name="Karly M. Murphy" userId="356800e2-27aa-4b4f-9e7a-e979cf0bfcd7" providerId="ADAL" clId="{4391D788-B3C3-4494-8C6B-DEF0886077D5}" dt="2023-03-27T14:17:53.292" v="1286" actId="478"/>
          <ac:picMkLst>
            <pc:docMk/>
            <pc:sldMk cId="2664980082" sldId="258"/>
            <ac:picMk id="2" creationId="{D8D87049-EDBA-0078-16C2-7C33F741E01A}"/>
          </ac:picMkLst>
        </pc:picChg>
        <pc:picChg chg="mod">
          <ac:chgData name="Karly M. Murphy" userId="356800e2-27aa-4b4f-9e7a-e979cf0bfcd7" providerId="ADAL" clId="{4391D788-B3C3-4494-8C6B-DEF0886077D5}" dt="2023-03-27T14:17:48.512" v="1284" actId="1076"/>
          <ac:picMkLst>
            <pc:docMk/>
            <pc:sldMk cId="2664980082" sldId="258"/>
            <ac:picMk id="1028" creationId="{9FB99A15-5958-1E36-67BE-2CBCEE3AB46A}"/>
          </ac:picMkLst>
        </pc:picChg>
      </pc:sldChg>
      <pc:sldChg chg="mod modShow">
        <pc:chgData name="Karly M. Murphy" userId="356800e2-27aa-4b4f-9e7a-e979cf0bfcd7" providerId="ADAL" clId="{4391D788-B3C3-4494-8C6B-DEF0886077D5}" dt="2023-03-09T14:12:55.264" v="1" actId="729"/>
        <pc:sldMkLst>
          <pc:docMk/>
          <pc:sldMk cId="4229247679" sldId="271"/>
        </pc:sldMkLst>
      </pc:sldChg>
      <pc:sldChg chg="mod modShow">
        <pc:chgData name="Karly M. Murphy" userId="356800e2-27aa-4b4f-9e7a-e979cf0bfcd7" providerId="ADAL" clId="{4391D788-B3C3-4494-8C6B-DEF0886077D5}" dt="2023-03-09T14:12:59.704" v="2" actId="729"/>
        <pc:sldMkLst>
          <pc:docMk/>
          <pc:sldMk cId="1376063756" sldId="272"/>
        </pc:sldMkLst>
      </pc:sldChg>
      <pc:sldChg chg="mod modShow">
        <pc:chgData name="Karly M. Murphy" userId="356800e2-27aa-4b4f-9e7a-e979cf0bfcd7" providerId="ADAL" clId="{4391D788-B3C3-4494-8C6B-DEF0886077D5}" dt="2023-03-09T14:13:04.561" v="3" actId="729"/>
        <pc:sldMkLst>
          <pc:docMk/>
          <pc:sldMk cId="837641864" sldId="274"/>
        </pc:sldMkLst>
      </pc:sldChg>
      <pc:sldChg chg="addSp delSp modSp new mod modNotesTx">
        <pc:chgData name="Karly M. Murphy" userId="356800e2-27aa-4b4f-9e7a-e979cf0bfcd7" providerId="ADAL" clId="{4391D788-B3C3-4494-8C6B-DEF0886077D5}" dt="2023-03-09T14:47:16.175" v="1283" actId="14100"/>
        <pc:sldMkLst>
          <pc:docMk/>
          <pc:sldMk cId="4176144418" sldId="279"/>
        </pc:sldMkLst>
        <pc:spChg chg="mod">
          <ac:chgData name="Karly M. Murphy" userId="356800e2-27aa-4b4f-9e7a-e979cf0bfcd7" providerId="ADAL" clId="{4391D788-B3C3-4494-8C6B-DEF0886077D5}" dt="2023-03-09T14:31:56.606" v="21" actId="20577"/>
          <ac:spMkLst>
            <pc:docMk/>
            <pc:sldMk cId="4176144418" sldId="279"/>
            <ac:spMk id="2" creationId="{378CABF9-0100-6F87-7474-D28C8BCE7425}"/>
          </ac:spMkLst>
        </pc:spChg>
        <pc:spChg chg="del">
          <ac:chgData name="Karly M. Murphy" userId="356800e2-27aa-4b4f-9e7a-e979cf0bfcd7" providerId="ADAL" clId="{4391D788-B3C3-4494-8C6B-DEF0886077D5}" dt="2023-03-09T14:43:30.824" v="1031"/>
          <ac:spMkLst>
            <pc:docMk/>
            <pc:sldMk cId="4176144418" sldId="279"/>
            <ac:spMk id="3" creationId="{15347A8D-3CFF-EBD3-6CA9-BF1CC155F887}"/>
          </ac:spMkLst>
        </pc:spChg>
        <pc:spChg chg="add mod">
          <ac:chgData name="Karly M. Murphy" userId="356800e2-27aa-4b4f-9e7a-e979cf0bfcd7" providerId="ADAL" clId="{4391D788-B3C3-4494-8C6B-DEF0886077D5}" dt="2023-03-09T14:43:56.983" v="1040" actId="478"/>
          <ac:spMkLst>
            <pc:docMk/>
            <pc:sldMk cId="4176144418" sldId="279"/>
            <ac:spMk id="6" creationId="{0BAB1850-F1D0-8E74-5584-D832E88F3452}"/>
          </ac:spMkLst>
        </pc:spChg>
        <pc:picChg chg="add del mod modCrop">
          <ac:chgData name="Karly M. Murphy" userId="356800e2-27aa-4b4f-9e7a-e979cf0bfcd7" providerId="ADAL" clId="{4391D788-B3C3-4494-8C6B-DEF0886077D5}" dt="2023-03-09T14:43:56.983" v="1040" actId="478"/>
          <ac:picMkLst>
            <pc:docMk/>
            <pc:sldMk cId="4176144418" sldId="279"/>
            <ac:picMk id="4" creationId="{190474A2-FA7C-F8E4-B1D3-18DD62C072BF}"/>
          </ac:picMkLst>
        </pc:picChg>
        <pc:picChg chg="add del mod">
          <ac:chgData name="Karly M. Murphy" userId="356800e2-27aa-4b4f-9e7a-e979cf0bfcd7" providerId="ADAL" clId="{4391D788-B3C3-4494-8C6B-DEF0886077D5}" dt="2023-03-09T14:42:50.567" v="1025" actId="478"/>
          <ac:picMkLst>
            <pc:docMk/>
            <pc:sldMk cId="4176144418" sldId="279"/>
            <ac:picMk id="1026" creationId="{438A71F9-A7FC-D44D-2B48-20C3145CA0A7}"/>
          </ac:picMkLst>
        </pc:picChg>
        <pc:picChg chg="add mod">
          <ac:chgData name="Karly M. Murphy" userId="356800e2-27aa-4b4f-9e7a-e979cf0bfcd7" providerId="ADAL" clId="{4391D788-B3C3-4494-8C6B-DEF0886077D5}" dt="2023-03-09T14:43:22.253" v="1030" actId="1076"/>
          <ac:picMkLst>
            <pc:docMk/>
            <pc:sldMk cId="4176144418" sldId="279"/>
            <ac:picMk id="1027" creationId="{6DA95012-0C48-B19E-3946-CB84BD7D5C13}"/>
          </ac:picMkLst>
        </pc:picChg>
        <pc:picChg chg="add mod">
          <ac:chgData name="Karly M. Murphy" userId="356800e2-27aa-4b4f-9e7a-e979cf0bfcd7" providerId="ADAL" clId="{4391D788-B3C3-4494-8C6B-DEF0886077D5}" dt="2023-03-09T14:43:18.551" v="1029" actId="14100"/>
          <ac:picMkLst>
            <pc:docMk/>
            <pc:sldMk cId="4176144418" sldId="279"/>
            <ac:picMk id="1028" creationId="{1DBF33BC-A649-61AE-533A-11EDEEC790FE}"/>
          </ac:picMkLst>
        </pc:picChg>
        <pc:picChg chg="add mod">
          <ac:chgData name="Karly M. Murphy" userId="356800e2-27aa-4b4f-9e7a-e979cf0bfcd7" providerId="ADAL" clId="{4391D788-B3C3-4494-8C6B-DEF0886077D5}" dt="2023-03-09T14:45:21.446" v="1055" actId="14100"/>
          <ac:picMkLst>
            <pc:docMk/>
            <pc:sldMk cId="4176144418" sldId="279"/>
            <ac:picMk id="1029" creationId="{CDD7E877-447A-2756-20DB-0C9EB3D967ED}"/>
          </ac:picMkLst>
        </pc:picChg>
        <pc:picChg chg="add mod">
          <ac:chgData name="Karly M. Murphy" userId="356800e2-27aa-4b4f-9e7a-e979cf0bfcd7" providerId="ADAL" clId="{4391D788-B3C3-4494-8C6B-DEF0886077D5}" dt="2023-03-09T14:47:16.175" v="1283" actId="14100"/>
          <ac:picMkLst>
            <pc:docMk/>
            <pc:sldMk cId="4176144418" sldId="279"/>
            <ac:picMk id="1030" creationId="{6A8D1D3A-D2E2-C3F6-EAF8-430673DB73BB}"/>
          </ac:picMkLst>
        </pc:picChg>
      </pc:sldChg>
    </pc:docChg>
  </pc:docChgLst>
  <pc:docChgLst>
    <pc:chgData name="Murphy, Karly" userId="be5f3f85-e960-40c1-ada4-cbde73c4848e" providerId="ADAL" clId="{4351A348-2AA6-4F64-90DD-EE93248ECAC0}"/>
    <pc:docChg chg="delSld">
      <pc:chgData name="Murphy, Karly" userId="be5f3f85-e960-40c1-ada4-cbde73c4848e" providerId="ADAL" clId="{4351A348-2AA6-4F64-90DD-EE93248ECAC0}" dt="2025-05-23T13:52:35.109" v="2" actId="2696"/>
      <pc:docMkLst>
        <pc:docMk/>
      </pc:docMkLst>
      <pc:sldChg chg="del">
        <pc:chgData name="Murphy, Karly" userId="be5f3f85-e960-40c1-ada4-cbde73c4848e" providerId="ADAL" clId="{4351A348-2AA6-4F64-90DD-EE93248ECAC0}" dt="2025-05-23T13:52:32.455" v="1" actId="2696"/>
        <pc:sldMkLst>
          <pc:docMk/>
          <pc:sldMk cId="1376063756" sldId="272"/>
        </pc:sldMkLst>
      </pc:sldChg>
      <pc:sldChg chg="del">
        <pc:chgData name="Murphy, Karly" userId="be5f3f85-e960-40c1-ada4-cbde73c4848e" providerId="ADAL" clId="{4351A348-2AA6-4F64-90DD-EE93248ECAC0}" dt="2025-05-23T13:52:35.109" v="2" actId="2696"/>
        <pc:sldMkLst>
          <pc:docMk/>
          <pc:sldMk cId="837641864" sldId="274"/>
        </pc:sldMkLst>
      </pc:sldChg>
      <pc:sldChg chg="del">
        <pc:chgData name="Murphy, Karly" userId="be5f3f85-e960-40c1-ada4-cbde73c4848e" providerId="ADAL" clId="{4351A348-2AA6-4F64-90DD-EE93248ECAC0}" dt="2025-05-23T13:52:23.413" v="0" actId="2696"/>
        <pc:sldMkLst>
          <pc:docMk/>
          <pc:sldMk cId="921405035" sldId="278"/>
        </pc:sldMkLst>
      </pc:sldChg>
    </pc:docChg>
  </pc:docChgLst>
</pc:chgInfo>
</file>

<file path=ppt/comments/modernComment_100_E0E6D698.xml><?xml version="1.0" encoding="utf-8"?>
<p188:cmLst xmlns:a="http://schemas.openxmlformats.org/drawingml/2006/main" xmlns:r="http://schemas.openxmlformats.org/officeDocument/2006/relationships" xmlns:p188="http://schemas.microsoft.com/office/powerpoint/2018/8/main">
  <p188:cm id="{6C8C5CB0-C993-42AB-94E9-8911B93A1DC4}" authorId="{6BED92B5-DACF-4B5B-1439-DD3E3B41A5A3}" status="resolved" created="2023-01-11T16:34:01.849" complete="100000">
    <ac:deMkLst xmlns:ac="http://schemas.microsoft.com/office/drawing/2013/main/command">
      <pc:docMk xmlns:pc="http://schemas.microsoft.com/office/powerpoint/2013/main/command"/>
      <pc:sldMk xmlns:pc="http://schemas.microsoft.com/office/powerpoint/2013/main/command" cId="3773224600" sldId="256"/>
      <ac:picMk id="6" creationId="{53BEDCEF-E904-0518-16CE-5741AB2E124C}"/>
    </ac:deMkLst>
    <p188:txBody>
      <a:bodyPr/>
      <a:lstStyle/>
      <a:p>
        <a:r>
          <a:rPr lang="en-US"/>
          <a:t>Remove daily from check-in title</a:t>
        </a:r>
      </a:p>
    </p188:txBody>
  </p188:cm>
</p188:cmLst>
</file>

<file path=ppt/comments/modernComment_104_58A381D1.xml><?xml version="1.0" encoding="utf-8"?>
<p188:cmLst xmlns:a="http://schemas.openxmlformats.org/drawingml/2006/main" xmlns:r="http://schemas.openxmlformats.org/officeDocument/2006/relationships" xmlns:p188="http://schemas.microsoft.com/office/powerpoint/2018/8/main">
  <p188:cm id="{103E9140-6659-4678-BF66-3F2AA545F61D}" authorId="{6BED92B5-DACF-4B5B-1439-DD3E3B41A5A3}" status="resolved" created="2023-01-11T16:34:34.278" complete="100000">
    <pc:sldMkLst xmlns:pc="http://schemas.microsoft.com/office/powerpoint/2013/main/command">
      <pc:docMk/>
      <pc:sldMk cId="1487110609" sldId="260"/>
    </pc:sldMkLst>
    <p188:txBody>
      <a:bodyPr/>
      <a:lstStyle/>
      <a:p>
        <a:r>
          <a:rPr lang="en-US"/>
          <a:t>Add version with check mark</a:t>
        </a:r>
      </a:p>
    </p188:txBody>
  </p188:cm>
</p188:cmLst>
</file>

<file path=ppt/comments/modernComment_105_A14FBA04.xml><?xml version="1.0" encoding="utf-8"?>
<p188:cmLst xmlns:a="http://schemas.openxmlformats.org/drawingml/2006/main" xmlns:r="http://schemas.openxmlformats.org/officeDocument/2006/relationships" xmlns:p188="http://schemas.microsoft.com/office/powerpoint/2018/8/main">
  <p188:cm id="{908BFEA3-5FC2-4114-95F9-7BE5EC99FB93}" authorId="{6BED92B5-DACF-4B5B-1439-DD3E3B41A5A3}" created="2023-01-11T16:43:41.583">
    <pc:sldMkLst xmlns:pc="http://schemas.microsoft.com/office/powerpoint/2013/main/command">
      <pc:docMk/>
      <pc:sldMk cId="2706356740" sldId="261"/>
    </pc:sldMkLst>
    <p188:txBody>
      <a:bodyPr/>
      <a:lstStyle/>
      <a:p>
        <a:r>
          <a:rPr lang="en-US"/>
          <a:t>Create version with more info about what modules are</a:t>
        </a:r>
      </a:p>
    </p188:txBody>
  </p188:cm>
</p188:cmLst>
</file>

<file path=ppt/comments/modernComment_106_27CEFE08.xml><?xml version="1.0" encoding="utf-8"?>
<p188:cmLst xmlns:a="http://schemas.openxmlformats.org/drawingml/2006/main" xmlns:r="http://schemas.openxmlformats.org/officeDocument/2006/relationships" xmlns:p188="http://schemas.microsoft.com/office/powerpoint/2018/8/main">
  <p188:cm id="{1F7B19F1-638C-43BB-9E3A-752690BE7BBC}" authorId="{6BED92B5-DACF-4B5B-1439-DD3E3B41A5A3}" created="2023-01-11T16:41:28.224">
    <pc:sldMkLst xmlns:pc="http://schemas.microsoft.com/office/powerpoint/2013/main/command">
      <pc:docMk/>
      <pc:sldMk cId="667876872" sldId="262"/>
    </pc:sldMkLst>
    <p188:txBody>
      <a:bodyPr/>
      <a:lstStyle/>
      <a:p>
        <a:r>
          <a:rPr lang="en-US"/>
          <a:t>Change example to have text as optional view</a:t>
        </a:r>
      </a:p>
    </p188:txBody>
  </p188:cm>
</p188:cmLst>
</file>

<file path=ppt/comments/modernComment_109_CE7327D8.xml><?xml version="1.0" encoding="utf-8"?>
<p188:cmLst xmlns:a="http://schemas.openxmlformats.org/drawingml/2006/main" xmlns:r="http://schemas.openxmlformats.org/officeDocument/2006/relationships" xmlns:p188="http://schemas.microsoft.com/office/powerpoint/2018/8/main">
  <p188:cm id="{93A63F48-8454-4208-926A-86CBEEF823A1}" authorId="{6BED92B5-DACF-4B5B-1439-DD3E3B41A5A3}" created="2023-01-11T16:41:36.471">
    <pc:sldMkLst xmlns:pc="http://schemas.microsoft.com/office/powerpoint/2013/main/command">
      <pc:docMk/>
      <pc:sldMk cId="3463653336" sldId="265"/>
    </pc:sldMkLst>
    <p188:txBody>
      <a:bodyPr/>
      <a:lstStyle/>
      <a:p>
        <a:r>
          <a:rPr lang="en-US"/>
          <a:t>Change example to have text as optional view</a:t>
        </a:r>
      </a:p>
    </p188:txBody>
  </p188:cm>
</p188:cmLst>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D80F380-3B92-445C-9991-34B8A33B2ECF}" type="doc">
      <dgm:prSet loTypeId="urn:microsoft.com/office/officeart/2005/8/layout/vList5" loCatId="list" qsTypeId="urn:microsoft.com/office/officeart/2005/8/quickstyle/simple1" qsCatId="simple" csTypeId="urn:microsoft.com/office/officeart/2005/8/colors/colorful5" csCatId="colorful" phldr="1"/>
      <dgm:spPr/>
      <dgm:t>
        <a:bodyPr/>
        <a:lstStyle/>
        <a:p>
          <a:endParaRPr lang="en-US"/>
        </a:p>
      </dgm:t>
    </dgm:pt>
    <dgm:pt modelId="{DB075803-47FD-4DB5-B83E-BF2A7CDBBD54}">
      <dgm:prSet phldrT="[Text]"/>
      <dgm:spPr/>
      <dgm:t>
        <a:bodyPr/>
        <a:lstStyle/>
        <a:p>
          <a:r>
            <a:rPr lang="en-US" dirty="0"/>
            <a:t>Education</a:t>
          </a:r>
        </a:p>
      </dgm:t>
    </dgm:pt>
    <dgm:pt modelId="{38310BF9-D507-44A9-AADB-CF44166423F0}" type="parTrans" cxnId="{C3A7DBC3-634B-460B-94F8-DAE278E5EAA4}">
      <dgm:prSet/>
      <dgm:spPr/>
      <dgm:t>
        <a:bodyPr/>
        <a:lstStyle/>
        <a:p>
          <a:endParaRPr lang="en-US"/>
        </a:p>
      </dgm:t>
    </dgm:pt>
    <dgm:pt modelId="{78942D9E-6C8F-4EA7-9B65-58C74C5FCE14}" type="sibTrans" cxnId="{C3A7DBC3-634B-460B-94F8-DAE278E5EAA4}">
      <dgm:prSet/>
      <dgm:spPr/>
      <dgm:t>
        <a:bodyPr/>
        <a:lstStyle/>
        <a:p>
          <a:endParaRPr lang="en-US"/>
        </a:p>
      </dgm:t>
    </dgm:pt>
    <dgm:pt modelId="{9745292D-6715-4E04-B91E-C0614E23867A}">
      <dgm:prSet phldrT="[Text]"/>
      <dgm:spPr/>
      <dgm:t>
        <a:bodyPr/>
        <a:lstStyle/>
        <a:p>
          <a:r>
            <a:rPr lang="en-US" dirty="0"/>
            <a:t>The relationship between behavior and mood</a:t>
          </a:r>
        </a:p>
      </dgm:t>
    </dgm:pt>
    <dgm:pt modelId="{F795554E-2EDE-4F4B-8917-D5917A218A88}" type="parTrans" cxnId="{A1592A71-DC9C-40CD-9FB9-A115B043B522}">
      <dgm:prSet/>
      <dgm:spPr/>
      <dgm:t>
        <a:bodyPr/>
        <a:lstStyle/>
        <a:p>
          <a:endParaRPr lang="en-US"/>
        </a:p>
      </dgm:t>
    </dgm:pt>
    <dgm:pt modelId="{7791AC7C-7DAF-4E12-AA31-CE07725457FF}" type="sibTrans" cxnId="{A1592A71-DC9C-40CD-9FB9-A115B043B522}">
      <dgm:prSet/>
      <dgm:spPr/>
      <dgm:t>
        <a:bodyPr/>
        <a:lstStyle/>
        <a:p>
          <a:endParaRPr lang="en-US"/>
        </a:p>
      </dgm:t>
    </dgm:pt>
    <dgm:pt modelId="{5D35BAFA-8687-4F25-94FA-8D9AA628343F}">
      <dgm:prSet phldrT="[Text]"/>
      <dgm:spPr/>
      <dgm:t>
        <a:bodyPr/>
        <a:lstStyle/>
        <a:p>
          <a:r>
            <a:rPr lang="en-US"/>
            <a:t>What downward spirals are and how they start</a:t>
          </a:r>
        </a:p>
      </dgm:t>
    </dgm:pt>
    <dgm:pt modelId="{64D35FE2-6687-4F5C-92D3-FCC8D1B641E6}" type="parTrans" cxnId="{9381E9E5-049B-4CCE-89B5-227100D374FC}">
      <dgm:prSet/>
      <dgm:spPr/>
      <dgm:t>
        <a:bodyPr/>
        <a:lstStyle/>
        <a:p>
          <a:endParaRPr lang="en-US"/>
        </a:p>
      </dgm:t>
    </dgm:pt>
    <dgm:pt modelId="{B4990353-A4CB-4120-914F-4B12CBB79BE1}" type="sibTrans" cxnId="{9381E9E5-049B-4CCE-89B5-227100D374FC}">
      <dgm:prSet/>
      <dgm:spPr/>
      <dgm:t>
        <a:bodyPr/>
        <a:lstStyle/>
        <a:p>
          <a:endParaRPr lang="en-US"/>
        </a:p>
      </dgm:t>
    </dgm:pt>
    <dgm:pt modelId="{9F2592C2-998B-4A47-9E58-E00937D37CFC}">
      <dgm:prSet phldrT="[Text]"/>
      <dgm:spPr/>
      <dgm:t>
        <a:bodyPr/>
        <a:lstStyle/>
        <a:p>
          <a:r>
            <a:rPr lang="en-US" dirty="0"/>
            <a:t>AYA Story</a:t>
          </a:r>
        </a:p>
      </dgm:t>
    </dgm:pt>
    <dgm:pt modelId="{883A47F4-AA77-49E4-90AA-DF6383217CA7}" type="parTrans" cxnId="{18D2AAB6-F302-4B7E-91DA-42CD9640BCC4}">
      <dgm:prSet/>
      <dgm:spPr/>
      <dgm:t>
        <a:bodyPr/>
        <a:lstStyle/>
        <a:p>
          <a:endParaRPr lang="en-US"/>
        </a:p>
      </dgm:t>
    </dgm:pt>
    <dgm:pt modelId="{B3F41A94-E23D-4BD5-A8E9-562302999318}" type="sibTrans" cxnId="{18D2AAB6-F302-4B7E-91DA-42CD9640BCC4}">
      <dgm:prSet/>
      <dgm:spPr/>
      <dgm:t>
        <a:bodyPr/>
        <a:lstStyle/>
        <a:p>
          <a:endParaRPr lang="en-US"/>
        </a:p>
      </dgm:t>
    </dgm:pt>
    <dgm:pt modelId="{6659CE27-AA55-4A46-B98B-82B5043589AD}">
      <dgm:prSet phldrT="[Text]"/>
      <dgm:spPr/>
      <dgm:t>
        <a:bodyPr/>
        <a:lstStyle/>
        <a:p>
          <a:r>
            <a:rPr lang="en-US"/>
            <a:t>The story of an AYA who experienced a downward spiral that led to feelings of depression</a:t>
          </a:r>
        </a:p>
      </dgm:t>
    </dgm:pt>
    <dgm:pt modelId="{F24DB68B-970C-49AE-97C6-EC37A141622B}" type="parTrans" cxnId="{919A0192-96AD-43F1-AF6D-E1A7F882077B}">
      <dgm:prSet/>
      <dgm:spPr/>
      <dgm:t>
        <a:bodyPr/>
        <a:lstStyle/>
        <a:p>
          <a:endParaRPr lang="en-US"/>
        </a:p>
      </dgm:t>
    </dgm:pt>
    <dgm:pt modelId="{63B75610-20CE-4243-93C5-54E6B1F6C7D6}" type="sibTrans" cxnId="{919A0192-96AD-43F1-AF6D-E1A7F882077B}">
      <dgm:prSet/>
      <dgm:spPr/>
      <dgm:t>
        <a:bodyPr/>
        <a:lstStyle/>
        <a:p>
          <a:endParaRPr lang="en-US"/>
        </a:p>
      </dgm:t>
    </dgm:pt>
    <dgm:pt modelId="{5F4A103B-4AA8-4418-82AC-7D096AD9B81C}">
      <dgm:prSet phldrT="[Text]"/>
      <dgm:spPr/>
      <dgm:t>
        <a:bodyPr/>
        <a:lstStyle/>
        <a:p>
          <a:r>
            <a:rPr lang="en-US" dirty="0"/>
            <a:t>Activity</a:t>
          </a:r>
        </a:p>
      </dgm:t>
    </dgm:pt>
    <dgm:pt modelId="{5BA346A5-4CA3-4BA8-9CC4-10CE51A66BC6}" type="parTrans" cxnId="{6E555E2C-2167-4A67-8C1C-F30787163993}">
      <dgm:prSet/>
      <dgm:spPr/>
      <dgm:t>
        <a:bodyPr/>
        <a:lstStyle/>
        <a:p>
          <a:endParaRPr lang="en-US"/>
        </a:p>
      </dgm:t>
    </dgm:pt>
    <dgm:pt modelId="{5E260F6B-7FE7-47F9-B575-BE5EB3F37287}" type="sibTrans" cxnId="{6E555E2C-2167-4A67-8C1C-F30787163993}">
      <dgm:prSet/>
      <dgm:spPr/>
      <dgm:t>
        <a:bodyPr/>
        <a:lstStyle/>
        <a:p>
          <a:endParaRPr lang="en-US"/>
        </a:p>
      </dgm:t>
    </dgm:pt>
    <dgm:pt modelId="{1A5ED0D3-96AB-419C-83FA-236E50BE8D16}">
      <dgm:prSet phldrT="[Text]"/>
      <dgm:spPr/>
      <dgm:t>
        <a:bodyPr/>
        <a:lstStyle/>
        <a:p>
          <a:r>
            <a:rPr lang="en-US"/>
            <a:t>Identifying the downward spiral the AYA experienced</a:t>
          </a:r>
        </a:p>
      </dgm:t>
    </dgm:pt>
    <dgm:pt modelId="{E2E60623-A6E2-4060-AD82-5441D91B0101}" type="parTrans" cxnId="{B40D0967-38AE-4E00-9644-C059D79E6094}">
      <dgm:prSet/>
      <dgm:spPr/>
      <dgm:t>
        <a:bodyPr/>
        <a:lstStyle/>
        <a:p>
          <a:endParaRPr lang="en-US"/>
        </a:p>
      </dgm:t>
    </dgm:pt>
    <dgm:pt modelId="{E2747C47-DDDA-4502-B577-46B78699E3D7}" type="sibTrans" cxnId="{B40D0967-38AE-4E00-9644-C059D79E6094}">
      <dgm:prSet/>
      <dgm:spPr/>
      <dgm:t>
        <a:bodyPr/>
        <a:lstStyle/>
        <a:p>
          <a:endParaRPr lang="en-US"/>
        </a:p>
      </dgm:t>
    </dgm:pt>
    <dgm:pt modelId="{3F045143-DC35-4B29-95B5-5BE2275ABAB4}">
      <dgm:prSet phldrT="[Text]"/>
      <dgm:spPr/>
      <dgm:t>
        <a:bodyPr/>
        <a:lstStyle/>
        <a:p>
          <a:r>
            <a:rPr lang="en-US"/>
            <a:t>Sharing a time where you experienced a downward spiral</a:t>
          </a:r>
        </a:p>
      </dgm:t>
    </dgm:pt>
    <dgm:pt modelId="{C834F8B6-E81D-46A1-BF24-070FA0D75E60}" type="parTrans" cxnId="{CD80D97C-7215-415A-9872-A7EE3FD575DE}">
      <dgm:prSet/>
      <dgm:spPr/>
      <dgm:t>
        <a:bodyPr/>
        <a:lstStyle/>
        <a:p>
          <a:endParaRPr lang="en-US"/>
        </a:p>
      </dgm:t>
    </dgm:pt>
    <dgm:pt modelId="{CD3D7471-FC66-423F-8ACE-B248C3DDE5F3}" type="sibTrans" cxnId="{CD80D97C-7215-415A-9872-A7EE3FD575DE}">
      <dgm:prSet/>
      <dgm:spPr/>
      <dgm:t>
        <a:bodyPr/>
        <a:lstStyle/>
        <a:p>
          <a:endParaRPr lang="en-US"/>
        </a:p>
      </dgm:t>
    </dgm:pt>
    <dgm:pt modelId="{06D83BE3-FCFA-4048-8D16-230C825D550A}">
      <dgm:prSet phldrT="[Text]"/>
      <dgm:spPr/>
      <dgm:t>
        <a:bodyPr/>
        <a:lstStyle/>
        <a:p>
          <a:r>
            <a:rPr lang="en-US" dirty="0"/>
            <a:t>AYA Story</a:t>
          </a:r>
        </a:p>
      </dgm:t>
    </dgm:pt>
    <dgm:pt modelId="{E66CF30B-F999-4F3C-BB5B-0D880C09F48D}" type="parTrans" cxnId="{7E0F7556-8DD3-4C78-BF97-7EAA5C20A5A6}">
      <dgm:prSet/>
      <dgm:spPr/>
      <dgm:t>
        <a:bodyPr/>
        <a:lstStyle/>
        <a:p>
          <a:endParaRPr lang="en-US"/>
        </a:p>
      </dgm:t>
    </dgm:pt>
    <dgm:pt modelId="{F71EC33C-0E95-4882-BF25-6F1F09743635}" type="sibTrans" cxnId="{7E0F7556-8DD3-4C78-BF97-7EAA5C20A5A6}">
      <dgm:prSet/>
      <dgm:spPr/>
      <dgm:t>
        <a:bodyPr/>
        <a:lstStyle/>
        <a:p>
          <a:endParaRPr lang="en-US"/>
        </a:p>
      </dgm:t>
    </dgm:pt>
    <dgm:pt modelId="{538CF43F-9C6A-4DEA-967F-FC4DD1C387DD}">
      <dgm:prSet phldrT="[Text]"/>
      <dgm:spPr/>
      <dgm:t>
        <a:bodyPr/>
        <a:lstStyle/>
        <a:p>
          <a:r>
            <a:rPr lang="en-US"/>
            <a:t>How the same AYA was able to stop their downward spiral and start an upward spiral</a:t>
          </a:r>
        </a:p>
      </dgm:t>
    </dgm:pt>
    <dgm:pt modelId="{1EEA00F7-25AC-4755-A2EE-4F5DE882DF9D}" type="parTrans" cxnId="{9C3AC200-6CDB-4F90-9FDC-051702D11EB1}">
      <dgm:prSet/>
      <dgm:spPr/>
      <dgm:t>
        <a:bodyPr/>
        <a:lstStyle/>
        <a:p>
          <a:endParaRPr lang="en-US"/>
        </a:p>
      </dgm:t>
    </dgm:pt>
    <dgm:pt modelId="{412D142B-01C4-4783-957A-762696A359B3}" type="sibTrans" cxnId="{9C3AC200-6CDB-4F90-9FDC-051702D11EB1}">
      <dgm:prSet/>
      <dgm:spPr/>
      <dgm:t>
        <a:bodyPr/>
        <a:lstStyle/>
        <a:p>
          <a:endParaRPr lang="en-US"/>
        </a:p>
      </dgm:t>
    </dgm:pt>
    <dgm:pt modelId="{7C92A925-4102-4FAD-A9B1-D4E3B87D2F8E}">
      <dgm:prSet phldrT="[Text]"/>
      <dgm:spPr/>
      <dgm:t>
        <a:bodyPr/>
        <a:lstStyle/>
        <a:p>
          <a:r>
            <a:rPr lang="en-US"/>
            <a:t>Activity</a:t>
          </a:r>
          <a:endParaRPr lang="en-US" dirty="0"/>
        </a:p>
      </dgm:t>
    </dgm:pt>
    <dgm:pt modelId="{1B581FE9-F870-4969-926F-51200D1A6A6A}" type="parTrans" cxnId="{DF61853D-0B45-43DB-A5E6-37E3A6E44B4D}">
      <dgm:prSet/>
      <dgm:spPr/>
      <dgm:t>
        <a:bodyPr/>
        <a:lstStyle/>
        <a:p>
          <a:endParaRPr lang="en-US"/>
        </a:p>
      </dgm:t>
    </dgm:pt>
    <dgm:pt modelId="{8B42E6B1-A368-479B-B9F9-E1B80644105E}" type="sibTrans" cxnId="{DF61853D-0B45-43DB-A5E6-37E3A6E44B4D}">
      <dgm:prSet/>
      <dgm:spPr/>
      <dgm:t>
        <a:bodyPr/>
        <a:lstStyle/>
        <a:p>
          <a:endParaRPr lang="en-US"/>
        </a:p>
      </dgm:t>
    </dgm:pt>
    <dgm:pt modelId="{96D559F2-D0FD-4BC2-8EC9-526379E7AD18}">
      <dgm:prSet phldrT="[Text]"/>
      <dgm:spPr/>
      <dgm:t>
        <a:bodyPr/>
        <a:lstStyle/>
        <a:p>
          <a:r>
            <a:rPr lang="en-US"/>
            <a:t>Identifying the upward spiral the AYA experienced</a:t>
          </a:r>
        </a:p>
      </dgm:t>
    </dgm:pt>
    <dgm:pt modelId="{B5D035D1-EE80-4CA5-91CE-F62713F7840C}" type="parTrans" cxnId="{7A8989A1-DDA0-4126-9873-0642C42C0F5A}">
      <dgm:prSet/>
      <dgm:spPr/>
      <dgm:t>
        <a:bodyPr/>
        <a:lstStyle/>
        <a:p>
          <a:endParaRPr lang="en-US"/>
        </a:p>
      </dgm:t>
    </dgm:pt>
    <dgm:pt modelId="{3AA75ACC-A82C-41CB-ACC4-22383A1704D5}" type="sibTrans" cxnId="{7A8989A1-DDA0-4126-9873-0642C42C0F5A}">
      <dgm:prSet/>
      <dgm:spPr/>
      <dgm:t>
        <a:bodyPr/>
        <a:lstStyle/>
        <a:p>
          <a:endParaRPr lang="en-US"/>
        </a:p>
      </dgm:t>
    </dgm:pt>
    <dgm:pt modelId="{3FE18A39-C52B-468E-893E-696793BB8CD5}">
      <dgm:prSet phldrT="[Text]"/>
      <dgm:spPr/>
      <dgm:t>
        <a:bodyPr/>
        <a:lstStyle/>
        <a:p>
          <a:r>
            <a:rPr lang="en-US"/>
            <a:t>Sharing a time where you experienced an upward spiral</a:t>
          </a:r>
        </a:p>
      </dgm:t>
    </dgm:pt>
    <dgm:pt modelId="{1AA94533-6EF1-44ED-93C8-D482BC438EF7}" type="parTrans" cxnId="{D5FD4839-67D1-4282-9EBC-C44F49E332B8}">
      <dgm:prSet/>
      <dgm:spPr/>
      <dgm:t>
        <a:bodyPr/>
        <a:lstStyle/>
        <a:p>
          <a:endParaRPr lang="en-US"/>
        </a:p>
      </dgm:t>
    </dgm:pt>
    <dgm:pt modelId="{E476412F-E350-406C-8102-18E9F6C6A41F}" type="sibTrans" cxnId="{D5FD4839-67D1-4282-9EBC-C44F49E332B8}">
      <dgm:prSet/>
      <dgm:spPr/>
      <dgm:t>
        <a:bodyPr/>
        <a:lstStyle/>
        <a:p>
          <a:endParaRPr lang="en-US"/>
        </a:p>
      </dgm:t>
    </dgm:pt>
    <dgm:pt modelId="{193B099A-39FC-4047-A261-82AC950A257A}">
      <dgm:prSet phldrT="[Text]"/>
      <dgm:spPr/>
      <dgm:t>
        <a:bodyPr/>
        <a:lstStyle/>
        <a:p>
          <a:r>
            <a:rPr lang="en-US" dirty="0"/>
            <a:t>Practice</a:t>
          </a:r>
        </a:p>
      </dgm:t>
    </dgm:pt>
    <dgm:pt modelId="{B6EC4905-A10A-45E1-A975-F763613F8DB7}" type="parTrans" cxnId="{AEDDC577-23BD-4384-B7AE-001627E1CF03}">
      <dgm:prSet/>
      <dgm:spPr/>
      <dgm:t>
        <a:bodyPr/>
        <a:lstStyle/>
        <a:p>
          <a:endParaRPr lang="en-US"/>
        </a:p>
      </dgm:t>
    </dgm:pt>
    <dgm:pt modelId="{DC0D5F73-CC38-42EB-BB83-162472AA134A}" type="sibTrans" cxnId="{AEDDC577-23BD-4384-B7AE-001627E1CF03}">
      <dgm:prSet/>
      <dgm:spPr/>
      <dgm:t>
        <a:bodyPr/>
        <a:lstStyle/>
        <a:p>
          <a:endParaRPr lang="en-US"/>
        </a:p>
      </dgm:t>
    </dgm:pt>
    <dgm:pt modelId="{A29821AE-302A-4B92-AC7E-952784B85349}">
      <dgm:prSet phldrT="[Text]"/>
      <dgm:spPr/>
      <dgm:t>
        <a:bodyPr/>
        <a:lstStyle/>
        <a:p>
          <a:r>
            <a:rPr lang="en-US"/>
            <a:t>Tracking how you feel after doing activities</a:t>
          </a:r>
        </a:p>
      </dgm:t>
    </dgm:pt>
    <dgm:pt modelId="{5BA37330-26F4-4626-8F00-A8459D8B624E}" type="parTrans" cxnId="{547FF4B0-03FE-4571-AFC4-5C6D0E39FB01}">
      <dgm:prSet/>
      <dgm:spPr/>
      <dgm:t>
        <a:bodyPr/>
        <a:lstStyle/>
        <a:p>
          <a:endParaRPr lang="en-US"/>
        </a:p>
      </dgm:t>
    </dgm:pt>
    <dgm:pt modelId="{5D9C1022-93FA-4E6B-8B2C-DC7263A8468F}" type="sibTrans" cxnId="{547FF4B0-03FE-4571-AFC4-5C6D0E39FB01}">
      <dgm:prSet/>
      <dgm:spPr/>
      <dgm:t>
        <a:bodyPr/>
        <a:lstStyle/>
        <a:p>
          <a:endParaRPr lang="en-US"/>
        </a:p>
      </dgm:t>
    </dgm:pt>
    <dgm:pt modelId="{A442D9E5-0C7F-45E7-9E89-5D96791D8BA6}">
      <dgm:prSet phldrT="[Text]"/>
      <dgm:spPr/>
      <dgm:t>
        <a:bodyPr/>
        <a:lstStyle/>
        <a:p>
          <a:r>
            <a:rPr lang="en-US"/>
            <a:t>Added to your check-in</a:t>
          </a:r>
        </a:p>
      </dgm:t>
    </dgm:pt>
    <dgm:pt modelId="{E105F7B4-83BF-4E00-A438-BA017D61A208}" type="parTrans" cxnId="{B2D3A30B-B810-48E2-B10C-A6B4A63F9C50}">
      <dgm:prSet/>
      <dgm:spPr/>
      <dgm:t>
        <a:bodyPr/>
        <a:lstStyle/>
        <a:p>
          <a:endParaRPr lang="en-US"/>
        </a:p>
      </dgm:t>
    </dgm:pt>
    <dgm:pt modelId="{C50000FF-F7E4-4B37-9CFA-3A05E2A565C2}" type="sibTrans" cxnId="{B2D3A30B-B810-48E2-B10C-A6B4A63F9C50}">
      <dgm:prSet/>
      <dgm:spPr/>
      <dgm:t>
        <a:bodyPr/>
        <a:lstStyle/>
        <a:p>
          <a:endParaRPr lang="en-US"/>
        </a:p>
      </dgm:t>
    </dgm:pt>
    <dgm:pt modelId="{810C17BD-7B7E-4D83-88E9-5C58C115F508}">
      <dgm:prSet phldrT="[Text]"/>
      <dgm:spPr/>
      <dgm:t>
        <a:bodyPr/>
        <a:lstStyle/>
        <a:p>
          <a:r>
            <a:rPr lang="en-US" dirty="0"/>
            <a:t>Education</a:t>
          </a:r>
        </a:p>
      </dgm:t>
    </dgm:pt>
    <dgm:pt modelId="{192B5EB6-75F1-49DA-A42A-D78D7B8407CE}" type="parTrans" cxnId="{DBBB1382-14DE-4F54-A094-5EC3D2D1E0E1}">
      <dgm:prSet/>
      <dgm:spPr/>
      <dgm:t>
        <a:bodyPr/>
        <a:lstStyle/>
        <a:p>
          <a:endParaRPr lang="en-US"/>
        </a:p>
      </dgm:t>
    </dgm:pt>
    <dgm:pt modelId="{A4BF771C-B458-4A71-9BF7-84580C8C3EC3}" type="sibTrans" cxnId="{DBBB1382-14DE-4F54-A094-5EC3D2D1E0E1}">
      <dgm:prSet/>
      <dgm:spPr/>
      <dgm:t>
        <a:bodyPr/>
        <a:lstStyle/>
        <a:p>
          <a:endParaRPr lang="en-US"/>
        </a:p>
      </dgm:t>
    </dgm:pt>
    <dgm:pt modelId="{CB61E494-D396-4621-AF3F-E3C0B0995F94}">
      <dgm:prSet phldrT="[Text]"/>
      <dgm:spPr/>
      <dgm:t>
        <a:bodyPr/>
        <a:lstStyle/>
        <a:p>
          <a:r>
            <a:rPr lang="en-US" dirty="0"/>
            <a:t>Stopping downward spirals</a:t>
          </a:r>
        </a:p>
      </dgm:t>
    </dgm:pt>
    <dgm:pt modelId="{DC170920-C042-4B03-B9BC-A9E1189AB832}" type="parTrans" cxnId="{E4F24938-FEBA-47C6-B71E-FE8590A89075}">
      <dgm:prSet/>
      <dgm:spPr/>
      <dgm:t>
        <a:bodyPr/>
        <a:lstStyle/>
        <a:p>
          <a:endParaRPr lang="en-US"/>
        </a:p>
      </dgm:t>
    </dgm:pt>
    <dgm:pt modelId="{B005A2D1-0999-43D0-8C45-CB93904F5203}" type="sibTrans" cxnId="{E4F24938-FEBA-47C6-B71E-FE8590A89075}">
      <dgm:prSet/>
      <dgm:spPr/>
      <dgm:t>
        <a:bodyPr/>
        <a:lstStyle/>
        <a:p>
          <a:endParaRPr lang="en-US"/>
        </a:p>
      </dgm:t>
    </dgm:pt>
    <dgm:pt modelId="{0AE20938-1B41-4640-9D3D-7271D505604F}">
      <dgm:prSet phldrT="[Text]"/>
      <dgm:spPr/>
      <dgm:t>
        <a:bodyPr/>
        <a:lstStyle/>
        <a:p>
          <a:r>
            <a:rPr lang="en-US" dirty="0"/>
            <a:t>Starting upward spirals</a:t>
          </a:r>
        </a:p>
      </dgm:t>
    </dgm:pt>
    <dgm:pt modelId="{90FE48D0-E624-427B-BDF5-21419A0CA42C}" type="parTrans" cxnId="{60E14518-F6D4-484B-A5ED-5679A9DEC7BD}">
      <dgm:prSet/>
      <dgm:spPr/>
      <dgm:t>
        <a:bodyPr/>
        <a:lstStyle/>
        <a:p>
          <a:endParaRPr lang="en-US"/>
        </a:p>
      </dgm:t>
    </dgm:pt>
    <dgm:pt modelId="{3C420805-1542-4249-93C3-2D96F7472340}" type="sibTrans" cxnId="{60E14518-F6D4-484B-A5ED-5679A9DEC7BD}">
      <dgm:prSet/>
      <dgm:spPr/>
      <dgm:t>
        <a:bodyPr/>
        <a:lstStyle/>
        <a:p>
          <a:endParaRPr lang="en-US"/>
        </a:p>
      </dgm:t>
    </dgm:pt>
    <dgm:pt modelId="{C1BBEA97-13F5-4E11-A031-17BAD9EBF99A}" type="pres">
      <dgm:prSet presAssocID="{3D80F380-3B92-445C-9991-34B8A33B2ECF}" presName="Name0" presStyleCnt="0">
        <dgm:presLayoutVars>
          <dgm:dir/>
          <dgm:animLvl val="lvl"/>
          <dgm:resizeHandles val="exact"/>
        </dgm:presLayoutVars>
      </dgm:prSet>
      <dgm:spPr/>
    </dgm:pt>
    <dgm:pt modelId="{46E2197D-7F88-467B-8EE5-DC11626686E2}" type="pres">
      <dgm:prSet presAssocID="{DB075803-47FD-4DB5-B83E-BF2A7CDBBD54}" presName="linNode" presStyleCnt="0"/>
      <dgm:spPr/>
    </dgm:pt>
    <dgm:pt modelId="{3092E2E4-F9C9-4F63-973A-0773214EC645}" type="pres">
      <dgm:prSet presAssocID="{DB075803-47FD-4DB5-B83E-BF2A7CDBBD54}" presName="parentText" presStyleLbl="node1" presStyleIdx="0" presStyleCnt="7">
        <dgm:presLayoutVars>
          <dgm:chMax val="1"/>
          <dgm:bulletEnabled val="1"/>
        </dgm:presLayoutVars>
      </dgm:prSet>
      <dgm:spPr/>
    </dgm:pt>
    <dgm:pt modelId="{9DACEBA6-B7F3-470B-ADE0-7C787F395B68}" type="pres">
      <dgm:prSet presAssocID="{DB075803-47FD-4DB5-B83E-BF2A7CDBBD54}" presName="descendantText" presStyleLbl="alignAccFollowNode1" presStyleIdx="0" presStyleCnt="7">
        <dgm:presLayoutVars>
          <dgm:bulletEnabled val="1"/>
        </dgm:presLayoutVars>
      </dgm:prSet>
      <dgm:spPr/>
    </dgm:pt>
    <dgm:pt modelId="{7AA1575C-1C73-4A7C-BDE0-9DB82851E80D}" type="pres">
      <dgm:prSet presAssocID="{78942D9E-6C8F-4EA7-9B65-58C74C5FCE14}" presName="sp" presStyleCnt="0"/>
      <dgm:spPr/>
    </dgm:pt>
    <dgm:pt modelId="{6F17102B-E77D-405E-9F8E-0904A6AC1919}" type="pres">
      <dgm:prSet presAssocID="{9F2592C2-998B-4A47-9E58-E00937D37CFC}" presName="linNode" presStyleCnt="0"/>
      <dgm:spPr/>
    </dgm:pt>
    <dgm:pt modelId="{50633897-3B87-42CF-9EE5-E4AD5C561271}" type="pres">
      <dgm:prSet presAssocID="{9F2592C2-998B-4A47-9E58-E00937D37CFC}" presName="parentText" presStyleLbl="node1" presStyleIdx="1" presStyleCnt="7">
        <dgm:presLayoutVars>
          <dgm:chMax val="1"/>
          <dgm:bulletEnabled val="1"/>
        </dgm:presLayoutVars>
      </dgm:prSet>
      <dgm:spPr/>
    </dgm:pt>
    <dgm:pt modelId="{5C5B57D6-C573-4FF5-8D2D-153330CE39BF}" type="pres">
      <dgm:prSet presAssocID="{9F2592C2-998B-4A47-9E58-E00937D37CFC}" presName="descendantText" presStyleLbl="alignAccFollowNode1" presStyleIdx="1" presStyleCnt="7">
        <dgm:presLayoutVars>
          <dgm:bulletEnabled val="1"/>
        </dgm:presLayoutVars>
      </dgm:prSet>
      <dgm:spPr/>
    </dgm:pt>
    <dgm:pt modelId="{A82357A7-EC76-44AB-B02D-22661D95AD9A}" type="pres">
      <dgm:prSet presAssocID="{B3F41A94-E23D-4BD5-A8E9-562302999318}" presName="sp" presStyleCnt="0"/>
      <dgm:spPr/>
    </dgm:pt>
    <dgm:pt modelId="{7A3F2C14-5BF2-45F3-B6DD-E8D7BA393605}" type="pres">
      <dgm:prSet presAssocID="{5F4A103B-4AA8-4418-82AC-7D096AD9B81C}" presName="linNode" presStyleCnt="0"/>
      <dgm:spPr/>
    </dgm:pt>
    <dgm:pt modelId="{9A84E1C7-ABDB-452D-A2BB-D2E2388A0633}" type="pres">
      <dgm:prSet presAssocID="{5F4A103B-4AA8-4418-82AC-7D096AD9B81C}" presName="parentText" presStyleLbl="node1" presStyleIdx="2" presStyleCnt="7">
        <dgm:presLayoutVars>
          <dgm:chMax val="1"/>
          <dgm:bulletEnabled val="1"/>
        </dgm:presLayoutVars>
      </dgm:prSet>
      <dgm:spPr/>
    </dgm:pt>
    <dgm:pt modelId="{1D004FCF-E91A-483C-9730-425CC505DE1C}" type="pres">
      <dgm:prSet presAssocID="{5F4A103B-4AA8-4418-82AC-7D096AD9B81C}" presName="descendantText" presStyleLbl="alignAccFollowNode1" presStyleIdx="2" presStyleCnt="7">
        <dgm:presLayoutVars>
          <dgm:bulletEnabled val="1"/>
        </dgm:presLayoutVars>
      </dgm:prSet>
      <dgm:spPr/>
    </dgm:pt>
    <dgm:pt modelId="{38DCDEC3-F55F-460A-AC3E-C225B370726C}" type="pres">
      <dgm:prSet presAssocID="{5E260F6B-7FE7-47F9-B575-BE5EB3F37287}" presName="sp" presStyleCnt="0"/>
      <dgm:spPr/>
    </dgm:pt>
    <dgm:pt modelId="{0B45CD7B-5F42-403F-8C3A-5F65AA5B9B99}" type="pres">
      <dgm:prSet presAssocID="{810C17BD-7B7E-4D83-88E9-5C58C115F508}" presName="linNode" presStyleCnt="0"/>
      <dgm:spPr/>
    </dgm:pt>
    <dgm:pt modelId="{BE93C424-47EE-431F-9F11-D78EA5D08920}" type="pres">
      <dgm:prSet presAssocID="{810C17BD-7B7E-4D83-88E9-5C58C115F508}" presName="parentText" presStyleLbl="node1" presStyleIdx="3" presStyleCnt="7">
        <dgm:presLayoutVars>
          <dgm:chMax val="1"/>
          <dgm:bulletEnabled val="1"/>
        </dgm:presLayoutVars>
      </dgm:prSet>
      <dgm:spPr/>
    </dgm:pt>
    <dgm:pt modelId="{95851911-1337-415F-9D84-EF5E60FC8F57}" type="pres">
      <dgm:prSet presAssocID="{810C17BD-7B7E-4D83-88E9-5C58C115F508}" presName="descendantText" presStyleLbl="alignAccFollowNode1" presStyleIdx="3" presStyleCnt="7">
        <dgm:presLayoutVars>
          <dgm:bulletEnabled val="1"/>
        </dgm:presLayoutVars>
      </dgm:prSet>
      <dgm:spPr/>
    </dgm:pt>
    <dgm:pt modelId="{0655EB3E-84C2-4E4A-99F6-19410BD0D420}" type="pres">
      <dgm:prSet presAssocID="{A4BF771C-B458-4A71-9BF7-84580C8C3EC3}" presName="sp" presStyleCnt="0"/>
      <dgm:spPr/>
    </dgm:pt>
    <dgm:pt modelId="{B255ED18-9ABA-4CD4-9201-95026C25F740}" type="pres">
      <dgm:prSet presAssocID="{06D83BE3-FCFA-4048-8D16-230C825D550A}" presName="linNode" presStyleCnt="0"/>
      <dgm:spPr/>
    </dgm:pt>
    <dgm:pt modelId="{D377DF79-CDC0-4998-B9B6-936269382C55}" type="pres">
      <dgm:prSet presAssocID="{06D83BE3-FCFA-4048-8D16-230C825D550A}" presName="parentText" presStyleLbl="node1" presStyleIdx="4" presStyleCnt="7">
        <dgm:presLayoutVars>
          <dgm:chMax val="1"/>
          <dgm:bulletEnabled val="1"/>
        </dgm:presLayoutVars>
      </dgm:prSet>
      <dgm:spPr/>
    </dgm:pt>
    <dgm:pt modelId="{FE1DED6C-1D78-4D0C-9015-56718EC33E2C}" type="pres">
      <dgm:prSet presAssocID="{06D83BE3-FCFA-4048-8D16-230C825D550A}" presName="descendantText" presStyleLbl="alignAccFollowNode1" presStyleIdx="4" presStyleCnt="7">
        <dgm:presLayoutVars>
          <dgm:bulletEnabled val="1"/>
        </dgm:presLayoutVars>
      </dgm:prSet>
      <dgm:spPr/>
    </dgm:pt>
    <dgm:pt modelId="{7CBF3F6A-72BF-4A9C-A378-CB33F1F127E6}" type="pres">
      <dgm:prSet presAssocID="{F71EC33C-0E95-4882-BF25-6F1F09743635}" presName="sp" presStyleCnt="0"/>
      <dgm:spPr/>
    </dgm:pt>
    <dgm:pt modelId="{8E91BD0A-DDB0-481B-B4F4-2BE608096BA3}" type="pres">
      <dgm:prSet presAssocID="{7C92A925-4102-4FAD-A9B1-D4E3B87D2F8E}" presName="linNode" presStyleCnt="0"/>
      <dgm:spPr/>
    </dgm:pt>
    <dgm:pt modelId="{40834933-7240-405D-BC12-8C6F826CEF86}" type="pres">
      <dgm:prSet presAssocID="{7C92A925-4102-4FAD-A9B1-D4E3B87D2F8E}" presName="parentText" presStyleLbl="node1" presStyleIdx="5" presStyleCnt="7">
        <dgm:presLayoutVars>
          <dgm:chMax val="1"/>
          <dgm:bulletEnabled val="1"/>
        </dgm:presLayoutVars>
      </dgm:prSet>
      <dgm:spPr/>
    </dgm:pt>
    <dgm:pt modelId="{C46D864B-4BB9-4140-A9DC-E6666ED80EFB}" type="pres">
      <dgm:prSet presAssocID="{7C92A925-4102-4FAD-A9B1-D4E3B87D2F8E}" presName="descendantText" presStyleLbl="alignAccFollowNode1" presStyleIdx="5" presStyleCnt="7">
        <dgm:presLayoutVars>
          <dgm:bulletEnabled val="1"/>
        </dgm:presLayoutVars>
      </dgm:prSet>
      <dgm:spPr/>
    </dgm:pt>
    <dgm:pt modelId="{F7CAD794-09D7-4CAC-8A39-D2BBE12E5ADB}" type="pres">
      <dgm:prSet presAssocID="{8B42E6B1-A368-479B-B9F9-E1B80644105E}" presName="sp" presStyleCnt="0"/>
      <dgm:spPr/>
    </dgm:pt>
    <dgm:pt modelId="{910430C3-CEEC-4EF5-B507-CD626ACCF11F}" type="pres">
      <dgm:prSet presAssocID="{193B099A-39FC-4047-A261-82AC950A257A}" presName="linNode" presStyleCnt="0"/>
      <dgm:spPr/>
    </dgm:pt>
    <dgm:pt modelId="{2477482A-E0D8-4105-B60F-16A4E647AB90}" type="pres">
      <dgm:prSet presAssocID="{193B099A-39FC-4047-A261-82AC950A257A}" presName="parentText" presStyleLbl="node1" presStyleIdx="6" presStyleCnt="7">
        <dgm:presLayoutVars>
          <dgm:chMax val="1"/>
          <dgm:bulletEnabled val="1"/>
        </dgm:presLayoutVars>
      </dgm:prSet>
      <dgm:spPr/>
    </dgm:pt>
    <dgm:pt modelId="{D4DA00CE-234C-4754-A39C-23B55302F42B}" type="pres">
      <dgm:prSet presAssocID="{193B099A-39FC-4047-A261-82AC950A257A}" presName="descendantText" presStyleLbl="alignAccFollowNode1" presStyleIdx="6" presStyleCnt="7">
        <dgm:presLayoutVars>
          <dgm:bulletEnabled val="1"/>
        </dgm:presLayoutVars>
      </dgm:prSet>
      <dgm:spPr/>
    </dgm:pt>
  </dgm:ptLst>
  <dgm:cxnLst>
    <dgm:cxn modelId="{9C3AC200-6CDB-4F90-9FDC-051702D11EB1}" srcId="{06D83BE3-FCFA-4048-8D16-230C825D550A}" destId="{538CF43F-9C6A-4DEA-967F-FC4DD1C387DD}" srcOrd="0" destOrd="0" parTransId="{1EEA00F7-25AC-4755-A2EE-4F5DE882DF9D}" sibTransId="{412D142B-01C4-4783-957A-762696A359B3}"/>
    <dgm:cxn modelId="{B2D3A30B-B810-48E2-B10C-A6B4A63F9C50}" srcId="{193B099A-39FC-4047-A261-82AC950A257A}" destId="{A442D9E5-0C7F-45E7-9E89-5D96791D8BA6}" srcOrd="1" destOrd="0" parTransId="{E105F7B4-83BF-4E00-A438-BA017D61A208}" sibTransId="{C50000FF-F7E4-4B37-9CFA-3A05E2A565C2}"/>
    <dgm:cxn modelId="{E965AD0D-F1D9-47E0-AEC5-C40A30509EC8}" type="presOf" srcId="{9F2592C2-998B-4A47-9E58-E00937D37CFC}" destId="{50633897-3B87-42CF-9EE5-E4AD5C561271}" srcOrd="0" destOrd="0" presId="urn:microsoft.com/office/officeart/2005/8/layout/vList5"/>
    <dgm:cxn modelId="{78989411-E3F4-48CB-AD01-359ECCAA6027}" type="presOf" srcId="{DB075803-47FD-4DB5-B83E-BF2A7CDBBD54}" destId="{3092E2E4-F9C9-4F63-973A-0773214EC645}" srcOrd="0" destOrd="0" presId="urn:microsoft.com/office/officeart/2005/8/layout/vList5"/>
    <dgm:cxn modelId="{60E14518-F6D4-484B-A5ED-5679A9DEC7BD}" srcId="{810C17BD-7B7E-4D83-88E9-5C58C115F508}" destId="{0AE20938-1B41-4640-9D3D-7271D505604F}" srcOrd="1" destOrd="0" parTransId="{90FE48D0-E624-427B-BDF5-21419A0CA42C}" sibTransId="{3C420805-1542-4249-93C3-2D96F7472340}"/>
    <dgm:cxn modelId="{78D9651C-50E3-45BB-A6A0-7BB1BA66D1DC}" type="presOf" srcId="{7C92A925-4102-4FAD-A9B1-D4E3B87D2F8E}" destId="{40834933-7240-405D-BC12-8C6F826CEF86}" srcOrd="0" destOrd="0" presId="urn:microsoft.com/office/officeart/2005/8/layout/vList5"/>
    <dgm:cxn modelId="{54C92A25-8591-44E9-8B28-420814CDE3AB}" type="presOf" srcId="{CB61E494-D396-4621-AF3F-E3C0B0995F94}" destId="{95851911-1337-415F-9D84-EF5E60FC8F57}" srcOrd="0" destOrd="0" presId="urn:microsoft.com/office/officeart/2005/8/layout/vList5"/>
    <dgm:cxn modelId="{6ABC7D25-40AC-4129-A08A-6B0DDAFC82A2}" type="presOf" srcId="{96D559F2-D0FD-4BC2-8EC9-526379E7AD18}" destId="{C46D864B-4BB9-4140-A9DC-E6666ED80EFB}" srcOrd="0" destOrd="0" presId="urn:microsoft.com/office/officeart/2005/8/layout/vList5"/>
    <dgm:cxn modelId="{02515526-E19D-4887-9881-68FE02F57F01}" type="presOf" srcId="{5D35BAFA-8687-4F25-94FA-8D9AA628343F}" destId="{9DACEBA6-B7F3-470B-ADE0-7C787F395B68}" srcOrd="0" destOrd="1" presId="urn:microsoft.com/office/officeart/2005/8/layout/vList5"/>
    <dgm:cxn modelId="{6E555E2C-2167-4A67-8C1C-F30787163993}" srcId="{3D80F380-3B92-445C-9991-34B8A33B2ECF}" destId="{5F4A103B-4AA8-4418-82AC-7D096AD9B81C}" srcOrd="2" destOrd="0" parTransId="{5BA346A5-4CA3-4BA8-9CC4-10CE51A66BC6}" sibTransId="{5E260F6B-7FE7-47F9-B575-BE5EB3F37287}"/>
    <dgm:cxn modelId="{E4F24938-FEBA-47C6-B71E-FE8590A89075}" srcId="{810C17BD-7B7E-4D83-88E9-5C58C115F508}" destId="{CB61E494-D396-4621-AF3F-E3C0B0995F94}" srcOrd="0" destOrd="0" parTransId="{DC170920-C042-4B03-B9BC-A9E1189AB832}" sibTransId="{B005A2D1-0999-43D0-8C45-CB93904F5203}"/>
    <dgm:cxn modelId="{D5FD4839-67D1-4282-9EBC-C44F49E332B8}" srcId="{7C92A925-4102-4FAD-A9B1-D4E3B87D2F8E}" destId="{3FE18A39-C52B-468E-893E-696793BB8CD5}" srcOrd="1" destOrd="0" parTransId="{1AA94533-6EF1-44ED-93C8-D482BC438EF7}" sibTransId="{E476412F-E350-406C-8102-18E9F6C6A41F}"/>
    <dgm:cxn modelId="{F74CF739-F67E-470C-B169-1107BC213704}" type="presOf" srcId="{3F045143-DC35-4B29-95B5-5BE2275ABAB4}" destId="{1D004FCF-E91A-483C-9730-425CC505DE1C}" srcOrd="0" destOrd="1" presId="urn:microsoft.com/office/officeart/2005/8/layout/vList5"/>
    <dgm:cxn modelId="{DF61853D-0B45-43DB-A5E6-37E3A6E44B4D}" srcId="{3D80F380-3B92-445C-9991-34B8A33B2ECF}" destId="{7C92A925-4102-4FAD-A9B1-D4E3B87D2F8E}" srcOrd="5" destOrd="0" parTransId="{1B581FE9-F870-4969-926F-51200D1A6A6A}" sibTransId="{8B42E6B1-A368-479B-B9F9-E1B80644105E}"/>
    <dgm:cxn modelId="{B40D0967-38AE-4E00-9644-C059D79E6094}" srcId="{5F4A103B-4AA8-4418-82AC-7D096AD9B81C}" destId="{1A5ED0D3-96AB-419C-83FA-236E50BE8D16}" srcOrd="0" destOrd="0" parTransId="{E2E60623-A6E2-4060-AD82-5441D91B0101}" sibTransId="{E2747C47-DDDA-4502-B577-46B78699E3D7}"/>
    <dgm:cxn modelId="{F51DBC6F-0153-4BD1-9545-795099311079}" type="presOf" srcId="{6659CE27-AA55-4A46-B98B-82B5043589AD}" destId="{5C5B57D6-C573-4FF5-8D2D-153330CE39BF}" srcOrd="0" destOrd="0" presId="urn:microsoft.com/office/officeart/2005/8/layout/vList5"/>
    <dgm:cxn modelId="{A1592A71-DC9C-40CD-9FB9-A115B043B522}" srcId="{DB075803-47FD-4DB5-B83E-BF2A7CDBBD54}" destId="{9745292D-6715-4E04-B91E-C0614E23867A}" srcOrd="0" destOrd="0" parTransId="{F795554E-2EDE-4F4B-8917-D5917A218A88}" sibTransId="{7791AC7C-7DAF-4E12-AA31-CE07725457FF}"/>
    <dgm:cxn modelId="{7E0F7556-8DD3-4C78-BF97-7EAA5C20A5A6}" srcId="{3D80F380-3B92-445C-9991-34B8A33B2ECF}" destId="{06D83BE3-FCFA-4048-8D16-230C825D550A}" srcOrd="4" destOrd="0" parTransId="{E66CF30B-F999-4F3C-BB5B-0D880C09F48D}" sibTransId="{F71EC33C-0E95-4882-BF25-6F1F09743635}"/>
    <dgm:cxn modelId="{AEDDC577-23BD-4384-B7AE-001627E1CF03}" srcId="{3D80F380-3B92-445C-9991-34B8A33B2ECF}" destId="{193B099A-39FC-4047-A261-82AC950A257A}" srcOrd="6" destOrd="0" parTransId="{B6EC4905-A10A-45E1-A975-F763613F8DB7}" sibTransId="{DC0D5F73-CC38-42EB-BB83-162472AA134A}"/>
    <dgm:cxn modelId="{7AA40E58-28C4-4A30-8C02-35270BE0EE29}" type="presOf" srcId="{9745292D-6715-4E04-B91E-C0614E23867A}" destId="{9DACEBA6-B7F3-470B-ADE0-7C787F395B68}" srcOrd="0" destOrd="0" presId="urn:microsoft.com/office/officeart/2005/8/layout/vList5"/>
    <dgm:cxn modelId="{DA9CF67A-B390-4AF1-97D6-A3689BC127FF}" type="presOf" srcId="{193B099A-39FC-4047-A261-82AC950A257A}" destId="{2477482A-E0D8-4105-B60F-16A4E647AB90}" srcOrd="0" destOrd="0" presId="urn:microsoft.com/office/officeart/2005/8/layout/vList5"/>
    <dgm:cxn modelId="{CD80D97C-7215-415A-9872-A7EE3FD575DE}" srcId="{5F4A103B-4AA8-4418-82AC-7D096AD9B81C}" destId="{3F045143-DC35-4B29-95B5-5BE2275ABAB4}" srcOrd="1" destOrd="0" parTransId="{C834F8B6-E81D-46A1-BF24-070FA0D75E60}" sibTransId="{CD3D7471-FC66-423F-8ACE-B248C3DDE5F3}"/>
    <dgm:cxn modelId="{69E8F480-5287-4F9E-9C22-9319E66177DE}" type="presOf" srcId="{A442D9E5-0C7F-45E7-9E89-5D96791D8BA6}" destId="{D4DA00CE-234C-4754-A39C-23B55302F42B}" srcOrd="0" destOrd="1" presId="urn:microsoft.com/office/officeart/2005/8/layout/vList5"/>
    <dgm:cxn modelId="{8F8FA481-F80F-4010-8D11-10D757796072}" type="presOf" srcId="{3D80F380-3B92-445C-9991-34B8A33B2ECF}" destId="{C1BBEA97-13F5-4E11-A031-17BAD9EBF99A}" srcOrd="0" destOrd="0" presId="urn:microsoft.com/office/officeart/2005/8/layout/vList5"/>
    <dgm:cxn modelId="{DBBB1382-14DE-4F54-A094-5EC3D2D1E0E1}" srcId="{3D80F380-3B92-445C-9991-34B8A33B2ECF}" destId="{810C17BD-7B7E-4D83-88E9-5C58C115F508}" srcOrd="3" destOrd="0" parTransId="{192B5EB6-75F1-49DA-A42A-D78D7B8407CE}" sibTransId="{A4BF771C-B458-4A71-9BF7-84580C8C3EC3}"/>
    <dgm:cxn modelId="{7919338B-1555-490B-9CC6-99300EFC254A}" type="presOf" srcId="{1A5ED0D3-96AB-419C-83FA-236E50BE8D16}" destId="{1D004FCF-E91A-483C-9730-425CC505DE1C}" srcOrd="0" destOrd="0" presId="urn:microsoft.com/office/officeart/2005/8/layout/vList5"/>
    <dgm:cxn modelId="{0254E98D-858F-43A5-A17F-3898AA81E6AC}" type="presOf" srcId="{06D83BE3-FCFA-4048-8D16-230C825D550A}" destId="{D377DF79-CDC0-4998-B9B6-936269382C55}" srcOrd="0" destOrd="0" presId="urn:microsoft.com/office/officeart/2005/8/layout/vList5"/>
    <dgm:cxn modelId="{F9F3288E-45E9-4943-B44E-6131B1C8800F}" type="presOf" srcId="{538CF43F-9C6A-4DEA-967F-FC4DD1C387DD}" destId="{FE1DED6C-1D78-4D0C-9015-56718EC33E2C}" srcOrd="0" destOrd="0" presId="urn:microsoft.com/office/officeart/2005/8/layout/vList5"/>
    <dgm:cxn modelId="{919A0192-96AD-43F1-AF6D-E1A7F882077B}" srcId="{9F2592C2-998B-4A47-9E58-E00937D37CFC}" destId="{6659CE27-AA55-4A46-B98B-82B5043589AD}" srcOrd="0" destOrd="0" parTransId="{F24DB68B-970C-49AE-97C6-EC37A141622B}" sibTransId="{63B75610-20CE-4243-93C5-54E6B1F6C7D6}"/>
    <dgm:cxn modelId="{7A8989A1-DDA0-4126-9873-0642C42C0F5A}" srcId="{7C92A925-4102-4FAD-A9B1-D4E3B87D2F8E}" destId="{96D559F2-D0FD-4BC2-8EC9-526379E7AD18}" srcOrd="0" destOrd="0" parTransId="{B5D035D1-EE80-4CA5-91CE-F62713F7840C}" sibTransId="{3AA75ACC-A82C-41CB-ACC4-22383A1704D5}"/>
    <dgm:cxn modelId="{8CF41BA4-D2E3-495D-B044-649FD0E3BCFD}" type="presOf" srcId="{0AE20938-1B41-4640-9D3D-7271D505604F}" destId="{95851911-1337-415F-9D84-EF5E60FC8F57}" srcOrd="0" destOrd="1" presId="urn:microsoft.com/office/officeart/2005/8/layout/vList5"/>
    <dgm:cxn modelId="{C89D4CAB-AE65-496D-B8D1-7FE50D60535C}" type="presOf" srcId="{3FE18A39-C52B-468E-893E-696793BB8CD5}" destId="{C46D864B-4BB9-4140-A9DC-E6666ED80EFB}" srcOrd="0" destOrd="1" presId="urn:microsoft.com/office/officeart/2005/8/layout/vList5"/>
    <dgm:cxn modelId="{547FF4B0-03FE-4571-AFC4-5C6D0E39FB01}" srcId="{193B099A-39FC-4047-A261-82AC950A257A}" destId="{A29821AE-302A-4B92-AC7E-952784B85349}" srcOrd="0" destOrd="0" parTransId="{5BA37330-26F4-4626-8F00-A8459D8B624E}" sibTransId="{5D9C1022-93FA-4E6B-8B2C-DC7263A8468F}"/>
    <dgm:cxn modelId="{18D2AAB6-F302-4B7E-91DA-42CD9640BCC4}" srcId="{3D80F380-3B92-445C-9991-34B8A33B2ECF}" destId="{9F2592C2-998B-4A47-9E58-E00937D37CFC}" srcOrd="1" destOrd="0" parTransId="{883A47F4-AA77-49E4-90AA-DF6383217CA7}" sibTransId="{B3F41A94-E23D-4BD5-A8E9-562302999318}"/>
    <dgm:cxn modelId="{C3A7DBC3-634B-460B-94F8-DAE278E5EAA4}" srcId="{3D80F380-3B92-445C-9991-34B8A33B2ECF}" destId="{DB075803-47FD-4DB5-B83E-BF2A7CDBBD54}" srcOrd="0" destOrd="0" parTransId="{38310BF9-D507-44A9-AADB-CF44166423F0}" sibTransId="{78942D9E-6C8F-4EA7-9B65-58C74C5FCE14}"/>
    <dgm:cxn modelId="{C4E2FCCF-482B-467B-A1CE-31F2EF0207CA}" type="presOf" srcId="{A29821AE-302A-4B92-AC7E-952784B85349}" destId="{D4DA00CE-234C-4754-A39C-23B55302F42B}" srcOrd="0" destOrd="0" presId="urn:microsoft.com/office/officeart/2005/8/layout/vList5"/>
    <dgm:cxn modelId="{9381E9E5-049B-4CCE-89B5-227100D374FC}" srcId="{DB075803-47FD-4DB5-B83E-BF2A7CDBBD54}" destId="{5D35BAFA-8687-4F25-94FA-8D9AA628343F}" srcOrd="1" destOrd="0" parTransId="{64D35FE2-6687-4F5C-92D3-FCC8D1B641E6}" sibTransId="{B4990353-A4CB-4120-914F-4B12CBB79BE1}"/>
    <dgm:cxn modelId="{2C5DECEA-B9C3-4065-BE10-68135CD175D6}" type="presOf" srcId="{5F4A103B-4AA8-4418-82AC-7D096AD9B81C}" destId="{9A84E1C7-ABDB-452D-A2BB-D2E2388A0633}" srcOrd="0" destOrd="0" presId="urn:microsoft.com/office/officeart/2005/8/layout/vList5"/>
    <dgm:cxn modelId="{BE90A7FD-DDFE-4B3C-8594-BE0B16D22BDA}" type="presOf" srcId="{810C17BD-7B7E-4D83-88E9-5C58C115F508}" destId="{BE93C424-47EE-431F-9F11-D78EA5D08920}" srcOrd="0" destOrd="0" presId="urn:microsoft.com/office/officeart/2005/8/layout/vList5"/>
    <dgm:cxn modelId="{B9BE6D5E-B7AA-420D-9EB8-A3AF1C0076FE}" type="presParOf" srcId="{C1BBEA97-13F5-4E11-A031-17BAD9EBF99A}" destId="{46E2197D-7F88-467B-8EE5-DC11626686E2}" srcOrd="0" destOrd="0" presId="urn:microsoft.com/office/officeart/2005/8/layout/vList5"/>
    <dgm:cxn modelId="{65585AA8-1A35-484F-9E98-C6D9CD15B889}" type="presParOf" srcId="{46E2197D-7F88-467B-8EE5-DC11626686E2}" destId="{3092E2E4-F9C9-4F63-973A-0773214EC645}" srcOrd="0" destOrd="0" presId="urn:microsoft.com/office/officeart/2005/8/layout/vList5"/>
    <dgm:cxn modelId="{D9D50265-F2D9-4311-8EFA-6113F92D83CE}" type="presParOf" srcId="{46E2197D-7F88-467B-8EE5-DC11626686E2}" destId="{9DACEBA6-B7F3-470B-ADE0-7C787F395B68}" srcOrd="1" destOrd="0" presId="urn:microsoft.com/office/officeart/2005/8/layout/vList5"/>
    <dgm:cxn modelId="{98DB2AB8-1956-45B2-A362-3AE0389E9F1B}" type="presParOf" srcId="{C1BBEA97-13F5-4E11-A031-17BAD9EBF99A}" destId="{7AA1575C-1C73-4A7C-BDE0-9DB82851E80D}" srcOrd="1" destOrd="0" presId="urn:microsoft.com/office/officeart/2005/8/layout/vList5"/>
    <dgm:cxn modelId="{BE733C00-9A42-4BBC-87A6-965FACDB31B1}" type="presParOf" srcId="{C1BBEA97-13F5-4E11-A031-17BAD9EBF99A}" destId="{6F17102B-E77D-405E-9F8E-0904A6AC1919}" srcOrd="2" destOrd="0" presId="urn:microsoft.com/office/officeart/2005/8/layout/vList5"/>
    <dgm:cxn modelId="{B79FCB58-9E2D-4130-B88D-E3EF1F7EAB48}" type="presParOf" srcId="{6F17102B-E77D-405E-9F8E-0904A6AC1919}" destId="{50633897-3B87-42CF-9EE5-E4AD5C561271}" srcOrd="0" destOrd="0" presId="urn:microsoft.com/office/officeart/2005/8/layout/vList5"/>
    <dgm:cxn modelId="{316A508D-16FF-43CC-8A78-738DD6936E33}" type="presParOf" srcId="{6F17102B-E77D-405E-9F8E-0904A6AC1919}" destId="{5C5B57D6-C573-4FF5-8D2D-153330CE39BF}" srcOrd="1" destOrd="0" presId="urn:microsoft.com/office/officeart/2005/8/layout/vList5"/>
    <dgm:cxn modelId="{98AD8DA8-DD3F-4544-8350-0CBE76C9E288}" type="presParOf" srcId="{C1BBEA97-13F5-4E11-A031-17BAD9EBF99A}" destId="{A82357A7-EC76-44AB-B02D-22661D95AD9A}" srcOrd="3" destOrd="0" presId="urn:microsoft.com/office/officeart/2005/8/layout/vList5"/>
    <dgm:cxn modelId="{FC2A1997-6FCD-4D51-9C20-873F6118D66D}" type="presParOf" srcId="{C1BBEA97-13F5-4E11-A031-17BAD9EBF99A}" destId="{7A3F2C14-5BF2-45F3-B6DD-E8D7BA393605}" srcOrd="4" destOrd="0" presId="urn:microsoft.com/office/officeart/2005/8/layout/vList5"/>
    <dgm:cxn modelId="{919532ED-875B-484F-A6D1-15091E89123E}" type="presParOf" srcId="{7A3F2C14-5BF2-45F3-B6DD-E8D7BA393605}" destId="{9A84E1C7-ABDB-452D-A2BB-D2E2388A0633}" srcOrd="0" destOrd="0" presId="urn:microsoft.com/office/officeart/2005/8/layout/vList5"/>
    <dgm:cxn modelId="{90D76702-B90B-40FB-ADCC-D95B291B0076}" type="presParOf" srcId="{7A3F2C14-5BF2-45F3-B6DD-E8D7BA393605}" destId="{1D004FCF-E91A-483C-9730-425CC505DE1C}" srcOrd="1" destOrd="0" presId="urn:microsoft.com/office/officeart/2005/8/layout/vList5"/>
    <dgm:cxn modelId="{FD065FEE-6E01-48B6-9B63-AF77AB8CB025}" type="presParOf" srcId="{C1BBEA97-13F5-4E11-A031-17BAD9EBF99A}" destId="{38DCDEC3-F55F-460A-AC3E-C225B370726C}" srcOrd="5" destOrd="0" presId="urn:microsoft.com/office/officeart/2005/8/layout/vList5"/>
    <dgm:cxn modelId="{2B9D5F91-2B57-4844-822A-38B568B1A81E}" type="presParOf" srcId="{C1BBEA97-13F5-4E11-A031-17BAD9EBF99A}" destId="{0B45CD7B-5F42-403F-8C3A-5F65AA5B9B99}" srcOrd="6" destOrd="0" presId="urn:microsoft.com/office/officeart/2005/8/layout/vList5"/>
    <dgm:cxn modelId="{17176175-22D4-4FEC-B19B-08D4FF1DE5D2}" type="presParOf" srcId="{0B45CD7B-5F42-403F-8C3A-5F65AA5B9B99}" destId="{BE93C424-47EE-431F-9F11-D78EA5D08920}" srcOrd="0" destOrd="0" presId="urn:microsoft.com/office/officeart/2005/8/layout/vList5"/>
    <dgm:cxn modelId="{D73628C8-1944-415A-8D00-01126187D150}" type="presParOf" srcId="{0B45CD7B-5F42-403F-8C3A-5F65AA5B9B99}" destId="{95851911-1337-415F-9D84-EF5E60FC8F57}" srcOrd="1" destOrd="0" presId="urn:microsoft.com/office/officeart/2005/8/layout/vList5"/>
    <dgm:cxn modelId="{71A88358-4C9D-4F20-B5A8-1814F1DFC2C9}" type="presParOf" srcId="{C1BBEA97-13F5-4E11-A031-17BAD9EBF99A}" destId="{0655EB3E-84C2-4E4A-99F6-19410BD0D420}" srcOrd="7" destOrd="0" presId="urn:microsoft.com/office/officeart/2005/8/layout/vList5"/>
    <dgm:cxn modelId="{E12B9ED0-0AAE-4727-AE74-4E97BFC63DD4}" type="presParOf" srcId="{C1BBEA97-13F5-4E11-A031-17BAD9EBF99A}" destId="{B255ED18-9ABA-4CD4-9201-95026C25F740}" srcOrd="8" destOrd="0" presId="urn:microsoft.com/office/officeart/2005/8/layout/vList5"/>
    <dgm:cxn modelId="{647F0D47-C478-4D64-B3EB-47D95771AAC0}" type="presParOf" srcId="{B255ED18-9ABA-4CD4-9201-95026C25F740}" destId="{D377DF79-CDC0-4998-B9B6-936269382C55}" srcOrd="0" destOrd="0" presId="urn:microsoft.com/office/officeart/2005/8/layout/vList5"/>
    <dgm:cxn modelId="{8A63AF5C-6AD4-4034-A15E-4573A4CA3970}" type="presParOf" srcId="{B255ED18-9ABA-4CD4-9201-95026C25F740}" destId="{FE1DED6C-1D78-4D0C-9015-56718EC33E2C}" srcOrd="1" destOrd="0" presId="urn:microsoft.com/office/officeart/2005/8/layout/vList5"/>
    <dgm:cxn modelId="{1B8437C2-B1E0-4DCF-B310-B078593E1996}" type="presParOf" srcId="{C1BBEA97-13F5-4E11-A031-17BAD9EBF99A}" destId="{7CBF3F6A-72BF-4A9C-A378-CB33F1F127E6}" srcOrd="9" destOrd="0" presId="urn:microsoft.com/office/officeart/2005/8/layout/vList5"/>
    <dgm:cxn modelId="{E00F2856-3FB1-4C54-902D-3DB82259BC5E}" type="presParOf" srcId="{C1BBEA97-13F5-4E11-A031-17BAD9EBF99A}" destId="{8E91BD0A-DDB0-481B-B4F4-2BE608096BA3}" srcOrd="10" destOrd="0" presId="urn:microsoft.com/office/officeart/2005/8/layout/vList5"/>
    <dgm:cxn modelId="{C30FED79-60FB-4EAC-B041-47419B506FB7}" type="presParOf" srcId="{8E91BD0A-DDB0-481B-B4F4-2BE608096BA3}" destId="{40834933-7240-405D-BC12-8C6F826CEF86}" srcOrd="0" destOrd="0" presId="urn:microsoft.com/office/officeart/2005/8/layout/vList5"/>
    <dgm:cxn modelId="{F57B9BD9-509B-448B-A714-059D38D4EA5A}" type="presParOf" srcId="{8E91BD0A-DDB0-481B-B4F4-2BE608096BA3}" destId="{C46D864B-4BB9-4140-A9DC-E6666ED80EFB}" srcOrd="1" destOrd="0" presId="urn:microsoft.com/office/officeart/2005/8/layout/vList5"/>
    <dgm:cxn modelId="{0EB3223B-2B35-4875-89A4-B69705E2F755}" type="presParOf" srcId="{C1BBEA97-13F5-4E11-A031-17BAD9EBF99A}" destId="{F7CAD794-09D7-4CAC-8A39-D2BBE12E5ADB}" srcOrd="11" destOrd="0" presId="urn:microsoft.com/office/officeart/2005/8/layout/vList5"/>
    <dgm:cxn modelId="{2750AD4F-3F1B-4236-9A65-1A669942D15F}" type="presParOf" srcId="{C1BBEA97-13F5-4E11-A031-17BAD9EBF99A}" destId="{910430C3-CEEC-4EF5-B507-CD626ACCF11F}" srcOrd="12" destOrd="0" presId="urn:microsoft.com/office/officeart/2005/8/layout/vList5"/>
    <dgm:cxn modelId="{6D1877F1-8CA5-4550-A3CD-B26CC6ED6C6A}" type="presParOf" srcId="{910430C3-CEEC-4EF5-B507-CD626ACCF11F}" destId="{2477482A-E0D8-4105-B60F-16A4E647AB90}" srcOrd="0" destOrd="0" presId="urn:microsoft.com/office/officeart/2005/8/layout/vList5"/>
    <dgm:cxn modelId="{CB6D1B53-F623-47D7-961C-9E2FC6C2CBD6}" type="presParOf" srcId="{910430C3-CEEC-4EF5-B507-CD626ACCF11F}" destId="{D4DA00CE-234C-4754-A39C-23B55302F42B}"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D80F380-3B92-445C-9991-34B8A33B2ECF}" type="doc">
      <dgm:prSet loTypeId="urn:microsoft.com/office/officeart/2005/8/layout/vList5" loCatId="list" qsTypeId="urn:microsoft.com/office/officeart/2005/8/quickstyle/simple1" qsCatId="simple" csTypeId="urn:microsoft.com/office/officeart/2005/8/colors/colorful5" csCatId="colorful" phldr="1"/>
      <dgm:spPr/>
      <dgm:t>
        <a:bodyPr/>
        <a:lstStyle/>
        <a:p>
          <a:endParaRPr lang="en-US"/>
        </a:p>
      </dgm:t>
    </dgm:pt>
    <dgm:pt modelId="{DB075803-47FD-4DB5-B83E-BF2A7CDBBD54}">
      <dgm:prSet phldrT="[Text]"/>
      <dgm:spPr/>
      <dgm:t>
        <a:bodyPr/>
        <a:lstStyle/>
        <a:p>
          <a:r>
            <a:rPr lang="en-US" dirty="0"/>
            <a:t>Education</a:t>
          </a:r>
        </a:p>
      </dgm:t>
    </dgm:pt>
    <dgm:pt modelId="{38310BF9-D507-44A9-AADB-CF44166423F0}" type="parTrans" cxnId="{C3A7DBC3-634B-460B-94F8-DAE278E5EAA4}">
      <dgm:prSet/>
      <dgm:spPr/>
      <dgm:t>
        <a:bodyPr/>
        <a:lstStyle/>
        <a:p>
          <a:endParaRPr lang="en-US"/>
        </a:p>
      </dgm:t>
    </dgm:pt>
    <dgm:pt modelId="{78942D9E-6C8F-4EA7-9B65-58C74C5FCE14}" type="sibTrans" cxnId="{C3A7DBC3-634B-460B-94F8-DAE278E5EAA4}">
      <dgm:prSet/>
      <dgm:spPr/>
      <dgm:t>
        <a:bodyPr/>
        <a:lstStyle/>
        <a:p>
          <a:endParaRPr lang="en-US"/>
        </a:p>
      </dgm:t>
    </dgm:pt>
    <dgm:pt modelId="{9745292D-6715-4E04-B91E-C0614E23867A}">
      <dgm:prSet phldrT="[Text]"/>
      <dgm:spPr/>
      <dgm:t>
        <a:bodyPr/>
        <a:lstStyle/>
        <a:p>
          <a:r>
            <a:rPr lang="en-US" dirty="0"/>
            <a:t>The relationship between behavior and mood</a:t>
          </a:r>
        </a:p>
      </dgm:t>
    </dgm:pt>
    <dgm:pt modelId="{F795554E-2EDE-4F4B-8917-D5917A218A88}" type="parTrans" cxnId="{A1592A71-DC9C-40CD-9FB9-A115B043B522}">
      <dgm:prSet/>
      <dgm:spPr/>
      <dgm:t>
        <a:bodyPr/>
        <a:lstStyle/>
        <a:p>
          <a:endParaRPr lang="en-US"/>
        </a:p>
      </dgm:t>
    </dgm:pt>
    <dgm:pt modelId="{7791AC7C-7DAF-4E12-AA31-CE07725457FF}" type="sibTrans" cxnId="{A1592A71-DC9C-40CD-9FB9-A115B043B522}">
      <dgm:prSet/>
      <dgm:spPr/>
      <dgm:t>
        <a:bodyPr/>
        <a:lstStyle/>
        <a:p>
          <a:endParaRPr lang="en-US"/>
        </a:p>
      </dgm:t>
    </dgm:pt>
    <dgm:pt modelId="{5D35BAFA-8687-4F25-94FA-8D9AA628343F}">
      <dgm:prSet phldrT="[Text]"/>
      <dgm:spPr/>
      <dgm:t>
        <a:bodyPr/>
        <a:lstStyle/>
        <a:p>
          <a:r>
            <a:rPr lang="en-US"/>
            <a:t>What downward spirals are and how they start</a:t>
          </a:r>
        </a:p>
      </dgm:t>
    </dgm:pt>
    <dgm:pt modelId="{64D35FE2-6687-4F5C-92D3-FCC8D1B641E6}" type="parTrans" cxnId="{9381E9E5-049B-4CCE-89B5-227100D374FC}">
      <dgm:prSet/>
      <dgm:spPr/>
      <dgm:t>
        <a:bodyPr/>
        <a:lstStyle/>
        <a:p>
          <a:endParaRPr lang="en-US"/>
        </a:p>
      </dgm:t>
    </dgm:pt>
    <dgm:pt modelId="{B4990353-A4CB-4120-914F-4B12CBB79BE1}" type="sibTrans" cxnId="{9381E9E5-049B-4CCE-89B5-227100D374FC}">
      <dgm:prSet/>
      <dgm:spPr/>
      <dgm:t>
        <a:bodyPr/>
        <a:lstStyle/>
        <a:p>
          <a:endParaRPr lang="en-US"/>
        </a:p>
      </dgm:t>
    </dgm:pt>
    <dgm:pt modelId="{9F2592C2-998B-4A47-9E58-E00937D37CFC}">
      <dgm:prSet phldrT="[Text]"/>
      <dgm:spPr/>
      <dgm:t>
        <a:bodyPr/>
        <a:lstStyle/>
        <a:p>
          <a:r>
            <a:rPr lang="en-US" dirty="0"/>
            <a:t>AYA Story</a:t>
          </a:r>
        </a:p>
      </dgm:t>
    </dgm:pt>
    <dgm:pt modelId="{883A47F4-AA77-49E4-90AA-DF6383217CA7}" type="parTrans" cxnId="{18D2AAB6-F302-4B7E-91DA-42CD9640BCC4}">
      <dgm:prSet/>
      <dgm:spPr/>
      <dgm:t>
        <a:bodyPr/>
        <a:lstStyle/>
        <a:p>
          <a:endParaRPr lang="en-US"/>
        </a:p>
      </dgm:t>
    </dgm:pt>
    <dgm:pt modelId="{B3F41A94-E23D-4BD5-A8E9-562302999318}" type="sibTrans" cxnId="{18D2AAB6-F302-4B7E-91DA-42CD9640BCC4}">
      <dgm:prSet/>
      <dgm:spPr/>
      <dgm:t>
        <a:bodyPr/>
        <a:lstStyle/>
        <a:p>
          <a:endParaRPr lang="en-US"/>
        </a:p>
      </dgm:t>
    </dgm:pt>
    <dgm:pt modelId="{6659CE27-AA55-4A46-B98B-82B5043589AD}">
      <dgm:prSet phldrT="[Text]"/>
      <dgm:spPr/>
      <dgm:t>
        <a:bodyPr/>
        <a:lstStyle/>
        <a:p>
          <a:r>
            <a:rPr lang="en-US"/>
            <a:t>The story of an AYA who experienced a downward spiral that led to feelings of depression</a:t>
          </a:r>
        </a:p>
      </dgm:t>
    </dgm:pt>
    <dgm:pt modelId="{F24DB68B-970C-49AE-97C6-EC37A141622B}" type="parTrans" cxnId="{919A0192-96AD-43F1-AF6D-E1A7F882077B}">
      <dgm:prSet/>
      <dgm:spPr/>
      <dgm:t>
        <a:bodyPr/>
        <a:lstStyle/>
        <a:p>
          <a:endParaRPr lang="en-US"/>
        </a:p>
      </dgm:t>
    </dgm:pt>
    <dgm:pt modelId="{63B75610-20CE-4243-93C5-54E6B1F6C7D6}" type="sibTrans" cxnId="{919A0192-96AD-43F1-AF6D-E1A7F882077B}">
      <dgm:prSet/>
      <dgm:spPr/>
      <dgm:t>
        <a:bodyPr/>
        <a:lstStyle/>
        <a:p>
          <a:endParaRPr lang="en-US"/>
        </a:p>
      </dgm:t>
    </dgm:pt>
    <dgm:pt modelId="{5F4A103B-4AA8-4418-82AC-7D096AD9B81C}">
      <dgm:prSet phldrT="[Text]"/>
      <dgm:spPr/>
      <dgm:t>
        <a:bodyPr/>
        <a:lstStyle/>
        <a:p>
          <a:r>
            <a:rPr lang="en-US" dirty="0"/>
            <a:t>Activity</a:t>
          </a:r>
        </a:p>
      </dgm:t>
    </dgm:pt>
    <dgm:pt modelId="{5BA346A5-4CA3-4BA8-9CC4-10CE51A66BC6}" type="parTrans" cxnId="{6E555E2C-2167-4A67-8C1C-F30787163993}">
      <dgm:prSet/>
      <dgm:spPr/>
      <dgm:t>
        <a:bodyPr/>
        <a:lstStyle/>
        <a:p>
          <a:endParaRPr lang="en-US"/>
        </a:p>
      </dgm:t>
    </dgm:pt>
    <dgm:pt modelId="{5E260F6B-7FE7-47F9-B575-BE5EB3F37287}" type="sibTrans" cxnId="{6E555E2C-2167-4A67-8C1C-F30787163993}">
      <dgm:prSet/>
      <dgm:spPr/>
      <dgm:t>
        <a:bodyPr/>
        <a:lstStyle/>
        <a:p>
          <a:endParaRPr lang="en-US"/>
        </a:p>
      </dgm:t>
    </dgm:pt>
    <dgm:pt modelId="{1A5ED0D3-96AB-419C-83FA-236E50BE8D16}">
      <dgm:prSet phldrT="[Text]"/>
      <dgm:spPr/>
      <dgm:t>
        <a:bodyPr/>
        <a:lstStyle/>
        <a:p>
          <a:r>
            <a:rPr lang="en-US"/>
            <a:t>Identifying the downward spiral the AYA experienced</a:t>
          </a:r>
        </a:p>
      </dgm:t>
    </dgm:pt>
    <dgm:pt modelId="{E2E60623-A6E2-4060-AD82-5441D91B0101}" type="parTrans" cxnId="{B40D0967-38AE-4E00-9644-C059D79E6094}">
      <dgm:prSet/>
      <dgm:spPr/>
      <dgm:t>
        <a:bodyPr/>
        <a:lstStyle/>
        <a:p>
          <a:endParaRPr lang="en-US"/>
        </a:p>
      </dgm:t>
    </dgm:pt>
    <dgm:pt modelId="{E2747C47-DDDA-4502-B577-46B78699E3D7}" type="sibTrans" cxnId="{B40D0967-38AE-4E00-9644-C059D79E6094}">
      <dgm:prSet/>
      <dgm:spPr/>
      <dgm:t>
        <a:bodyPr/>
        <a:lstStyle/>
        <a:p>
          <a:endParaRPr lang="en-US"/>
        </a:p>
      </dgm:t>
    </dgm:pt>
    <dgm:pt modelId="{3F045143-DC35-4B29-95B5-5BE2275ABAB4}">
      <dgm:prSet phldrT="[Text]"/>
      <dgm:spPr/>
      <dgm:t>
        <a:bodyPr/>
        <a:lstStyle/>
        <a:p>
          <a:r>
            <a:rPr lang="en-US"/>
            <a:t>Sharing a time where you experienced a downward spiral</a:t>
          </a:r>
        </a:p>
      </dgm:t>
    </dgm:pt>
    <dgm:pt modelId="{C834F8B6-E81D-46A1-BF24-070FA0D75E60}" type="parTrans" cxnId="{CD80D97C-7215-415A-9872-A7EE3FD575DE}">
      <dgm:prSet/>
      <dgm:spPr/>
      <dgm:t>
        <a:bodyPr/>
        <a:lstStyle/>
        <a:p>
          <a:endParaRPr lang="en-US"/>
        </a:p>
      </dgm:t>
    </dgm:pt>
    <dgm:pt modelId="{CD3D7471-FC66-423F-8ACE-B248C3DDE5F3}" type="sibTrans" cxnId="{CD80D97C-7215-415A-9872-A7EE3FD575DE}">
      <dgm:prSet/>
      <dgm:spPr/>
      <dgm:t>
        <a:bodyPr/>
        <a:lstStyle/>
        <a:p>
          <a:endParaRPr lang="en-US"/>
        </a:p>
      </dgm:t>
    </dgm:pt>
    <dgm:pt modelId="{06D83BE3-FCFA-4048-8D16-230C825D550A}">
      <dgm:prSet phldrT="[Text]"/>
      <dgm:spPr/>
      <dgm:t>
        <a:bodyPr/>
        <a:lstStyle/>
        <a:p>
          <a:r>
            <a:rPr lang="en-US" dirty="0"/>
            <a:t>AYA Story</a:t>
          </a:r>
        </a:p>
      </dgm:t>
    </dgm:pt>
    <dgm:pt modelId="{E66CF30B-F999-4F3C-BB5B-0D880C09F48D}" type="parTrans" cxnId="{7E0F7556-8DD3-4C78-BF97-7EAA5C20A5A6}">
      <dgm:prSet/>
      <dgm:spPr/>
      <dgm:t>
        <a:bodyPr/>
        <a:lstStyle/>
        <a:p>
          <a:endParaRPr lang="en-US"/>
        </a:p>
      </dgm:t>
    </dgm:pt>
    <dgm:pt modelId="{F71EC33C-0E95-4882-BF25-6F1F09743635}" type="sibTrans" cxnId="{7E0F7556-8DD3-4C78-BF97-7EAA5C20A5A6}">
      <dgm:prSet/>
      <dgm:spPr/>
      <dgm:t>
        <a:bodyPr/>
        <a:lstStyle/>
        <a:p>
          <a:endParaRPr lang="en-US"/>
        </a:p>
      </dgm:t>
    </dgm:pt>
    <dgm:pt modelId="{538CF43F-9C6A-4DEA-967F-FC4DD1C387DD}">
      <dgm:prSet phldrT="[Text]"/>
      <dgm:spPr/>
      <dgm:t>
        <a:bodyPr/>
        <a:lstStyle/>
        <a:p>
          <a:r>
            <a:rPr lang="en-US"/>
            <a:t>How the same AYA was able to stop their downward spiral and start an upward spiral</a:t>
          </a:r>
        </a:p>
      </dgm:t>
    </dgm:pt>
    <dgm:pt modelId="{1EEA00F7-25AC-4755-A2EE-4F5DE882DF9D}" type="parTrans" cxnId="{9C3AC200-6CDB-4F90-9FDC-051702D11EB1}">
      <dgm:prSet/>
      <dgm:spPr/>
      <dgm:t>
        <a:bodyPr/>
        <a:lstStyle/>
        <a:p>
          <a:endParaRPr lang="en-US"/>
        </a:p>
      </dgm:t>
    </dgm:pt>
    <dgm:pt modelId="{412D142B-01C4-4783-957A-762696A359B3}" type="sibTrans" cxnId="{9C3AC200-6CDB-4F90-9FDC-051702D11EB1}">
      <dgm:prSet/>
      <dgm:spPr/>
      <dgm:t>
        <a:bodyPr/>
        <a:lstStyle/>
        <a:p>
          <a:endParaRPr lang="en-US"/>
        </a:p>
      </dgm:t>
    </dgm:pt>
    <dgm:pt modelId="{7C92A925-4102-4FAD-A9B1-D4E3B87D2F8E}">
      <dgm:prSet phldrT="[Text]"/>
      <dgm:spPr/>
      <dgm:t>
        <a:bodyPr/>
        <a:lstStyle/>
        <a:p>
          <a:r>
            <a:rPr lang="en-US"/>
            <a:t>Activity</a:t>
          </a:r>
          <a:endParaRPr lang="en-US" dirty="0"/>
        </a:p>
      </dgm:t>
    </dgm:pt>
    <dgm:pt modelId="{1B581FE9-F870-4969-926F-51200D1A6A6A}" type="parTrans" cxnId="{DF61853D-0B45-43DB-A5E6-37E3A6E44B4D}">
      <dgm:prSet/>
      <dgm:spPr/>
      <dgm:t>
        <a:bodyPr/>
        <a:lstStyle/>
        <a:p>
          <a:endParaRPr lang="en-US"/>
        </a:p>
      </dgm:t>
    </dgm:pt>
    <dgm:pt modelId="{8B42E6B1-A368-479B-B9F9-E1B80644105E}" type="sibTrans" cxnId="{DF61853D-0B45-43DB-A5E6-37E3A6E44B4D}">
      <dgm:prSet/>
      <dgm:spPr/>
      <dgm:t>
        <a:bodyPr/>
        <a:lstStyle/>
        <a:p>
          <a:endParaRPr lang="en-US"/>
        </a:p>
      </dgm:t>
    </dgm:pt>
    <dgm:pt modelId="{96D559F2-D0FD-4BC2-8EC9-526379E7AD18}">
      <dgm:prSet phldrT="[Text]"/>
      <dgm:spPr/>
      <dgm:t>
        <a:bodyPr/>
        <a:lstStyle/>
        <a:p>
          <a:r>
            <a:rPr lang="en-US"/>
            <a:t>Identifying the upward spiral the AYA experienced</a:t>
          </a:r>
        </a:p>
      </dgm:t>
    </dgm:pt>
    <dgm:pt modelId="{B5D035D1-EE80-4CA5-91CE-F62713F7840C}" type="parTrans" cxnId="{7A8989A1-DDA0-4126-9873-0642C42C0F5A}">
      <dgm:prSet/>
      <dgm:spPr/>
      <dgm:t>
        <a:bodyPr/>
        <a:lstStyle/>
        <a:p>
          <a:endParaRPr lang="en-US"/>
        </a:p>
      </dgm:t>
    </dgm:pt>
    <dgm:pt modelId="{3AA75ACC-A82C-41CB-ACC4-22383A1704D5}" type="sibTrans" cxnId="{7A8989A1-DDA0-4126-9873-0642C42C0F5A}">
      <dgm:prSet/>
      <dgm:spPr/>
      <dgm:t>
        <a:bodyPr/>
        <a:lstStyle/>
        <a:p>
          <a:endParaRPr lang="en-US"/>
        </a:p>
      </dgm:t>
    </dgm:pt>
    <dgm:pt modelId="{3FE18A39-C52B-468E-893E-696793BB8CD5}">
      <dgm:prSet phldrT="[Text]"/>
      <dgm:spPr/>
      <dgm:t>
        <a:bodyPr/>
        <a:lstStyle/>
        <a:p>
          <a:r>
            <a:rPr lang="en-US"/>
            <a:t>Sharing a time where you experienced an upward spiral</a:t>
          </a:r>
        </a:p>
      </dgm:t>
    </dgm:pt>
    <dgm:pt modelId="{1AA94533-6EF1-44ED-93C8-D482BC438EF7}" type="parTrans" cxnId="{D5FD4839-67D1-4282-9EBC-C44F49E332B8}">
      <dgm:prSet/>
      <dgm:spPr/>
      <dgm:t>
        <a:bodyPr/>
        <a:lstStyle/>
        <a:p>
          <a:endParaRPr lang="en-US"/>
        </a:p>
      </dgm:t>
    </dgm:pt>
    <dgm:pt modelId="{E476412F-E350-406C-8102-18E9F6C6A41F}" type="sibTrans" cxnId="{D5FD4839-67D1-4282-9EBC-C44F49E332B8}">
      <dgm:prSet/>
      <dgm:spPr/>
      <dgm:t>
        <a:bodyPr/>
        <a:lstStyle/>
        <a:p>
          <a:endParaRPr lang="en-US"/>
        </a:p>
      </dgm:t>
    </dgm:pt>
    <dgm:pt modelId="{193B099A-39FC-4047-A261-82AC950A257A}">
      <dgm:prSet phldrT="[Text]"/>
      <dgm:spPr/>
      <dgm:t>
        <a:bodyPr/>
        <a:lstStyle/>
        <a:p>
          <a:r>
            <a:rPr lang="en-US" dirty="0"/>
            <a:t>Practice</a:t>
          </a:r>
        </a:p>
      </dgm:t>
    </dgm:pt>
    <dgm:pt modelId="{B6EC4905-A10A-45E1-A975-F763613F8DB7}" type="parTrans" cxnId="{AEDDC577-23BD-4384-B7AE-001627E1CF03}">
      <dgm:prSet/>
      <dgm:spPr/>
      <dgm:t>
        <a:bodyPr/>
        <a:lstStyle/>
        <a:p>
          <a:endParaRPr lang="en-US"/>
        </a:p>
      </dgm:t>
    </dgm:pt>
    <dgm:pt modelId="{DC0D5F73-CC38-42EB-BB83-162472AA134A}" type="sibTrans" cxnId="{AEDDC577-23BD-4384-B7AE-001627E1CF03}">
      <dgm:prSet/>
      <dgm:spPr/>
      <dgm:t>
        <a:bodyPr/>
        <a:lstStyle/>
        <a:p>
          <a:endParaRPr lang="en-US"/>
        </a:p>
      </dgm:t>
    </dgm:pt>
    <dgm:pt modelId="{A29821AE-302A-4B92-AC7E-952784B85349}">
      <dgm:prSet phldrT="[Text]"/>
      <dgm:spPr/>
      <dgm:t>
        <a:bodyPr/>
        <a:lstStyle/>
        <a:p>
          <a:r>
            <a:rPr lang="en-US"/>
            <a:t>Tracking how you feel after doing activities</a:t>
          </a:r>
        </a:p>
      </dgm:t>
    </dgm:pt>
    <dgm:pt modelId="{5BA37330-26F4-4626-8F00-A8459D8B624E}" type="parTrans" cxnId="{547FF4B0-03FE-4571-AFC4-5C6D0E39FB01}">
      <dgm:prSet/>
      <dgm:spPr/>
      <dgm:t>
        <a:bodyPr/>
        <a:lstStyle/>
        <a:p>
          <a:endParaRPr lang="en-US"/>
        </a:p>
      </dgm:t>
    </dgm:pt>
    <dgm:pt modelId="{5D9C1022-93FA-4E6B-8B2C-DC7263A8468F}" type="sibTrans" cxnId="{547FF4B0-03FE-4571-AFC4-5C6D0E39FB01}">
      <dgm:prSet/>
      <dgm:spPr/>
      <dgm:t>
        <a:bodyPr/>
        <a:lstStyle/>
        <a:p>
          <a:endParaRPr lang="en-US"/>
        </a:p>
      </dgm:t>
    </dgm:pt>
    <dgm:pt modelId="{A442D9E5-0C7F-45E7-9E89-5D96791D8BA6}">
      <dgm:prSet phldrT="[Text]"/>
      <dgm:spPr/>
      <dgm:t>
        <a:bodyPr/>
        <a:lstStyle/>
        <a:p>
          <a:r>
            <a:rPr lang="en-US"/>
            <a:t>Added to your check-in</a:t>
          </a:r>
        </a:p>
      </dgm:t>
    </dgm:pt>
    <dgm:pt modelId="{E105F7B4-83BF-4E00-A438-BA017D61A208}" type="parTrans" cxnId="{B2D3A30B-B810-48E2-B10C-A6B4A63F9C50}">
      <dgm:prSet/>
      <dgm:spPr/>
      <dgm:t>
        <a:bodyPr/>
        <a:lstStyle/>
        <a:p>
          <a:endParaRPr lang="en-US"/>
        </a:p>
      </dgm:t>
    </dgm:pt>
    <dgm:pt modelId="{C50000FF-F7E4-4B37-9CFA-3A05E2A565C2}" type="sibTrans" cxnId="{B2D3A30B-B810-48E2-B10C-A6B4A63F9C50}">
      <dgm:prSet/>
      <dgm:spPr/>
      <dgm:t>
        <a:bodyPr/>
        <a:lstStyle/>
        <a:p>
          <a:endParaRPr lang="en-US"/>
        </a:p>
      </dgm:t>
    </dgm:pt>
    <dgm:pt modelId="{810C17BD-7B7E-4D83-88E9-5C58C115F508}">
      <dgm:prSet phldrT="[Text]"/>
      <dgm:spPr/>
      <dgm:t>
        <a:bodyPr/>
        <a:lstStyle/>
        <a:p>
          <a:r>
            <a:rPr lang="en-US" dirty="0"/>
            <a:t>Education</a:t>
          </a:r>
        </a:p>
      </dgm:t>
    </dgm:pt>
    <dgm:pt modelId="{192B5EB6-75F1-49DA-A42A-D78D7B8407CE}" type="parTrans" cxnId="{DBBB1382-14DE-4F54-A094-5EC3D2D1E0E1}">
      <dgm:prSet/>
      <dgm:spPr/>
      <dgm:t>
        <a:bodyPr/>
        <a:lstStyle/>
        <a:p>
          <a:endParaRPr lang="en-US"/>
        </a:p>
      </dgm:t>
    </dgm:pt>
    <dgm:pt modelId="{A4BF771C-B458-4A71-9BF7-84580C8C3EC3}" type="sibTrans" cxnId="{DBBB1382-14DE-4F54-A094-5EC3D2D1E0E1}">
      <dgm:prSet/>
      <dgm:spPr/>
      <dgm:t>
        <a:bodyPr/>
        <a:lstStyle/>
        <a:p>
          <a:endParaRPr lang="en-US"/>
        </a:p>
      </dgm:t>
    </dgm:pt>
    <dgm:pt modelId="{CB61E494-D396-4621-AF3F-E3C0B0995F94}">
      <dgm:prSet phldrT="[Text]"/>
      <dgm:spPr/>
      <dgm:t>
        <a:bodyPr/>
        <a:lstStyle/>
        <a:p>
          <a:r>
            <a:rPr lang="en-US" dirty="0"/>
            <a:t>Stopping downward spirals</a:t>
          </a:r>
        </a:p>
      </dgm:t>
    </dgm:pt>
    <dgm:pt modelId="{DC170920-C042-4B03-B9BC-A9E1189AB832}" type="parTrans" cxnId="{E4F24938-FEBA-47C6-B71E-FE8590A89075}">
      <dgm:prSet/>
      <dgm:spPr/>
      <dgm:t>
        <a:bodyPr/>
        <a:lstStyle/>
        <a:p>
          <a:endParaRPr lang="en-US"/>
        </a:p>
      </dgm:t>
    </dgm:pt>
    <dgm:pt modelId="{B005A2D1-0999-43D0-8C45-CB93904F5203}" type="sibTrans" cxnId="{E4F24938-FEBA-47C6-B71E-FE8590A89075}">
      <dgm:prSet/>
      <dgm:spPr/>
      <dgm:t>
        <a:bodyPr/>
        <a:lstStyle/>
        <a:p>
          <a:endParaRPr lang="en-US"/>
        </a:p>
      </dgm:t>
    </dgm:pt>
    <dgm:pt modelId="{0AE20938-1B41-4640-9D3D-7271D505604F}">
      <dgm:prSet phldrT="[Text]"/>
      <dgm:spPr/>
      <dgm:t>
        <a:bodyPr/>
        <a:lstStyle/>
        <a:p>
          <a:r>
            <a:rPr lang="en-US" dirty="0"/>
            <a:t>Starting upward spirals</a:t>
          </a:r>
        </a:p>
      </dgm:t>
    </dgm:pt>
    <dgm:pt modelId="{90FE48D0-E624-427B-BDF5-21419A0CA42C}" type="parTrans" cxnId="{60E14518-F6D4-484B-A5ED-5679A9DEC7BD}">
      <dgm:prSet/>
      <dgm:spPr/>
      <dgm:t>
        <a:bodyPr/>
        <a:lstStyle/>
        <a:p>
          <a:endParaRPr lang="en-US"/>
        </a:p>
      </dgm:t>
    </dgm:pt>
    <dgm:pt modelId="{3C420805-1542-4249-93C3-2D96F7472340}" type="sibTrans" cxnId="{60E14518-F6D4-484B-A5ED-5679A9DEC7BD}">
      <dgm:prSet/>
      <dgm:spPr/>
      <dgm:t>
        <a:bodyPr/>
        <a:lstStyle/>
        <a:p>
          <a:endParaRPr lang="en-US"/>
        </a:p>
      </dgm:t>
    </dgm:pt>
    <dgm:pt modelId="{C1BBEA97-13F5-4E11-A031-17BAD9EBF99A}" type="pres">
      <dgm:prSet presAssocID="{3D80F380-3B92-445C-9991-34B8A33B2ECF}" presName="Name0" presStyleCnt="0">
        <dgm:presLayoutVars>
          <dgm:dir/>
          <dgm:animLvl val="lvl"/>
          <dgm:resizeHandles val="exact"/>
        </dgm:presLayoutVars>
      </dgm:prSet>
      <dgm:spPr/>
    </dgm:pt>
    <dgm:pt modelId="{46E2197D-7F88-467B-8EE5-DC11626686E2}" type="pres">
      <dgm:prSet presAssocID="{DB075803-47FD-4DB5-B83E-BF2A7CDBBD54}" presName="linNode" presStyleCnt="0"/>
      <dgm:spPr/>
    </dgm:pt>
    <dgm:pt modelId="{3092E2E4-F9C9-4F63-973A-0773214EC645}" type="pres">
      <dgm:prSet presAssocID="{DB075803-47FD-4DB5-B83E-BF2A7CDBBD54}" presName="parentText" presStyleLbl="node1" presStyleIdx="0" presStyleCnt="7">
        <dgm:presLayoutVars>
          <dgm:chMax val="1"/>
          <dgm:bulletEnabled val="1"/>
        </dgm:presLayoutVars>
      </dgm:prSet>
      <dgm:spPr/>
    </dgm:pt>
    <dgm:pt modelId="{9DACEBA6-B7F3-470B-ADE0-7C787F395B68}" type="pres">
      <dgm:prSet presAssocID="{DB075803-47FD-4DB5-B83E-BF2A7CDBBD54}" presName="descendantText" presStyleLbl="alignAccFollowNode1" presStyleIdx="0" presStyleCnt="7">
        <dgm:presLayoutVars>
          <dgm:bulletEnabled val="1"/>
        </dgm:presLayoutVars>
      </dgm:prSet>
      <dgm:spPr/>
    </dgm:pt>
    <dgm:pt modelId="{7AA1575C-1C73-4A7C-BDE0-9DB82851E80D}" type="pres">
      <dgm:prSet presAssocID="{78942D9E-6C8F-4EA7-9B65-58C74C5FCE14}" presName="sp" presStyleCnt="0"/>
      <dgm:spPr/>
    </dgm:pt>
    <dgm:pt modelId="{6F17102B-E77D-405E-9F8E-0904A6AC1919}" type="pres">
      <dgm:prSet presAssocID="{9F2592C2-998B-4A47-9E58-E00937D37CFC}" presName="linNode" presStyleCnt="0"/>
      <dgm:spPr/>
    </dgm:pt>
    <dgm:pt modelId="{50633897-3B87-42CF-9EE5-E4AD5C561271}" type="pres">
      <dgm:prSet presAssocID="{9F2592C2-998B-4A47-9E58-E00937D37CFC}" presName="parentText" presStyleLbl="node1" presStyleIdx="1" presStyleCnt="7">
        <dgm:presLayoutVars>
          <dgm:chMax val="1"/>
          <dgm:bulletEnabled val="1"/>
        </dgm:presLayoutVars>
      </dgm:prSet>
      <dgm:spPr/>
    </dgm:pt>
    <dgm:pt modelId="{5C5B57D6-C573-4FF5-8D2D-153330CE39BF}" type="pres">
      <dgm:prSet presAssocID="{9F2592C2-998B-4A47-9E58-E00937D37CFC}" presName="descendantText" presStyleLbl="alignAccFollowNode1" presStyleIdx="1" presStyleCnt="7">
        <dgm:presLayoutVars>
          <dgm:bulletEnabled val="1"/>
        </dgm:presLayoutVars>
      </dgm:prSet>
      <dgm:spPr/>
    </dgm:pt>
    <dgm:pt modelId="{A82357A7-EC76-44AB-B02D-22661D95AD9A}" type="pres">
      <dgm:prSet presAssocID="{B3F41A94-E23D-4BD5-A8E9-562302999318}" presName="sp" presStyleCnt="0"/>
      <dgm:spPr/>
    </dgm:pt>
    <dgm:pt modelId="{7A3F2C14-5BF2-45F3-B6DD-E8D7BA393605}" type="pres">
      <dgm:prSet presAssocID="{5F4A103B-4AA8-4418-82AC-7D096AD9B81C}" presName="linNode" presStyleCnt="0"/>
      <dgm:spPr/>
    </dgm:pt>
    <dgm:pt modelId="{9A84E1C7-ABDB-452D-A2BB-D2E2388A0633}" type="pres">
      <dgm:prSet presAssocID="{5F4A103B-4AA8-4418-82AC-7D096AD9B81C}" presName="parentText" presStyleLbl="node1" presStyleIdx="2" presStyleCnt="7">
        <dgm:presLayoutVars>
          <dgm:chMax val="1"/>
          <dgm:bulletEnabled val="1"/>
        </dgm:presLayoutVars>
      </dgm:prSet>
      <dgm:spPr/>
    </dgm:pt>
    <dgm:pt modelId="{1D004FCF-E91A-483C-9730-425CC505DE1C}" type="pres">
      <dgm:prSet presAssocID="{5F4A103B-4AA8-4418-82AC-7D096AD9B81C}" presName="descendantText" presStyleLbl="alignAccFollowNode1" presStyleIdx="2" presStyleCnt="7">
        <dgm:presLayoutVars>
          <dgm:bulletEnabled val="1"/>
        </dgm:presLayoutVars>
      </dgm:prSet>
      <dgm:spPr/>
    </dgm:pt>
    <dgm:pt modelId="{38DCDEC3-F55F-460A-AC3E-C225B370726C}" type="pres">
      <dgm:prSet presAssocID="{5E260F6B-7FE7-47F9-B575-BE5EB3F37287}" presName="sp" presStyleCnt="0"/>
      <dgm:spPr/>
    </dgm:pt>
    <dgm:pt modelId="{0B45CD7B-5F42-403F-8C3A-5F65AA5B9B99}" type="pres">
      <dgm:prSet presAssocID="{810C17BD-7B7E-4D83-88E9-5C58C115F508}" presName="linNode" presStyleCnt="0"/>
      <dgm:spPr/>
    </dgm:pt>
    <dgm:pt modelId="{BE93C424-47EE-431F-9F11-D78EA5D08920}" type="pres">
      <dgm:prSet presAssocID="{810C17BD-7B7E-4D83-88E9-5C58C115F508}" presName="parentText" presStyleLbl="node1" presStyleIdx="3" presStyleCnt="7">
        <dgm:presLayoutVars>
          <dgm:chMax val="1"/>
          <dgm:bulletEnabled val="1"/>
        </dgm:presLayoutVars>
      </dgm:prSet>
      <dgm:spPr/>
    </dgm:pt>
    <dgm:pt modelId="{95851911-1337-415F-9D84-EF5E60FC8F57}" type="pres">
      <dgm:prSet presAssocID="{810C17BD-7B7E-4D83-88E9-5C58C115F508}" presName="descendantText" presStyleLbl="alignAccFollowNode1" presStyleIdx="3" presStyleCnt="7">
        <dgm:presLayoutVars>
          <dgm:bulletEnabled val="1"/>
        </dgm:presLayoutVars>
      </dgm:prSet>
      <dgm:spPr/>
    </dgm:pt>
    <dgm:pt modelId="{0655EB3E-84C2-4E4A-99F6-19410BD0D420}" type="pres">
      <dgm:prSet presAssocID="{A4BF771C-B458-4A71-9BF7-84580C8C3EC3}" presName="sp" presStyleCnt="0"/>
      <dgm:spPr/>
    </dgm:pt>
    <dgm:pt modelId="{B255ED18-9ABA-4CD4-9201-95026C25F740}" type="pres">
      <dgm:prSet presAssocID="{06D83BE3-FCFA-4048-8D16-230C825D550A}" presName="linNode" presStyleCnt="0"/>
      <dgm:spPr/>
    </dgm:pt>
    <dgm:pt modelId="{D377DF79-CDC0-4998-B9B6-936269382C55}" type="pres">
      <dgm:prSet presAssocID="{06D83BE3-FCFA-4048-8D16-230C825D550A}" presName="parentText" presStyleLbl="node1" presStyleIdx="4" presStyleCnt="7">
        <dgm:presLayoutVars>
          <dgm:chMax val="1"/>
          <dgm:bulletEnabled val="1"/>
        </dgm:presLayoutVars>
      </dgm:prSet>
      <dgm:spPr/>
    </dgm:pt>
    <dgm:pt modelId="{FE1DED6C-1D78-4D0C-9015-56718EC33E2C}" type="pres">
      <dgm:prSet presAssocID="{06D83BE3-FCFA-4048-8D16-230C825D550A}" presName="descendantText" presStyleLbl="alignAccFollowNode1" presStyleIdx="4" presStyleCnt="7">
        <dgm:presLayoutVars>
          <dgm:bulletEnabled val="1"/>
        </dgm:presLayoutVars>
      </dgm:prSet>
      <dgm:spPr/>
    </dgm:pt>
    <dgm:pt modelId="{7CBF3F6A-72BF-4A9C-A378-CB33F1F127E6}" type="pres">
      <dgm:prSet presAssocID="{F71EC33C-0E95-4882-BF25-6F1F09743635}" presName="sp" presStyleCnt="0"/>
      <dgm:spPr/>
    </dgm:pt>
    <dgm:pt modelId="{8E91BD0A-DDB0-481B-B4F4-2BE608096BA3}" type="pres">
      <dgm:prSet presAssocID="{7C92A925-4102-4FAD-A9B1-D4E3B87D2F8E}" presName="linNode" presStyleCnt="0"/>
      <dgm:spPr/>
    </dgm:pt>
    <dgm:pt modelId="{40834933-7240-405D-BC12-8C6F826CEF86}" type="pres">
      <dgm:prSet presAssocID="{7C92A925-4102-4FAD-A9B1-D4E3B87D2F8E}" presName="parentText" presStyleLbl="node1" presStyleIdx="5" presStyleCnt="7">
        <dgm:presLayoutVars>
          <dgm:chMax val="1"/>
          <dgm:bulletEnabled val="1"/>
        </dgm:presLayoutVars>
      </dgm:prSet>
      <dgm:spPr/>
    </dgm:pt>
    <dgm:pt modelId="{C46D864B-4BB9-4140-A9DC-E6666ED80EFB}" type="pres">
      <dgm:prSet presAssocID="{7C92A925-4102-4FAD-A9B1-D4E3B87D2F8E}" presName="descendantText" presStyleLbl="alignAccFollowNode1" presStyleIdx="5" presStyleCnt="7">
        <dgm:presLayoutVars>
          <dgm:bulletEnabled val="1"/>
        </dgm:presLayoutVars>
      </dgm:prSet>
      <dgm:spPr/>
    </dgm:pt>
    <dgm:pt modelId="{F7CAD794-09D7-4CAC-8A39-D2BBE12E5ADB}" type="pres">
      <dgm:prSet presAssocID="{8B42E6B1-A368-479B-B9F9-E1B80644105E}" presName="sp" presStyleCnt="0"/>
      <dgm:spPr/>
    </dgm:pt>
    <dgm:pt modelId="{910430C3-CEEC-4EF5-B507-CD626ACCF11F}" type="pres">
      <dgm:prSet presAssocID="{193B099A-39FC-4047-A261-82AC950A257A}" presName="linNode" presStyleCnt="0"/>
      <dgm:spPr/>
    </dgm:pt>
    <dgm:pt modelId="{2477482A-E0D8-4105-B60F-16A4E647AB90}" type="pres">
      <dgm:prSet presAssocID="{193B099A-39FC-4047-A261-82AC950A257A}" presName="parentText" presStyleLbl="node1" presStyleIdx="6" presStyleCnt="7">
        <dgm:presLayoutVars>
          <dgm:chMax val="1"/>
          <dgm:bulletEnabled val="1"/>
        </dgm:presLayoutVars>
      </dgm:prSet>
      <dgm:spPr/>
    </dgm:pt>
    <dgm:pt modelId="{D4DA00CE-234C-4754-A39C-23B55302F42B}" type="pres">
      <dgm:prSet presAssocID="{193B099A-39FC-4047-A261-82AC950A257A}" presName="descendantText" presStyleLbl="alignAccFollowNode1" presStyleIdx="6" presStyleCnt="7">
        <dgm:presLayoutVars>
          <dgm:bulletEnabled val="1"/>
        </dgm:presLayoutVars>
      </dgm:prSet>
      <dgm:spPr/>
    </dgm:pt>
  </dgm:ptLst>
  <dgm:cxnLst>
    <dgm:cxn modelId="{9C3AC200-6CDB-4F90-9FDC-051702D11EB1}" srcId="{06D83BE3-FCFA-4048-8D16-230C825D550A}" destId="{538CF43F-9C6A-4DEA-967F-FC4DD1C387DD}" srcOrd="0" destOrd="0" parTransId="{1EEA00F7-25AC-4755-A2EE-4F5DE882DF9D}" sibTransId="{412D142B-01C4-4783-957A-762696A359B3}"/>
    <dgm:cxn modelId="{B2D3A30B-B810-48E2-B10C-A6B4A63F9C50}" srcId="{193B099A-39FC-4047-A261-82AC950A257A}" destId="{A442D9E5-0C7F-45E7-9E89-5D96791D8BA6}" srcOrd="1" destOrd="0" parTransId="{E105F7B4-83BF-4E00-A438-BA017D61A208}" sibTransId="{C50000FF-F7E4-4B37-9CFA-3A05E2A565C2}"/>
    <dgm:cxn modelId="{E965AD0D-F1D9-47E0-AEC5-C40A30509EC8}" type="presOf" srcId="{9F2592C2-998B-4A47-9E58-E00937D37CFC}" destId="{50633897-3B87-42CF-9EE5-E4AD5C561271}" srcOrd="0" destOrd="0" presId="urn:microsoft.com/office/officeart/2005/8/layout/vList5"/>
    <dgm:cxn modelId="{78989411-E3F4-48CB-AD01-359ECCAA6027}" type="presOf" srcId="{DB075803-47FD-4DB5-B83E-BF2A7CDBBD54}" destId="{3092E2E4-F9C9-4F63-973A-0773214EC645}" srcOrd="0" destOrd="0" presId="urn:microsoft.com/office/officeart/2005/8/layout/vList5"/>
    <dgm:cxn modelId="{60E14518-F6D4-484B-A5ED-5679A9DEC7BD}" srcId="{810C17BD-7B7E-4D83-88E9-5C58C115F508}" destId="{0AE20938-1B41-4640-9D3D-7271D505604F}" srcOrd="1" destOrd="0" parTransId="{90FE48D0-E624-427B-BDF5-21419A0CA42C}" sibTransId="{3C420805-1542-4249-93C3-2D96F7472340}"/>
    <dgm:cxn modelId="{78D9651C-50E3-45BB-A6A0-7BB1BA66D1DC}" type="presOf" srcId="{7C92A925-4102-4FAD-A9B1-D4E3B87D2F8E}" destId="{40834933-7240-405D-BC12-8C6F826CEF86}" srcOrd="0" destOrd="0" presId="urn:microsoft.com/office/officeart/2005/8/layout/vList5"/>
    <dgm:cxn modelId="{54C92A25-8591-44E9-8B28-420814CDE3AB}" type="presOf" srcId="{CB61E494-D396-4621-AF3F-E3C0B0995F94}" destId="{95851911-1337-415F-9D84-EF5E60FC8F57}" srcOrd="0" destOrd="0" presId="urn:microsoft.com/office/officeart/2005/8/layout/vList5"/>
    <dgm:cxn modelId="{6ABC7D25-40AC-4129-A08A-6B0DDAFC82A2}" type="presOf" srcId="{96D559F2-D0FD-4BC2-8EC9-526379E7AD18}" destId="{C46D864B-4BB9-4140-A9DC-E6666ED80EFB}" srcOrd="0" destOrd="0" presId="urn:microsoft.com/office/officeart/2005/8/layout/vList5"/>
    <dgm:cxn modelId="{02515526-E19D-4887-9881-68FE02F57F01}" type="presOf" srcId="{5D35BAFA-8687-4F25-94FA-8D9AA628343F}" destId="{9DACEBA6-B7F3-470B-ADE0-7C787F395B68}" srcOrd="0" destOrd="1" presId="urn:microsoft.com/office/officeart/2005/8/layout/vList5"/>
    <dgm:cxn modelId="{6E555E2C-2167-4A67-8C1C-F30787163993}" srcId="{3D80F380-3B92-445C-9991-34B8A33B2ECF}" destId="{5F4A103B-4AA8-4418-82AC-7D096AD9B81C}" srcOrd="2" destOrd="0" parTransId="{5BA346A5-4CA3-4BA8-9CC4-10CE51A66BC6}" sibTransId="{5E260F6B-7FE7-47F9-B575-BE5EB3F37287}"/>
    <dgm:cxn modelId="{E4F24938-FEBA-47C6-B71E-FE8590A89075}" srcId="{810C17BD-7B7E-4D83-88E9-5C58C115F508}" destId="{CB61E494-D396-4621-AF3F-E3C0B0995F94}" srcOrd="0" destOrd="0" parTransId="{DC170920-C042-4B03-B9BC-A9E1189AB832}" sibTransId="{B005A2D1-0999-43D0-8C45-CB93904F5203}"/>
    <dgm:cxn modelId="{D5FD4839-67D1-4282-9EBC-C44F49E332B8}" srcId="{7C92A925-4102-4FAD-A9B1-D4E3B87D2F8E}" destId="{3FE18A39-C52B-468E-893E-696793BB8CD5}" srcOrd="1" destOrd="0" parTransId="{1AA94533-6EF1-44ED-93C8-D482BC438EF7}" sibTransId="{E476412F-E350-406C-8102-18E9F6C6A41F}"/>
    <dgm:cxn modelId="{F74CF739-F67E-470C-B169-1107BC213704}" type="presOf" srcId="{3F045143-DC35-4B29-95B5-5BE2275ABAB4}" destId="{1D004FCF-E91A-483C-9730-425CC505DE1C}" srcOrd="0" destOrd="1" presId="urn:microsoft.com/office/officeart/2005/8/layout/vList5"/>
    <dgm:cxn modelId="{DF61853D-0B45-43DB-A5E6-37E3A6E44B4D}" srcId="{3D80F380-3B92-445C-9991-34B8A33B2ECF}" destId="{7C92A925-4102-4FAD-A9B1-D4E3B87D2F8E}" srcOrd="5" destOrd="0" parTransId="{1B581FE9-F870-4969-926F-51200D1A6A6A}" sibTransId="{8B42E6B1-A368-479B-B9F9-E1B80644105E}"/>
    <dgm:cxn modelId="{B40D0967-38AE-4E00-9644-C059D79E6094}" srcId="{5F4A103B-4AA8-4418-82AC-7D096AD9B81C}" destId="{1A5ED0D3-96AB-419C-83FA-236E50BE8D16}" srcOrd="0" destOrd="0" parTransId="{E2E60623-A6E2-4060-AD82-5441D91B0101}" sibTransId="{E2747C47-DDDA-4502-B577-46B78699E3D7}"/>
    <dgm:cxn modelId="{F51DBC6F-0153-4BD1-9545-795099311079}" type="presOf" srcId="{6659CE27-AA55-4A46-B98B-82B5043589AD}" destId="{5C5B57D6-C573-4FF5-8D2D-153330CE39BF}" srcOrd="0" destOrd="0" presId="urn:microsoft.com/office/officeart/2005/8/layout/vList5"/>
    <dgm:cxn modelId="{A1592A71-DC9C-40CD-9FB9-A115B043B522}" srcId="{DB075803-47FD-4DB5-B83E-BF2A7CDBBD54}" destId="{9745292D-6715-4E04-B91E-C0614E23867A}" srcOrd="0" destOrd="0" parTransId="{F795554E-2EDE-4F4B-8917-D5917A218A88}" sibTransId="{7791AC7C-7DAF-4E12-AA31-CE07725457FF}"/>
    <dgm:cxn modelId="{7E0F7556-8DD3-4C78-BF97-7EAA5C20A5A6}" srcId="{3D80F380-3B92-445C-9991-34B8A33B2ECF}" destId="{06D83BE3-FCFA-4048-8D16-230C825D550A}" srcOrd="4" destOrd="0" parTransId="{E66CF30B-F999-4F3C-BB5B-0D880C09F48D}" sibTransId="{F71EC33C-0E95-4882-BF25-6F1F09743635}"/>
    <dgm:cxn modelId="{AEDDC577-23BD-4384-B7AE-001627E1CF03}" srcId="{3D80F380-3B92-445C-9991-34B8A33B2ECF}" destId="{193B099A-39FC-4047-A261-82AC950A257A}" srcOrd="6" destOrd="0" parTransId="{B6EC4905-A10A-45E1-A975-F763613F8DB7}" sibTransId="{DC0D5F73-CC38-42EB-BB83-162472AA134A}"/>
    <dgm:cxn modelId="{7AA40E58-28C4-4A30-8C02-35270BE0EE29}" type="presOf" srcId="{9745292D-6715-4E04-B91E-C0614E23867A}" destId="{9DACEBA6-B7F3-470B-ADE0-7C787F395B68}" srcOrd="0" destOrd="0" presId="urn:microsoft.com/office/officeart/2005/8/layout/vList5"/>
    <dgm:cxn modelId="{DA9CF67A-B390-4AF1-97D6-A3689BC127FF}" type="presOf" srcId="{193B099A-39FC-4047-A261-82AC950A257A}" destId="{2477482A-E0D8-4105-B60F-16A4E647AB90}" srcOrd="0" destOrd="0" presId="urn:microsoft.com/office/officeart/2005/8/layout/vList5"/>
    <dgm:cxn modelId="{CD80D97C-7215-415A-9872-A7EE3FD575DE}" srcId="{5F4A103B-4AA8-4418-82AC-7D096AD9B81C}" destId="{3F045143-DC35-4B29-95B5-5BE2275ABAB4}" srcOrd="1" destOrd="0" parTransId="{C834F8B6-E81D-46A1-BF24-070FA0D75E60}" sibTransId="{CD3D7471-FC66-423F-8ACE-B248C3DDE5F3}"/>
    <dgm:cxn modelId="{69E8F480-5287-4F9E-9C22-9319E66177DE}" type="presOf" srcId="{A442D9E5-0C7F-45E7-9E89-5D96791D8BA6}" destId="{D4DA00CE-234C-4754-A39C-23B55302F42B}" srcOrd="0" destOrd="1" presId="urn:microsoft.com/office/officeart/2005/8/layout/vList5"/>
    <dgm:cxn modelId="{8F8FA481-F80F-4010-8D11-10D757796072}" type="presOf" srcId="{3D80F380-3B92-445C-9991-34B8A33B2ECF}" destId="{C1BBEA97-13F5-4E11-A031-17BAD9EBF99A}" srcOrd="0" destOrd="0" presId="urn:microsoft.com/office/officeart/2005/8/layout/vList5"/>
    <dgm:cxn modelId="{DBBB1382-14DE-4F54-A094-5EC3D2D1E0E1}" srcId="{3D80F380-3B92-445C-9991-34B8A33B2ECF}" destId="{810C17BD-7B7E-4D83-88E9-5C58C115F508}" srcOrd="3" destOrd="0" parTransId="{192B5EB6-75F1-49DA-A42A-D78D7B8407CE}" sibTransId="{A4BF771C-B458-4A71-9BF7-84580C8C3EC3}"/>
    <dgm:cxn modelId="{7919338B-1555-490B-9CC6-99300EFC254A}" type="presOf" srcId="{1A5ED0D3-96AB-419C-83FA-236E50BE8D16}" destId="{1D004FCF-E91A-483C-9730-425CC505DE1C}" srcOrd="0" destOrd="0" presId="urn:microsoft.com/office/officeart/2005/8/layout/vList5"/>
    <dgm:cxn modelId="{0254E98D-858F-43A5-A17F-3898AA81E6AC}" type="presOf" srcId="{06D83BE3-FCFA-4048-8D16-230C825D550A}" destId="{D377DF79-CDC0-4998-B9B6-936269382C55}" srcOrd="0" destOrd="0" presId="urn:microsoft.com/office/officeart/2005/8/layout/vList5"/>
    <dgm:cxn modelId="{F9F3288E-45E9-4943-B44E-6131B1C8800F}" type="presOf" srcId="{538CF43F-9C6A-4DEA-967F-FC4DD1C387DD}" destId="{FE1DED6C-1D78-4D0C-9015-56718EC33E2C}" srcOrd="0" destOrd="0" presId="urn:microsoft.com/office/officeart/2005/8/layout/vList5"/>
    <dgm:cxn modelId="{919A0192-96AD-43F1-AF6D-E1A7F882077B}" srcId="{9F2592C2-998B-4A47-9E58-E00937D37CFC}" destId="{6659CE27-AA55-4A46-B98B-82B5043589AD}" srcOrd="0" destOrd="0" parTransId="{F24DB68B-970C-49AE-97C6-EC37A141622B}" sibTransId="{63B75610-20CE-4243-93C5-54E6B1F6C7D6}"/>
    <dgm:cxn modelId="{7A8989A1-DDA0-4126-9873-0642C42C0F5A}" srcId="{7C92A925-4102-4FAD-A9B1-D4E3B87D2F8E}" destId="{96D559F2-D0FD-4BC2-8EC9-526379E7AD18}" srcOrd="0" destOrd="0" parTransId="{B5D035D1-EE80-4CA5-91CE-F62713F7840C}" sibTransId="{3AA75ACC-A82C-41CB-ACC4-22383A1704D5}"/>
    <dgm:cxn modelId="{8CF41BA4-D2E3-495D-B044-649FD0E3BCFD}" type="presOf" srcId="{0AE20938-1B41-4640-9D3D-7271D505604F}" destId="{95851911-1337-415F-9D84-EF5E60FC8F57}" srcOrd="0" destOrd="1" presId="urn:microsoft.com/office/officeart/2005/8/layout/vList5"/>
    <dgm:cxn modelId="{C89D4CAB-AE65-496D-B8D1-7FE50D60535C}" type="presOf" srcId="{3FE18A39-C52B-468E-893E-696793BB8CD5}" destId="{C46D864B-4BB9-4140-A9DC-E6666ED80EFB}" srcOrd="0" destOrd="1" presId="urn:microsoft.com/office/officeart/2005/8/layout/vList5"/>
    <dgm:cxn modelId="{547FF4B0-03FE-4571-AFC4-5C6D0E39FB01}" srcId="{193B099A-39FC-4047-A261-82AC950A257A}" destId="{A29821AE-302A-4B92-AC7E-952784B85349}" srcOrd="0" destOrd="0" parTransId="{5BA37330-26F4-4626-8F00-A8459D8B624E}" sibTransId="{5D9C1022-93FA-4E6B-8B2C-DC7263A8468F}"/>
    <dgm:cxn modelId="{18D2AAB6-F302-4B7E-91DA-42CD9640BCC4}" srcId="{3D80F380-3B92-445C-9991-34B8A33B2ECF}" destId="{9F2592C2-998B-4A47-9E58-E00937D37CFC}" srcOrd="1" destOrd="0" parTransId="{883A47F4-AA77-49E4-90AA-DF6383217CA7}" sibTransId="{B3F41A94-E23D-4BD5-A8E9-562302999318}"/>
    <dgm:cxn modelId="{C3A7DBC3-634B-460B-94F8-DAE278E5EAA4}" srcId="{3D80F380-3B92-445C-9991-34B8A33B2ECF}" destId="{DB075803-47FD-4DB5-B83E-BF2A7CDBBD54}" srcOrd="0" destOrd="0" parTransId="{38310BF9-D507-44A9-AADB-CF44166423F0}" sibTransId="{78942D9E-6C8F-4EA7-9B65-58C74C5FCE14}"/>
    <dgm:cxn modelId="{C4E2FCCF-482B-467B-A1CE-31F2EF0207CA}" type="presOf" srcId="{A29821AE-302A-4B92-AC7E-952784B85349}" destId="{D4DA00CE-234C-4754-A39C-23B55302F42B}" srcOrd="0" destOrd="0" presId="urn:microsoft.com/office/officeart/2005/8/layout/vList5"/>
    <dgm:cxn modelId="{9381E9E5-049B-4CCE-89B5-227100D374FC}" srcId="{DB075803-47FD-4DB5-B83E-BF2A7CDBBD54}" destId="{5D35BAFA-8687-4F25-94FA-8D9AA628343F}" srcOrd="1" destOrd="0" parTransId="{64D35FE2-6687-4F5C-92D3-FCC8D1B641E6}" sibTransId="{B4990353-A4CB-4120-914F-4B12CBB79BE1}"/>
    <dgm:cxn modelId="{2C5DECEA-B9C3-4065-BE10-68135CD175D6}" type="presOf" srcId="{5F4A103B-4AA8-4418-82AC-7D096AD9B81C}" destId="{9A84E1C7-ABDB-452D-A2BB-D2E2388A0633}" srcOrd="0" destOrd="0" presId="urn:microsoft.com/office/officeart/2005/8/layout/vList5"/>
    <dgm:cxn modelId="{BE90A7FD-DDFE-4B3C-8594-BE0B16D22BDA}" type="presOf" srcId="{810C17BD-7B7E-4D83-88E9-5C58C115F508}" destId="{BE93C424-47EE-431F-9F11-D78EA5D08920}" srcOrd="0" destOrd="0" presId="urn:microsoft.com/office/officeart/2005/8/layout/vList5"/>
    <dgm:cxn modelId="{B9BE6D5E-B7AA-420D-9EB8-A3AF1C0076FE}" type="presParOf" srcId="{C1BBEA97-13F5-4E11-A031-17BAD9EBF99A}" destId="{46E2197D-7F88-467B-8EE5-DC11626686E2}" srcOrd="0" destOrd="0" presId="urn:microsoft.com/office/officeart/2005/8/layout/vList5"/>
    <dgm:cxn modelId="{65585AA8-1A35-484F-9E98-C6D9CD15B889}" type="presParOf" srcId="{46E2197D-7F88-467B-8EE5-DC11626686E2}" destId="{3092E2E4-F9C9-4F63-973A-0773214EC645}" srcOrd="0" destOrd="0" presId="urn:microsoft.com/office/officeart/2005/8/layout/vList5"/>
    <dgm:cxn modelId="{D9D50265-F2D9-4311-8EFA-6113F92D83CE}" type="presParOf" srcId="{46E2197D-7F88-467B-8EE5-DC11626686E2}" destId="{9DACEBA6-B7F3-470B-ADE0-7C787F395B68}" srcOrd="1" destOrd="0" presId="urn:microsoft.com/office/officeart/2005/8/layout/vList5"/>
    <dgm:cxn modelId="{98DB2AB8-1956-45B2-A362-3AE0389E9F1B}" type="presParOf" srcId="{C1BBEA97-13F5-4E11-A031-17BAD9EBF99A}" destId="{7AA1575C-1C73-4A7C-BDE0-9DB82851E80D}" srcOrd="1" destOrd="0" presId="urn:microsoft.com/office/officeart/2005/8/layout/vList5"/>
    <dgm:cxn modelId="{BE733C00-9A42-4BBC-87A6-965FACDB31B1}" type="presParOf" srcId="{C1BBEA97-13F5-4E11-A031-17BAD9EBF99A}" destId="{6F17102B-E77D-405E-9F8E-0904A6AC1919}" srcOrd="2" destOrd="0" presId="urn:microsoft.com/office/officeart/2005/8/layout/vList5"/>
    <dgm:cxn modelId="{B79FCB58-9E2D-4130-B88D-E3EF1F7EAB48}" type="presParOf" srcId="{6F17102B-E77D-405E-9F8E-0904A6AC1919}" destId="{50633897-3B87-42CF-9EE5-E4AD5C561271}" srcOrd="0" destOrd="0" presId="urn:microsoft.com/office/officeart/2005/8/layout/vList5"/>
    <dgm:cxn modelId="{316A508D-16FF-43CC-8A78-738DD6936E33}" type="presParOf" srcId="{6F17102B-E77D-405E-9F8E-0904A6AC1919}" destId="{5C5B57D6-C573-4FF5-8D2D-153330CE39BF}" srcOrd="1" destOrd="0" presId="urn:microsoft.com/office/officeart/2005/8/layout/vList5"/>
    <dgm:cxn modelId="{98AD8DA8-DD3F-4544-8350-0CBE76C9E288}" type="presParOf" srcId="{C1BBEA97-13F5-4E11-A031-17BAD9EBF99A}" destId="{A82357A7-EC76-44AB-B02D-22661D95AD9A}" srcOrd="3" destOrd="0" presId="urn:microsoft.com/office/officeart/2005/8/layout/vList5"/>
    <dgm:cxn modelId="{FC2A1997-6FCD-4D51-9C20-873F6118D66D}" type="presParOf" srcId="{C1BBEA97-13F5-4E11-A031-17BAD9EBF99A}" destId="{7A3F2C14-5BF2-45F3-B6DD-E8D7BA393605}" srcOrd="4" destOrd="0" presId="urn:microsoft.com/office/officeart/2005/8/layout/vList5"/>
    <dgm:cxn modelId="{919532ED-875B-484F-A6D1-15091E89123E}" type="presParOf" srcId="{7A3F2C14-5BF2-45F3-B6DD-E8D7BA393605}" destId="{9A84E1C7-ABDB-452D-A2BB-D2E2388A0633}" srcOrd="0" destOrd="0" presId="urn:microsoft.com/office/officeart/2005/8/layout/vList5"/>
    <dgm:cxn modelId="{90D76702-B90B-40FB-ADCC-D95B291B0076}" type="presParOf" srcId="{7A3F2C14-5BF2-45F3-B6DD-E8D7BA393605}" destId="{1D004FCF-E91A-483C-9730-425CC505DE1C}" srcOrd="1" destOrd="0" presId="urn:microsoft.com/office/officeart/2005/8/layout/vList5"/>
    <dgm:cxn modelId="{FD065FEE-6E01-48B6-9B63-AF77AB8CB025}" type="presParOf" srcId="{C1BBEA97-13F5-4E11-A031-17BAD9EBF99A}" destId="{38DCDEC3-F55F-460A-AC3E-C225B370726C}" srcOrd="5" destOrd="0" presId="urn:microsoft.com/office/officeart/2005/8/layout/vList5"/>
    <dgm:cxn modelId="{2B9D5F91-2B57-4844-822A-38B568B1A81E}" type="presParOf" srcId="{C1BBEA97-13F5-4E11-A031-17BAD9EBF99A}" destId="{0B45CD7B-5F42-403F-8C3A-5F65AA5B9B99}" srcOrd="6" destOrd="0" presId="urn:microsoft.com/office/officeart/2005/8/layout/vList5"/>
    <dgm:cxn modelId="{17176175-22D4-4FEC-B19B-08D4FF1DE5D2}" type="presParOf" srcId="{0B45CD7B-5F42-403F-8C3A-5F65AA5B9B99}" destId="{BE93C424-47EE-431F-9F11-D78EA5D08920}" srcOrd="0" destOrd="0" presId="urn:microsoft.com/office/officeart/2005/8/layout/vList5"/>
    <dgm:cxn modelId="{D73628C8-1944-415A-8D00-01126187D150}" type="presParOf" srcId="{0B45CD7B-5F42-403F-8C3A-5F65AA5B9B99}" destId="{95851911-1337-415F-9D84-EF5E60FC8F57}" srcOrd="1" destOrd="0" presId="urn:microsoft.com/office/officeart/2005/8/layout/vList5"/>
    <dgm:cxn modelId="{71A88358-4C9D-4F20-B5A8-1814F1DFC2C9}" type="presParOf" srcId="{C1BBEA97-13F5-4E11-A031-17BAD9EBF99A}" destId="{0655EB3E-84C2-4E4A-99F6-19410BD0D420}" srcOrd="7" destOrd="0" presId="urn:microsoft.com/office/officeart/2005/8/layout/vList5"/>
    <dgm:cxn modelId="{E12B9ED0-0AAE-4727-AE74-4E97BFC63DD4}" type="presParOf" srcId="{C1BBEA97-13F5-4E11-A031-17BAD9EBF99A}" destId="{B255ED18-9ABA-4CD4-9201-95026C25F740}" srcOrd="8" destOrd="0" presId="urn:microsoft.com/office/officeart/2005/8/layout/vList5"/>
    <dgm:cxn modelId="{647F0D47-C478-4D64-B3EB-47D95771AAC0}" type="presParOf" srcId="{B255ED18-9ABA-4CD4-9201-95026C25F740}" destId="{D377DF79-CDC0-4998-B9B6-936269382C55}" srcOrd="0" destOrd="0" presId="urn:microsoft.com/office/officeart/2005/8/layout/vList5"/>
    <dgm:cxn modelId="{8A63AF5C-6AD4-4034-A15E-4573A4CA3970}" type="presParOf" srcId="{B255ED18-9ABA-4CD4-9201-95026C25F740}" destId="{FE1DED6C-1D78-4D0C-9015-56718EC33E2C}" srcOrd="1" destOrd="0" presId="urn:microsoft.com/office/officeart/2005/8/layout/vList5"/>
    <dgm:cxn modelId="{1B8437C2-B1E0-4DCF-B310-B078593E1996}" type="presParOf" srcId="{C1BBEA97-13F5-4E11-A031-17BAD9EBF99A}" destId="{7CBF3F6A-72BF-4A9C-A378-CB33F1F127E6}" srcOrd="9" destOrd="0" presId="urn:microsoft.com/office/officeart/2005/8/layout/vList5"/>
    <dgm:cxn modelId="{E00F2856-3FB1-4C54-902D-3DB82259BC5E}" type="presParOf" srcId="{C1BBEA97-13F5-4E11-A031-17BAD9EBF99A}" destId="{8E91BD0A-DDB0-481B-B4F4-2BE608096BA3}" srcOrd="10" destOrd="0" presId="urn:microsoft.com/office/officeart/2005/8/layout/vList5"/>
    <dgm:cxn modelId="{C30FED79-60FB-4EAC-B041-47419B506FB7}" type="presParOf" srcId="{8E91BD0A-DDB0-481B-B4F4-2BE608096BA3}" destId="{40834933-7240-405D-BC12-8C6F826CEF86}" srcOrd="0" destOrd="0" presId="urn:microsoft.com/office/officeart/2005/8/layout/vList5"/>
    <dgm:cxn modelId="{F57B9BD9-509B-448B-A714-059D38D4EA5A}" type="presParOf" srcId="{8E91BD0A-DDB0-481B-B4F4-2BE608096BA3}" destId="{C46D864B-4BB9-4140-A9DC-E6666ED80EFB}" srcOrd="1" destOrd="0" presId="urn:microsoft.com/office/officeart/2005/8/layout/vList5"/>
    <dgm:cxn modelId="{0EB3223B-2B35-4875-89A4-B69705E2F755}" type="presParOf" srcId="{C1BBEA97-13F5-4E11-A031-17BAD9EBF99A}" destId="{F7CAD794-09D7-4CAC-8A39-D2BBE12E5ADB}" srcOrd="11" destOrd="0" presId="urn:microsoft.com/office/officeart/2005/8/layout/vList5"/>
    <dgm:cxn modelId="{2750AD4F-3F1B-4236-9A65-1A669942D15F}" type="presParOf" srcId="{C1BBEA97-13F5-4E11-A031-17BAD9EBF99A}" destId="{910430C3-CEEC-4EF5-B507-CD626ACCF11F}" srcOrd="12" destOrd="0" presId="urn:microsoft.com/office/officeart/2005/8/layout/vList5"/>
    <dgm:cxn modelId="{6D1877F1-8CA5-4550-A3CD-B26CC6ED6C6A}" type="presParOf" srcId="{910430C3-CEEC-4EF5-B507-CD626ACCF11F}" destId="{2477482A-E0D8-4105-B60F-16A4E647AB90}" srcOrd="0" destOrd="0" presId="urn:microsoft.com/office/officeart/2005/8/layout/vList5"/>
    <dgm:cxn modelId="{CB6D1B53-F623-47D7-961C-9E2FC6C2CBD6}" type="presParOf" srcId="{910430C3-CEEC-4EF5-B507-CD626ACCF11F}" destId="{D4DA00CE-234C-4754-A39C-23B55302F42B}"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DACEBA6-B7F3-470B-ADE0-7C787F395B68}">
      <dsp:nvSpPr>
        <dsp:cNvPr id="0" name=""/>
        <dsp:cNvSpPr/>
      </dsp:nvSpPr>
      <dsp:spPr>
        <a:xfrm rot="5400000">
          <a:off x="6912153" y="-3066551"/>
          <a:ext cx="476909" cy="6729984"/>
        </a:xfrm>
        <a:prstGeom prst="round2Same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The relationship between behavior and mood</a:t>
          </a:r>
        </a:p>
        <a:p>
          <a:pPr marL="114300" lvl="1" indent="-114300" algn="l" defTabSz="533400">
            <a:lnSpc>
              <a:spcPct val="90000"/>
            </a:lnSpc>
            <a:spcBef>
              <a:spcPct val="0"/>
            </a:spcBef>
            <a:spcAft>
              <a:spcPct val="15000"/>
            </a:spcAft>
            <a:buChar char="•"/>
          </a:pPr>
          <a:r>
            <a:rPr lang="en-US" sz="1200" kern="1200"/>
            <a:t>What downward spirals are and how they start</a:t>
          </a:r>
        </a:p>
      </dsp:txBody>
      <dsp:txXfrm rot="-5400000">
        <a:off x="3785616" y="83267"/>
        <a:ext cx="6706703" cy="430347"/>
      </dsp:txXfrm>
    </dsp:sp>
    <dsp:sp modelId="{3092E2E4-F9C9-4F63-973A-0773214EC645}">
      <dsp:nvSpPr>
        <dsp:cNvPr id="0" name=""/>
        <dsp:cNvSpPr/>
      </dsp:nvSpPr>
      <dsp:spPr>
        <a:xfrm>
          <a:off x="0" y="371"/>
          <a:ext cx="3785616" cy="596137"/>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Education</a:t>
          </a:r>
        </a:p>
      </dsp:txBody>
      <dsp:txXfrm>
        <a:off x="29101" y="29472"/>
        <a:ext cx="3727414" cy="537935"/>
      </dsp:txXfrm>
    </dsp:sp>
    <dsp:sp modelId="{5C5B57D6-C573-4FF5-8D2D-153330CE39BF}">
      <dsp:nvSpPr>
        <dsp:cNvPr id="0" name=""/>
        <dsp:cNvSpPr/>
      </dsp:nvSpPr>
      <dsp:spPr>
        <a:xfrm rot="5400000">
          <a:off x="6912153" y="-2440607"/>
          <a:ext cx="476909" cy="6729984"/>
        </a:xfrm>
        <a:prstGeom prst="round2SameRect">
          <a:avLst/>
        </a:prstGeom>
        <a:solidFill>
          <a:schemeClr val="accent5">
            <a:tint val="40000"/>
            <a:alpha val="90000"/>
            <a:hueOff val="-1123294"/>
            <a:satOff val="-3805"/>
            <a:lumOff val="-488"/>
            <a:alphaOff val="0"/>
          </a:schemeClr>
        </a:solidFill>
        <a:ln w="12700" cap="flat" cmpd="sng" algn="ctr">
          <a:solidFill>
            <a:schemeClr val="accent5">
              <a:tint val="40000"/>
              <a:alpha val="90000"/>
              <a:hueOff val="-1123294"/>
              <a:satOff val="-3805"/>
              <a:lumOff val="-488"/>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The story of an AYA who experienced a downward spiral that led to feelings of depression</a:t>
          </a:r>
        </a:p>
      </dsp:txBody>
      <dsp:txXfrm rot="-5400000">
        <a:off x="3785616" y="709211"/>
        <a:ext cx="6706703" cy="430347"/>
      </dsp:txXfrm>
    </dsp:sp>
    <dsp:sp modelId="{50633897-3B87-42CF-9EE5-E4AD5C561271}">
      <dsp:nvSpPr>
        <dsp:cNvPr id="0" name=""/>
        <dsp:cNvSpPr/>
      </dsp:nvSpPr>
      <dsp:spPr>
        <a:xfrm>
          <a:off x="0" y="626315"/>
          <a:ext cx="3785616" cy="596137"/>
        </a:xfrm>
        <a:prstGeom prst="roundRect">
          <a:avLst/>
        </a:prstGeom>
        <a:solidFill>
          <a:schemeClr val="accent5">
            <a:hueOff val="-1126424"/>
            <a:satOff val="-2903"/>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YA Story</a:t>
          </a:r>
        </a:p>
      </dsp:txBody>
      <dsp:txXfrm>
        <a:off x="29101" y="655416"/>
        <a:ext cx="3727414" cy="537935"/>
      </dsp:txXfrm>
    </dsp:sp>
    <dsp:sp modelId="{1D004FCF-E91A-483C-9730-425CC505DE1C}">
      <dsp:nvSpPr>
        <dsp:cNvPr id="0" name=""/>
        <dsp:cNvSpPr/>
      </dsp:nvSpPr>
      <dsp:spPr>
        <a:xfrm rot="5400000">
          <a:off x="6912153" y="-1814663"/>
          <a:ext cx="476909" cy="6729984"/>
        </a:xfrm>
        <a:prstGeom prst="round2SameRect">
          <a:avLst/>
        </a:prstGeom>
        <a:solidFill>
          <a:schemeClr val="accent5">
            <a:tint val="40000"/>
            <a:alpha val="90000"/>
            <a:hueOff val="-2246587"/>
            <a:satOff val="-7611"/>
            <a:lumOff val="-976"/>
            <a:alphaOff val="0"/>
          </a:schemeClr>
        </a:solidFill>
        <a:ln w="12700" cap="flat" cmpd="sng" algn="ctr">
          <a:solidFill>
            <a:schemeClr val="accent5">
              <a:tint val="40000"/>
              <a:alpha val="90000"/>
              <a:hueOff val="-2246587"/>
              <a:satOff val="-7611"/>
              <a:lumOff val="-976"/>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Identifying the downward spiral the AYA experienced</a:t>
          </a:r>
        </a:p>
        <a:p>
          <a:pPr marL="114300" lvl="1" indent="-114300" algn="l" defTabSz="533400">
            <a:lnSpc>
              <a:spcPct val="90000"/>
            </a:lnSpc>
            <a:spcBef>
              <a:spcPct val="0"/>
            </a:spcBef>
            <a:spcAft>
              <a:spcPct val="15000"/>
            </a:spcAft>
            <a:buChar char="•"/>
          </a:pPr>
          <a:r>
            <a:rPr lang="en-US" sz="1200" kern="1200"/>
            <a:t>Sharing a time where you experienced a downward spiral</a:t>
          </a:r>
        </a:p>
      </dsp:txBody>
      <dsp:txXfrm rot="-5400000">
        <a:off x="3785616" y="1335155"/>
        <a:ext cx="6706703" cy="430347"/>
      </dsp:txXfrm>
    </dsp:sp>
    <dsp:sp modelId="{9A84E1C7-ABDB-452D-A2BB-D2E2388A0633}">
      <dsp:nvSpPr>
        <dsp:cNvPr id="0" name=""/>
        <dsp:cNvSpPr/>
      </dsp:nvSpPr>
      <dsp:spPr>
        <a:xfrm>
          <a:off x="0" y="1252259"/>
          <a:ext cx="3785616" cy="596137"/>
        </a:xfrm>
        <a:prstGeom prst="roundRect">
          <a:avLst/>
        </a:prstGeom>
        <a:solidFill>
          <a:schemeClr val="accent5">
            <a:hueOff val="-2252848"/>
            <a:satOff val="-5806"/>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ctivity</a:t>
          </a:r>
        </a:p>
      </dsp:txBody>
      <dsp:txXfrm>
        <a:off x="29101" y="1281360"/>
        <a:ext cx="3727414" cy="537935"/>
      </dsp:txXfrm>
    </dsp:sp>
    <dsp:sp modelId="{95851911-1337-415F-9D84-EF5E60FC8F57}">
      <dsp:nvSpPr>
        <dsp:cNvPr id="0" name=""/>
        <dsp:cNvSpPr/>
      </dsp:nvSpPr>
      <dsp:spPr>
        <a:xfrm rot="5400000">
          <a:off x="6912153" y="-1188720"/>
          <a:ext cx="476909" cy="6729984"/>
        </a:xfrm>
        <a:prstGeom prst="round2SameRect">
          <a:avLst/>
        </a:prstGeom>
        <a:solidFill>
          <a:schemeClr val="accent5">
            <a:tint val="40000"/>
            <a:alpha val="90000"/>
            <a:hueOff val="-3369881"/>
            <a:satOff val="-11416"/>
            <a:lumOff val="-1464"/>
            <a:alphaOff val="0"/>
          </a:schemeClr>
        </a:solidFill>
        <a:ln w="12700" cap="flat" cmpd="sng" algn="ctr">
          <a:solidFill>
            <a:schemeClr val="accent5">
              <a:tint val="40000"/>
              <a:alpha val="90000"/>
              <a:hueOff val="-3369881"/>
              <a:satOff val="-11416"/>
              <a:lumOff val="-1464"/>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Stopping downward spirals</a:t>
          </a:r>
        </a:p>
        <a:p>
          <a:pPr marL="114300" lvl="1" indent="-114300" algn="l" defTabSz="533400">
            <a:lnSpc>
              <a:spcPct val="90000"/>
            </a:lnSpc>
            <a:spcBef>
              <a:spcPct val="0"/>
            </a:spcBef>
            <a:spcAft>
              <a:spcPct val="15000"/>
            </a:spcAft>
            <a:buChar char="•"/>
          </a:pPr>
          <a:r>
            <a:rPr lang="en-US" sz="1200" kern="1200" dirty="0"/>
            <a:t>Starting upward spirals</a:t>
          </a:r>
        </a:p>
      </dsp:txBody>
      <dsp:txXfrm rot="-5400000">
        <a:off x="3785616" y="1961098"/>
        <a:ext cx="6706703" cy="430347"/>
      </dsp:txXfrm>
    </dsp:sp>
    <dsp:sp modelId="{BE93C424-47EE-431F-9F11-D78EA5D08920}">
      <dsp:nvSpPr>
        <dsp:cNvPr id="0" name=""/>
        <dsp:cNvSpPr/>
      </dsp:nvSpPr>
      <dsp:spPr>
        <a:xfrm>
          <a:off x="0" y="1878203"/>
          <a:ext cx="3785616" cy="596137"/>
        </a:xfrm>
        <a:prstGeom prst="roundRec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Education</a:t>
          </a:r>
        </a:p>
      </dsp:txBody>
      <dsp:txXfrm>
        <a:off x="29101" y="1907304"/>
        <a:ext cx="3727414" cy="537935"/>
      </dsp:txXfrm>
    </dsp:sp>
    <dsp:sp modelId="{FE1DED6C-1D78-4D0C-9015-56718EC33E2C}">
      <dsp:nvSpPr>
        <dsp:cNvPr id="0" name=""/>
        <dsp:cNvSpPr/>
      </dsp:nvSpPr>
      <dsp:spPr>
        <a:xfrm rot="5400000">
          <a:off x="6912153" y="-562776"/>
          <a:ext cx="476909" cy="6729984"/>
        </a:xfrm>
        <a:prstGeom prst="round2SameRect">
          <a:avLst/>
        </a:prstGeom>
        <a:solidFill>
          <a:schemeClr val="accent5">
            <a:tint val="40000"/>
            <a:alpha val="90000"/>
            <a:hueOff val="-4493175"/>
            <a:satOff val="-15221"/>
            <a:lumOff val="-1952"/>
            <a:alphaOff val="0"/>
          </a:schemeClr>
        </a:solidFill>
        <a:ln w="12700" cap="flat" cmpd="sng" algn="ctr">
          <a:solidFill>
            <a:schemeClr val="accent5">
              <a:tint val="40000"/>
              <a:alpha val="90000"/>
              <a:hueOff val="-4493175"/>
              <a:satOff val="-15221"/>
              <a:lumOff val="-1952"/>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How the same AYA was able to stop their downward spiral and start an upward spiral</a:t>
          </a:r>
        </a:p>
      </dsp:txBody>
      <dsp:txXfrm rot="-5400000">
        <a:off x="3785616" y="2587042"/>
        <a:ext cx="6706703" cy="430347"/>
      </dsp:txXfrm>
    </dsp:sp>
    <dsp:sp modelId="{D377DF79-CDC0-4998-B9B6-936269382C55}">
      <dsp:nvSpPr>
        <dsp:cNvPr id="0" name=""/>
        <dsp:cNvSpPr/>
      </dsp:nvSpPr>
      <dsp:spPr>
        <a:xfrm>
          <a:off x="0" y="2504147"/>
          <a:ext cx="3785616" cy="596137"/>
        </a:xfrm>
        <a:prstGeom prst="roundRect">
          <a:avLst/>
        </a:prstGeom>
        <a:solidFill>
          <a:schemeClr val="accent5">
            <a:hueOff val="-4505695"/>
            <a:satOff val="-11613"/>
            <a:lumOff val="-784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YA Story</a:t>
          </a:r>
        </a:p>
      </dsp:txBody>
      <dsp:txXfrm>
        <a:off x="29101" y="2533248"/>
        <a:ext cx="3727414" cy="537935"/>
      </dsp:txXfrm>
    </dsp:sp>
    <dsp:sp modelId="{C46D864B-4BB9-4140-A9DC-E6666ED80EFB}">
      <dsp:nvSpPr>
        <dsp:cNvPr id="0" name=""/>
        <dsp:cNvSpPr/>
      </dsp:nvSpPr>
      <dsp:spPr>
        <a:xfrm rot="5400000">
          <a:off x="6912153" y="63167"/>
          <a:ext cx="476909" cy="6729984"/>
        </a:xfrm>
        <a:prstGeom prst="round2SameRect">
          <a:avLst/>
        </a:prstGeom>
        <a:solidFill>
          <a:schemeClr val="accent5">
            <a:tint val="40000"/>
            <a:alpha val="90000"/>
            <a:hueOff val="-5616468"/>
            <a:satOff val="-19027"/>
            <a:lumOff val="-2440"/>
            <a:alphaOff val="0"/>
          </a:schemeClr>
        </a:solidFill>
        <a:ln w="12700" cap="flat" cmpd="sng" algn="ctr">
          <a:solidFill>
            <a:schemeClr val="accent5">
              <a:tint val="40000"/>
              <a:alpha val="90000"/>
              <a:hueOff val="-5616468"/>
              <a:satOff val="-19027"/>
              <a:lumOff val="-244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Identifying the upward spiral the AYA experienced</a:t>
          </a:r>
        </a:p>
        <a:p>
          <a:pPr marL="114300" lvl="1" indent="-114300" algn="l" defTabSz="533400">
            <a:lnSpc>
              <a:spcPct val="90000"/>
            </a:lnSpc>
            <a:spcBef>
              <a:spcPct val="0"/>
            </a:spcBef>
            <a:spcAft>
              <a:spcPct val="15000"/>
            </a:spcAft>
            <a:buChar char="•"/>
          </a:pPr>
          <a:r>
            <a:rPr lang="en-US" sz="1200" kern="1200"/>
            <a:t>Sharing a time where you experienced an upward spiral</a:t>
          </a:r>
        </a:p>
      </dsp:txBody>
      <dsp:txXfrm rot="-5400000">
        <a:off x="3785616" y="3212986"/>
        <a:ext cx="6706703" cy="430347"/>
      </dsp:txXfrm>
    </dsp:sp>
    <dsp:sp modelId="{40834933-7240-405D-BC12-8C6F826CEF86}">
      <dsp:nvSpPr>
        <dsp:cNvPr id="0" name=""/>
        <dsp:cNvSpPr/>
      </dsp:nvSpPr>
      <dsp:spPr>
        <a:xfrm>
          <a:off x="0" y="3130091"/>
          <a:ext cx="3785616" cy="596137"/>
        </a:xfrm>
        <a:prstGeom prst="roundRect">
          <a:avLst/>
        </a:prstGeom>
        <a:solidFill>
          <a:schemeClr val="accent5">
            <a:hueOff val="-5632119"/>
            <a:satOff val="-14516"/>
            <a:lumOff val="-980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a:t>Activity</a:t>
          </a:r>
          <a:endParaRPr lang="en-US" sz="3000" kern="1200" dirty="0"/>
        </a:p>
      </dsp:txBody>
      <dsp:txXfrm>
        <a:off x="29101" y="3159192"/>
        <a:ext cx="3727414" cy="537935"/>
      </dsp:txXfrm>
    </dsp:sp>
    <dsp:sp modelId="{D4DA00CE-234C-4754-A39C-23B55302F42B}">
      <dsp:nvSpPr>
        <dsp:cNvPr id="0" name=""/>
        <dsp:cNvSpPr/>
      </dsp:nvSpPr>
      <dsp:spPr>
        <a:xfrm rot="5400000">
          <a:off x="6912153" y="689111"/>
          <a:ext cx="476909" cy="6729984"/>
        </a:xfrm>
        <a:prstGeom prst="round2SameRect">
          <a:avLst/>
        </a:prstGeom>
        <a:solidFill>
          <a:schemeClr val="accent5">
            <a:tint val="40000"/>
            <a:alpha val="90000"/>
            <a:hueOff val="-6739762"/>
            <a:satOff val="-22832"/>
            <a:lumOff val="-2928"/>
            <a:alphaOff val="0"/>
          </a:schemeClr>
        </a:solidFill>
        <a:ln w="12700" cap="flat" cmpd="sng" algn="ctr">
          <a:solidFill>
            <a:schemeClr val="accent5">
              <a:tint val="40000"/>
              <a:alpha val="90000"/>
              <a:hueOff val="-6739762"/>
              <a:satOff val="-22832"/>
              <a:lumOff val="-2928"/>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Tracking how you feel after doing activities</a:t>
          </a:r>
        </a:p>
        <a:p>
          <a:pPr marL="114300" lvl="1" indent="-114300" algn="l" defTabSz="533400">
            <a:lnSpc>
              <a:spcPct val="90000"/>
            </a:lnSpc>
            <a:spcBef>
              <a:spcPct val="0"/>
            </a:spcBef>
            <a:spcAft>
              <a:spcPct val="15000"/>
            </a:spcAft>
            <a:buChar char="•"/>
          </a:pPr>
          <a:r>
            <a:rPr lang="en-US" sz="1200" kern="1200"/>
            <a:t>Added to your check-in</a:t>
          </a:r>
        </a:p>
      </dsp:txBody>
      <dsp:txXfrm rot="-5400000">
        <a:off x="3785616" y="3838930"/>
        <a:ext cx="6706703" cy="430347"/>
      </dsp:txXfrm>
    </dsp:sp>
    <dsp:sp modelId="{2477482A-E0D8-4105-B60F-16A4E647AB90}">
      <dsp:nvSpPr>
        <dsp:cNvPr id="0" name=""/>
        <dsp:cNvSpPr/>
      </dsp:nvSpPr>
      <dsp:spPr>
        <a:xfrm>
          <a:off x="0" y="3756035"/>
          <a:ext cx="3785616" cy="596137"/>
        </a:xfrm>
        <a:prstGeom prst="roundRec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Practice</a:t>
          </a:r>
        </a:p>
      </dsp:txBody>
      <dsp:txXfrm>
        <a:off x="29101" y="3785136"/>
        <a:ext cx="3727414" cy="5379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DACEBA6-B7F3-470B-ADE0-7C787F395B68}">
      <dsp:nvSpPr>
        <dsp:cNvPr id="0" name=""/>
        <dsp:cNvSpPr/>
      </dsp:nvSpPr>
      <dsp:spPr>
        <a:xfrm rot="5400000">
          <a:off x="6912219" y="-3066634"/>
          <a:ext cx="476777" cy="6729984"/>
        </a:xfrm>
        <a:prstGeom prst="round2Same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The relationship between behavior and mood</a:t>
          </a:r>
        </a:p>
        <a:p>
          <a:pPr marL="114300" lvl="1" indent="-114300" algn="l" defTabSz="533400">
            <a:lnSpc>
              <a:spcPct val="90000"/>
            </a:lnSpc>
            <a:spcBef>
              <a:spcPct val="0"/>
            </a:spcBef>
            <a:spcAft>
              <a:spcPct val="15000"/>
            </a:spcAft>
            <a:buChar char="•"/>
          </a:pPr>
          <a:r>
            <a:rPr lang="en-US" sz="1200" kern="1200"/>
            <a:t>What downward spirals are and how they start</a:t>
          </a:r>
        </a:p>
      </dsp:txBody>
      <dsp:txXfrm rot="-5400000">
        <a:off x="3785616" y="83243"/>
        <a:ext cx="6706710" cy="430229"/>
      </dsp:txXfrm>
    </dsp:sp>
    <dsp:sp modelId="{3092E2E4-F9C9-4F63-973A-0773214EC645}">
      <dsp:nvSpPr>
        <dsp:cNvPr id="0" name=""/>
        <dsp:cNvSpPr/>
      </dsp:nvSpPr>
      <dsp:spPr>
        <a:xfrm>
          <a:off x="0" y="371"/>
          <a:ext cx="3785616" cy="595971"/>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Education</a:t>
          </a:r>
        </a:p>
      </dsp:txBody>
      <dsp:txXfrm>
        <a:off x="29093" y="29464"/>
        <a:ext cx="3727430" cy="537785"/>
      </dsp:txXfrm>
    </dsp:sp>
    <dsp:sp modelId="{5C5B57D6-C573-4FF5-8D2D-153330CE39BF}">
      <dsp:nvSpPr>
        <dsp:cNvPr id="0" name=""/>
        <dsp:cNvSpPr/>
      </dsp:nvSpPr>
      <dsp:spPr>
        <a:xfrm rot="5400000">
          <a:off x="6912219" y="-2440863"/>
          <a:ext cx="476777" cy="6729984"/>
        </a:xfrm>
        <a:prstGeom prst="round2SameRect">
          <a:avLst/>
        </a:prstGeom>
        <a:solidFill>
          <a:schemeClr val="accent5">
            <a:tint val="40000"/>
            <a:alpha val="90000"/>
            <a:hueOff val="-1123294"/>
            <a:satOff val="-3805"/>
            <a:lumOff val="-488"/>
            <a:alphaOff val="0"/>
          </a:schemeClr>
        </a:solidFill>
        <a:ln w="12700" cap="flat" cmpd="sng" algn="ctr">
          <a:solidFill>
            <a:schemeClr val="accent5">
              <a:tint val="40000"/>
              <a:alpha val="90000"/>
              <a:hueOff val="-1123294"/>
              <a:satOff val="-3805"/>
              <a:lumOff val="-488"/>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The story of an AYA who experienced a downward spiral that led to feelings of depression</a:t>
          </a:r>
        </a:p>
      </dsp:txBody>
      <dsp:txXfrm rot="-5400000">
        <a:off x="3785616" y="709014"/>
        <a:ext cx="6706710" cy="430229"/>
      </dsp:txXfrm>
    </dsp:sp>
    <dsp:sp modelId="{50633897-3B87-42CF-9EE5-E4AD5C561271}">
      <dsp:nvSpPr>
        <dsp:cNvPr id="0" name=""/>
        <dsp:cNvSpPr/>
      </dsp:nvSpPr>
      <dsp:spPr>
        <a:xfrm>
          <a:off x="0" y="626142"/>
          <a:ext cx="3785616" cy="595971"/>
        </a:xfrm>
        <a:prstGeom prst="roundRect">
          <a:avLst/>
        </a:prstGeom>
        <a:solidFill>
          <a:schemeClr val="accent5">
            <a:hueOff val="-1126424"/>
            <a:satOff val="-2903"/>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YA Story</a:t>
          </a:r>
        </a:p>
      </dsp:txBody>
      <dsp:txXfrm>
        <a:off x="29093" y="655235"/>
        <a:ext cx="3727430" cy="537785"/>
      </dsp:txXfrm>
    </dsp:sp>
    <dsp:sp modelId="{1D004FCF-E91A-483C-9730-425CC505DE1C}">
      <dsp:nvSpPr>
        <dsp:cNvPr id="0" name=""/>
        <dsp:cNvSpPr/>
      </dsp:nvSpPr>
      <dsp:spPr>
        <a:xfrm rot="5400000">
          <a:off x="6912219" y="-1815093"/>
          <a:ext cx="476777" cy="6729984"/>
        </a:xfrm>
        <a:prstGeom prst="round2SameRect">
          <a:avLst/>
        </a:prstGeom>
        <a:solidFill>
          <a:schemeClr val="accent5">
            <a:tint val="40000"/>
            <a:alpha val="90000"/>
            <a:hueOff val="-2246587"/>
            <a:satOff val="-7611"/>
            <a:lumOff val="-976"/>
            <a:alphaOff val="0"/>
          </a:schemeClr>
        </a:solidFill>
        <a:ln w="12700" cap="flat" cmpd="sng" algn="ctr">
          <a:solidFill>
            <a:schemeClr val="accent5">
              <a:tint val="40000"/>
              <a:alpha val="90000"/>
              <a:hueOff val="-2246587"/>
              <a:satOff val="-7611"/>
              <a:lumOff val="-976"/>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Identifying the downward spiral the AYA experienced</a:t>
          </a:r>
        </a:p>
        <a:p>
          <a:pPr marL="114300" lvl="1" indent="-114300" algn="l" defTabSz="533400">
            <a:lnSpc>
              <a:spcPct val="90000"/>
            </a:lnSpc>
            <a:spcBef>
              <a:spcPct val="0"/>
            </a:spcBef>
            <a:spcAft>
              <a:spcPct val="15000"/>
            </a:spcAft>
            <a:buChar char="•"/>
          </a:pPr>
          <a:r>
            <a:rPr lang="en-US" sz="1200" kern="1200"/>
            <a:t>Sharing a time where you experienced a downward spiral</a:t>
          </a:r>
        </a:p>
      </dsp:txBody>
      <dsp:txXfrm rot="-5400000">
        <a:off x="3785616" y="1334784"/>
        <a:ext cx="6706710" cy="430229"/>
      </dsp:txXfrm>
    </dsp:sp>
    <dsp:sp modelId="{9A84E1C7-ABDB-452D-A2BB-D2E2388A0633}">
      <dsp:nvSpPr>
        <dsp:cNvPr id="0" name=""/>
        <dsp:cNvSpPr/>
      </dsp:nvSpPr>
      <dsp:spPr>
        <a:xfrm>
          <a:off x="0" y="1251912"/>
          <a:ext cx="3785616" cy="595971"/>
        </a:xfrm>
        <a:prstGeom prst="roundRect">
          <a:avLst/>
        </a:prstGeom>
        <a:solidFill>
          <a:schemeClr val="accent5">
            <a:hueOff val="-2252848"/>
            <a:satOff val="-5806"/>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ctivity</a:t>
          </a:r>
        </a:p>
      </dsp:txBody>
      <dsp:txXfrm>
        <a:off x="29093" y="1281005"/>
        <a:ext cx="3727430" cy="537785"/>
      </dsp:txXfrm>
    </dsp:sp>
    <dsp:sp modelId="{95851911-1337-415F-9D84-EF5E60FC8F57}">
      <dsp:nvSpPr>
        <dsp:cNvPr id="0" name=""/>
        <dsp:cNvSpPr/>
      </dsp:nvSpPr>
      <dsp:spPr>
        <a:xfrm rot="5400000">
          <a:off x="6912219" y="-1189323"/>
          <a:ext cx="476777" cy="6729984"/>
        </a:xfrm>
        <a:prstGeom prst="round2SameRect">
          <a:avLst/>
        </a:prstGeom>
        <a:solidFill>
          <a:schemeClr val="accent5">
            <a:tint val="40000"/>
            <a:alpha val="90000"/>
            <a:hueOff val="-3369881"/>
            <a:satOff val="-11416"/>
            <a:lumOff val="-1464"/>
            <a:alphaOff val="0"/>
          </a:schemeClr>
        </a:solidFill>
        <a:ln w="12700" cap="flat" cmpd="sng" algn="ctr">
          <a:solidFill>
            <a:schemeClr val="accent5">
              <a:tint val="40000"/>
              <a:alpha val="90000"/>
              <a:hueOff val="-3369881"/>
              <a:satOff val="-11416"/>
              <a:lumOff val="-1464"/>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Stopping downward spirals</a:t>
          </a:r>
        </a:p>
        <a:p>
          <a:pPr marL="114300" lvl="1" indent="-114300" algn="l" defTabSz="533400">
            <a:lnSpc>
              <a:spcPct val="90000"/>
            </a:lnSpc>
            <a:spcBef>
              <a:spcPct val="0"/>
            </a:spcBef>
            <a:spcAft>
              <a:spcPct val="15000"/>
            </a:spcAft>
            <a:buChar char="•"/>
          </a:pPr>
          <a:r>
            <a:rPr lang="en-US" sz="1200" kern="1200" dirty="0"/>
            <a:t>Starting upward spirals</a:t>
          </a:r>
        </a:p>
      </dsp:txBody>
      <dsp:txXfrm rot="-5400000">
        <a:off x="3785616" y="1960554"/>
        <a:ext cx="6706710" cy="430229"/>
      </dsp:txXfrm>
    </dsp:sp>
    <dsp:sp modelId="{BE93C424-47EE-431F-9F11-D78EA5D08920}">
      <dsp:nvSpPr>
        <dsp:cNvPr id="0" name=""/>
        <dsp:cNvSpPr/>
      </dsp:nvSpPr>
      <dsp:spPr>
        <a:xfrm>
          <a:off x="0" y="1877683"/>
          <a:ext cx="3785616" cy="595971"/>
        </a:xfrm>
        <a:prstGeom prst="roundRec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Education</a:t>
          </a:r>
        </a:p>
      </dsp:txBody>
      <dsp:txXfrm>
        <a:off x="29093" y="1906776"/>
        <a:ext cx="3727430" cy="537785"/>
      </dsp:txXfrm>
    </dsp:sp>
    <dsp:sp modelId="{FE1DED6C-1D78-4D0C-9015-56718EC33E2C}">
      <dsp:nvSpPr>
        <dsp:cNvPr id="0" name=""/>
        <dsp:cNvSpPr/>
      </dsp:nvSpPr>
      <dsp:spPr>
        <a:xfrm rot="5400000">
          <a:off x="6912219" y="-563552"/>
          <a:ext cx="476777" cy="6729984"/>
        </a:xfrm>
        <a:prstGeom prst="round2SameRect">
          <a:avLst/>
        </a:prstGeom>
        <a:solidFill>
          <a:schemeClr val="accent5">
            <a:tint val="40000"/>
            <a:alpha val="90000"/>
            <a:hueOff val="-4493175"/>
            <a:satOff val="-15221"/>
            <a:lumOff val="-1952"/>
            <a:alphaOff val="0"/>
          </a:schemeClr>
        </a:solidFill>
        <a:ln w="12700" cap="flat" cmpd="sng" algn="ctr">
          <a:solidFill>
            <a:schemeClr val="accent5">
              <a:tint val="40000"/>
              <a:alpha val="90000"/>
              <a:hueOff val="-4493175"/>
              <a:satOff val="-15221"/>
              <a:lumOff val="-1952"/>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How the same AYA was able to stop their downward spiral and start an upward spiral</a:t>
          </a:r>
        </a:p>
      </dsp:txBody>
      <dsp:txXfrm rot="-5400000">
        <a:off x="3785616" y="2586325"/>
        <a:ext cx="6706710" cy="430229"/>
      </dsp:txXfrm>
    </dsp:sp>
    <dsp:sp modelId="{D377DF79-CDC0-4998-B9B6-936269382C55}">
      <dsp:nvSpPr>
        <dsp:cNvPr id="0" name=""/>
        <dsp:cNvSpPr/>
      </dsp:nvSpPr>
      <dsp:spPr>
        <a:xfrm>
          <a:off x="0" y="2503453"/>
          <a:ext cx="3785616" cy="595971"/>
        </a:xfrm>
        <a:prstGeom prst="roundRect">
          <a:avLst/>
        </a:prstGeom>
        <a:solidFill>
          <a:schemeClr val="accent5">
            <a:hueOff val="-4505695"/>
            <a:satOff val="-11613"/>
            <a:lumOff val="-784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AYA Story</a:t>
          </a:r>
        </a:p>
      </dsp:txBody>
      <dsp:txXfrm>
        <a:off x="29093" y="2532546"/>
        <a:ext cx="3727430" cy="537785"/>
      </dsp:txXfrm>
    </dsp:sp>
    <dsp:sp modelId="{C46D864B-4BB9-4140-A9DC-E6666ED80EFB}">
      <dsp:nvSpPr>
        <dsp:cNvPr id="0" name=""/>
        <dsp:cNvSpPr/>
      </dsp:nvSpPr>
      <dsp:spPr>
        <a:xfrm rot="5400000">
          <a:off x="6912219" y="62217"/>
          <a:ext cx="476777" cy="6729984"/>
        </a:xfrm>
        <a:prstGeom prst="round2SameRect">
          <a:avLst/>
        </a:prstGeom>
        <a:solidFill>
          <a:schemeClr val="accent5">
            <a:tint val="40000"/>
            <a:alpha val="90000"/>
            <a:hueOff val="-5616468"/>
            <a:satOff val="-19027"/>
            <a:lumOff val="-2440"/>
            <a:alphaOff val="0"/>
          </a:schemeClr>
        </a:solidFill>
        <a:ln w="12700" cap="flat" cmpd="sng" algn="ctr">
          <a:solidFill>
            <a:schemeClr val="accent5">
              <a:tint val="40000"/>
              <a:alpha val="90000"/>
              <a:hueOff val="-5616468"/>
              <a:satOff val="-19027"/>
              <a:lumOff val="-244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Identifying the upward spiral the AYA experienced</a:t>
          </a:r>
        </a:p>
        <a:p>
          <a:pPr marL="114300" lvl="1" indent="-114300" algn="l" defTabSz="533400">
            <a:lnSpc>
              <a:spcPct val="90000"/>
            </a:lnSpc>
            <a:spcBef>
              <a:spcPct val="0"/>
            </a:spcBef>
            <a:spcAft>
              <a:spcPct val="15000"/>
            </a:spcAft>
            <a:buChar char="•"/>
          </a:pPr>
          <a:r>
            <a:rPr lang="en-US" sz="1200" kern="1200"/>
            <a:t>Sharing a time where you experienced an upward spiral</a:t>
          </a:r>
        </a:p>
      </dsp:txBody>
      <dsp:txXfrm rot="-5400000">
        <a:off x="3785616" y="3212094"/>
        <a:ext cx="6706710" cy="430229"/>
      </dsp:txXfrm>
    </dsp:sp>
    <dsp:sp modelId="{40834933-7240-405D-BC12-8C6F826CEF86}">
      <dsp:nvSpPr>
        <dsp:cNvPr id="0" name=""/>
        <dsp:cNvSpPr/>
      </dsp:nvSpPr>
      <dsp:spPr>
        <a:xfrm>
          <a:off x="0" y="3129223"/>
          <a:ext cx="3785616" cy="595971"/>
        </a:xfrm>
        <a:prstGeom prst="roundRect">
          <a:avLst/>
        </a:prstGeom>
        <a:solidFill>
          <a:schemeClr val="accent5">
            <a:hueOff val="-5632119"/>
            <a:satOff val="-14516"/>
            <a:lumOff val="-980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a:t>Activity</a:t>
          </a:r>
          <a:endParaRPr lang="en-US" sz="3000" kern="1200" dirty="0"/>
        </a:p>
      </dsp:txBody>
      <dsp:txXfrm>
        <a:off x="29093" y="3158316"/>
        <a:ext cx="3727430" cy="537785"/>
      </dsp:txXfrm>
    </dsp:sp>
    <dsp:sp modelId="{D4DA00CE-234C-4754-A39C-23B55302F42B}">
      <dsp:nvSpPr>
        <dsp:cNvPr id="0" name=""/>
        <dsp:cNvSpPr/>
      </dsp:nvSpPr>
      <dsp:spPr>
        <a:xfrm rot="5400000">
          <a:off x="6912219" y="687988"/>
          <a:ext cx="476777" cy="6729984"/>
        </a:xfrm>
        <a:prstGeom prst="round2SameRect">
          <a:avLst/>
        </a:prstGeom>
        <a:solidFill>
          <a:schemeClr val="accent5">
            <a:tint val="40000"/>
            <a:alpha val="90000"/>
            <a:hueOff val="-6739762"/>
            <a:satOff val="-22832"/>
            <a:lumOff val="-2928"/>
            <a:alphaOff val="0"/>
          </a:schemeClr>
        </a:solidFill>
        <a:ln w="12700" cap="flat" cmpd="sng" algn="ctr">
          <a:solidFill>
            <a:schemeClr val="accent5">
              <a:tint val="40000"/>
              <a:alpha val="90000"/>
              <a:hueOff val="-6739762"/>
              <a:satOff val="-22832"/>
              <a:lumOff val="-2928"/>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a:t>Tracking how you feel after doing activities</a:t>
          </a:r>
        </a:p>
        <a:p>
          <a:pPr marL="114300" lvl="1" indent="-114300" algn="l" defTabSz="533400">
            <a:lnSpc>
              <a:spcPct val="90000"/>
            </a:lnSpc>
            <a:spcBef>
              <a:spcPct val="0"/>
            </a:spcBef>
            <a:spcAft>
              <a:spcPct val="15000"/>
            </a:spcAft>
            <a:buChar char="•"/>
          </a:pPr>
          <a:r>
            <a:rPr lang="en-US" sz="1200" kern="1200"/>
            <a:t>Added to your check-in</a:t>
          </a:r>
        </a:p>
      </dsp:txBody>
      <dsp:txXfrm rot="-5400000">
        <a:off x="3785616" y="3837865"/>
        <a:ext cx="6706710" cy="430229"/>
      </dsp:txXfrm>
    </dsp:sp>
    <dsp:sp modelId="{2477482A-E0D8-4105-B60F-16A4E647AB90}">
      <dsp:nvSpPr>
        <dsp:cNvPr id="0" name=""/>
        <dsp:cNvSpPr/>
      </dsp:nvSpPr>
      <dsp:spPr>
        <a:xfrm>
          <a:off x="0" y="3754994"/>
          <a:ext cx="3785616" cy="595971"/>
        </a:xfrm>
        <a:prstGeom prst="roundRec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Practice</a:t>
          </a:r>
        </a:p>
      </dsp:txBody>
      <dsp:txXfrm>
        <a:off x="29093" y="3784087"/>
        <a:ext cx="3727430" cy="537785"/>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85C256-AE4C-4F3A-8206-5DDF42BDDDA2}" type="datetimeFigureOut">
              <a:rPr lang="en-US" smtClean="0"/>
              <a:t>5/2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E94229F-CBC9-4256-BB4D-541759E8685A}" type="slidenum">
              <a:rPr lang="en-US" smtClean="0"/>
              <a:t>‹#›</a:t>
            </a:fld>
            <a:endParaRPr lang="en-US"/>
          </a:p>
        </p:txBody>
      </p:sp>
    </p:spTree>
    <p:extLst>
      <p:ext uri="{BB962C8B-B14F-4D97-AF65-F5344CB8AC3E}">
        <p14:creationId xmlns:p14="http://schemas.microsoft.com/office/powerpoint/2010/main" val="13624508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Arial" panose="020B0604020202020204" pitchFamily="34" charset="0"/>
                <a:ea typeface="Calibri" panose="020F0502020204030204" pitchFamily="34" charset="0"/>
              </a:rPr>
              <a:t>Reminder about record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Arial" panose="020B0604020202020204" pitchFamily="34" charset="0"/>
                <a:ea typeface="Calibri" panose="020F0502020204030204" pitchFamily="34" charset="0"/>
              </a:rPr>
              <a:t>We are trying to design a web-based tool that can help AYA cancer survivors like you improve their well-being, especially if they are feeling down or depressed. So far, we have talked to some adolescent and young adult (AYA, aged 15-39) cancer survivors and providers. Based on their feedback, we have designed some options for the tool we are planning to build. Even though you could use any device that connects to the internet to access it, we expect that most people will use their phone to do so, so we have designed the app to look best on a phone. I’d like you to look at these options and give me your honest feedback about them. </a:t>
            </a: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a:t>
            </a:fld>
            <a:endParaRPr lang="en-US"/>
          </a:p>
        </p:txBody>
      </p:sp>
    </p:spTree>
    <p:extLst>
      <p:ext uri="{BB962C8B-B14F-4D97-AF65-F5344CB8AC3E}">
        <p14:creationId xmlns:p14="http://schemas.microsoft.com/office/powerpoint/2010/main" val="232687569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1" indent="0">
              <a:spcBef>
                <a:spcPts val="0"/>
              </a:spcBef>
              <a:spcAft>
                <a:spcPts val="0"/>
              </a:spcAft>
              <a:buFont typeface="+mj-lt"/>
              <a:buNone/>
            </a:pPr>
            <a:endParaRPr lang="en-US" sz="18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endParaRPr lang="en-US" sz="18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0</a:t>
            </a:fld>
            <a:endParaRPr lang="en-US"/>
          </a:p>
        </p:txBody>
      </p:sp>
    </p:spTree>
    <p:extLst>
      <p:ext uri="{BB962C8B-B14F-4D97-AF65-F5344CB8AC3E}">
        <p14:creationId xmlns:p14="http://schemas.microsoft.com/office/powerpoint/2010/main" val="14043719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742950" marR="0" lvl="1" indent="-28575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For the activities during the session where you are thinking about the AYA story, how would you like to input your responses (e.g., multiple choice, free text)? It could be one of these options or something completely different.</a:t>
            </a:r>
          </a:p>
        </p:txBody>
      </p:sp>
      <p:sp>
        <p:nvSpPr>
          <p:cNvPr id="4" name="Slide Number Placeholder 3"/>
          <p:cNvSpPr>
            <a:spLocks noGrp="1"/>
          </p:cNvSpPr>
          <p:nvPr>
            <p:ph type="sldNum" sz="quarter" idx="5"/>
          </p:nvPr>
        </p:nvSpPr>
        <p:spPr/>
        <p:txBody>
          <a:bodyPr/>
          <a:lstStyle/>
          <a:p>
            <a:fld id="{AE94229F-CBC9-4256-BB4D-541759E8685A}" type="slidenum">
              <a:rPr lang="en-US" smtClean="0"/>
              <a:t>11</a:t>
            </a:fld>
            <a:endParaRPr lang="en-US"/>
          </a:p>
        </p:txBody>
      </p:sp>
    </p:spTree>
    <p:extLst>
      <p:ext uri="{BB962C8B-B14F-4D97-AF65-F5344CB8AC3E}">
        <p14:creationId xmlns:p14="http://schemas.microsoft.com/office/powerpoint/2010/main" val="15975962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742950" marR="0" lvl="1" indent="-28575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What are your thoughts on reflecting on stressful situations using a tool like this?</a:t>
            </a:r>
          </a:p>
          <a:p>
            <a:pPr marL="742950" marR="0" lvl="1" indent="-28575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For the activities during the session where you are thinking about your own experience, how would you like to input your responses (e.g., multiple choice, free text)? It could be one of these options or something completely different.</a:t>
            </a:r>
            <a:endParaRPr lang="en-US" sz="12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2</a:t>
            </a:fld>
            <a:endParaRPr lang="en-US"/>
          </a:p>
        </p:txBody>
      </p:sp>
    </p:spTree>
    <p:extLst>
      <p:ext uri="{BB962C8B-B14F-4D97-AF65-F5344CB8AC3E}">
        <p14:creationId xmlns:p14="http://schemas.microsoft.com/office/powerpoint/2010/main" val="418277451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sz="1200" dirty="0">
                <a:solidFill>
                  <a:srgbClr val="000000"/>
                </a:solidFill>
                <a:effectLst/>
                <a:latin typeface="Arial" panose="020B0604020202020204" pitchFamily="34" charset="0"/>
                <a:ea typeface="Calibri" panose="020F0502020204030204" pitchFamily="34" charset="0"/>
              </a:rPr>
              <a:t>Now that you have seen some examples of what a session might look like, I have a few questions for you.</a:t>
            </a:r>
          </a:p>
          <a:p>
            <a:pPr marL="742950" marR="0" lvl="1" indent="-285750">
              <a:spcBef>
                <a:spcPts val="0"/>
              </a:spcBef>
              <a:spcAft>
                <a:spcPts val="0"/>
              </a:spcAft>
              <a:buFont typeface="+mj-lt"/>
              <a:buAutoNum type="alphaLcPeriod"/>
            </a:pPr>
            <a:r>
              <a:rPr lang="en-US" sz="1200" dirty="0">
                <a:solidFill>
                  <a:srgbClr val="000000"/>
                </a:solidFill>
                <a:effectLst/>
                <a:latin typeface="Arial" panose="020B0604020202020204" pitchFamily="34" charset="0"/>
                <a:ea typeface="Calibri" panose="020F0502020204030204" pitchFamily="34" charset="0"/>
              </a:rPr>
              <a:t>About how long would you like to spend on a session like this?</a:t>
            </a:r>
          </a:p>
          <a:p>
            <a:pPr marL="742950" marR="0" lvl="1" indent="-285750">
              <a:spcBef>
                <a:spcPts val="0"/>
              </a:spcBef>
              <a:spcAft>
                <a:spcPts val="0"/>
              </a:spcAft>
              <a:buFont typeface="+mj-lt"/>
              <a:buAutoNum type="alphaLcPeriod"/>
            </a:pPr>
            <a:r>
              <a:rPr lang="en-US" sz="1200" dirty="0">
                <a:solidFill>
                  <a:srgbClr val="000000"/>
                </a:solidFill>
                <a:effectLst/>
                <a:latin typeface="Arial" panose="020B0604020202020204" pitchFamily="34" charset="0"/>
                <a:ea typeface="Calibri" panose="020F0502020204030204" pitchFamily="34" charset="0"/>
              </a:rPr>
              <a:t>What would make it more likely that you would complete a session like this?</a:t>
            </a:r>
          </a:p>
          <a:p>
            <a:pPr marL="742950" marR="0" lvl="1" indent="-285750">
              <a:spcBef>
                <a:spcPts val="0"/>
              </a:spcBef>
              <a:spcAft>
                <a:spcPts val="0"/>
              </a:spcAft>
              <a:buFont typeface="+mj-lt"/>
              <a:buAutoNum type="alphaLcPeriod"/>
            </a:pPr>
            <a:endParaRPr lang="en-US" sz="1200" dirty="0">
              <a:solidFill>
                <a:srgbClr val="000000"/>
              </a:solidFill>
              <a:effectLst/>
              <a:latin typeface="Arial" panose="020B0604020202020204" pitchFamily="34" charset="0"/>
              <a:ea typeface="Calibri" panose="020F0502020204030204" pitchFamily="34" charset="0"/>
            </a:endParaRPr>
          </a:p>
          <a:p>
            <a:pPr marL="0" marR="0" lvl="0" indent="0">
              <a:spcBef>
                <a:spcPts val="0"/>
              </a:spcBef>
              <a:spcAft>
                <a:spcPts val="0"/>
              </a:spcAft>
              <a:buFont typeface="+mj-lt"/>
              <a:buNone/>
            </a:pPr>
            <a:r>
              <a:rPr lang="en-US" sz="1100" dirty="0">
                <a:solidFill>
                  <a:srgbClr val="000000"/>
                </a:solidFill>
                <a:effectLst/>
                <a:latin typeface="Arial" panose="020B0604020202020204" pitchFamily="34" charset="0"/>
                <a:ea typeface="Calibri" panose="020F0502020204030204" pitchFamily="34" charset="0"/>
              </a:rPr>
              <a:t>After you complete the session, you will be asked to do an activity that helps you practice what you have learned. For this session, we would ask you to keep track of your activities and how you felt before and after doing them.</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Each time you track your activities and mood it would only take a couple of minutes. How many times per day would you be willing to track your activities and mood?</a:t>
            </a:r>
            <a:endParaRPr lang="en-US" sz="1200" dirty="0">
              <a:solidFill>
                <a:srgbClr val="000000"/>
              </a:solidFill>
              <a:effectLst/>
              <a:latin typeface="Arial" panose="020B0604020202020204" pitchFamily="34" charset="0"/>
              <a:ea typeface="Calibri" panose="020F0502020204030204" pitchFamily="34" charset="0"/>
              <a:cs typeface="+mn-cs"/>
            </a:endParaRPr>
          </a:p>
          <a:p>
            <a:pPr marL="742950" marR="0" lvl="1" indent="-285750">
              <a:spcBef>
                <a:spcPts val="0"/>
              </a:spcBef>
              <a:spcAft>
                <a:spcPts val="0"/>
              </a:spcAft>
              <a:buFont typeface="+mj-lt"/>
              <a:buAutoNum type="alphaLcPeriod"/>
            </a:pPr>
            <a:r>
              <a:rPr lang="en-US" sz="1100" dirty="0">
                <a:effectLst/>
                <a:latin typeface="Calibri" panose="020F0502020204030204" pitchFamily="34" charset="0"/>
                <a:ea typeface="Calibri" panose="020F0502020204030204" pitchFamily="34" charset="0"/>
                <a:cs typeface="Times New Roman" panose="02020603050405020304" pitchFamily="18" charset="0"/>
              </a:rPr>
              <a:t>What type of interface would you want to use to track this information (e.g. multiple choice, free text, messaging with a chat bot, rating scale)?</a:t>
            </a:r>
          </a:p>
          <a:p>
            <a:pPr marL="742950" marR="0" lvl="1" indent="-285750" algn="l" defTabSz="914400" rtl="0" eaLnBrk="1" fontAlgn="auto" latinLnBrk="0" hangingPunct="1">
              <a:lnSpc>
                <a:spcPct val="100000"/>
              </a:lnSpc>
              <a:spcBef>
                <a:spcPts val="0"/>
              </a:spcBef>
              <a:spcAft>
                <a:spcPts val="0"/>
              </a:spcAft>
              <a:buClrTx/>
              <a:buSzTx/>
              <a:buFont typeface="+mj-lt"/>
              <a:buAutoNum type="alphaLcPeriod"/>
              <a:tabLst/>
              <a:defRPr/>
            </a:pPr>
            <a:r>
              <a:rPr lang="en-US" sz="1800" dirty="0">
                <a:solidFill>
                  <a:srgbClr val="000000"/>
                </a:solidFill>
                <a:effectLst/>
                <a:latin typeface="Arial" panose="020B0604020202020204" pitchFamily="34" charset="0"/>
                <a:ea typeface="Calibri" panose="020F0502020204030204" pitchFamily="34" charset="0"/>
              </a:rPr>
              <a:t>After you complete a session, an item will be added to your daily check-in that helps you practice what you have learned. How many days do you want to practice something new before starting a new session?</a:t>
            </a:r>
            <a:endParaRPr lang="en-US" sz="20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endParaRPr lang="en-US" sz="1800" dirty="0">
              <a:solidFill>
                <a:srgbClr val="000000"/>
              </a:solidFill>
              <a:effectLst/>
              <a:latin typeface="Arial" panose="020B0604020202020204" pitchFamily="34" charset="0"/>
              <a:ea typeface="Calibri" panose="020F0502020204030204" pitchFamily="34" charset="0"/>
            </a:endParaRPr>
          </a:p>
          <a:p>
            <a:pPr marL="457200" marR="0" lvl="1" indent="0">
              <a:spcBef>
                <a:spcPts val="0"/>
              </a:spcBef>
              <a:spcAft>
                <a:spcPts val="0"/>
              </a:spcAft>
              <a:buFont typeface="+mj-lt"/>
              <a:buNone/>
            </a:pPr>
            <a:endParaRPr lang="en-US" sz="12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3</a:t>
            </a:fld>
            <a:endParaRPr lang="en-US"/>
          </a:p>
        </p:txBody>
      </p:sp>
    </p:spTree>
    <p:extLst>
      <p:ext uri="{BB962C8B-B14F-4D97-AF65-F5344CB8AC3E}">
        <p14:creationId xmlns:p14="http://schemas.microsoft.com/office/powerpoint/2010/main" val="93170933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solidFill>
                  <a:srgbClr val="000000"/>
                </a:solidFill>
                <a:effectLst/>
                <a:latin typeface="Arial" panose="020B0604020202020204" pitchFamily="34" charset="0"/>
                <a:ea typeface="Calibri" panose="020F0502020204030204" pitchFamily="34" charset="0"/>
              </a:rPr>
              <a:t>We are planning to use some of the content from Wakeful, an existing meditation course, in this tool.</a:t>
            </a:r>
          </a:p>
          <a:p>
            <a:pPr marL="342900" marR="0" lvl="0" indent="-342900">
              <a:spcBef>
                <a:spcPts val="0"/>
              </a:spcBef>
              <a:spcAft>
                <a:spcPts val="0"/>
              </a:spcAft>
              <a:buFont typeface="+mj-lt"/>
              <a:buAutoNum type="arabicPeriod"/>
            </a:pPr>
            <a:r>
              <a:rPr lang="en-US" sz="1800" dirty="0">
                <a:solidFill>
                  <a:srgbClr val="000000"/>
                </a:solidFill>
                <a:effectLst/>
                <a:latin typeface="Arial" panose="020B0604020202020204" pitchFamily="34" charset="0"/>
                <a:ea typeface="Calibri" panose="020F0502020204030204" pitchFamily="34" charset="0"/>
              </a:rPr>
              <a:t>Taking a brief look at the different meditations here, are there any you think we should be sure to include? Alternatively, are there any we should avoid including?</a:t>
            </a:r>
          </a:p>
          <a:p>
            <a:pPr marL="342900" marR="0" lvl="0" indent="-342900">
              <a:spcBef>
                <a:spcPts val="0"/>
              </a:spcBef>
              <a:spcAft>
                <a:spcPts val="0"/>
              </a:spcAft>
              <a:buFont typeface="+mj-lt"/>
              <a:buAutoNum type="arabicPeriod"/>
            </a:pPr>
            <a:r>
              <a:rPr lang="en-US" sz="1800" dirty="0">
                <a:solidFill>
                  <a:srgbClr val="000000"/>
                </a:solidFill>
                <a:effectLst/>
                <a:latin typeface="Arial" panose="020B0604020202020204" pitchFamily="34" charset="0"/>
                <a:ea typeface="Calibri" panose="020F0502020204030204" pitchFamily="34" charset="0"/>
              </a:rPr>
              <a:t>How often do you think it is reasonable to ask an AYA cancer survivor like yourself to meditate? </a:t>
            </a: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4</a:t>
            </a:fld>
            <a:endParaRPr lang="en-US"/>
          </a:p>
        </p:txBody>
      </p:sp>
    </p:spTree>
    <p:extLst>
      <p:ext uri="{BB962C8B-B14F-4D97-AF65-F5344CB8AC3E}">
        <p14:creationId xmlns:p14="http://schemas.microsoft.com/office/powerpoint/2010/main" val="32931871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planning to provide opportunities for participants to connect with each other via discussion boards.</a:t>
            </a:r>
          </a:p>
          <a:p>
            <a:pPr marL="171450" indent="-171450">
              <a:buFont typeface="Arial" panose="020B0604020202020204" pitchFamily="34" charset="0"/>
              <a:buChar char="•"/>
            </a:pPr>
            <a:r>
              <a:rPr lang="en-US" dirty="0"/>
              <a:t>We will have sections where participants can discuss what they are learning through the program – the way we have it right now is that you can share your responses to the questions asked during activities and when using tools, you can choose whether to share it to the relevant board. Do you think this is a feature you would use? You can also start a discussion that is not related to a question.</a:t>
            </a:r>
          </a:p>
          <a:p>
            <a:pPr marL="171450" indent="-171450">
              <a:buFont typeface="Arial" panose="020B0604020202020204" pitchFamily="34" charset="0"/>
              <a:buChar char="•"/>
            </a:pPr>
            <a:r>
              <a:rPr lang="en-US" dirty="0"/>
              <a:t>Are there other topics you think will be important to provide AYAs with an area to discuss?</a:t>
            </a:r>
          </a:p>
          <a:p>
            <a:pPr marL="171450" indent="-171450">
              <a:buFont typeface="Arial" panose="020B0604020202020204" pitchFamily="34" charset="0"/>
              <a:buChar char="•"/>
            </a:pPr>
            <a:r>
              <a:rPr lang="en-US" dirty="0"/>
              <a:t>In addition to responding to other people’s posts by writing back to them, we’ll also have ways you can react to their posts. What are some reactions you would like to be able to give?</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5</a:t>
            </a:fld>
            <a:endParaRPr lang="en-US"/>
          </a:p>
        </p:txBody>
      </p:sp>
    </p:spTree>
    <p:extLst>
      <p:ext uri="{BB962C8B-B14F-4D97-AF65-F5344CB8AC3E}">
        <p14:creationId xmlns:p14="http://schemas.microsoft.com/office/powerpoint/2010/main" val="159255121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100" dirty="0">
                <a:solidFill>
                  <a:srgbClr val="000000"/>
                </a:solidFill>
                <a:effectLst/>
                <a:latin typeface="Arial" panose="020B0604020202020204" pitchFamily="34" charset="0"/>
                <a:ea typeface="Calibri" panose="020F0502020204030204" pitchFamily="34" charset="0"/>
              </a:rPr>
              <a:t>Now that you have seen what we have come up with so far, I want to ask you a few more questions about your overall thoughts about the tool we are designing.</a:t>
            </a:r>
            <a:endParaRPr lang="en-US" sz="1200" dirty="0">
              <a:solidFill>
                <a:srgbClr val="000000"/>
              </a:solidFill>
              <a:effectLst/>
              <a:latin typeface="Arial" panose="020B060402020202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100" dirty="0">
                <a:solidFill>
                  <a:srgbClr val="000000"/>
                </a:solidFill>
                <a:effectLst/>
                <a:latin typeface="Arial" panose="020B0604020202020204" pitchFamily="34" charset="0"/>
                <a:ea typeface="Calibri" panose="020F0502020204030204" pitchFamily="34" charset="0"/>
              </a:rPr>
              <a:t>What about </a:t>
            </a:r>
            <a:r>
              <a:rPr lang="en-US" sz="1100" dirty="0" err="1">
                <a:solidFill>
                  <a:srgbClr val="000000"/>
                </a:solidFill>
                <a:effectLst/>
                <a:latin typeface="Arial" panose="020B0604020202020204" pitchFamily="34" charset="0"/>
                <a:ea typeface="Calibri" panose="020F0502020204030204" pitchFamily="34" charset="0"/>
              </a:rPr>
              <a:t>iManageAYA</a:t>
            </a:r>
            <a:r>
              <a:rPr lang="en-US" sz="1100" dirty="0">
                <a:solidFill>
                  <a:srgbClr val="000000"/>
                </a:solidFill>
                <a:effectLst/>
                <a:latin typeface="Arial" panose="020B0604020202020204" pitchFamily="34" charset="0"/>
                <a:ea typeface="Calibri" panose="020F0502020204030204" pitchFamily="34" charset="0"/>
              </a:rPr>
              <a:t> do you think would be helpful? What would NOT be helpful? </a:t>
            </a:r>
            <a:endParaRPr lang="en-US" sz="1200" dirty="0">
              <a:solidFill>
                <a:srgbClr val="000000"/>
              </a:solidFill>
              <a:effectLst/>
              <a:latin typeface="Arial" panose="020B060402020202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100" dirty="0">
                <a:solidFill>
                  <a:srgbClr val="000000"/>
                </a:solidFill>
                <a:effectLst/>
                <a:latin typeface="Arial" panose="020B0604020202020204" pitchFamily="34" charset="0"/>
                <a:ea typeface="Calibri" panose="020F0502020204030204" pitchFamily="34" charset="0"/>
              </a:rPr>
              <a:t>What would you want to see be different about </a:t>
            </a:r>
            <a:r>
              <a:rPr lang="en-US" sz="1100" dirty="0" err="1">
                <a:solidFill>
                  <a:srgbClr val="000000"/>
                </a:solidFill>
                <a:effectLst/>
                <a:latin typeface="Arial" panose="020B0604020202020204" pitchFamily="34" charset="0"/>
                <a:ea typeface="Calibri" panose="020F0502020204030204" pitchFamily="34" charset="0"/>
              </a:rPr>
              <a:t>iManageAYA</a:t>
            </a:r>
            <a:r>
              <a:rPr lang="en-US" sz="1100" dirty="0">
                <a:solidFill>
                  <a:srgbClr val="000000"/>
                </a:solidFill>
                <a:effectLst/>
                <a:latin typeface="Arial" panose="020B0604020202020204" pitchFamily="34" charset="0"/>
                <a:ea typeface="Calibri" panose="020F0502020204030204" pitchFamily="34" charset="0"/>
              </a:rPr>
              <a:t> from what you have seen today? </a:t>
            </a:r>
            <a:endParaRPr lang="en-US" sz="1200" dirty="0">
              <a:solidFill>
                <a:srgbClr val="000000"/>
              </a:solidFill>
              <a:effectLst/>
              <a:latin typeface="Arial" panose="020B060402020202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100" dirty="0">
                <a:solidFill>
                  <a:srgbClr val="000000"/>
                </a:solidFill>
                <a:effectLst/>
                <a:latin typeface="Arial" panose="020B0604020202020204" pitchFamily="34" charset="0"/>
                <a:ea typeface="Calibri" panose="020F0502020204030204" pitchFamily="34" charset="0"/>
              </a:rPr>
              <a:t>How often can you see yourself using an app like this? For how long (both per use and over time)? In what situations?</a:t>
            </a:r>
            <a:endParaRPr lang="en-US" sz="1200" dirty="0">
              <a:solidFill>
                <a:srgbClr val="000000"/>
              </a:solidFill>
              <a:effectLst/>
              <a:latin typeface="Arial" panose="020B060402020202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100" dirty="0">
                <a:solidFill>
                  <a:srgbClr val="000000"/>
                </a:solidFill>
                <a:effectLst/>
                <a:latin typeface="Arial" panose="020B0604020202020204" pitchFamily="34" charset="0"/>
                <a:ea typeface="Calibri" panose="020F0502020204030204" pitchFamily="34" charset="0"/>
              </a:rPr>
              <a:t>What would make cancer survivors your age want to use </a:t>
            </a:r>
            <a:r>
              <a:rPr lang="en-US" sz="1100" dirty="0" err="1">
                <a:solidFill>
                  <a:srgbClr val="000000"/>
                </a:solidFill>
                <a:effectLst/>
                <a:latin typeface="Arial" panose="020B0604020202020204" pitchFamily="34" charset="0"/>
                <a:ea typeface="Calibri" panose="020F0502020204030204" pitchFamily="34" charset="0"/>
              </a:rPr>
              <a:t>iManageAYA</a:t>
            </a:r>
            <a:r>
              <a:rPr lang="en-US" sz="1100" dirty="0">
                <a:solidFill>
                  <a:srgbClr val="000000"/>
                </a:solidFill>
                <a:effectLst/>
                <a:latin typeface="Arial" panose="020B0604020202020204" pitchFamily="34" charset="0"/>
                <a:ea typeface="Calibri" panose="020F0502020204030204" pitchFamily="34" charset="0"/>
              </a:rPr>
              <a:t>?</a:t>
            </a:r>
            <a:endParaRPr lang="en-US" sz="1200" dirty="0">
              <a:solidFill>
                <a:srgbClr val="000000"/>
              </a:solidFill>
              <a:effectLst/>
              <a:latin typeface="Arial" panose="020B060402020202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100" dirty="0">
                <a:solidFill>
                  <a:srgbClr val="000000"/>
                </a:solidFill>
                <a:effectLst/>
                <a:latin typeface="Arial" panose="020B0604020202020204" pitchFamily="34" charset="0"/>
                <a:ea typeface="Calibri" panose="020F0502020204030204" pitchFamily="34" charset="0"/>
              </a:rPr>
              <a:t>What do you think about how </a:t>
            </a:r>
            <a:r>
              <a:rPr lang="en-US" sz="1100" dirty="0" err="1">
                <a:solidFill>
                  <a:srgbClr val="000000"/>
                </a:solidFill>
                <a:effectLst/>
                <a:latin typeface="Arial" panose="020B0604020202020204" pitchFamily="34" charset="0"/>
                <a:ea typeface="Calibri" panose="020F0502020204030204" pitchFamily="34" charset="0"/>
              </a:rPr>
              <a:t>iManageAYA</a:t>
            </a:r>
            <a:r>
              <a:rPr lang="en-US" sz="1100" dirty="0">
                <a:solidFill>
                  <a:srgbClr val="000000"/>
                </a:solidFill>
                <a:effectLst/>
                <a:latin typeface="Arial" panose="020B0604020202020204" pitchFamily="34" charset="0"/>
                <a:ea typeface="Calibri" panose="020F0502020204030204" pitchFamily="34" charset="0"/>
              </a:rPr>
              <a:t> looks?</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Color scheme</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Graphics (e.g. photos v. icons)</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Text (size, color, font, amount on each page)</a:t>
            </a:r>
          </a:p>
          <a:p>
            <a:pPr marL="285750" marR="0" lvl="0" indent="-285750">
              <a:spcBef>
                <a:spcPts val="0"/>
              </a:spcBef>
              <a:spcAft>
                <a:spcPts val="0"/>
              </a:spcAft>
              <a:buFont typeface="+mj-lt"/>
              <a:buAutoNum type="arabicPeriod"/>
            </a:pPr>
            <a:r>
              <a:rPr lang="en-US" sz="1200" dirty="0">
                <a:solidFill>
                  <a:srgbClr val="000000"/>
                </a:solidFill>
                <a:effectLst/>
                <a:latin typeface="Arial" panose="020B0604020202020204" pitchFamily="34" charset="0"/>
                <a:ea typeface="Calibri" panose="020F0502020204030204" pitchFamily="34" charset="0"/>
              </a:rPr>
              <a:t>What do you think about the name </a:t>
            </a:r>
            <a:r>
              <a:rPr lang="en-US" sz="1200" dirty="0" err="1">
                <a:solidFill>
                  <a:srgbClr val="000000"/>
                </a:solidFill>
                <a:effectLst/>
                <a:latin typeface="Arial" panose="020B0604020202020204" pitchFamily="34" charset="0"/>
                <a:ea typeface="Calibri" panose="020F0502020204030204" pitchFamily="34" charset="0"/>
              </a:rPr>
              <a:t>iManageAYA</a:t>
            </a:r>
            <a:r>
              <a:rPr lang="en-US" sz="1200" dirty="0">
                <a:solidFill>
                  <a:srgbClr val="000000"/>
                </a:solidFill>
                <a:effectLst/>
                <a:latin typeface="Arial" panose="020B0604020202020204" pitchFamily="34" charset="0"/>
                <a:ea typeface="Calibri" panose="020F0502020204030204" pitchFamily="34" charset="0"/>
              </a:rPr>
              <a:t>? Is there something else we should call this tool?</a:t>
            </a:r>
          </a:p>
          <a:p>
            <a:pPr marL="285750" marR="0" lvl="0" indent="-285750">
              <a:spcBef>
                <a:spcPts val="0"/>
              </a:spcBef>
              <a:spcAft>
                <a:spcPts val="0"/>
              </a:spcAft>
              <a:buFont typeface="+mj-lt"/>
              <a:buAutoNum type="arabicPeriod"/>
            </a:pPr>
            <a:r>
              <a:rPr lang="en-US" sz="1200" dirty="0">
                <a:solidFill>
                  <a:srgbClr val="000000"/>
                </a:solidFill>
                <a:effectLst/>
                <a:latin typeface="Arial" panose="020B0604020202020204" pitchFamily="34" charset="0"/>
                <a:ea typeface="Calibri" panose="020F0502020204030204" pitchFamily="34" charset="0"/>
              </a:rPr>
              <a:t>How would you want to find out about this app?</a:t>
            </a: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16</a:t>
            </a:fld>
            <a:endParaRPr lang="en-US"/>
          </a:p>
        </p:txBody>
      </p:sp>
    </p:spTree>
    <p:extLst>
      <p:ext uri="{BB962C8B-B14F-4D97-AF65-F5344CB8AC3E}">
        <p14:creationId xmlns:p14="http://schemas.microsoft.com/office/powerpoint/2010/main" val="11664816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sz="1100" dirty="0">
                <a:solidFill>
                  <a:srgbClr val="000000"/>
                </a:solidFill>
                <a:effectLst/>
                <a:latin typeface="Arial" panose="020B0604020202020204" pitchFamily="34" charset="0"/>
                <a:ea typeface="Calibri" panose="020F0502020204030204" pitchFamily="34" charset="0"/>
              </a:rPr>
              <a:t>After you sign up for the tool, each time you open it the first screen you will see is the dashboard. You can also come back here any time by clicking the “home” icon down at the bottom here.</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What do you like about it?</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What do you dislike about it?</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Is there anything you wish were different about it?</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What do you think would be most important to change?</a:t>
            </a:r>
            <a:endParaRPr lang="en-US" sz="12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2</a:t>
            </a:fld>
            <a:endParaRPr lang="en-US"/>
          </a:p>
        </p:txBody>
      </p:sp>
    </p:spTree>
    <p:extLst>
      <p:ext uri="{BB962C8B-B14F-4D97-AF65-F5344CB8AC3E}">
        <p14:creationId xmlns:p14="http://schemas.microsoft.com/office/powerpoint/2010/main" val="23094034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sz="1100" dirty="0">
                <a:solidFill>
                  <a:srgbClr val="000000"/>
                </a:solidFill>
                <a:effectLst/>
                <a:latin typeface="Arial" panose="020B0604020202020204" pitchFamily="34" charset="0"/>
                <a:ea typeface="Calibri" panose="020F0502020204030204" pitchFamily="34" charset="0"/>
              </a:rPr>
              <a:t>As you might have noticed, the top item on the dashboard is a question about how you are feeling. We have some options for ways you could respond to this question. </a:t>
            </a:r>
            <a:endParaRPr lang="en-US" sz="1200" dirty="0">
              <a:solidFill>
                <a:srgbClr val="000000"/>
              </a:solidFill>
              <a:effectLst/>
              <a:latin typeface="Arial" panose="020B0604020202020204" pitchFamily="34" charset="0"/>
              <a:ea typeface="Calibri" panose="020F0502020204030204" pitchFamily="34" charset="0"/>
            </a:endParaRPr>
          </a:p>
          <a:p>
            <a:pPr marL="685800" marR="0" lvl="1" indent="-22860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Looking at these options, how would you prefer to respond to this question? It could be one of these options, a combination of them, or something completely different.</a:t>
            </a:r>
            <a:endParaRPr lang="en-US" sz="1200" dirty="0">
              <a:solidFill>
                <a:srgbClr val="000000"/>
              </a:solidFill>
              <a:effectLst/>
              <a:latin typeface="Arial" panose="020B0604020202020204" pitchFamily="34" charset="0"/>
              <a:ea typeface="Calibri" panose="020F0502020204030204" pitchFamily="34" charset="0"/>
            </a:endParaRPr>
          </a:p>
          <a:p>
            <a:pPr marL="685800" marR="0" lvl="1" indent="-22860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How often would you want to respond to this question? (Multiple times per day? Daily? Every other day? Weekly?)</a:t>
            </a:r>
            <a:endParaRPr lang="en-US" sz="12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3</a:t>
            </a:fld>
            <a:endParaRPr lang="en-US"/>
          </a:p>
        </p:txBody>
      </p:sp>
    </p:spTree>
    <p:extLst>
      <p:ext uri="{BB962C8B-B14F-4D97-AF65-F5344CB8AC3E}">
        <p14:creationId xmlns:p14="http://schemas.microsoft.com/office/powerpoint/2010/main" val="33010882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sz="1100" dirty="0">
                <a:solidFill>
                  <a:srgbClr val="000000"/>
                </a:solidFill>
                <a:effectLst/>
                <a:latin typeface="Arial" panose="020B0604020202020204" pitchFamily="34" charset="0"/>
                <a:ea typeface="Calibri" panose="020F0502020204030204" pitchFamily="34" charset="0"/>
              </a:rPr>
              <a:t>Once you respond to the question, this spot on the dashboard will show your mood over time until it’s time to answer again. How do you think we should show this?</a:t>
            </a:r>
            <a:r>
              <a:rPr lang="en-US" sz="1100" i="1" u="sng" dirty="0">
                <a:solidFill>
                  <a:srgbClr val="000000"/>
                </a:solidFill>
                <a:effectLst/>
                <a:latin typeface="Arial" panose="020B0604020202020204" pitchFamily="34" charset="0"/>
                <a:ea typeface="Calibri" panose="020F0502020204030204" pitchFamily="34" charset="0"/>
              </a:rPr>
              <a:t> </a:t>
            </a:r>
            <a:r>
              <a:rPr lang="en-US" sz="1100" dirty="0">
                <a:solidFill>
                  <a:srgbClr val="000000"/>
                </a:solidFill>
                <a:effectLst/>
                <a:latin typeface="Arial" panose="020B0604020202020204" pitchFamily="34" charset="0"/>
                <a:ea typeface="Calibri" panose="020F0502020204030204" pitchFamily="34" charset="0"/>
              </a:rPr>
              <a:t>It could be one of these options, or something completely different.</a:t>
            </a:r>
            <a:endParaRPr lang="en-US" sz="1200" dirty="0">
              <a:solidFill>
                <a:srgbClr val="000000"/>
              </a:solidFill>
              <a:effectLst/>
              <a:latin typeface="Arial" panose="020B0604020202020204" pitchFamily="34" charset="0"/>
              <a:ea typeface="Calibri" panose="020F0502020204030204" pitchFamily="34" charset="0"/>
            </a:endParaRPr>
          </a:p>
          <a:p>
            <a:pPr marL="685800" marR="0" lvl="1" indent="-22860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How far back would you want this information to go?</a:t>
            </a:r>
            <a:endParaRPr lang="en-US" sz="1200" dirty="0">
              <a:solidFill>
                <a:srgbClr val="000000"/>
              </a:solidFill>
              <a:effectLst/>
              <a:latin typeface="Arial" panose="020B060402020202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4</a:t>
            </a:fld>
            <a:endParaRPr lang="en-US"/>
          </a:p>
        </p:txBody>
      </p:sp>
    </p:spTree>
    <p:extLst>
      <p:ext uri="{BB962C8B-B14F-4D97-AF65-F5344CB8AC3E}">
        <p14:creationId xmlns:p14="http://schemas.microsoft.com/office/powerpoint/2010/main" val="19765659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solidFill>
                  <a:srgbClr val="000000"/>
                </a:solidFill>
                <a:effectLst/>
                <a:latin typeface="Arial" panose="020B0604020202020204" pitchFamily="34" charset="0"/>
                <a:ea typeface="Calibri" panose="020F0502020204030204" pitchFamily="34" charset="0"/>
              </a:rPr>
              <a:t>If we click on the “Learn” icon down at the bottom here, there will be several learning modules to choose from.</a:t>
            </a:r>
          </a:p>
          <a:p>
            <a:pPr marL="800100" marR="0" lvl="1" indent="-34290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What are your thoughts on the names for each of these modules? The designs of the icons?</a:t>
            </a:r>
          </a:p>
          <a:p>
            <a:pPr marL="800100" marR="0" lvl="1" indent="-34290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Would you want to be assigned a module to start with or be able to choose where you begin?</a:t>
            </a:r>
          </a:p>
          <a:p>
            <a:pPr marL="800100" marR="0" lvl="1" indent="-342900">
              <a:spcBef>
                <a:spcPts val="0"/>
              </a:spcBef>
              <a:spcAft>
                <a:spcPts val="0"/>
              </a:spcAft>
              <a:buFont typeface="+mj-lt"/>
              <a:buAutoNum type="alphaLcPeriod"/>
            </a:pPr>
            <a:r>
              <a:rPr lang="en-US" sz="1800" dirty="0">
                <a:solidFill>
                  <a:srgbClr val="000000"/>
                </a:solidFill>
                <a:effectLst/>
                <a:latin typeface="Arial" panose="020B0604020202020204" pitchFamily="34" charset="0"/>
                <a:ea typeface="Calibri" panose="020F0502020204030204" pitchFamily="34" charset="0"/>
              </a:rPr>
              <a:t>Would you want to be able to do only one new module at a time, or be able to work on multiple modules simultaneously?</a:t>
            </a:r>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5</a:t>
            </a:fld>
            <a:endParaRPr lang="en-US"/>
          </a:p>
        </p:txBody>
      </p:sp>
    </p:spTree>
    <p:extLst>
      <p:ext uri="{BB962C8B-B14F-4D97-AF65-F5344CB8AC3E}">
        <p14:creationId xmlns:p14="http://schemas.microsoft.com/office/powerpoint/2010/main" val="20974028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100" dirty="0">
                <a:solidFill>
                  <a:srgbClr val="000000"/>
                </a:solidFill>
                <a:effectLst/>
                <a:latin typeface="Arial" panose="020B0604020202020204" pitchFamily="34" charset="0"/>
                <a:ea typeface="Calibri" panose="020F0502020204030204" pitchFamily="34" charset="0"/>
              </a:rPr>
              <a:t>The first learning module I want to show you is based on an intervention called behavioral activation. This intervention uses the idea that changing what we do (our behavior) affects how we feel.</a:t>
            </a:r>
            <a:r>
              <a:rPr lang="en-US" sz="1200" dirty="0">
                <a:solidFill>
                  <a:srgbClr val="000000"/>
                </a:solidFill>
                <a:effectLst/>
                <a:latin typeface="Arial" panose="020B0604020202020204" pitchFamily="34" charset="0"/>
                <a:ea typeface="Calibri" panose="020F0502020204030204" pitchFamily="34" charset="0"/>
              </a:rPr>
              <a:t> </a:t>
            </a:r>
            <a:r>
              <a:rPr lang="en-US" sz="1100" dirty="0">
                <a:solidFill>
                  <a:srgbClr val="000000"/>
                </a:solidFill>
                <a:effectLst/>
                <a:latin typeface="Arial" panose="020B0604020202020204" pitchFamily="34" charset="0"/>
                <a:ea typeface="Calibri" panose="020F0502020204030204" pitchFamily="34" charset="0"/>
              </a:rPr>
              <a:t>In this module, there will be six sessions. This page will help you track your progress and show you what your next steps are.</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What are your thoughts on the names of each of these sessions?</a:t>
            </a:r>
            <a:endParaRPr lang="en-US" sz="1200" dirty="0">
              <a:solidFill>
                <a:srgbClr val="000000"/>
              </a:solidFill>
              <a:effectLst/>
              <a:latin typeface="Arial" panose="020B0604020202020204" pitchFamily="34" charset="0"/>
              <a:ea typeface="Calibri" panose="020F0502020204030204" pitchFamily="34" charset="0"/>
            </a:endParaRPr>
          </a:p>
          <a:p>
            <a:pPr marL="742950" marR="0" lvl="1" indent="-285750">
              <a:spcBef>
                <a:spcPts val="0"/>
              </a:spcBef>
              <a:spcAft>
                <a:spcPts val="0"/>
              </a:spcAft>
              <a:buFont typeface="+mj-lt"/>
              <a:buAutoNum type="alphaLcPeriod"/>
            </a:pPr>
            <a:r>
              <a:rPr lang="en-US" sz="1100" dirty="0">
                <a:solidFill>
                  <a:srgbClr val="000000"/>
                </a:solidFill>
                <a:effectLst/>
                <a:latin typeface="Arial" panose="020B0604020202020204" pitchFamily="34" charset="0"/>
                <a:ea typeface="Calibri" panose="020F0502020204030204" pitchFamily="34" charset="0"/>
              </a:rPr>
              <a:t>Is there any other information you think would be helpful to include on this page?</a:t>
            </a: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6</a:t>
            </a:fld>
            <a:endParaRPr lang="en-US"/>
          </a:p>
        </p:txBody>
      </p:sp>
    </p:spTree>
    <p:extLst>
      <p:ext uri="{BB962C8B-B14F-4D97-AF65-F5344CB8AC3E}">
        <p14:creationId xmlns:p14="http://schemas.microsoft.com/office/powerpoint/2010/main" val="37952600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Each session will be a little different, but will include a combination of stories from AYAs, information based on research at the intersection of psychology and cancer, interactive activities you complete during the session, and practice activities to complete after the session. Here is an example of the course content for the first session of this component. </a:t>
            </a:r>
            <a:endParaRPr lang="en-US" sz="1200" dirty="0">
              <a:effectLst/>
              <a:latin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AE94229F-CBC9-4256-BB4D-541759E8685A}" type="slidenum">
              <a:rPr lang="en-US" smtClean="0"/>
              <a:t>7</a:t>
            </a:fld>
            <a:endParaRPr lang="en-US"/>
          </a:p>
        </p:txBody>
      </p:sp>
    </p:spTree>
    <p:extLst>
      <p:ext uri="{BB962C8B-B14F-4D97-AF65-F5344CB8AC3E}">
        <p14:creationId xmlns:p14="http://schemas.microsoft.com/office/powerpoint/2010/main" val="16610718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mj-lt"/>
              <a:buNone/>
              <a:tabLst/>
              <a:defRPr/>
            </a:pPr>
            <a:r>
              <a:rPr lang="en-US" sz="1800" dirty="0">
                <a:solidFill>
                  <a:srgbClr val="000000"/>
                </a:solidFill>
                <a:effectLst/>
                <a:latin typeface="Arial" panose="020B0604020202020204" pitchFamily="34" charset="0"/>
                <a:ea typeface="Calibri" panose="020F0502020204030204" pitchFamily="34" charset="0"/>
              </a:rPr>
              <a:t>How do you think the information about downward spirals should be presented (e.g. video of psychologist talking about it, animated video with voiceover, text you read)?</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000000"/>
                </a:solidFill>
                <a:effectLst/>
                <a:latin typeface="Arial" panose="020B0604020202020204" pitchFamily="34" charset="0"/>
                <a:ea typeface="Calibri" panose="020F0502020204030204" pitchFamily="34" charset="0"/>
              </a:rPr>
              <a:t>What do you think about the design we have created to present this information? How would you want it to work?</a:t>
            </a:r>
          </a:p>
        </p:txBody>
      </p:sp>
      <p:sp>
        <p:nvSpPr>
          <p:cNvPr id="4" name="Slide Number Placeholder 3"/>
          <p:cNvSpPr>
            <a:spLocks noGrp="1"/>
          </p:cNvSpPr>
          <p:nvPr>
            <p:ph type="sldNum" sz="quarter" idx="5"/>
          </p:nvPr>
        </p:nvSpPr>
        <p:spPr/>
        <p:txBody>
          <a:bodyPr/>
          <a:lstStyle/>
          <a:p>
            <a:fld id="{AE94229F-CBC9-4256-BB4D-541759E8685A}" type="slidenum">
              <a:rPr lang="en-US" smtClean="0"/>
              <a:t>8</a:t>
            </a:fld>
            <a:endParaRPr lang="en-US"/>
          </a:p>
        </p:txBody>
      </p:sp>
    </p:spTree>
    <p:extLst>
      <p:ext uri="{BB962C8B-B14F-4D97-AF65-F5344CB8AC3E}">
        <p14:creationId xmlns:p14="http://schemas.microsoft.com/office/powerpoint/2010/main" val="21130710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sz="1800" dirty="0">
                <a:solidFill>
                  <a:srgbClr val="000000"/>
                </a:solidFill>
                <a:effectLst/>
                <a:latin typeface="Arial" panose="020B0604020202020204" pitchFamily="34" charset="0"/>
                <a:ea typeface="Calibri" panose="020F0502020204030204" pitchFamily="34" charset="0"/>
              </a:rPr>
              <a:t>How do you think the AYA stories should be presented (e.g. video of them sharing, animated video with voice over, text you read)?</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000000"/>
                </a:solidFill>
                <a:effectLst/>
                <a:latin typeface="Arial" panose="020B0604020202020204" pitchFamily="34" charset="0"/>
                <a:ea typeface="Calibri" panose="020F0502020204030204" pitchFamily="34" charset="0"/>
              </a:rPr>
              <a:t>What do you think about the design we have created to present this information? How would you want it to work?</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000000"/>
                </a:solidFill>
                <a:effectLst/>
                <a:latin typeface="Arial" panose="020B0604020202020204" pitchFamily="34" charset="0"/>
                <a:ea typeface="Calibri" panose="020F0502020204030204" pitchFamily="34" charset="0"/>
              </a:rPr>
              <a:t>One of the features we have added is the ability to bookmark videos.</a:t>
            </a:r>
          </a:p>
          <a:p>
            <a:pPr marL="742950"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000000"/>
                </a:solidFill>
                <a:effectLst/>
                <a:latin typeface="Arial" panose="020B0604020202020204" pitchFamily="34" charset="0"/>
                <a:ea typeface="Calibri" panose="020F0502020204030204" pitchFamily="34" charset="0"/>
              </a:rPr>
              <a:t>Is this something you think you would use?</a:t>
            </a:r>
          </a:p>
          <a:p>
            <a:pPr marL="742950"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000000"/>
                </a:solidFill>
                <a:effectLst/>
                <a:latin typeface="Arial" panose="020B0604020202020204" pitchFamily="34" charset="0"/>
                <a:ea typeface="Calibri" panose="020F0502020204030204" pitchFamily="34" charset="0"/>
              </a:rPr>
              <a:t>If so, where would you like to be able to find your saved videos?</a:t>
            </a:r>
          </a:p>
          <a:p>
            <a:pPr marL="0" marR="0" lvl="0" indent="0">
              <a:spcBef>
                <a:spcPts val="0"/>
              </a:spcBef>
              <a:spcAft>
                <a:spcPts val="0"/>
              </a:spcAft>
              <a:buFont typeface="+mj-lt"/>
              <a:buNone/>
            </a:pPr>
            <a:endParaRPr lang="en-US" sz="1800" dirty="0">
              <a:solidFill>
                <a:srgbClr val="000000"/>
              </a:solidFill>
              <a:effectLst/>
              <a:latin typeface="Arial" panose="020B0604020202020204" pitchFamily="34" charset="0"/>
              <a:ea typeface="Calibri" panose="020F0502020204030204" pitchFamily="34" charset="0"/>
            </a:endParaRPr>
          </a:p>
        </p:txBody>
      </p:sp>
      <p:sp>
        <p:nvSpPr>
          <p:cNvPr id="4" name="Slide Number Placeholder 3"/>
          <p:cNvSpPr>
            <a:spLocks noGrp="1"/>
          </p:cNvSpPr>
          <p:nvPr>
            <p:ph type="sldNum" sz="quarter" idx="5"/>
          </p:nvPr>
        </p:nvSpPr>
        <p:spPr/>
        <p:txBody>
          <a:bodyPr/>
          <a:lstStyle/>
          <a:p>
            <a:fld id="{AE94229F-CBC9-4256-BB4D-541759E8685A}" type="slidenum">
              <a:rPr lang="en-US" smtClean="0"/>
              <a:t>9</a:t>
            </a:fld>
            <a:endParaRPr lang="en-US"/>
          </a:p>
        </p:txBody>
      </p:sp>
    </p:spTree>
    <p:extLst>
      <p:ext uri="{BB962C8B-B14F-4D97-AF65-F5344CB8AC3E}">
        <p14:creationId xmlns:p14="http://schemas.microsoft.com/office/powerpoint/2010/main" val="21217425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558CD3-27E3-87D7-5C4C-13838BF511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D8D60DB-9462-BE74-8402-3BF8D99B6E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CE35D4C-64CD-8AF0-0A0E-1277A48B6C90}"/>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9FA6434E-D883-3B92-8346-946DD3CB5F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CE47E3-9FBC-7A48-F8BA-3EE51C57D2CF}"/>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2865598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ADD29C-D50A-B8FB-56F7-D76CC3194A8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82B43B9-4C8A-E7D9-5441-9BE74B1F915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F5551D-B908-9077-E994-3E579CA99365}"/>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E70BFFF5-CD52-6678-0B7C-3CB516A181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F5A325E-1E7C-B2B3-DD70-191D5E8B52C3}"/>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42153565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98942E8-2B5D-0A17-5E71-2FABC6FEC29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5ADE4CB-8361-B99E-E784-C203B6B4352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D0E518-D72F-2B5B-B651-295D3166C0F0}"/>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57562F1A-C4B1-6D9E-C1E6-F2EC017877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61D0B8-CD4D-FC51-6069-1C6A56F28A59}"/>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19987051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2D8F95-22A6-3759-7B38-1080389A7A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7AFDB7C-AC77-462F-EFBD-6D4DFD500CF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6D48A9B-7A45-B79B-FD84-3C0B5F5E3115}"/>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AF93782D-D670-3F3B-5FF8-8841225E24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ABD76B-3F70-AA01-5A0D-65FF8C49E063}"/>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25642190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4FC409-97EB-A724-62F1-62D0799A51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145F914-341B-5622-4F27-85B2C137BC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A3FE5F3-AABB-9AEB-0BFB-6FB6FBCACC6E}"/>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54BB7F9D-D8C5-7584-7800-FA8CDED68E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FA26BCC-92FC-17AD-3F17-64E0D43B746D}"/>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35219148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857468-031A-71B3-237D-D60F7226244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F69B42A-02F5-6168-956F-40C8924E02D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3BCCFC9-499A-C31C-F593-F77E03AE8C7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90BF100-F5EC-5D70-B879-A7F995355287}"/>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6" name="Footer Placeholder 5">
            <a:extLst>
              <a:ext uri="{FF2B5EF4-FFF2-40B4-BE49-F238E27FC236}">
                <a16:creationId xmlns:a16="http://schemas.microsoft.com/office/drawing/2014/main" id="{2616B68A-8914-658F-0745-8E52F4EBFF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6EEA0DF-53DF-6AA4-CC10-9E73E70694A7}"/>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727831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C11F3-ABCB-D876-209F-45F793669BA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3CC5721-D497-0F6B-06A3-B2505A22827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CE6EC96-0E9B-9A5E-3F98-CEB40CF9028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CF6746E-898B-EF0C-4537-D78F0CE3BBE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9374830-AD9E-05B7-47A7-47B837036BB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E08ABB8-2D1B-9ACF-48C7-318681DC22DB}"/>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8" name="Footer Placeholder 7">
            <a:extLst>
              <a:ext uri="{FF2B5EF4-FFF2-40B4-BE49-F238E27FC236}">
                <a16:creationId xmlns:a16="http://schemas.microsoft.com/office/drawing/2014/main" id="{5A0D2FC1-79A6-61B8-8FF6-69769DB4F1F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BF30539-3850-7434-1E57-7390E1C7F039}"/>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41354367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64D054-527A-7CC3-6451-A234F43790F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CCA3304-E595-3B50-7A33-CC05BB5C66EB}"/>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4" name="Footer Placeholder 3">
            <a:extLst>
              <a:ext uri="{FF2B5EF4-FFF2-40B4-BE49-F238E27FC236}">
                <a16:creationId xmlns:a16="http://schemas.microsoft.com/office/drawing/2014/main" id="{7C0B3C2F-5B69-1DBC-636F-87058D583C9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541C6A9-6C32-E3D8-2EBF-7A3B2297CA39}"/>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1425490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F02B46A-5FAB-F169-4391-9023F7FA9C19}"/>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3" name="Footer Placeholder 2">
            <a:extLst>
              <a:ext uri="{FF2B5EF4-FFF2-40B4-BE49-F238E27FC236}">
                <a16:creationId xmlns:a16="http://schemas.microsoft.com/office/drawing/2014/main" id="{112C26EE-94A1-429C-50DB-5151105E883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AC4899D-E401-51E9-FED8-AFB42D9D23F5}"/>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20000826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F0C54B-B759-7C54-35BB-566BB9EBB1A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AC07765-4E4C-4AF7-00FF-83503598164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2A28D3F-C695-6617-6F76-E43197AAA2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7249886-4296-CAC3-69B6-3CFEDD0439CB}"/>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6" name="Footer Placeholder 5">
            <a:extLst>
              <a:ext uri="{FF2B5EF4-FFF2-40B4-BE49-F238E27FC236}">
                <a16:creationId xmlns:a16="http://schemas.microsoft.com/office/drawing/2014/main" id="{99625404-D662-88EA-7376-ACAE83C5B64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D165789-686B-6106-BB55-057E6CB2785B}"/>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11168218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AAD53E-366C-B35C-6452-D570324213F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458F117-5DB0-F4B4-2A27-788A3F4F23A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BF578BD-06CF-D374-5564-E85AB2B032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BF1D7A2-5E65-FA72-377A-9555EC19AF6A}"/>
              </a:ext>
            </a:extLst>
          </p:cNvPr>
          <p:cNvSpPr>
            <a:spLocks noGrp="1"/>
          </p:cNvSpPr>
          <p:nvPr>
            <p:ph type="dt" sz="half" idx="10"/>
          </p:nvPr>
        </p:nvSpPr>
        <p:spPr/>
        <p:txBody>
          <a:bodyPr/>
          <a:lstStyle/>
          <a:p>
            <a:fld id="{021A3759-7991-4F64-BCC0-880B0F87470F}" type="datetimeFigureOut">
              <a:rPr lang="en-US" smtClean="0"/>
              <a:t>5/23/2025</a:t>
            </a:fld>
            <a:endParaRPr lang="en-US"/>
          </a:p>
        </p:txBody>
      </p:sp>
      <p:sp>
        <p:nvSpPr>
          <p:cNvPr id="6" name="Footer Placeholder 5">
            <a:extLst>
              <a:ext uri="{FF2B5EF4-FFF2-40B4-BE49-F238E27FC236}">
                <a16:creationId xmlns:a16="http://schemas.microsoft.com/office/drawing/2014/main" id="{CCFD3782-736B-CA11-D74D-CBA5A2F575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6BE82E-55BE-F22A-68B2-D7912DE35F0C}"/>
              </a:ext>
            </a:extLst>
          </p:cNvPr>
          <p:cNvSpPr>
            <a:spLocks noGrp="1"/>
          </p:cNvSpPr>
          <p:nvPr>
            <p:ph type="sldNum" sz="quarter" idx="12"/>
          </p:nvPr>
        </p:nvSpPr>
        <p:spPr/>
        <p:txBody>
          <a:bodyPr/>
          <a:lstStyle/>
          <a:p>
            <a:fld id="{72647DE8-156C-4C30-8956-932744A5C7CD}" type="slidenum">
              <a:rPr lang="en-US" smtClean="0"/>
              <a:t>‹#›</a:t>
            </a:fld>
            <a:endParaRPr lang="en-US"/>
          </a:p>
        </p:txBody>
      </p:sp>
    </p:spTree>
    <p:extLst>
      <p:ext uri="{BB962C8B-B14F-4D97-AF65-F5344CB8AC3E}">
        <p14:creationId xmlns:p14="http://schemas.microsoft.com/office/powerpoint/2010/main" val="23042649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8FF38DD-8EBC-CE1E-2A09-C78152139DF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ABD868D-4DC2-D087-0C5F-5F16CF06FDD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8337EF0-38EC-9CED-B890-ACBE5FECEEB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1A3759-7991-4F64-BCC0-880B0F87470F}" type="datetimeFigureOut">
              <a:rPr lang="en-US" smtClean="0"/>
              <a:t>5/23/2025</a:t>
            </a:fld>
            <a:endParaRPr lang="en-US"/>
          </a:p>
        </p:txBody>
      </p:sp>
      <p:sp>
        <p:nvSpPr>
          <p:cNvPr id="5" name="Footer Placeholder 4">
            <a:extLst>
              <a:ext uri="{FF2B5EF4-FFF2-40B4-BE49-F238E27FC236}">
                <a16:creationId xmlns:a16="http://schemas.microsoft.com/office/drawing/2014/main" id="{07C9E1FD-BF92-6AAB-A658-F5FE0F59431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66FF833-A30B-8418-2B71-F89A9476DD1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647DE8-156C-4C30-8956-932744A5C7CD}" type="slidenum">
              <a:rPr lang="en-US" smtClean="0"/>
              <a:t>‹#›</a:t>
            </a:fld>
            <a:endParaRPr lang="en-US"/>
          </a:p>
        </p:txBody>
      </p:sp>
    </p:spTree>
    <p:extLst>
      <p:ext uri="{BB962C8B-B14F-4D97-AF65-F5344CB8AC3E}">
        <p14:creationId xmlns:p14="http://schemas.microsoft.com/office/powerpoint/2010/main" val="905508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16.png"/><Relationship Id="rId4" Type="http://schemas.openxmlformats.org/officeDocument/2006/relationships/image" Target="../media/image15.png"/></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1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23.png"/><Relationship Id="rId4" Type="http://schemas.openxmlformats.org/officeDocument/2006/relationships/image" Target="../media/image22.png"/></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openxmlformats.org/officeDocument/2006/relationships/image" Target="../media/image26.png"/><Relationship Id="rId4" Type="http://schemas.openxmlformats.org/officeDocument/2006/relationships/image" Target="../media/image25.png"/></Relationships>
</file>

<file path=ppt/slides/_rels/slide15.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30.png"/><Relationship Id="rId5" Type="http://schemas.openxmlformats.org/officeDocument/2006/relationships/image" Target="../media/image29.jpeg"/><Relationship Id="rId4" Type="http://schemas.openxmlformats.org/officeDocument/2006/relationships/image" Target="../media/image28.jpe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microsoft.com/office/2018/10/relationships/comments" Target="../comments/modernComment_100_E0E6D698.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jpe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microsoft.com/office/2018/10/relationships/comments" Target="../comments/modernComment_105_A14FBA04.xm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3" Type="http://schemas.microsoft.com/office/2018/10/relationships/comments" Target="../comments/modernComment_104_58A381D1.xml"/><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3" Type="http://schemas.microsoft.com/office/2018/10/relationships/comments" Target="../comments/modernComment_106_27CEFE08.xml"/><Relationship Id="rId2" Type="http://schemas.openxmlformats.org/officeDocument/2006/relationships/notesSlide" Target="../notesSlides/notesSlide8.xml"/><Relationship Id="rId1" Type="http://schemas.openxmlformats.org/officeDocument/2006/relationships/slideLayout" Target="../slideLayouts/slideLayout4.xml"/><Relationship Id="rId4" Type="http://schemas.openxmlformats.org/officeDocument/2006/relationships/image" Target="../media/image12.png"/></Relationships>
</file>

<file path=ppt/slides/_rels/slide9.xml.rels><?xml version="1.0" encoding="UTF-8" standalone="yes"?>
<Relationships xmlns="http://schemas.openxmlformats.org/package/2006/relationships"><Relationship Id="rId3" Type="http://schemas.microsoft.com/office/2018/10/relationships/comments" Target="../comments/modernComment_109_CE7327D8.xml"/><Relationship Id="rId2" Type="http://schemas.openxmlformats.org/officeDocument/2006/relationships/notesSlide" Target="../notesSlides/notesSlide9.xml"/><Relationship Id="rId1" Type="http://schemas.openxmlformats.org/officeDocument/2006/relationships/slideLayout" Target="../slideLayouts/slideLayout4.xml"/><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68" name="Rectangle 2067">
            <a:extLst>
              <a:ext uri="{FF2B5EF4-FFF2-40B4-BE49-F238E27FC236}">
                <a16:creationId xmlns:a16="http://schemas.microsoft.com/office/drawing/2014/main" id="{59264BFD-360D-430E-B593-7BC0D00FBD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FFFFFF"/>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070" name="Group 2069">
            <a:extLst>
              <a:ext uri="{FF2B5EF4-FFF2-40B4-BE49-F238E27FC236}">
                <a16:creationId xmlns:a16="http://schemas.microsoft.com/office/drawing/2014/main" id="{A4538145-ACBA-40C0-AFBD-DE742723D57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 y="0"/>
            <a:ext cx="12191996" cy="6858000"/>
            <a:chOff x="1" y="0"/>
            <a:chExt cx="12191996" cy="6858000"/>
          </a:xfrm>
        </p:grpSpPr>
        <p:sp useBgFill="1">
          <p:nvSpPr>
            <p:cNvPr id="2071" name="Rectangle 2070">
              <a:extLst>
                <a:ext uri="{FF2B5EF4-FFF2-40B4-BE49-F238E27FC236}">
                  <a16:creationId xmlns:a16="http://schemas.microsoft.com/office/drawing/2014/main" id="{7BAD3960-6DE9-4457-8083-F6FFBD58D74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ltGray">
            <a:xfrm>
              <a:off x="1" y="0"/>
              <a:ext cx="12191996" cy="6858000"/>
            </a:xfrm>
            <a:prstGeom prst="rect">
              <a:avLst/>
            </a:prstGeom>
            <a:ln w="0">
              <a:noFill/>
              <a:prstDash val="solid"/>
              <a:round/>
              <a:headEnd/>
              <a:tailEnd/>
            </a:ln>
          </p:spPr>
          <p:txBody>
            <a:bodyPr rtlCol="0" anchor="ctr"/>
            <a:lstStyle/>
            <a:p>
              <a:pPr algn="ctr" defTabSz="457200"/>
              <a:endParaRPr lang="en-US">
                <a:solidFill>
                  <a:schemeClr val="tx1"/>
                </a:solidFill>
              </a:endParaRPr>
            </a:p>
          </p:txBody>
        </p:sp>
        <p:sp>
          <p:nvSpPr>
            <p:cNvPr id="2072" name="Rectangle 2071">
              <a:extLst>
                <a:ext uri="{FF2B5EF4-FFF2-40B4-BE49-F238E27FC236}">
                  <a16:creationId xmlns:a16="http://schemas.microsoft.com/office/drawing/2014/main" id="{F3F5E368-26F9-408D-9C1D-D007FCE0C20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ltGray">
            <a:xfrm>
              <a:off x="1" y="0"/>
              <a:ext cx="12191996" cy="6858000"/>
            </a:xfrm>
            <a:prstGeom prst="rect">
              <a:avLst/>
            </a:prstGeom>
            <a:solidFill>
              <a:schemeClr val="accent1">
                <a:lumMod val="50000"/>
                <a:alpha val="25000"/>
              </a:schemeClr>
            </a:solidFill>
            <a:ln w="0">
              <a:noFill/>
              <a:prstDash val="solid"/>
              <a:round/>
              <a:headEnd/>
              <a:tailEnd/>
            </a:ln>
          </p:spPr>
          <p:txBody>
            <a:bodyPr rtlCol="0" anchor="ctr"/>
            <a:lstStyle/>
            <a:p>
              <a:pPr algn="ctr" defTabSz="457200"/>
              <a:endParaRPr lang="en-US" dirty="0">
                <a:solidFill>
                  <a:schemeClr val="tx1"/>
                </a:solidFill>
              </a:endParaRPr>
            </a:p>
          </p:txBody>
        </p:sp>
      </p:grpSp>
      <p:sp>
        <p:nvSpPr>
          <p:cNvPr id="2" name="Title 1">
            <a:extLst>
              <a:ext uri="{FF2B5EF4-FFF2-40B4-BE49-F238E27FC236}">
                <a16:creationId xmlns:a16="http://schemas.microsoft.com/office/drawing/2014/main" id="{EAAA324D-5E38-9501-8691-847E840B4865}"/>
              </a:ext>
            </a:extLst>
          </p:cNvPr>
          <p:cNvSpPr>
            <a:spLocks noGrp="1"/>
          </p:cNvSpPr>
          <p:nvPr>
            <p:ph type="title"/>
          </p:nvPr>
        </p:nvSpPr>
        <p:spPr>
          <a:xfrm>
            <a:off x="765051" y="662400"/>
            <a:ext cx="4516505" cy="1492132"/>
          </a:xfrm>
        </p:spPr>
        <p:txBody>
          <a:bodyPr vert="horz" lIns="91440" tIns="45720" rIns="91440" bIns="45720" rtlCol="0" anchor="t">
            <a:normAutofit/>
          </a:bodyPr>
          <a:lstStyle/>
          <a:p>
            <a:r>
              <a:rPr lang="en-US" kern="1200">
                <a:latin typeface="+mj-lt"/>
                <a:ea typeface="+mj-ea"/>
                <a:cs typeface="+mj-cs"/>
              </a:rPr>
              <a:t>Intro</a:t>
            </a:r>
          </a:p>
        </p:txBody>
      </p:sp>
      <p:sp>
        <p:nvSpPr>
          <p:cNvPr id="2065" name="Content Placeholder 2064">
            <a:extLst>
              <a:ext uri="{FF2B5EF4-FFF2-40B4-BE49-F238E27FC236}">
                <a16:creationId xmlns:a16="http://schemas.microsoft.com/office/drawing/2014/main" id="{65B82839-1CBB-AB55-8FE4-1109CF81BCCE}"/>
              </a:ext>
            </a:extLst>
          </p:cNvPr>
          <p:cNvSpPr>
            <a:spLocks noGrp="1"/>
          </p:cNvSpPr>
          <p:nvPr>
            <p:ph idx="1"/>
          </p:nvPr>
        </p:nvSpPr>
        <p:spPr>
          <a:xfrm>
            <a:off x="765052" y="2286001"/>
            <a:ext cx="4389998" cy="3844800"/>
          </a:xfrm>
        </p:spPr>
        <p:txBody>
          <a:bodyPr>
            <a:normAutofit/>
          </a:bodyPr>
          <a:lstStyle/>
          <a:p>
            <a:endParaRPr lang="en-US" sz="2000">
              <a:solidFill>
                <a:schemeClr val="tx1">
                  <a:alpha val="60000"/>
                </a:schemeClr>
              </a:solidFill>
            </a:endParaRPr>
          </a:p>
        </p:txBody>
      </p:sp>
      <p:sp>
        <p:nvSpPr>
          <p:cNvPr id="2074" name="Freeform: Shape 2073">
            <a:extLst>
              <a:ext uri="{FF2B5EF4-FFF2-40B4-BE49-F238E27FC236}">
                <a16:creationId xmlns:a16="http://schemas.microsoft.com/office/drawing/2014/main" id="{F249C1C3-EBDE-4C27-BD12-A6AE40A4DB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87375" y="0"/>
            <a:ext cx="6404625" cy="6373368"/>
          </a:xfrm>
          <a:custGeom>
            <a:avLst/>
            <a:gdLst>
              <a:gd name="connsiteX0" fmla="*/ 353272 w 6404625"/>
              <a:gd name="connsiteY0" fmla="*/ 0 h 6373368"/>
              <a:gd name="connsiteX1" fmla="*/ 6404625 w 6404625"/>
              <a:gd name="connsiteY1" fmla="*/ 0 h 6373368"/>
              <a:gd name="connsiteX2" fmla="*/ 6404625 w 6404625"/>
              <a:gd name="connsiteY2" fmla="*/ 6008204 h 6373368"/>
              <a:gd name="connsiteX3" fmla="*/ 6374459 w 6404625"/>
              <a:gd name="connsiteY3" fmla="*/ 6023890 h 6373368"/>
              <a:gd name="connsiteX4" fmla="*/ 6290584 w 6404625"/>
              <a:gd name="connsiteY4" fmla="*/ 6049055 h 6373368"/>
              <a:gd name="connsiteX5" fmla="*/ 6203913 w 6404625"/>
              <a:gd name="connsiteY5" fmla="*/ 6060237 h 6373368"/>
              <a:gd name="connsiteX6" fmla="*/ 6114448 w 6404625"/>
              <a:gd name="connsiteY6" fmla="*/ 6063033 h 6373368"/>
              <a:gd name="connsiteX7" fmla="*/ 6019391 w 6404625"/>
              <a:gd name="connsiteY7" fmla="*/ 6054644 h 6373368"/>
              <a:gd name="connsiteX8" fmla="*/ 5924332 w 6404625"/>
              <a:gd name="connsiteY8" fmla="*/ 6043462 h 6373368"/>
              <a:gd name="connsiteX9" fmla="*/ 5829275 w 6404625"/>
              <a:gd name="connsiteY9" fmla="*/ 6029482 h 6373368"/>
              <a:gd name="connsiteX10" fmla="*/ 5734216 w 6404625"/>
              <a:gd name="connsiteY10" fmla="*/ 6018300 h 6373368"/>
              <a:gd name="connsiteX11" fmla="*/ 5639159 w 6404625"/>
              <a:gd name="connsiteY11" fmla="*/ 6012708 h 6373368"/>
              <a:gd name="connsiteX12" fmla="*/ 5546898 w 6404625"/>
              <a:gd name="connsiteY12" fmla="*/ 6012708 h 6373368"/>
              <a:gd name="connsiteX13" fmla="*/ 5460227 w 6404625"/>
              <a:gd name="connsiteY13" fmla="*/ 6023890 h 6373368"/>
              <a:gd name="connsiteX14" fmla="*/ 5370760 w 6404625"/>
              <a:gd name="connsiteY14" fmla="*/ 6046258 h 6373368"/>
              <a:gd name="connsiteX15" fmla="*/ 5289681 w 6404625"/>
              <a:gd name="connsiteY15" fmla="*/ 6079807 h 6373368"/>
              <a:gd name="connsiteX16" fmla="*/ 5205808 w 6404625"/>
              <a:gd name="connsiteY16" fmla="*/ 6124541 h 6373368"/>
              <a:gd name="connsiteX17" fmla="*/ 5121933 w 6404625"/>
              <a:gd name="connsiteY17" fmla="*/ 6169276 h 6373368"/>
              <a:gd name="connsiteX18" fmla="*/ 5038061 w 6404625"/>
              <a:gd name="connsiteY18" fmla="*/ 6219598 h 6373368"/>
              <a:gd name="connsiteX19" fmla="*/ 4956981 w 6404625"/>
              <a:gd name="connsiteY19" fmla="*/ 6267129 h 6373368"/>
              <a:gd name="connsiteX20" fmla="*/ 4870311 w 6404625"/>
              <a:gd name="connsiteY20" fmla="*/ 6309065 h 6373368"/>
              <a:gd name="connsiteX21" fmla="*/ 4786435 w 6404625"/>
              <a:gd name="connsiteY21" fmla="*/ 6342614 h 6373368"/>
              <a:gd name="connsiteX22" fmla="*/ 4699765 w 6404625"/>
              <a:gd name="connsiteY22" fmla="*/ 6364982 h 6373368"/>
              <a:gd name="connsiteX23" fmla="*/ 4610299 w 6404625"/>
              <a:gd name="connsiteY23" fmla="*/ 6373368 h 6373368"/>
              <a:gd name="connsiteX24" fmla="*/ 4520833 w 6404625"/>
              <a:gd name="connsiteY24" fmla="*/ 6364982 h 6373368"/>
              <a:gd name="connsiteX25" fmla="*/ 4434163 w 6404625"/>
              <a:gd name="connsiteY25" fmla="*/ 6342614 h 6373368"/>
              <a:gd name="connsiteX26" fmla="*/ 4350289 w 6404625"/>
              <a:gd name="connsiteY26" fmla="*/ 6309065 h 6373368"/>
              <a:gd name="connsiteX27" fmla="*/ 4263617 w 6404625"/>
              <a:gd name="connsiteY27" fmla="*/ 6267129 h 6373368"/>
              <a:gd name="connsiteX28" fmla="*/ 4182539 w 6404625"/>
              <a:gd name="connsiteY28" fmla="*/ 6219598 h 6373368"/>
              <a:gd name="connsiteX29" fmla="*/ 4098666 w 6404625"/>
              <a:gd name="connsiteY29" fmla="*/ 6169276 h 6373368"/>
              <a:gd name="connsiteX30" fmla="*/ 4014791 w 6404625"/>
              <a:gd name="connsiteY30" fmla="*/ 6124541 h 6373368"/>
              <a:gd name="connsiteX31" fmla="*/ 3930916 w 6404625"/>
              <a:gd name="connsiteY31" fmla="*/ 6079807 h 6373368"/>
              <a:gd name="connsiteX32" fmla="*/ 3847041 w 6404625"/>
              <a:gd name="connsiteY32" fmla="*/ 6046258 h 6373368"/>
              <a:gd name="connsiteX33" fmla="*/ 3760372 w 6404625"/>
              <a:gd name="connsiteY33" fmla="*/ 6023890 h 6373368"/>
              <a:gd name="connsiteX34" fmla="*/ 3673701 w 6404625"/>
              <a:gd name="connsiteY34" fmla="*/ 6012708 h 6373368"/>
              <a:gd name="connsiteX35" fmla="*/ 3581438 w 6404625"/>
              <a:gd name="connsiteY35" fmla="*/ 6012708 h 6373368"/>
              <a:gd name="connsiteX36" fmla="*/ 3486381 w 6404625"/>
              <a:gd name="connsiteY36" fmla="*/ 6018300 h 6373368"/>
              <a:gd name="connsiteX37" fmla="*/ 3391322 w 6404625"/>
              <a:gd name="connsiteY37" fmla="*/ 6029482 h 6373368"/>
              <a:gd name="connsiteX38" fmla="*/ 3296265 w 6404625"/>
              <a:gd name="connsiteY38" fmla="*/ 6043462 h 6373368"/>
              <a:gd name="connsiteX39" fmla="*/ 3201210 w 6404625"/>
              <a:gd name="connsiteY39" fmla="*/ 6054644 h 6373368"/>
              <a:gd name="connsiteX40" fmla="*/ 3106151 w 6404625"/>
              <a:gd name="connsiteY40" fmla="*/ 6063033 h 6373368"/>
              <a:gd name="connsiteX41" fmla="*/ 3016684 w 6404625"/>
              <a:gd name="connsiteY41" fmla="*/ 6060237 h 6373368"/>
              <a:gd name="connsiteX42" fmla="*/ 2930015 w 6404625"/>
              <a:gd name="connsiteY42" fmla="*/ 6049055 h 6373368"/>
              <a:gd name="connsiteX43" fmla="*/ 2846140 w 6404625"/>
              <a:gd name="connsiteY43" fmla="*/ 6023890 h 6373368"/>
              <a:gd name="connsiteX44" fmla="*/ 2776243 w 6404625"/>
              <a:gd name="connsiteY44" fmla="*/ 5987546 h 6373368"/>
              <a:gd name="connsiteX45" fmla="*/ 2709145 w 6404625"/>
              <a:gd name="connsiteY45" fmla="*/ 5940017 h 6373368"/>
              <a:gd name="connsiteX46" fmla="*/ 2650432 w 6404625"/>
              <a:gd name="connsiteY46" fmla="*/ 5884101 h 6373368"/>
              <a:gd name="connsiteX47" fmla="*/ 2591719 w 6404625"/>
              <a:gd name="connsiteY47" fmla="*/ 5819798 h 6373368"/>
              <a:gd name="connsiteX48" fmla="*/ 2538599 w 6404625"/>
              <a:gd name="connsiteY48" fmla="*/ 5752697 h 6373368"/>
              <a:gd name="connsiteX49" fmla="*/ 2485480 w 6404625"/>
              <a:gd name="connsiteY49" fmla="*/ 5682802 h 6373368"/>
              <a:gd name="connsiteX50" fmla="*/ 2432360 w 6404625"/>
              <a:gd name="connsiteY50" fmla="*/ 5612908 h 6373368"/>
              <a:gd name="connsiteX51" fmla="*/ 2379237 w 6404625"/>
              <a:gd name="connsiteY51" fmla="*/ 5545809 h 6373368"/>
              <a:gd name="connsiteX52" fmla="*/ 2323320 w 6404625"/>
              <a:gd name="connsiteY52" fmla="*/ 5481502 h 6373368"/>
              <a:gd name="connsiteX53" fmla="*/ 2259018 w 6404625"/>
              <a:gd name="connsiteY53" fmla="*/ 5425586 h 6373368"/>
              <a:gd name="connsiteX54" fmla="*/ 2197511 w 6404625"/>
              <a:gd name="connsiteY54" fmla="*/ 5375263 h 6373368"/>
              <a:gd name="connsiteX55" fmla="*/ 2127614 w 6404625"/>
              <a:gd name="connsiteY55" fmla="*/ 5336121 h 6373368"/>
              <a:gd name="connsiteX56" fmla="*/ 2052128 w 6404625"/>
              <a:gd name="connsiteY56" fmla="*/ 5302573 h 6373368"/>
              <a:gd name="connsiteX57" fmla="*/ 1971049 w 6404625"/>
              <a:gd name="connsiteY57" fmla="*/ 5274612 h 6373368"/>
              <a:gd name="connsiteX58" fmla="*/ 1887176 w 6404625"/>
              <a:gd name="connsiteY58" fmla="*/ 5249450 h 6373368"/>
              <a:gd name="connsiteX59" fmla="*/ 1803301 w 6404625"/>
              <a:gd name="connsiteY59" fmla="*/ 5227084 h 6373368"/>
              <a:gd name="connsiteX60" fmla="*/ 1716630 w 6404625"/>
              <a:gd name="connsiteY60" fmla="*/ 5204720 h 6373368"/>
              <a:gd name="connsiteX61" fmla="*/ 1635551 w 6404625"/>
              <a:gd name="connsiteY61" fmla="*/ 5179557 h 6373368"/>
              <a:gd name="connsiteX62" fmla="*/ 1554473 w 6404625"/>
              <a:gd name="connsiteY62" fmla="*/ 5151597 h 6373368"/>
              <a:gd name="connsiteX63" fmla="*/ 1478988 w 6404625"/>
              <a:gd name="connsiteY63" fmla="*/ 5118049 h 6373368"/>
              <a:gd name="connsiteX64" fmla="*/ 1411887 w 6404625"/>
              <a:gd name="connsiteY64" fmla="*/ 5076112 h 6373368"/>
              <a:gd name="connsiteX65" fmla="*/ 1350380 w 6404625"/>
              <a:gd name="connsiteY65" fmla="*/ 5025785 h 6373368"/>
              <a:gd name="connsiteX66" fmla="*/ 1300053 w 6404625"/>
              <a:gd name="connsiteY66" fmla="*/ 4964279 h 6373368"/>
              <a:gd name="connsiteX67" fmla="*/ 1258117 w 6404625"/>
              <a:gd name="connsiteY67" fmla="*/ 4897178 h 6373368"/>
              <a:gd name="connsiteX68" fmla="*/ 1224567 w 6404625"/>
              <a:gd name="connsiteY68" fmla="*/ 4821691 h 6373368"/>
              <a:gd name="connsiteX69" fmla="*/ 1196609 w 6404625"/>
              <a:gd name="connsiteY69" fmla="*/ 4740614 h 6373368"/>
              <a:gd name="connsiteX70" fmla="*/ 1171447 w 6404625"/>
              <a:gd name="connsiteY70" fmla="*/ 4659533 h 6373368"/>
              <a:gd name="connsiteX71" fmla="*/ 1149080 w 6404625"/>
              <a:gd name="connsiteY71" fmla="*/ 4572865 h 6373368"/>
              <a:gd name="connsiteX72" fmla="*/ 1126714 w 6404625"/>
              <a:gd name="connsiteY72" fmla="*/ 4488990 h 6373368"/>
              <a:gd name="connsiteX73" fmla="*/ 1101552 w 6404625"/>
              <a:gd name="connsiteY73" fmla="*/ 4405115 h 6373368"/>
              <a:gd name="connsiteX74" fmla="*/ 1073593 w 6404625"/>
              <a:gd name="connsiteY74" fmla="*/ 4324036 h 6373368"/>
              <a:gd name="connsiteX75" fmla="*/ 1040045 w 6404625"/>
              <a:gd name="connsiteY75" fmla="*/ 4248549 h 6373368"/>
              <a:gd name="connsiteX76" fmla="*/ 1000902 w 6404625"/>
              <a:gd name="connsiteY76" fmla="*/ 4178654 h 6373368"/>
              <a:gd name="connsiteX77" fmla="*/ 950576 w 6404625"/>
              <a:gd name="connsiteY77" fmla="*/ 4117146 h 6373368"/>
              <a:gd name="connsiteX78" fmla="*/ 894659 w 6404625"/>
              <a:gd name="connsiteY78" fmla="*/ 4052841 h 6373368"/>
              <a:gd name="connsiteX79" fmla="*/ 830356 w 6404625"/>
              <a:gd name="connsiteY79" fmla="*/ 3996926 h 6373368"/>
              <a:gd name="connsiteX80" fmla="*/ 760460 w 6404625"/>
              <a:gd name="connsiteY80" fmla="*/ 3943806 h 6373368"/>
              <a:gd name="connsiteX81" fmla="*/ 690567 w 6404625"/>
              <a:gd name="connsiteY81" fmla="*/ 3890685 h 6373368"/>
              <a:gd name="connsiteX82" fmla="*/ 620671 w 6404625"/>
              <a:gd name="connsiteY82" fmla="*/ 3837564 h 6373368"/>
              <a:gd name="connsiteX83" fmla="*/ 553571 w 6404625"/>
              <a:gd name="connsiteY83" fmla="*/ 3784444 h 6373368"/>
              <a:gd name="connsiteX84" fmla="*/ 489269 w 6404625"/>
              <a:gd name="connsiteY84" fmla="*/ 3725731 h 6373368"/>
              <a:gd name="connsiteX85" fmla="*/ 433350 w 6404625"/>
              <a:gd name="connsiteY85" fmla="*/ 3667021 h 6373368"/>
              <a:gd name="connsiteX86" fmla="*/ 385824 w 6404625"/>
              <a:gd name="connsiteY86" fmla="*/ 3599922 h 6373368"/>
              <a:gd name="connsiteX87" fmla="*/ 349477 w 6404625"/>
              <a:gd name="connsiteY87" fmla="*/ 3530025 h 6373368"/>
              <a:gd name="connsiteX88" fmla="*/ 324315 w 6404625"/>
              <a:gd name="connsiteY88" fmla="*/ 3446150 h 6373368"/>
              <a:gd name="connsiteX89" fmla="*/ 313131 w 6404625"/>
              <a:gd name="connsiteY89" fmla="*/ 3359479 h 6373368"/>
              <a:gd name="connsiteX90" fmla="*/ 310335 w 6404625"/>
              <a:gd name="connsiteY90" fmla="*/ 3270014 h 6373368"/>
              <a:gd name="connsiteX91" fmla="*/ 318723 w 6404625"/>
              <a:gd name="connsiteY91" fmla="*/ 3174955 h 6373368"/>
              <a:gd name="connsiteX92" fmla="*/ 329907 w 6404625"/>
              <a:gd name="connsiteY92" fmla="*/ 3079898 h 6373368"/>
              <a:gd name="connsiteX93" fmla="*/ 343885 w 6404625"/>
              <a:gd name="connsiteY93" fmla="*/ 2984841 h 6373368"/>
              <a:gd name="connsiteX94" fmla="*/ 355069 w 6404625"/>
              <a:gd name="connsiteY94" fmla="*/ 2889784 h 6373368"/>
              <a:gd name="connsiteX95" fmla="*/ 360659 w 6404625"/>
              <a:gd name="connsiteY95" fmla="*/ 2794725 h 6373368"/>
              <a:gd name="connsiteX96" fmla="*/ 360659 w 6404625"/>
              <a:gd name="connsiteY96" fmla="*/ 2702464 h 6373368"/>
              <a:gd name="connsiteX97" fmla="*/ 349477 w 6404625"/>
              <a:gd name="connsiteY97" fmla="*/ 2615793 h 6373368"/>
              <a:gd name="connsiteX98" fmla="*/ 327111 w 6404625"/>
              <a:gd name="connsiteY98" fmla="*/ 2529122 h 6373368"/>
              <a:gd name="connsiteX99" fmla="*/ 293561 w 6404625"/>
              <a:gd name="connsiteY99" fmla="*/ 2448045 h 6373368"/>
              <a:gd name="connsiteX100" fmla="*/ 251625 w 6404625"/>
              <a:gd name="connsiteY100" fmla="*/ 2364170 h 6373368"/>
              <a:gd name="connsiteX101" fmla="*/ 204096 w 6404625"/>
              <a:gd name="connsiteY101" fmla="*/ 2280295 h 6373368"/>
              <a:gd name="connsiteX102" fmla="*/ 153769 w 6404625"/>
              <a:gd name="connsiteY102" fmla="*/ 2196423 h 6373368"/>
              <a:gd name="connsiteX103" fmla="*/ 106240 w 6404625"/>
              <a:gd name="connsiteY103" fmla="*/ 2115344 h 6373368"/>
              <a:gd name="connsiteX104" fmla="*/ 64305 w 6404625"/>
              <a:gd name="connsiteY104" fmla="*/ 2028673 h 6373368"/>
              <a:gd name="connsiteX105" fmla="*/ 30754 w 6404625"/>
              <a:gd name="connsiteY105" fmla="*/ 1944798 h 6373368"/>
              <a:gd name="connsiteX106" fmla="*/ 8387 w 6404625"/>
              <a:gd name="connsiteY106" fmla="*/ 1858129 h 6373368"/>
              <a:gd name="connsiteX107" fmla="*/ 0 w 6404625"/>
              <a:gd name="connsiteY107" fmla="*/ 1768662 h 6373368"/>
              <a:gd name="connsiteX108" fmla="*/ 8387 w 6404625"/>
              <a:gd name="connsiteY108" fmla="*/ 1679195 h 6373368"/>
              <a:gd name="connsiteX109" fmla="*/ 30754 w 6404625"/>
              <a:gd name="connsiteY109" fmla="*/ 1592526 h 6373368"/>
              <a:gd name="connsiteX110" fmla="*/ 64305 w 6404625"/>
              <a:gd name="connsiteY110" fmla="*/ 1508651 h 6373368"/>
              <a:gd name="connsiteX111" fmla="*/ 106240 w 6404625"/>
              <a:gd name="connsiteY111" fmla="*/ 1421980 h 6373368"/>
              <a:gd name="connsiteX112" fmla="*/ 153769 w 6404625"/>
              <a:gd name="connsiteY112" fmla="*/ 1340903 h 6373368"/>
              <a:gd name="connsiteX113" fmla="*/ 204096 w 6404625"/>
              <a:gd name="connsiteY113" fmla="*/ 1257028 h 6373368"/>
              <a:gd name="connsiteX114" fmla="*/ 251625 w 6404625"/>
              <a:gd name="connsiteY114" fmla="*/ 1173153 h 6373368"/>
              <a:gd name="connsiteX115" fmla="*/ 293561 w 6404625"/>
              <a:gd name="connsiteY115" fmla="*/ 1089278 h 6373368"/>
              <a:gd name="connsiteX116" fmla="*/ 327111 w 6404625"/>
              <a:gd name="connsiteY116" fmla="*/ 1008199 h 6373368"/>
              <a:gd name="connsiteX117" fmla="*/ 349477 w 6404625"/>
              <a:gd name="connsiteY117" fmla="*/ 921528 h 6373368"/>
              <a:gd name="connsiteX118" fmla="*/ 360659 w 6404625"/>
              <a:gd name="connsiteY118" fmla="*/ 834859 h 6373368"/>
              <a:gd name="connsiteX119" fmla="*/ 360659 w 6404625"/>
              <a:gd name="connsiteY119" fmla="*/ 742599 h 6373368"/>
              <a:gd name="connsiteX120" fmla="*/ 355069 w 6404625"/>
              <a:gd name="connsiteY120" fmla="*/ 647539 h 6373368"/>
              <a:gd name="connsiteX121" fmla="*/ 343885 w 6404625"/>
              <a:gd name="connsiteY121" fmla="*/ 552482 h 6373368"/>
              <a:gd name="connsiteX122" fmla="*/ 329907 w 6404625"/>
              <a:gd name="connsiteY122" fmla="*/ 457425 h 6373368"/>
              <a:gd name="connsiteX123" fmla="*/ 318723 w 6404625"/>
              <a:gd name="connsiteY123" fmla="*/ 362366 h 6373368"/>
              <a:gd name="connsiteX124" fmla="*/ 310335 w 6404625"/>
              <a:gd name="connsiteY124" fmla="*/ 267309 h 6373368"/>
              <a:gd name="connsiteX125" fmla="*/ 313131 w 6404625"/>
              <a:gd name="connsiteY125" fmla="*/ 177842 h 6373368"/>
              <a:gd name="connsiteX126" fmla="*/ 324315 w 6404625"/>
              <a:gd name="connsiteY126" fmla="*/ 91173 h 6373368"/>
              <a:gd name="connsiteX127" fmla="*/ 349477 w 6404625"/>
              <a:gd name="connsiteY127" fmla="*/ 7296 h 63733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Lst>
            <a:rect l="l" t="t" r="r" b="b"/>
            <a:pathLst>
              <a:path w="6404625" h="6373368">
                <a:moveTo>
                  <a:pt x="353272" y="0"/>
                </a:moveTo>
                <a:lnTo>
                  <a:pt x="6404625" y="0"/>
                </a:lnTo>
                <a:lnTo>
                  <a:pt x="6404625" y="6008204"/>
                </a:lnTo>
                <a:lnTo>
                  <a:pt x="6374459" y="6023890"/>
                </a:lnTo>
                <a:lnTo>
                  <a:pt x="6290584" y="6049055"/>
                </a:lnTo>
                <a:lnTo>
                  <a:pt x="6203913" y="6060237"/>
                </a:lnTo>
                <a:lnTo>
                  <a:pt x="6114448" y="6063033"/>
                </a:lnTo>
                <a:lnTo>
                  <a:pt x="6019391" y="6054644"/>
                </a:lnTo>
                <a:lnTo>
                  <a:pt x="5924332" y="6043462"/>
                </a:lnTo>
                <a:lnTo>
                  <a:pt x="5829275" y="6029482"/>
                </a:lnTo>
                <a:lnTo>
                  <a:pt x="5734216" y="6018300"/>
                </a:lnTo>
                <a:lnTo>
                  <a:pt x="5639159" y="6012708"/>
                </a:lnTo>
                <a:lnTo>
                  <a:pt x="5546898" y="6012708"/>
                </a:lnTo>
                <a:lnTo>
                  <a:pt x="5460227" y="6023890"/>
                </a:lnTo>
                <a:lnTo>
                  <a:pt x="5370760" y="6046258"/>
                </a:lnTo>
                <a:lnTo>
                  <a:pt x="5289681" y="6079807"/>
                </a:lnTo>
                <a:lnTo>
                  <a:pt x="5205808" y="6124541"/>
                </a:lnTo>
                <a:lnTo>
                  <a:pt x="5121933" y="6169276"/>
                </a:lnTo>
                <a:lnTo>
                  <a:pt x="5038061" y="6219598"/>
                </a:lnTo>
                <a:lnTo>
                  <a:pt x="4956981" y="6267129"/>
                </a:lnTo>
                <a:lnTo>
                  <a:pt x="4870311" y="6309065"/>
                </a:lnTo>
                <a:lnTo>
                  <a:pt x="4786435" y="6342614"/>
                </a:lnTo>
                <a:lnTo>
                  <a:pt x="4699765" y="6364982"/>
                </a:lnTo>
                <a:lnTo>
                  <a:pt x="4610299" y="6373368"/>
                </a:lnTo>
                <a:lnTo>
                  <a:pt x="4520833" y="6364982"/>
                </a:lnTo>
                <a:lnTo>
                  <a:pt x="4434163" y="6342614"/>
                </a:lnTo>
                <a:lnTo>
                  <a:pt x="4350289" y="6309065"/>
                </a:lnTo>
                <a:lnTo>
                  <a:pt x="4263617" y="6267129"/>
                </a:lnTo>
                <a:lnTo>
                  <a:pt x="4182539" y="6219598"/>
                </a:lnTo>
                <a:lnTo>
                  <a:pt x="4098666" y="6169276"/>
                </a:lnTo>
                <a:lnTo>
                  <a:pt x="4014791" y="6124541"/>
                </a:lnTo>
                <a:lnTo>
                  <a:pt x="3930916" y="6079807"/>
                </a:lnTo>
                <a:lnTo>
                  <a:pt x="3847041" y="6046258"/>
                </a:lnTo>
                <a:lnTo>
                  <a:pt x="3760372" y="6023890"/>
                </a:lnTo>
                <a:lnTo>
                  <a:pt x="3673701" y="6012708"/>
                </a:lnTo>
                <a:lnTo>
                  <a:pt x="3581438" y="6012708"/>
                </a:lnTo>
                <a:lnTo>
                  <a:pt x="3486381" y="6018300"/>
                </a:lnTo>
                <a:lnTo>
                  <a:pt x="3391322" y="6029482"/>
                </a:lnTo>
                <a:lnTo>
                  <a:pt x="3296265" y="6043462"/>
                </a:lnTo>
                <a:lnTo>
                  <a:pt x="3201210" y="6054644"/>
                </a:lnTo>
                <a:lnTo>
                  <a:pt x="3106151" y="6063033"/>
                </a:lnTo>
                <a:lnTo>
                  <a:pt x="3016684" y="6060237"/>
                </a:lnTo>
                <a:lnTo>
                  <a:pt x="2930015" y="6049055"/>
                </a:lnTo>
                <a:lnTo>
                  <a:pt x="2846140" y="6023890"/>
                </a:lnTo>
                <a:lnTo>
                  <a:pt x="2776243" y="5987546"/>
                </a:lnTo>
                <a:lnTo>
                  <a:pt x="2709145" y="5940017"/>
                </a:lnTo>
                <a:lnTo>
                  <a:pt x="2650432" y="5884101"/>
                </a:lnTo>
                <a:lnTo>
                  <a:pt x="2591719" y="5819798"/>
                </a:lnTo>
                <a:lnTo>
                  <a:pt x="2538599" y="5752697"/>
                </a:lnTo>
                <a:lnTo>
                  <a:pt x="2485480" y="5682802"/>
                </a:lnTo>
                <a:lnTo>
                  <a:pt x="2432360" y="5612908"/>
                </a:lnTo>
                <a:lnTo>
                  <a:pt x="2379237" y="5545809"/>
                </a:lnTo>
                <a:lnTo>
                  <a:pt x="2323320" y="5481502"/>
                </a:lnTo>
                <a:lnTo>
                  <a:pt x="2259018" y="5425586"/>
                </a:lnTo>
                <a:lnTo>
                  <a:pt x="2197511" y="5375263"/>
                </a:lnTo>
                <a:lnTo>
                  <a:pt x="2127614" y="5336121"/>
                </a:lnTo>
                <a:lnTo>
                  <a:pt x="2052128" y="5302573"/>
                </a:lnTo>
                <a:lnTo>
                  <a:pt x="1971049" y="5274612"/>
                </a:lnTo>
                <a:lnTo>
                  <a:pt x="1887176" y="5249450"/>
                </a:lnTo>
                <a:lnTo>
                  <a:pt x="1803301" y="5227084"/>
                </a:lnTo>
                <a:lnTo>
                  <a:pt x="1716630" y="5204720"/>
                </a:lnTo>
                <a:lnTo>
                  <a:pt x="1635551" y="5179557"/>
                </a:lnTo>
                <a:lnTo>
                  <a:pt x="1554473" y="5151597"/>
                </a:lnTo>
                <a:lnTo>
                  <a:pt x="1478988" y="5118049"/>
                </a:lnTo>
                <a:lnTo>
                  <a:pt x="1411887" y="5076112"/>
                </a:lnTo>
                <a:lnTo>
                  <a:pt x="1350380" y="5025785"/>
                </a:lnTo>
                <a:lnTo>
                  <a:pt x="1300053" y="4964279"/>
                </a:lnTo>
                <a:lnTo>
                  <a:pt x="1258117" y="4897178"/>
                </a:lnTo>
                <a:lnTo>
                  <a:pt x="1224567" y="4821691"/>
                </a:lnTo>
                <a:lnTo>
                  <a:pt x="1196609" y="4740614"/>
                </a:lnTo>
                <a:lnTo>
                  <a:pt x="1171447" y="4659533"/>
                </a:lnTo>
                <a:lnTo>
                  <a:pt x="1149080" y="4572865"/>
                </a:lnTo>
                <a:lnTo>
                  <a:pt x="1126714" y="4488990"/>
                </a:lnTo>
                <a:lnTo>
                  <a:pt x="1101552" y="4405115"/>
                </a:lnTo>
                <a:lnTo>
                  <a:pt x="1073593" y="4324036"/>
                </a:lnTo>
                <a:lnTo>
                  <a:pt x="1040045" y="4248549"/>
                </a:lnTo>
                <a:lnTo>
                  <a:pt x="1000902" y="4178654"/>
                </a:lnTo>
                <a:lnTo>
                  <a:pt x="950576" y="4117146"/>
                </a:lnTo>
                <a:lnTo>
                  <a:pt x="894659" y="4052841"/>
                </a:lnTo>
                <a:lnTo>
                  <a:pt x="830356" y="3996926"/>
                </a:lnTo>
                <a:lnTo>
                  <a:pt x="760460" y="3943806"/>
                </a:lnTo>
                <a:lnTo>
                  <a:pt x="690567" y="3890685"/>
                </a:lnTo>
                <a:lnTo>
                  <a:pt x="620671" y="3837564"/>
                </a:lnTo>
                <a:lnTo>
                  <a:pt x="553571" y="3784444"/>
                </a:lnTo>
                <a:lnTo>
                  <a:pt x="489269" y="3725731"/>
                </a:lnTo>
                <a:lnTo>
                  <a:pt x="433350" y="3667021"/>
                </a:lnTo>
                <a:lnTo>
                  <a:pt x="385824" y="3599922"/>
                </a:lnTo>
                <a:lnTo>
                  <a:pt x="349477" y="3530025"/>
                </a:lnTo>
                <a:lnTo>
                  <a:pt x="324315" y="3446150"/>
                </a:lnTo>
                <a:lnTo>
                  <a:pt x="313131" y="3359479"/>
                </a:lnTo>
                <a:lnTo>
                  <a:pt x="310335" y="3270014"/>
                </a:lnTo>
                <a:lnTo>
                  <a:pt x="318723" y="3174955"/>
                </a:lnTo>
                <a:lnTo>
                  <a:pt x="329907" y="3079898"/>
                </a:lnTo>
                <a:lnTo>
                  <a:pt x="343885" y="2984841"/>
                </a:lnTo>
                <a:lnTo>
                  <a:pt x="355069" y="2889784"/>
                </a:lnTo>
                <a:lnTo>
                  <a:pt x="360659" y="2794725"/>
                </a:lnTo>
                <a:lnTo>
                  <a:pt x="360659" y="2702464"/>
                </a:lnTo>
                <a:lnTo>
                  <a:pt x="349477" y="2615793"/>
                </a:lnTo>
                <a:lnTo>
                  <a:pt x="327111" y="2529122"/>
                </a:lnTo>
                <a:lnTo>
                  <a:pt x="293561" y="2448045"/>
                </a:lnTo>
                <a:lnTo>
                  <a:pt x="251625" y="2364170"/>
                </a:lnTo>
                <a:lnTo>
                  <a:pt x="204096" y="2280295"/>
                </a:lnTo>
                <a:lnTo>
                  <a:pt x="153769" y="2196423"/>
                </a:lnTo>
                <a:lnTo>
                  <a:pt x="106240" y="2115344"/>
                </a:lnTo>
                <a:lnTo>
                  <a:pt x="64305" y="2028673"/>
                </a:lnTo>
                <a:lnTo>
                  <a:pt x="30754" y="1944798"/>
                </a:lnTo>
                <a:lnTo>
                  <a:pt x="8387" y="1858129"/>
                </a:lnTo>
                <a:lnTo>
                  <a:pt x="0" y="1768662"/>
                </a:lnTo>
                <a:lnTo>
                  <a:pt x="8387" y="1679195"/>
                </a:lnTo>
                <a:lnTo>
                  <a:pt x="30754" y="1592526"/>
                </a:lnTo>
                <a:lnTo>
                  <a:pt x="64305" y="1508651"/>
                </a:lnTo>
                <a:lnTo>
                  <a:pt x="106240" y="1421980"/>
                </a:lnTo>
                <a:lnTo>
                  <a:pt x="153769" y="1340903"/>
                </a:lnTo>
                <a:lnTo>
                  <a:pt x="204096" y="1257028"/>
                </a:lnTo>
                <a:lnTo>
                  <a:pt x="251625" y="1173153"/>
                </a:lnTo>
                <a:lnTo>
                  <a:pt x="293561" y="1089278"/>
                </a:lnTo>
                <a:lnTo>
                  <a:pt x="327111" y="1008199"/>
                </a:lnTo>
                <a:lnTo>
                  <a:pt x="349477" y="921528"/>
                </a:lnTo>
                <a:lnTo>
                  <a:pt x="360659" y="834859"/>
                </a:lnTo>
                <a:lnTo>
                  <a:pt x="360659" y="742599"/>
                </a:lnTo>
                <a:lnTo>
                  <a:pt x="355069" y="647539"/>
                </a:lnTo>
                <a:lnTo>
                  <a:pt x="343885" y="552482"/>
                </a:lnTo>
                <a:lnTo>
                  <a:pt x="329907" y="457425"/>
                </a:lnTo>
                <a:lnTo>
                  <a:pt x="318723" y="362366"/>
                </a:lnTo>
                <a:lnTo>
                  <a:pt x="310335" y="267309"/>
                </a:lnTo>
                <a:lnTo>
                  <a:pt x="313131" y="177842"/>
                </a:lnTo>
                <a:lnTo>
                  <a:pt x="324315" y="91173"/>
                </a:lnTo>
                <a:lnTo>
                  <a:pt x="349477" y="7296"/>
                </a:lnTo>
                <a:close/>
              </a:path>
            </a:pathLst>
          </a:cu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pic>
        <p:nvPicPr>
          <p:cNvPr id="2050" name="Picture 2" descr="Digital School Binder - Learning at SCUSD">
            <a:extLst>
              <a:ext uri="{FF2B5EF4-FFF2-40B4-BE49-F238E27FC236}">
                <a16:creationId xmlns:a16="http://schemas.microsoft.com/office/drawing/2014/main" id="{6EE0D8DA-B03A-020F-1511-0C04EC81C64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487"/>
          <a:stretch/>
        </p:blipFill>
        <p:spPr bwMode="auto">
          <a:xfrm>
            <a:off x="6003221" y="10"/>
            <a:ext cx="6188779" cy="6157770"/>
          </a:xfrm>
          <a:custGeom>
            <a:avLst/>
            <a:gdLst/>
            <a:ahLst/>
            <a:cxnLst/>
            <a:rect l="l" t="t" r="r" b="b"/>
            <a:pathLst>
              <a:path w="6188779" h="6157780">
                <a:moveTo>
                  <a:pt x="384150" y="0"/>
                </a:moveTo>
                <a:lnTo>
                  <a:pt x="6188779" y="0"/>
                </a:lnTo>
                <a:lnTo>
                  <a:pt x="6188779" y="5757340"/>
                </a:lnTo>
                <a:lnTo>
                  <a:pt x="6142640" y="5790022"/>
                </a:lnTo>
                <a:lnTo>
                  <a:pt x="6076017" y="5824665"/>
                </a:lnTo>
                <a:lnTo>
                  <a:pt x="5996070" y="5848651"/>
                </a:lnTo>
                <a:lnTo>
                  <a:pt x="5913457" y="5859310"/>
                </a:lnTo>
                <a:lnTo>
                  <a:pt x="5828180" y="5861974"/>
                </a:lnTo>
                <a:lnTo>
                  <a:pt x="5737573" y="5853979"/>
                </a:lnTo>
                <a:lnTo>
                  <a:pt x="5646965" y="5843320"/>
                </a:lnTo>
                <a:lnTo>
                  <a:pt x="5556358" y="5829995"/>
                </a:lnTo>
                <a:lnTo>
                  <a:pt x="5465751" y="5819336"/>
                </a:lnTo>
                <a:lnTo>
                  <a:pt x="5375143" y="5814006"/>
                </a:lnTo>
                <a:lnTo>
                  <a:pt x="5287201" y="5814006"/>
                </a:lnTo>
                <a:lnTo>
                  <a:pt x="5204589" y="5824665"/>
                </a:lnTo>
                <a:lnTo>
                  <a:pt x="5119310" y="5845985"/>
                </a:lnTo>
                <a:lnTo>
                  <a:pt x="5042027" y="5877963"/>
                </a:lnTo>
                <a:lnTo>
                  <a:pt x="4962081" y="5920603"/>
                </a:lnTo>
                <a:lnTo>
                  <a:pt x="4882133" y="5963242"/>
                </a:lnTo>
                <a:lnTo>
                  <a:pt x="4802186" y="6011210"/>
                </a:lnTo>
                <a:lnTo>
                  <a:pt x="4724903" y="6056514"/>
                </a:lnTo>
                <a:lnTo>
                  <a:pt x="4642291" y="6096487"/>
                </a:lnTo>
                <a:lnTo>
                  <a:pt x="4562343" y="6128466"/>
                </a:lnTo>
                <a:lnTo>
                  <a:pt x="4479729" y="6149785"/>
                </a:lnTo>
                <a:lnTo>
                  <a:pt x="4394453" y="6157780"/>
                </a:lnTo>
                <a:lnTo>
                  <a:pt x="4309175" y="6149785"/>
                </a:lnTo>
                <a:lnTo>
                  <a:pt x="4226563" y="6128466"/>
                </a:lnTo>
                <a:lnTo>
                  <a:pt x="4146616" y="6096487"/>
                </a:lnTo>
                <a:lnTo>
                  <a:pt x="4064003" y="6056514"/>
                </a:lnTo>
                <a:lnTo>
                  <a:pt x="3986719" y="6011210"/>
                </a:lnTo>
                <a:lnTo>
                  <a:pt x="3906773" y="5963242"/>
                </a:lnTo>
                <a:lnTo>
                  <a:pt x="3826826" y="5920603"/>
                </a:lnTo>
                <a:lnTo>
                  <a:pt x="3746877" y="5877963"/>
                </a:lnTo>
                <a:lnTo>
                  <a:pt x="3666929" y="5845985"/>
                </a:lnTo>
                <a:lnTo>
                  <a:pt x="3584318" y="5824665"/>
                </a:lnTo>
                <a:lnTo>
                  <a:pt x="3501705" y="5814006"/>
                </a:lnTo>
                <a:lnTo>
                  <a:pt x="3413762" y="5814006"/>
                </a:lnTo>
                <a:lnTo>
                  <a:pt x="3323155" y="5819336"/>
                </a:lnTo>
                <a:lnTo>
                  <a:pt x="3232547" y="5829995"/>
                </a:lnTo>
                <a:lnTo>
                  <a:pt x="3141940" y="5843320"/>
                </a:lnTo>
                <a:lnTo>
                  <a:pt x="3051334" y="5853979"/>
                </a:lnTo>
                <a:lnTo>
                  <a:pt x="2960727" y="5861974"/>
                </a:lnTo>
                <a:lnTo>
                  <a:pt x="2875448" y="5859310"/>
                </a:lnTo>
                <a:lnTo>
                  <a:pt x="2792837" y="5848651"/>
                </a:lnTo>
                <a:lnTo>
                  <a:pt x="2712889" y="5824665"/>
                </a:lnTo>
                <a:lnTo>
                  <a:pt x="2646265" y="5790022"/>
                </a:lnTo>
                <a:lnTo>
                  <a:pt x="2582308" y="5744719"/>
                </a:lnTo>
                <a:lnTo>
                  <a:pt x="2526343" y="5691420"/>
                </a:lnTo>
                <a:lnTo>
                  <a:pt x="2470381" y="5630127"/>
                </a:lnTo>
                <a:lnTo>
                  <a:pt x="2419747" y="5566168"/>
                </a:lnTo>
                <a:lnTo>
                  <a:pt x="2369114" y="5499546"/>
                </a:lnTo>
                <a:lnTo>
                  <a:pt x="2318480" y="5432923"/>
                </a:lnTo>
                <a:lnTo>
                  <a:pt x="2267846" y="5368966"/>
                </a:lnTo>
                <a:lnTo>
                  <a:pt x="2214548" y="5307671"/>
                </a:lnTo>
                <a:lnTo>
                  <a:pt x="2153255" y="5254373"/>
                </a:lnTo>
                <a:lnTo>
                  <a:pt x="2094628" y="5206405"/>
                </a:lnTo>
                <a:lnTo>
                  <a:pt x="2028005" y="5169096"/>
                </a:lnTo>
                <a:lnTo>
                  <a:pt x="1956051" y="5137117"/>
                </a:lnTo>
                <a:lnTo>
                  <a:pt x="1878768" y="5110467"/>
                </a:lnTo>
                <a:lnTo>
                  <a:pt x="1798822" y="5086483"/>
                </a:lnTo>
                <a:lnTo>
                  <a:pt x="1718873" y="5065163"/>
                </a:lnTo>
                <a:lnTo>
                  <a:pt x="1636260" y="5043845"/>
                </a:lnTo>
                <a:lnTo>
                  <a:pt x="1558978" y="5019861"/>
                </a:lnTo>
                <a:lnTo>
                  <a:pt x="1481696" y="4993211"/>
                </a:lnTo>
                <a:lnTo>
                  <a:pt x="1409744" y="4961233"/>
                </a:lnTo>
                <a:lnTo>
                  <a:pt x="1345785" y="4921259"/>
                </a:lnTo>
                <a:lnTo>
                  <a:pt x="1287158" y="4873289"/>
                </a:lnTo>
                <a:lnTo>
                  <a:pt x="1239188" y="4814663"/>
                </a:lnTo>
                <a:lnTo>
                  <a:pt x="1199215" y="4750703"/>
                </a:lnTo>
                <a:lnTo>
                  <a:pt x="1167237" y="4678752"/>
                </a:lnTo>
                <a:lnTo>
                  <a:pt x="1140586" y="4601469"/>
                </a:lnTo>
                <a:lnTo>
                  <a:pt x="1116602" y="4524185"/>
                </a:lnTo>
                <a:lnTo>
                  <a:pt x="1095283" y="4441574"/>
                </a:lnTo>
                <a:lnTo>
                  <a:pt x="1073962" y="4361626"/>
                </a:lnTo>
                <a:lnTo>
                  <a:pt x="1049979" y="4281677"/>
                </a:lnTo>
                <a:lnTo>
                  <a:pt x="1023330" y="4204395"/>
                </a:lnTo>
                <a:lnTo>
                  <a:pt x="991351" y="4132443"/>
                </a:lnTo>
                <a:lnTo>
                  <a:pt x="954043" y="4065820"/>
                </a:lnTo>
                <a:lnTo>
                  <a:pt x="906073" y="4007191"/>
                </a:lnTo>
                <a:lnTo>
                  <a:pt x="852774" y="3945898"/>
                </a:lnTo>
                <a:lnTo>
                  <a:pt x="791482" y="3892600"/>
                </a:lnTo>
                <a:lnTo>
                  <a:pt x="724858" y="3841967"/>
                </a:lnTo>
                <a:lnTo>
                  <a:pt x="658236" y="3791333"/>
                </a:lnTo>
                <a:lnTo>
                  <a:pt x="591613" y="3740699"/>
                </a:lnTo>
                <a:lnTo>
                  <a:pt x="527656" y="3690067"/>
                </a:lnTo>
                <a:lnTo>
                  <a:pt x="466362" y="3634102"/>
                </a:lnTo>
                <a:lnTo>
                  <a:pt x="413063" y="3578140"/>
                </a:lnTo>
                <a:lnTo>
                  <a:pt x="367761" y="3514183"/>
                </a:lnTo>
                <a:lnTo>
                  <a:pt x="333116" y="3447559"/>
                </a:lnTo>
                <a:lnTo>
                  <a:pt x="309132" y="3367611"/>
                </a:lnTo>
                <a:lnTo>
                  <a:pt x="298471" y="3284998"/>
                </a:lnTo>
                <a:lnTo>
                  <a:pt x="295806" y="3199721"/>
                </a:lnTo>
                <a:lnTo>
                  <a:pt x="303802" y="3109114"/>
                </a:lnTo>
                <a:lnTo>
                  <a:pt x="314462" y="3018506"/>
                </a:lnTo>
                <a:lnTo>
                  <a:pt x="327785" y="2927901"/>
                </a:lnTo>
                <a:lnTo>
                  <a:pt x="338446" y="2837293"/>
                </a:lnTo>
                <a:lnTo>
                  <a:pt x="343774" y="2746686"/>
                </a:lnTo>
                <a:lnTo>
                  <a:pt x="343774" y="2658743"/>
                </a:lnTo>
                <a:lnTo>
                  <a:pt x="333116" y="2576130"/>
                </a:lnTo>
                <a:lnTo>
                  <a:pt x="311796" y="2493517"/>
                </a:lnTo>
                <a:lnTo>
                  <a:pt x="279817" y="2416237"/>
                </a:lnTo>
                <a:lnTo>
                  <a:pt x="239844" y="2336288"/>
                </a:lnTo>
                <a:lnTo>
                  <a:pt x="194541" y="2256340"/>
                </a:lnTo>
                <a:lnTo>
                  <a:pt x="146571" y="2176393"/>
                </a:lnTo>
                <a:lnTo>
                  <a:pt x="101267" y="2099111"/>
                </a:lnTo>
                <a:lnTo>
                  <a:pt x="61293" y="2016498"/>
                </a:lnTo>
                <a:lnTo>
                  <a:pt x="29315" y="1936550"/>
                </a:lnTo>
                <a:lnTo>
                  <a:pt x="7995" y="1853939"/>
                </a:lnTo>
                <a:lnTo>
                  <a:pt x="0" y="1768660"/>
                </a:lnTo>
                <a:lnTo>
                  <a:pt x="7995" y="1683383"/>
                </a:lnTo>
                <a:lnTo>
                  <a:pt x="29315" y="1600771"/>
                </a:lnTo>
                <a:lnTo>
                  <a:pt x="61293" y="1520824"/>
                </a:lnTo>
                <a:lnTo>
                  <a:pt x="101267" y="1438211"/>
                </a:lnTo>
                <a:lnTo>
                  <a:pt x="146571" y="1360929"/>
                </a:lnTo>
                <a:lnTo>
                  <a:pt x="194541" y="1280980"/>
                </a:lnTo>
                <a:lnTo>
                  <a:pt x="239844" y="1201034"/>
                </a:lnTo>
                <a:lnTo>
                  <a:pt x="279817" y="1121085"/>
                </a:lnTo>
                <a:lnTo>
                  <a:pt x="311796" y="1043803"/>
                </a:lnTo>
                <a:lnTo>
                  <a:pt x="333116" y="961190"/>
                </a:lnTo>
                <a:lnTo>
                  <a:pt x="343774" y="878578"/>
                </a:lnTo>
                <a:lnTo>
                  <a:pt x="343774" y="790636"/>
                </a:lnTo>
                <a:lnTo>
                  <a:pt x="338446" y="700029"/>
                </a:lnTo>
                <a:lnTo>
                  <a:pt x="327785" y="609422"/>
                </a:lnTo>
                <a:lnTo>
                  <a:pt x="314462" y="518814"/>
                </a:lnTo>
                <a:lnTo>
                  <a:pt x="303802" y="428207"/>
                </a:lnTo>
                <a:lnTo>
                  <a:pt x="295806" y="337599"/>
                </a:lnTo>
                <a:lnTo>
                  <a:pt x="298471" y="252322"/>
                </a:lnTo>
                <a:lnTo>
                  <a:pt x="309132" y="169710"/>
                </a:lnTo>
                <a:lnTo>
                  <a:pt x="333116" y="89761"/>
                </a:lnTo>
                <a:lnTo>
                  <a:pt x="367761" y="23140"/>
                </a:lnTo>
                <a:close/>
              </a:path>
            </a:pathLst>
          </a:custGeom>
          <a:noFill/>
          <a:ln w="203200">
            <a:no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3245103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AF3BD6-ACD3-8B0F-3765-FBD3649D0D1C}"/>
              </a:ext>
            </a:extLst>
          </p:cNvPr>
          <p:cNvSpPr>
            <a:spLocks noGrp="1"/>
          </p:cNvSpPr>
          <p:nvPr>
            <p:ph type="title"/>
          </p:nvPr>
        </p:nvSpPr>
        <p:spPr>
          <a:xfrm>
            <a:off x="838200" y="278037"/>
            <a:ext cx="10515600" cy="1325563"/>
          </a:xfrm>
        </p:spPr>
        <p:txBody>
          <a:bodyPr/>
          <a:lstStyle/>
          <a:p>
            <a:r>
              <a:rPr lang="en-US" dirty="0"/>
              <a:t>Activity Example: Intro to Doing &amp; Feeling</a:t>
            </a:r>
          </a:p>
        </p:txBody>
      </p:sp>
      <p:pic>
        <p:nvPicPr>
          <p:cNvPr id="6" name="Picture 5">
            <a:extLst>
              <a:ext uri="{FF2B5EF4-FFF2-40B4-BE49-F238E27FC236}">
                <a16:creationId xmlns:a16="http://schemas.microsoft.com/office/drawing/2014/main" id="{D5FD65F6-636C-C386-F368-0801FD9C32EA}"/>
              </a:ext>
            </a:extLst>
          </p:cNvPr>
          <p:cNvPicPr>
            <a:picLocks noChangeAspect="1"/>
          </p:cNvPicPr>
          <p:nvPr/>
        </p:nvPicPr>
        <p:blipFill>
          <a:blip r:embed="rId3"/>
          <a:stretch>
            <a:fillRect/>
          </a:stretch>
        </p:blipFill>
        <p:spPr>
          <a:xfrm>
            <a:off x="838200" y="1631128"/>
            <a:ext cx="2134830" cy="4504929"/>
          </a:xfrm>
          <a:prstGeom prst="rect">
            <a:avLst/>
          </a:prstGeom>
        </p:spPr>
      </p:pic>
      <p:pic>
        <p:nvPicPr>
          <p:cNvPr id="7" name="Picture 6">
            <a:extLst>
              <a:ext uri="{FF2B5EF4-FFF2-40B4-BE49-F238E27FC236}">
                <a16:creationId xmlns:a16="http://schemas.microsoft.com/office/drawing/2014/main" id="{C04E1D7F-4DAC-1F85-B1AA-0F9CDB9330D4}"/>
              </a:ext>
            </a:extLst>
          </p:cNvPr>
          <p:cNvPicPr>
            <a:picLocks noChangeAspect="1"/>
          </p:cNvPicPr>
          <p:nvPr/>
        </p:nvPicPr>
        <p:blipFill>
          <a:blip r:embed="rId4"/>
          <a:stretch>
            <a:fillRect/>
          </a:stretch>
        </p:blipFill>
        <p:spPr>
          <a:xfrm>
            <a:off x="3581966" y="1613148"/>
            <a:ext cx="2134830" cy="4540889"/>
          </a:xfrm>
          <a:prstGeom prst="rect">
            <a:avLst/>
          </a:prstGeom>
        </p:spPr>
      </p:pic>
      <p:pic>
        <p:nvPicPr>
          <p:cNvPr id="8" name="Picture 7">
            <a:extLst>
              <a:ext uri="{FF2B5EF4-FFF2-40B4-BE49-F238E27FC236}">
                <a16:creationId xmlns:a16="http://schemas.microsoft.com/office/drawing/2014/main" id="{165E8E64-E9C4-3299-9BDD-F9ABE2E1E87B}"/>
              </a:ext>
            </a:extLst>
          </p:cNvPr>
          <p:cNvPicPr>
            <a:picLocks noChangeAspect="1"/>
          </p:cNvPicPr>
          <p:nvPr/>
        </p:nvPicPr>
        <p:blipFill>
          <a:blip r:embed="rId5"/>
          <a:stretch>
            <a:fillRect/>
          </a:stretch>
        </p:blipFill>
        <p:spPr>
          <a:xfrm>
            <a:off x="6325732" y="1612590"/>
            <a:ext cx="2134830" cy="4542004"/>
          </a:xfrm>
          <a:prstGeom prst="rect">
            <a:avLst/>
          </a:prstGeom>
        </p:spPr>
      </p:pic>
      <p:pic>
        <p:nvPicPr>
          <p:cNvPr id="9" name="Picture 8">
            <a:extLst>
              <a:ext uri="{FF2B5EF4-FFF2-40B4-BE49-F238E27FC236}">
                <a16:creationId xmlns:a16="http://schemas.microsoft.com/office/drawing/2014/main" id="{A5570408-0A1E-7DE2-B976-7E6C1657C166}"/>
              </a:ext>
            </a:extLst>
          </p:cNvPr>
          <p:cNvPicPr>
            <a:picLocks noChangeAspect="1"/>
          </p:cNvPicPr>
          <p:nvPr/>
        </p:nvPicPr>
        <p:blipFill>
          <a:blip r:embed="rId3"/>
          <a:stretch>
            <a:fillRect/>
          </a:stretch>
        </p:blipFill>
        <p:spPr>
          <a:xfrm>
            <a:off x="9069498" y="1612590"/>
            <a:ext cx="2152399" cy="4542004"/>
          </a:xfrm>
          <a:prstGeom prst="rect">
            <a:avLst/>
          </a:prstGeom>
        </p:spPr>
      </p:pic>
      <p:cxnSp>
        <p:nvCxnSpPr>
          <p:cNvPr id="21" name="Straight Arrow Connector 20">
            <a:extLst>
              <a:ext uri="{FF2B5EF4-FFF2-40B4-BE49-F238E27FC236}">
                <a16:creationId xmlns:a16="http://schemas.microsoft.com/office/drawing/2014/main" id="{92F06A9C-CAEF-B7CE-56C6-DD4F016AA87D}"/>
              </a:ext>
            </a:extLst>
          </p:cNvPr>
          <p:cNvCxnSpPr>
            <a:cxnSpLocks/>
            <a:stCxn id="6" idx="3"/>
            <a:endCxn id="7" idx="1"/>
          </p:cNvCxnSpPr>
          <p:nvPr/>
        </p:nvCxnSpPr>
        <p:spPr>
          <a:xfrm>
            <a:off x="2973030" y="3883593"/>
            <a:ext cx="60893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3" name="Straight Arrow Connector 42">
            <a:extLst>
              <a:ext uri="{FF2B5EF4-FFF2-40B4-BE49-F238E27FC236}">
                <a16:creationId xmlns:a16="http://schemas.microsoft.com/office/drawing/2014/main" id="{2FCDDE9F-97D8-8311-6B9C-CE8BB60124AC}"/>
              </a:ext>
            </a:extLst>
          </p:cNvPr>
          <p:cNvCxnSpPr>
            <a:stCxn id="7" idx="3"/>
            <a:endCxn id="8" idx="1"/>
          </p:cNvCxnSpPr>
          <p:nvPr/>
        </p:nvCxnSpPr>
        <p:spPr>
          <a:xfrm flipV="1">
            <a:off x="5716796" y="3883592"/>
            <a:ext cx="608936"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5" name="Straight Arrow Connector 44">
            <a:extLst>
              <a:ext uri="{FF2B5EF4-FFF2-40B4-BE49-F238E27FC236}">
                <a16:creationId xmlns:a16="http://schemas.microsoft.com/office/drawing/2014/main" id="{0766E7CA-6C10-8F91-03CA-CCE78ADE0486}"/>
              </a:ext>
            </a:extLst>
          </p:cNvPr>
          <p:cNvCxnSpPr>
            <a:stCxn id="8" idx="3"/>
            <a:endCxn id="9" idx="1"/>
          </p:cNvCxnSpPr>
          <p:nvPr/>
        </p:nvCxnSpPr>
        <p:spPr>
          <a:xfrm>
            <a:off x="8460562" y="3883592"/>
            <a:ext cx="60893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87156619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AF3BD6-ACD3-8B0F-3765-FBD3649D0D1C}"/>
              </a:ext>
            </a:extLst>
          </p:cNvPr>
          <p:cNvSpPr>
            <a:spLocks noGrp="1"/>
          </p:cNvSpPr>
          <p:nvPr>
            <p:ph type="title"/>
          </p:nvPr>
        </p:nvSpPr>
        <p:spPr>
          <a:xfrm>
            <a:off x="838200" y="278037"/>
            <a:ext cx="10515600" cy="1325563"/>
          </a:xfrm>
        </p:spPr>
        <p:txBody>
          <a:bodyPr/>
          <a:lstStyle/>
          <a:p>
            <a:r>
              <a:rPr lang="en-US" dirty="0"/>
              <a:t>Activity Example: Intro to Doing &amp; Feeling</a:t>
            </a:r>
          </a:p>
        </p:txBody>
      </p:sp>
      <p:pic>
        <p:nvPicPr>
          <p:cNvPr id="3" name="Picture 2">
            <a:extLst>
              <a:ext uri="{FF2B5EF4-FFF2-40B4-BE49-F238E27FC236}">
                <a16:creationId xmlns:a16="http://schemas.microsoft.com/office/drawing/2014/main" id="{A7B6E0AC-1133-4D36-D4CD-51D7AAC23458}"/>
              </a:ext>
            </a:extLst>
          </p:cNvPr>
          <p:cNvPicPr>
            <a:picLocks noChangeAspect="1"/>
          </p:cNvPicPr>
          <p:nvPr/>
        </p:nvPicPr>
        <p:blipFill>
          <a:blip r:embed="rId3"/>
          <a:stretch>
            <a:fillRect/>
          </a:stretch>
        </p:blipFill>
        <p:spPr>
          <a:xfrm>
            <a:off x="838200" y="1633878"/>
            <a:ext cx="2044440" cy="4402757"/>
          </a:xfrm>
          <a:prstGeom prst="rect">
            <a:avLst/>
          </a:prstGeom>
        </p:spPr>
      </p:pic>
      <p:pic>
        <p:nvPicPr>
          <p:cNvPr id="4" name="Picture 3">
            <a:extLst>
              <a:ext uri="{FF2B5EF4-FFF2-40B4-BE49-F238E27FC236}">
                <a16:creationId xmlns:a16="http://schemas.microsoft.com/office/drawing/2014/main" id="{5201D744-F878-B836-F8FF-E63F59FB3DF8}"/>
              </a:ext>
            </a:extLst>
          </p:cNvPr>
          <p:cNvPicPr>
            <a:picLocks noChangeAspect="1"/>
          </p:cNvPicPr>
          <p:nvPr/>
        </p:nvPicPr>
        <p:blipFill>
          <a:blip r:embed="rId4"/>
          <a:stretch>
            <a:fillRect/>
          </a:stretch>
        </p:blipFill>
        <p:spPr>
          <a:xfrm>
            <a:off x="3590301" y="1660409"/>
            <a:ext cx="2044440" cy="4349694"/>
          </a:xfrm>
          <a:prstGeom prst="rect">
            <a:avLst/>
          </a:prstGeom>
        </p:spPr>
      </p:pic>
      <p:pic>
        <p:nvPicPr>
          <p:cNvPr id="5" name="Picture 4">
            <a:extLst>
              <a:ext uri="{FF2B5EF4-FFF2-40B4-BE49-F238E27FC236}">
                <a16:creationId xmlns:a16="http://schemas.microsoft.com/office/drawing/2014/main" id="{2491FCBC-8237-3048-8D02-9B64FEA0E542}"/>
              </a:ext>
            </a:extLst>
          </p:cNvPr>
          <p:cNvPicPr>
            <a:picLocks noChangeAspect="1"/>
          </p:cNvPicPr>
          <p:nvPr/>
        </p:nvPicPr>
        <p:blipFill>
          <a:blip r:embed="rId5"/>
          <a:stretch>
            <a:fillRect/>
          </a:stretch>
        </p:blipFill>
        <p:spPr>
          <a:xfrm>
            <a:off x="6342402" y="1643630"/>
            <a:ext cx="2061281" cy="4383253"/>
          </a:xfrm>
          <a:prstGeom prst="rect">
            <a:avLst/>
          </a:prstGeom>
        </p:spPr>
      </p:pic>
      <p:pic>
        <p:nvPicPr>
          <p:cNvPr id="10" name="Picture 9">
            <a:extLst>
              <a:ext uri="{FF2B5EF4-FFF2-40B4-BE49-F238E27FC236}">
                <a16:creationId xmlns:a16="http://schemas.microsoft.com/office/drawing/2014/main" id="{528F58F4-6229-4D41-FF7E-D6C60B3346F1}"/>
              </a:ext>
            </a:extLst>
          </p:cNvPr>
          <p:cNvPicPr>
            <a:picLocks noChangeAspect="1"/>
          </p:cNvPicPr>
          <p:nvPr/>
        </p:nvPicPr>
        <p:blipFill>
          <a:blip r:embed="rId6"/>
          <a:stretch>
            <a:fillRect/>
          </a:stretch>
        </p:blipFill>
        <p:spPr>
          <a:xfrm>
            <a:off x="9111343" y="1643630"/>
            <a:ext cx="2049549" cy="4383253"/>
          </a:xfrm>
          <a:prstGeom prst="rect">
            <a:avLst/>
          </a:prstGeom>
        </p:spPr>
      </p:pic>
      <p:cxnSp>
        <p:nvCxnSpPr>
          <p:cNvPr id="15" name="Straight Arrow Connector 14">
            <a:extLst>
              <a:ext uri="{FF2B5EF4-FFF2-40B4-BE49-F238E27FC236}">
                <a16:creationId xmlns:a16="http://schemas.microsoft.com/office/drawing/2014/main" id="{8E6F1211-CB95-3C10-B7ED-66F9F3BE629C}"/>
              </a:ext>
            </a:extLst>
          </p:cNvPr>
          <p:cNvCxnSpPr>
            <a:stCxn id="3" idx="3"/>
            <a:endCxn id="4" idx="1"/>
          </p:cNvCxnSpPr>
          <p:nvPr/>
        </p:nvCxnSpPr>
        <p:spPr>
          <a:xfrm flipV="1">
            <a:off x="2882640" y="3835256"/>
            <a:ext cx="707661"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7" name="Straight Arrow Connector 16">
            <a:extLst>
              <a:ext uri="{FF2B5EF4-FFF2-40B4-BE49-F238E27FC236}">
                <a16:creationId xmlns:a16="http://schemas.microsoft.com/office/drawing/2014/main" id="{D191101A-BA57-AFB7-C029-83FB1A982352}"/>
              </a:ext>
            </a:extLst>
          </p:cNvPr>
          <p:cNvCxnSpPr>
            <a:stCxn id="4" idx="3"/>
            <a:endCxn id="5" idx="1"/>
          </p:cNvCxnSpPr>
          <p:nvPr/>
        </p:nvCxnSpPr>
        <p:spPr>
          <a:xfrm>
            <a:off x="5634741" y="3835256"/>
            <a:ext cx="707661"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9" name="Straight Arrow Connector 18">
            <a:extLst>
              <a:ext uri="{FF2B5EF4-FFF2-40B4-BE49-F238E27FC236}">
                <a16:creationId xmlns:a16="http://schemas.microsoft.com/office/drawing/2014/main" id="{21BBFA93-795F-4E3A-9D45-65682339CEE6}"/>
              </a:ext>
            </a:extLst>
          </p:cNvPr>
          <p:cNvCxnSpPr>
            <a:stCxn id="5" idx="3"/>
            <a:endCxn id="10" idx="1"/>
          </p:cNvCxnSpPr>
          <p:nvPr/>
        </p:nvCxnSpPr>
        <p:spPr>
          <a:xfrm>
            <a:off x="8403683" y="3835257"/>
            <a:ext cx="70766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14149389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68A1EB-097D-CEBB-5C57-A17A96BDF8C0}"/>
              </a:ext>
            </a:extLst>
          </p:cNvPr>
          <p:cNvSpPr>
            <a:spLocks noGrp="1"/>
          </p:cNvSpPr>
          <p:nvPr>
            <p:ph type="title"/>
          </p:nvPr>
        </p:nvSpPr>
        <p:spPr/>
        <p:txBody>
          <a:bodyPr/>
          <a:lstStyle/>
          <a:p>
            <a:r>
              <a:rPr lang="en-US" dirty="0"/>
              <a:t>Activity Example: Intro to Doing &amp; Feeling</a:t>
            </a:r>
          </a:p>
        </p:txBody>
      </p:sp>
      <p:sp>
        <p:nvSpPr>
          <p:cNvPr id="3" name="Content Placeholder 2">
            <a:extLst>
              <a:ext uri="{FF2B5EF4-FFF2-40B4-BE49-F238E27FC236}">
                <a16:creationId xmlns:a16="http://schemas.microsoft.com/office/drawing/2014/main" id="{773AB2C1-7064-4A7E-E279-E59CC6BCAE6B}"/>
              </a:ext>
            </a:extLst>
          </p:cNvPr>
          <p:cNvSpPr>
            <a:spLocks noGrp="1"/>
          </p:cNvSpPr>
          <p:nvPr>
            <p:ph idx="1"/>
          </p:nvPr>
        </p:nvSpPr>
        <p:spPr/>
        <p:txBody>
          <a:bodyPr/>
          <a:lstStyle/>
          <a:p>
            <a:endParaRPr lang="en-US" dirty="0"/>
          </a:p>
        </p:txBody>
      </p:sp>
      <p:pic>
        <p:nvPicPr>
          <p:cNvPr id="5" name="Picture 4">
            <a:extLst>
              <a:ext uri="{FF2B5EF4-FFF2-40B4-BE49-F238E27FC236}">
                <a16:creationId xmlns:a16="http://schemas.microsoft.com/office/drawing/2014/main" id="{F261742E-F2FC-C4C3-C9AC-1C78493CF040}"/>
              </a:ext>
            </a:extLst>
          </p:cNvPr>
          <p:cNvPicPr>
            <a:picLocks noChangeAspect="1"/>
          </p:cNvPicPr>
          <p:nvPr/>
        </p:nvPicPr>
        <p:blipFill>
          <a:blip r:embed="rId3"/>
          <a:stretch>
            <a:fillRect/>
          </a:stretch>
        </p:blipFill>
        <p:spPr>
          <a:xfrm>
            <a:off x="2601686" y="1842351"/>
            <a:ext cx="2116011" cy="4474029"/>
          </a:xfrm>
          <a:prstGeom prst="rect">
            <a:avLst/>
          </a:prstGeom>
        </p:spPr>
      </p:pic>
      <p:pic>
        <p:nvPicPr>
          <p:cNvPr id="7" name="Picture 6">
            <a:extLst>
              <a:ext uri="{FF2B5EF4-FFF2-40B4-BE49-F238E27FC236}">
                <a16:creationId xmlns:a16="http://schemas.microsoft.com/office/drawing/2014/main" id="{A8843A93-DFAF-DDC9-4CE2-97264B2D5860}"/>
              </a:ext>
            </a:extLst>
          </p:cNvPr>
          <p:cNvPicPr>
            <a:picLocks noChangeAspect="1"/>
          </p:cNvPicPr>
          <p:nvPr/>
        </p:nvPicPr>
        <p:blipFill>
          <a:blip r:embed="rId4"/>
          <a:stretch>
            <a:fillRect/>
          </a:stretch>
        </p:blipFill>
        <p:spPr>
          <a:xfrm>
            <a:off x="5148313" y="1813105"/>
            <a:ext cx="2116011" cy="4532521"/>
          </a:xfrm>
          <a:prstGeom prst="rect">
            <a:avLst/>
          </a:prstGeom>
        </p:spPr>
      </p:pic>
      <p:cxnSp>
        <p:nvCxnSpPr>
          <p:cNvPr id="9" name="Straight Arrow Connector 8">
            <a:extLst>
              <a:ext uri="{FF2B5EF4-FFF2-40B4-BE49-F238E27FC236}">
                <a16:creationId xmlns:a16="http://schemas.microsoft.com/office/drawing/2014/main" id="{574CF902-1CB3-DACC-0C83-B764D47BB8ED}"/>
              </a:ext>
            </a:extLst>
          </p:cNvPr>
          <p:cNvCxnSpPr>
            <a:cxnSpLocks/>
            <a:stCxn id="5" idx="3"/>
            <a:endCxn id="7" idx="1"/>
          </p:cNvCxnSpPr>
          <p:nvPr/>
        </p:nvCxnSpPr>
        <p:spPr>
          <a:xfrm>
            <a:off x="4717697" y="4079366"/>
            <a:ext cx="43061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12" name="Picture 11">
            <a:extLst>
              <a:ext uri="{FF2B5EF4-FFF2-40B4-BE49-F238E27FC236}">
                <a16:creationId xmlns:a16="http://schemas.microsoft.com/office/drawing/2014/main" id="{9FD18230-2596-F3E1-065D-40A3861DC08D}"/>
              </a:ext>
            </a:extLst>
          </p:cNvPr>
          <p:cNvPicPr>
            <a:picLocks noChangeAspect="1"/>
          </p:cNvPicPr>
          <p:nvPr/>
        </p:nvPicPr>
        <p:blipFill>
          <a:blip r:embed="rId5"/>
          <a:stretch>
            <a:fillRect/>
          </a:stretch>
        </p:blipFill>
        <p:spPr>
          <a:xfrm>
            <a:off x="7756312" y="1825625"/>
            <a:ext cx="2116011" cy="4507480"/>
          </a:xfrm>
          <a:prstGeom prst="rect">
            <a:avLst/>
          </a:prstGeom>
        </p:spPr>
      </p:pic>
      <p:cxnSp>
        <p:nvCxnSpPr>
          <p:cNvPr id="14" name="Straight Arrow Connector 13">
            <a:extLst>
              <a:ext uri="{FF2B5EF4-FFF2-40B4-BE49-F238E27FC236}">
                <a16:creationId xmlns:a16="http://schemas.microsoft.com/office/drawing/2014/main" id="{3D8D62BE-ECDF-9BEF-C8E5-8A2CAE96B7A2}"/>
              </a:ext>
            </a:extLst>
          </p:cNvPr>
          <p:cNvCxnSpPr>
            <a:cxnSpLocks/>
            <a:endCxn id="12" idx="1"/>
          </p:cNvCxnSpPr>
          <p:nvPr/>
        </p:nvCxnSpPr>
        <p:spPr>
          <a:xfrm flipV="1">
            <a:off x="7264324" y="4079365"/>
            <a:ext cx="491988" cy="210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8135657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8">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7CD2E64-CB69-FBE9-38F0-2E3142294725}"/>
              </a:ext>
            </a:extLst>
          </p:cNvPr>
          <p:cNvSpPr>
            <a:spLocks noGrp="1"/>
          </p:cNvSpPr>
          <p:nvPr>
            <p:ph type="title"/>
          </p:nvPr>
        </p:nvSpPr>
        <p:spPr>
          <a:xfrm>
            <a:off x="838200" y="557188"/>
            <a:ext cx="10515600" cy="1133499"/>
          </a:xfrm>
        </p:spPr>
        <p:txBody>
          <a:bodyPr>
            <a:normAutofit/>
          </a:bodyPr>
          <a:lstStyle/>
          <a:p>
            <a:pPr algn="ctr"/>
            <a:r>
              <a:rPr lang="en-US" sz="4800"/>
              <a:t>Session Example: Intro to Doing &amp; Feeling</a:t>
            </a:r>
          </a:p>
        </p:txBody>
      </p:sp>
      <p:graphicFrame>
        <p:nvGraphicFramePr>
          <p:cNvPr id="6" name="Content Placeholder 3">
            <a:extLst>
              <a:ext uri="{FF2B5EF4-FFF2-40B4-BE49-F238E27FC236}">
                <a16:creationId xmlns:a16="http://schemas.microsoft.com/office/drawing/2014/main" id="{708FB29F-BB57-37C0-3D46-F071693C3984}"/>
              </a:ext>
            </a:extLst>
          </p:cNvPr>
          <p:cNvGraphicFramePr>
            <a:graphicFrameLocks noGrp="1"/>
          </p:cNvGraphicFramePr>
          <p:nvPr>
            <p:ph idx="1"/>
            <p:extLst>
              <p:ext uri="{D42A27DB-BD31-4B8C-83A1-F6EECF244321}">
                <p14:modId xmlns:p14="http://schemas.microsoft.com/office/powerpoint/2010/main" val="3162433812"/>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40815765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9">
            <a:extLst>
              <a:ext uri="{FF2B5EF4-FFF2-40B4-BE49-F238E27FC236}">
                <a16:creationId xmlns:a16="http://schemas.microsoft.com/office/drawing/2014/main" id="{C2EFD392-2680-41C6-A661-44456DAA5A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A095B8D-2EEE-A358-B643-B3FFCA6F9F22}"/>
              </a:ext>
            </a:extLst>
          </p:cNvPr>
          <p:cNvSpPr>
            <a:spLocks noGrp="1"/>
          </p:cNvSpPr>
          <p:nvPr>
            <p:ph type="title"/>
          </p:nvPr>
        </p:nvSpPr>
        <p:spPr>
          <a:xfrm>
            <a:off x="1252800" y="662399"/>
            <a:ext cx="5995987" cy="1494000"/>
          </a:xfrm>
        </p:spPr>
        <p:txBody>
          <a:bodyPr vert="horz" lIns="91440" tIns="45720" rIns="91440" bIns="45720" rtlCol="0" anchor="t">
            <a:normAutofit/>
          </a:bodyPr>
          <a:lstStyle/>
          <a:p>
            <a:r>
              <a:rPr lang="en-US" kern="1200">
                <a:latin typeface="+mj-lt"/>
                <a:ea typeface="+mj-ea"/>
                <a:cs typeface="+mj-cs"/>
              </a:rPr>
              <a:t>Practice Example: Being &amp; Feeling</a:t>
            </a:r>
          </a:p>
        </p:txBody>
      </p:sp>
      <p:grpSp>
        <p:nvGrpSpPr>
          <p:cNvPr id="22" name="Group 21">
            <a:extLst>
              <a:ext uri="{FF2B5EF4-FFF2-40B4-BE49-F238E27FC236}">
                <a16:creationId xmlns:a16="http://schemas.microsoft.com/office/drawing/2014/main" id="{DE866941-6974-471B-96DC-E7D4042D816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885825" cy="6858000"/>
            <a:chOff x="0" y="0"/>
            <a:chExt cx="885825" cy="6858000"/>
          </a:xfrm>
        </p:grpSpPr>
        <p:sp>
          <p:nvSpPr>
            <p:cNvPr id="23" name="Freeform 6">
              <a:extLst>
                <a:ext uri="{FF2B5EF4-FFF2-40B4-BE49-F238E27FC236}">
                  <a16:creationId xmlns:a16="http://schemas.microsoft.com/office/drawing/2014/main" id="{FDDB1D1D-BDCA-4CA7-ACB7-28E2D624CB3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rgbClr val="FFFFFF"/>
            </a:solidFill>
            <a:ln w="0">
              <a:noFill/>
              <a:prstDash val="solid"/>
              <a:round/>
              <a:headEnd/>
              <a:tailEnd/>
            </a:ln>
          </p:spPr>
          <p:txBody>
            <a:bodyPr/>
            <a:lstStyle/>
            <a:p>
              <a:endParaRPr lang="en-US"/>
            </a:p>
          </p:txBody>
        </p:sp>
        <p:sp>
          <p:nvSpPr>
            <p:cNvPr id="24" name="Freeform 6">
              <a:extLst>
                <a:ext uri="{FF2B5EF4-FFF2-40B4-BE49-F238E27FC236}">
                  <a16:creationId xmlns:a16="http://schemas.microsoft.com/office/drawing/2014/main" id="{91FF3012-8189-40F6-B836-E04371B029D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accent1">
                <a:lumMod val="50000"/>
                <a:alpha val="25000"/>
              </a:schemeClr>
            </a:solidFill>
            <a:ln w="0">
              <a:noFill/>
              <a:prstDash val="solid"/>
              <a:round/>
              <a:headEnd/>
              <a:tailEnd/>
            </a:ln>
          </p:spPr>
          <p:txBody>
            <a:bodyPr/>
            <a:lstStyle/>
            <a:p>
              <a:endParaRPr lang="en-US" dirty="0"/>
            </a:p>
          </p:txBody>
        </p:sp>
      </p:grpSp>
      <p:sp>
        <p:nvSpPr>
          <p:cNvPr id="17" name="Content Placeholder 16">
            <a:extLst>
              <a:ext uri="{FF2B5EF4-FFF2-40B4-BE49-F238E27FC236}">
                <a16:creationId xmlns:a16="http://schemas.microsoft.com/office/drawing/2014/main" id="{51753CC3-0B6E-84F7-C29A-5537E7491E16}"/>
              </a:ext>
            </a:extLst>
          </p:cNvPr>
          <p:cNvSpPr>
            <a:spLocks noGrp="1"/>
          </p:cNvSpPr>
          <p:nvPr>
            <p:ph idx="1"/>
          </p:nvPr>
        </p:nvSpPr>
        <p:spPr>
          <a:xfrm>
            <a:off x="1251678" y="2286001"/>
            <a:ext cx="6015897" cy="3593591"/>
          </a:xfrm>
        </p:spPr>
        <p:txBody>
          <a:bodyPr>
            <a:normAutofit/>
          </a:bodyPr>
          <a:lstStyle/>
          <a:p>
            <a:endParaRPr lang="en-US" sz="2000">
              <a:solidFill>
                <a:schemeClr val="tx1">
                  <a:alpha val="60000"/>
                </a:schemeClr>
              </a:solidFill>
            </a:endParaRPr>
          </a:p>
        </p:txBody>
      </p:sp>
      <p:pic>
        <p:nvPicPr>
          <p:cNvPr id="7" name="Picture 6">
            <a:extLst>
              <a:ext uri="{FF2B5EF4-FFF2-40B4-BE49-F238E27FC236}">
                <a16:creationId xmlns:a16="http://schemas.microsoft.com/office/drawing/2014/main" id="{4E9896A9-BBAB-5110-64AB-7AE7A15EE56F}"/>
              </a:ext>
            </a:extLst>
          </p:cNvPr>
          <p:cNvPicPr>
            <a:picLocks noChangeAspect="1"/>
          </p:cNvPicPr>
          <p:nvPr/>
        </p:nvPicPr>
        <p:blipFill>
          <a:blip r:embed="rId3"/>
          <a:stretch>
            <a:fillRect/>
          </a:stretch>
        </p:blipFill>
        <p:spPr>
          <a:xfrm>
            <a:off x="6830789" y="2600919"/>
            <a:ext cx="5247709" cy="3581563"/>
          </a:xfrm>
          <a:prstGeom prst="rect">
            <a:avLst/>
          </a:prstGeom>
        </p:spPr>
      </p:pic>
      <p:pic>
        <p:nvPicPr>
          <p:cNvPr id="13" name="Content Placeholder 12">
            <a:extLst>
              <a:ext uri="{FF2B5EF4-FFF2-40B4-BE49-F238E27FC236}">
                <a16:creationId xmlns:a16="http://schemas.microsoft.com/office/drawing/2014/main" id="{526F7BEE-CD02-68AD-94BE-2658815B7D96}"/>
              </a:ext>
            </a:extLst>
          </p:cNvPr>
          <p:cNvPicPr>
            <a:picLocks noChangeAspect="1"/>
          </p:cNvPicPr>
          <p:nvPr/>
        </p:nvPicPr>
        <p:blipFill>
          <a:blip r:embed="rId4"/>
          <a:stretch>
            <a:fillRect/>
          </a:stretch>
        </p:blipFill>
        <p:spPr>
          <a:xfrm>
            <a:off x="6830789" y="554258"/>
            <a:ext cx="5247709" cy="1731743"/>
          </a:xfrm>
          <a:prstGeom prst="rect">
            <a:avLst/>
          </a:prstGeom>
          <a:noFill/>
        </p:spPr>
      </p:pic>
      <p:pic>
        <p:nvPicPr>
          <p:cNvPr id="10" name="Picture 9">
            <a:extLst>
              <a:ext uri="{FF2B5EF4-FFF2-40B4-BE49-F238E27FC236}">
                <a16:creationId xmlns:a16="http://schemas.microsoft.com/office/drawing/2014/main" id="{A08BA781-BB7C-B25C-CD85-16A70A9AAF49}"/>
              </a:ext>
            </a:extLst>
          </p:cNvPr>
          <p:cNvPicPr>
            <a:picLocks noChangeAspect="1"/>
          </p:cNvPicPr>
          <p:nvPr/>
        </p:nvPicPr>
        <p:blipFill>
          <a:blip r:embed="rId5"/>
          <a:stretch>
            <a:fillRect/>
          </a:stretch>
        </p:blipFill>
        <p:spPr>
          <a:xfrm>
            <a:off x="1291202" y="2587800"/>
            <a:ext cx="5247710" cy="3594682"/>
          </a:xfrm>
          <a:prstGeom prst="rect">
            <a:avLst/>
          </a:prstGeom>
        </p:spPr>
      </p:pic>
    </p:spTree>
    <p:extLst>
      <p:ext uri="{BB962C8B-B14F-4D97-AF65-F5344CB8AC3E}">
        <p14:creationId xmlns:p14="http://schemas.microsoft.com/office/powerpoint/2010/main" val="42292476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8CABF9-0100-6F87-7474-D28C8BCE7425}"/>
              </a:ext>
            </a:extLst>
          </p:cNvPr>
          <p:cNvSpPr>
            <a:spLocks noGrp="1"/>
          </p:cNvSpPr>
          <p:nvPr>
            <p:ph type="title"/>
          </p:nvPr>
        </p:nvSpPr>
        <p:spPr/>
        <p:txBody>
          <a:bodyPr/>
          <a:lstStyle/>
          <a:p>
            <a:r>
              <a:rPr lang="en-US" dirty="0"/>
              <a:t>Discussion Boards</a:t>
            </a:r>
          </a:p>
        </p:txBody>
      </p:sp>
      <p:pic>
        <p:nvPicPr>
          <p:cNvPr id="1027" name="Picture 3">
            <a:extLst>
              <a:ext uri="{FF2B5EF4-FFF2-40B4-BE49-F238E27FC236}">
                <a16:creationId xmlns:a16="http://schemas.microsoft.com/office/drawing/2014/main" id="{6DA95012-0C48-B19E-3946-CB84BD7D5C13}"/>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3036" b="9286"/>
          <a:stretch/>
        </p:blipFill>
        <p:spPr bwMode="auto">
          <a:xfrm>
            <a:off x="6476320" y="1792521"/>
            <a:ext cx="2601687" cy="43844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8" name="Picture 4">
            <a:extLst>
              <a:ext uri="{FF2B5EF4-FFF2-40B4-BE49-F238E27FC236}">
                <a16:creationId xmlns:a16="http://schemas.microsoft.com/office/drawing/2014/main" id="{1DBF33BC-A649-61AE-533A-11EDEEC790FE}"/>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12809" b="9090"/>
          <a:stretch/>
        </p:blipFill>
        <p:spPr bwMode="auto">
          <a:xfrm>
            <a:off x="838201" y="1828800"/>
            <a:ext cx="2601688" cy="4405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Content Placeholder 5">
            <a:extLst>
              <a:ext uri="{FF2B5EF4-FFF2-40B4-BE49-F238E27FC236}">
                <a16:creationId xmlns:a16="http://schemas.microsoft.com/office/drawing/2014/main" id="{0BAB1850-F1D0-8E74-5584-D832E88F3452}"/>
              </a:ext>
            </a:extLst>
          </p:cNvPr>
          <p:cNvSpPr>
            <a:spLocks noGrp="1"/>
          </p:cNvSpPr>
          <p:nvPr>
            <p:ph idx="1"/>
          </p:nvPr>
        </p:nvSpPr>
        <p:spPr/>
        <p:txBody>
          <a:bodyPr/>
          <a:lstStyle/>
          <a:p>
            <a:endParaRPr lang="en-US" dirty="0"/>
          </a:p>
        </p:txBody>
      </p:sp>
      <p:pic>
        <p:nvPicPr>
          <p:cNvPr id="1029" name="Picture 5">
            <a:extLst>
              <a:ext uri="{FF2B5EF4-FFF2-40B4-BE49-F238E27FC236}">
                <a16:creationId xmlns:a16="http://schemas.microsoft.com/office/drawing/2014/main" id="{CDD7E877-447A-2756-20DB-0C9EB3D967ED}"/>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t="12905" b="9001"/>
          <a:stretch/>
        </p:blipFill>
        <p:spPr bwMode="auto">
          <a:xfrm>
            <a:off x="3667128" y="1825625"/>
            <a:ext cx="2570158"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0" name="Picture 6">
            <a:extLst>
              <a:ext uri="{FF2B5EF4-FFF2-40B4-BE49-F238E27FC236}">
                <a16:creationId xmlns:a16="http://schemas.microsoft.com/office/drawing/2014/main" id="{6A8D1D3A-D2E2-C3F6-EAF8-430673DB73BB}"/>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t="12602" b="9006"/>
          <a:stretch/>
        </p:blipFill>
        <p:spPr bwMode="auto">
          <a:xfrm>
            <a:off x="9273717" y="1792522"/>
            <a:ext cx="2590147" cy="4405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17614441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955CD93-8D2A-4939-84B0-5515271288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A7EA17DF-8D42-4599-A066-12036B429F8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 y="0"/>
            <a:ext cx="12191996" cy="6858000"/>
            <a:chOff x="1" y="0"/>
            <a:chExt cx="12191996" cy="6858000"/>
          </a:xfrm>
        </p:grpSpPr>
        <p:sp useBgFill="1">
          <p:nvSpPr>
            <p:cNvPr id="11" name="Rectangle 10">
              <a:extLst>
                <a:ext uri="{FF2B5EF4-FFF2-40B4-BE49-F238E27FC236}">
                  <a16:creationId xmlns:a16="http://schemas.microsoft.com/office/drawing/2014/main" id="{7D8DB204-7B58-4A19-827A-914E5542B69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ltGray">
            <a:xfrm>
              <a:off x="1" y="0"/>
              <a:ext cx="12191996" cy="6858000"/>
            </a:xfrm>
            <a:prstGeom prst="rect">
              <a:avLst/>
            </a:prstGeom>
            <a:ln w="0">
              <a:noFill/>
              <a:prstDash val="solid"/>
              <a:round/>
              <a:headEnd/>
              <a:tailEnd/>
            </a:ln>
          </p:spPr>
          <p:txBody>
            <a:bodyPr rtlCol="0" anchor="ctr"/>
            <a:lstStyle/>
            <a:p>
              <a:pPr algn="ctr" defTabSz="457200"/>
              <a:endParaRPr lang="en-US">
                <a:solidFill>
                  <a:schemeClr val="tx1"/>
                </a:solidFill>
              </a:endParaRPr>
            </a:p>
          </p:txBody>
        </p:sp>
        <p:sp>
          <p:nvSpPr>
            <p:cNvPr id="12" name="Rectangle 11">
              <a:extLst>
                <a:ext uri="{FF2B5EF4-FFF2-40B4-BE49-F238E27FC236}">
                  <a16:creationId xmlns:a16="http://schemas.microsoft.com/office/drawing/2014/main" id="{8B88DBA6-392D-4BB3-9B59-8EBA44B24E9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ltGray">
            <a:xfrm>
              <a:off x="1" y="0"/>
              <a:ext cx="12191996" cy="6858000"/>
            </a:xfrm>
            <a:prstGeom prst="rect">
              <a:avLst/>
            </a:prstGeom>
            <a:solidFill>
              <a:schemeClr val="accent1">
                <a:lumMod val="50000"/>
                <a:alpha val="25000"/>
              </a:schemeClr>
            </a:solidFill>
            <a:ln w="0">
              <a:noFill/>
              <a:prstDash val="solid"/>
              <a:round/>
              <a:headEnd/>
              <a:tailEnd/>
            </a:ln>
          </p:spPr>
          <p:txBody>
            <a:bodyPr rtlCol="0" anchor="ctr"/>
            <a:lstStyle/>
            <a:p>
              <a:pPr algn="ctr" defTabSz="457200"/>
              <a:endParaRPr lang="en-US" dirty="0"/>
            </a:p>
          </p:txBody>
        </p:sp>
      </p:grpSp>
      <p:sp>
        <p:nvSpPr>
          <p:cNvPr id="2" name="Title 1">
            <a:extLst>
              <a:ext uri="{FF2B5EF4-FFF2-40B4-BE49-F238E27FC236}">
                <a16:creationId xmlns:a16="http://schemas.microsoft.com/office/drawing/2014/main" id="{E1C8EF69-6050-1092-9C29-68C19C58BFE9}"/>
              </a:ext>
            </a:extLst>
          </p:cNvPr>
          <p:cNvSpPr>
            <a:spLocks noGrp="1"/>
          </p:cNvSpPr>
          <p:nvPr>
            <p:ph type="title"/>
          </p:nvPr>
        </p:nvSpPr>
        <p:spPr>
          <a:xfrm>
            <a:off x="2071003" y="136525"/>
            <a:ext cx="8535999" cy="4242858"/>
          </a:xfrm>
        </p:spPr>
        <p:txBody>
          <a:bodyPr vert="horz" lIns="91440" tIns="45720" rIns="91440" bIns="45720" rtlCol="0" anchor="b">
            <a:normAutofit/>
          </a:bodyPr>
          <a:lstStyle/>
          <a:p>
            <a:pPr algn="ctr"/>
            <a:r>
              <a:rPr lang="en-US" sz="8800" kern="1200">
                <a:solidFill>
                  <a:schemeClr val="tx1"/>
                </a:solidFill>
                <a:latin typeface="+mj-lt"/>
                <a:ea typeface="+mj-ea"/>
                <a:cs typeface="+mj-cs"/>
              </a:rPr>
              <a:t>Wrap-up Questions</a:t>
            </a:r>
          </a:p>
        </p:txBody>
      </p:sp>
      <p:sp>
        <p:nvSpPr>
          <p:cNvPr id="3" name="Text Placeholder 2">
            <a:extLst>
              <a:ext uri="{FF2B5EF4-FFF2-40B4-BE49-F238E27FC236}">
                <a16:creationId xmlns:a16="http://schemas.microsoft.com/office/drawing/2014/main" id="{F66F7F3D-ED2C-601A-F791-E2539DE7EB27}"/>
              </a:ext>
            </a:extLst>
          </p:cNvPr>
          <p:cNvSpPr>
            <a:spLocks noGrp="1"/>
          </p:cNvSpPr>
          <p:nvPr>
            <p:ph type="body" idx="1"/>
          </p:nvPr>
        </p:nvSpPr>
        <p:spPr>
          <a:xfrm>
            <a:off x="2559699" y="4512733"/>
            <a:ext cx="7558609" cy="1066799"/>
          </a:xfrm>
        </p:spPr>
        <p:txBody>
          <a:bodyPr vert="horz" lIns="91440" tIns="45720" rIns="91440" bIns="45720" rtlCol="0">
            <a:normAutofit/>
          </a:bodyPr>
          <a:lstStyle/>
          <a:p>
            <a:pPr algn="ctr"/>
            <a:endParaRPr lang="en-US" sz="2000" kern="1200">
              <a:solidFill>
                <a:schemeClr val="tx1">
                  <a:alpha val="60000"/>
                </a:schemeClr>
              </a:solidFill>
              <a:latin typeface="+mn-lt"/>
              <a:ea typeface="+mn-ea"/>
              <a:cs typeface="+mn-cs"/>
            </a:endParaRPr>
          </a:p>
        </p:txBody>
      </p:sp>
      <p:grpSp>
        <p:nvGrpSpPr>
          <p:cNvPr id="14" name="Group 13">
            <a:extLst>
              <a:ext uri="{FF2B5EF4-FFF2-40B4-BE49-F238E27FC236}">
                <a16:creationId xmlns:a16="http://schemas.microsoft.com/office/drawing/2014/main" id="{50483D03-B230-4400-8301-33F3412829E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885825" cy="6858000"/>
            <a:chOff x="0" y="0"/>
            <a:chExt cx="885825" cy="6858000"/>
          </a:xfrm>
        </p:grpSpPr>
        <p:sp>
          <p:nvSpPr>
            <p:cNvPr id="15" name="Freeform 6">
              <a:extLst>
                <a:ext uri="{FF2B5EF4-FFF2-40B4-BE49-F238E27FC236}">
                  <a16:creationId xmlns:a16="http://schemas.microsoft.com/office/drawing/2014/main" id="{ECADAA64-BE10-4EAD-A7DA-F601862B972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tx1"/>
            </a:solidFill>
            <a:ln w="0">
              <a:noFill/>
              <a:prstDash val="solid"/>
              <a:round/>
              <a:headEnd/>
              <a:tailEnd/>
            </a:ln>
          </p:spPr>
          <p:txBody>
            <a:bodyPr/>
            <a:lstStyle/>
            <a:p>
              <a:endParaRPr lang="en-US"/>
            </a:p>
          </p:txBody>
        </p:sp>
        <p:sp>
          <p:nvSpPr>
            <p:cNvPr id="16" name="Freeform 6">
              <a:extLst>
                <a:ext uri="{FF2B5EF4-FFF2-40B4-BE49-F238E27FC236}">
                  <a16:creationId xmlns:a16="http://schemas.microsoft.com/office/drawing/2014/main" id="{7A478424-EC38-4BA6-B5A6-C2EF42F5E38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accent1">
                <a:lumMod val="50000"/>
                <a:alpha val="40000"/>
              </a:schemeClr>
            </a:solidFill>
            <a:ln w="0">
              <a:noFill/>
              <a:prstDash val="solid"/>
              <a:round/>
              <a:headEnd/>
              <a:tailEnd/>
            </a:ln>
          </p:spPr>
          <p:txBody>
            <a:bodyPr/>
            <a:lstStyle/>
            <a:p>
              <a:endParaRPr lang="en-US"/>
            </a:p>
          </p:txBody>
        </p:sp>
      </p:grpSp>
    </p:spTree>
    <p:extLst>
      <p:ext uri="{BB962C8B-B14F-4D97-AF65-F5344CB8AC3E}">
        <p14:creationId xmlns:p14="http://schemas.microsoft.com/office/powerpoint/2010/main" val="12560967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10">
            <a:extLst>
              <a:ext uri="{FF2B5EF4-FFF2-40B4-BE49-F238E27FC236}">
                <a16:creationId xmlns:a16="http://schemas.microsoft.com/office/drawing/2014/main" id="{1825AC39-5F85-4CAA-8A81-A1287086B2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FFFFFF"/>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Freeform: Shape 12">
            <a:extLst>
              <a:ext uri="{FF2B5EF4-FFF2-40B4-BE49-F238E27FC236}">
                <a16:creationId xmlns:a16="http://schemas.microsoft.com/office/drawing/2014/main" id="{95DA4D23-37FC-4B90-8188-F0377C5FF4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417162" cy="6858000"/>
          </a:xfrm>
          <a:custGeom>
            <a:avLst/>
            <a:gdLst>
              <a:gd name="connsiteX0" fmla="*/ 0 w 4417162"/>
              <a:gd name="connsiteY0" fmla="*/ 0 h 6858000"/>
              <a:gd name="connsiteX1" fmla="*/ 144378 w 4417162"/>
              <a:gd name="connsiteY1" fmla="*/ 0 h 6858000"/>
              <a:gd name="connsiteX2" fmla="*/ 2310062 w 4417162"/>
              <a:gd name="connsiteY2" fmla="*/ 0 h 6858000"/>
              <a:gd name="connsiteX3" fmla="*/ 4227367 w 4417162"/>
              <a:gd name="connsiteY3" fmla="*/ 0 h 6858000"/>
              <a:gd name="connsiteX4" fmla="*/ 4232407 w 4417162"/>
              <a:gd name="connsiteY4" fmla="*/ 66675 h 6858000"/>
              <a:gd name="connsiteX5" fmla="*/ 4240804 w 4417162"/>
              <a:gd name="connsiteY5" fmla="*/ 122237 h 6858000"/>
              <a:gd name="connsiteX6" fmla="*/ 4250882 w 4417162"/>
              <a:gd name="connsiteY6" fmla="*/ 174625 h 6858000"/>
              <a:gd name="connsiteX7" fmla="*/ 4267678 w 4417162"/>
              <a:gd name="connsiteY7" fmla="*/ 217487 h 6858000"/>
              <a:gd name="connsiteX8" fmla="*/ 4284474 w 4417162"/>
              <a:gd name="connsiteY8" fmla="*/ 260350 h 6858000"/>
              <a:gd name="connsiteX9" fmla="*/ 4304629 w 4417162"/>
              <a:gd name="connsiteY9" fmla="*/ 296862 h 6858000"/>
              <a:gd name="connsiteX10" fmla="*/ 4324784 w 4417162"/>
              <a:gd name="connsiteY10" fmla="*/ 334962 h 6858000"/>
              <a:gd name="connsiteX11" fmla="*/ 4343260 w 4417162"/>
              <a:gd name="connsiteY11" fmla="*/ 369887 h 6858000"/>
              <a:gd name="connsiteX12" fmla="*/ 4361735 w 4417162"/>
              <a:gd name="connsiteY12" fmla="*/ 409575 h 6858000"/>
              <a:gd name="connsiteX13" fmla="*/ 4378531 w 4417162"/>
              <a:gd name="connsiteY13" fmla="*/ 450850 h 6858000"/>
              <a:gd name="connsiteX14" fmla="*/ 4393648 w 4417162"/>
              <a:gd name="connsiteY14" fmla="*/ 496887 h 6858000"/>
              <a:gd name="connsiteX15" fmla="*/ 4405405 w 4417162"/>
              <a:gd name="connsiteY15" fmla="*/ 546100 h 6858000"/>
              <a:gd name="connsiteX16" fmla="*/ 4413803 w 4417162"/>
              <a:gd name="connsiteY16" fmla="*/ 606425 h 6858000"/>
              <a:gd name="connsiteX17" fmla="*/ 4417162 w 4417162"/>
              <a:gd name="connsiteY17" fmla="*/ 673100 h 6858000"/>
              <a:gd name="connsiteX18" fmla="*/ 4413803 w 4417162"/>
              <a:gd name="connsiteY18" fmla="*/ 744537 h 6858000"/>
              <a:gd name="connsiteX19" fmla="*/ 4405405 w 4417162"/>
              <a:gd name="connsiteY19" fmla="*/ 801687 h 6858000"/>
              <a:gd name="connsiteX20" fmla="*/ 4393648 w 4417162"/>
              <a:gd name="connsiteY20" fmla="*/ 854075 h 6858000"/>
              <a:gd name="connsiteX21" fmla="*/ 4378531 w 4417162"/>
              <a:gd name="connsiteY21" fmla="*/ 901700 h 6858000"/>
              <a:gd name="connsiteX22" fmla="*/ 4361735 w 4417162"/>
              <a:gd name="connsiteY22" fmla="*/ 942975 h 6858000"/>
              <a:gd name="connsiteX23" fmla="*/ 4341580 w 4417162"/>
              <a:gd name="connsiteY23" fmla="*/ 981075 h 6858000"/>
              <a:gd name="connsiteX24" fmla="*/ 4321425 w 4417162"/>
              <a:gd name="connsiteY24" fmla="*/ 1017587 h 6858000"/>
              <a:gd name="connsiteX25" fmla="*/ 4301270 w 4417162"/>
              <a:gd name="connsiteY25" fmla="*/ 1055687 h 6858000"/>
              <a:gd name="connsiteX26" fmla="*/ 4282794 w 4417162"/>
              <a:gd name="connsiteY26" fmla="*/ 1095375 h 6858000"/>
              <a:gd name="connsiteX27" fmla="*/ 4264318 w 4417162"/>
              <a:gd name="connsiteY27" fmla="*/ 1136650 h 6858000"/>
              <a:gd name="connsiteX28" fmla="*/ 4249203 w 4417162"/>
              <a:gd name="connsiteY28" fmla="*/ 1182687 h 6858000"/>
              <a:gd name="connsiteX29" fmla="*/ 4239125 w 4417162"/>
              <a:gd name="connsiteY29" fmla="*/ 1235075 h 6858000"/>
              <a:gd name="connsiteX30" fmla="*/ 4229047 w 4417162"/>
              <a:gd name="connsiteY30" fmla="*/ 1295400 h 6858000"/>
              <a:gd name="connsiteX31" fmla="*/ 4227367 w 4417162"/>
              <a:gd name="connsiteY31" fmla="*/ 1363662 h 6858000"/>
              <a:gd name="connsiteX32" fmla="*/ 4229047 w 4417162"/>
              <a:gd name="connsiteY32" fmla="*/ 1431925 h 6858000"/>
              <a:gd name="connsiteX33" fmla="*/ 4239125 w 4417162"/>
              <a:gd name="connsiteY33" fmla="*/ 1492250 h 6858000"/>
              <a:gd name="connsiteX34" fmla="*/ 4249203 w 4417162"/>
              <a:gd name="connsiteY34" fmla="*/ 1544637 h 6858000"/>
              <a:gd name="connsiteX35" fmla="*/ 4264318 w 4417162"/>
              <a:gd name="connsiteY35" fmla="*/ 1589087 h 6858000"/>
              <a:gd name="connsiteX36" fmla="*/ 4282794 w 4417162"/>
              <a:gd name="connsiteY36" fmla="*/ 1631950 h 6858000"/>
              <a:gd name="connsiteX37" fmla="*/ 4301270 w 4417162"/>
              <a:gd name="connsiteY37" fmla="*/ 1671637 h 6858000"/>
              <a:gd name="connsiteX38" fmla="*/ 4321425 w 4417162"/>
              <a:gd name="connsiteY38" fmla="*/ 1708150 h 6858000"/>
              <a:gd name="connsiteX39" fmla="*/ 4341580 w 4417162"/>
              <a:gd name="connsiteY39" fmla="*/ 1743075 h 6858000"/>
              <a:gd name="connsiteX40" fmla="*/ 4361735 w 4417162"/>
              <a:gd name="connsiteY40" fmla="*/ 1782762 h 6858000"/>
              <a:gd name="connsiteX41" fmla="*/ 4378531 w 4417162"/>
              <a:gd name="connsiteY41" fmla="*/ 1824037 h 6858000"/>
              <a:gd name="connsiteX42" fmla="*/ 4393648 w 4417162"/>
              <a:gd name="connsiteY42" fmla="*/ 1870075 h 6858000"/>
              <a:gd name="connsiteX43" fmla="*/ 4405405 w 4417162"/>
              <a:gd name="connsiteY43" fmla="*/ 1922462 h 6858000"/>
              <a:gd name="connsiteX44" fmla="*/ 4413803 w 4417162"/>
              <a:gd name="connsiteY44" fmla="*/ 1982787 h 6858000"/>
              <a:gd name="connsiteX45" fmla="*/ 4417162 w 4417162"/>
              <a:gd name="connsiteY45" fmla="*/ 2051050 h 6858000"/>
              <a:gd name="connsiteX46" fmla="*/ 4413803 w 4417162"/>
              <a:gd name="connsiteY46" fmla="*/ 2119312 h 6858000"/>
              <a:gd name="connsiteX47" fmla="*/ 4405405 w 4417162"/>
              <a:gd name="connsiteY47" fmla="*/ 2179637 h 6858000"/>
              <a:gd name="connsiteX48" fmla="*/ 4393648 w 4417162"/>
              <a:gd name="connsiteY48" fmla="*/ 2232025 h 6858000"/>
              <a:gd name="connsiteX49" fmla="*/ 4378531 w 4417162"/>
              <a:gd name="connsiteY49" fmla="*/ 2278062 h 6858000"/>
              <a:gd name="connsiteX50" fmla="*/ 4361735 w 4417162"/>
              <a:gd name="connsiteY50" fmla="*/ 2319337 h 6858000"/>
              <a:gd name="connsiteX51" fmla="*/ 4341580 w 4417162"/>
              <a:gd name="connsiteY51" fmla="*/ 2359025 h 6858000"/>
              <a:gd name="connsiteX52" fmla="*/ 4321425 w 4417162"/>
              <a:gd name="connsiteY52" fmla="*/ 2395537 h 6858000"/>
              <a:gd name="connsiteX53" fmla="*/ 4301270 w 4417162"/>
              <a:gd name="connsiteY53" fmla="*/ 2433637 h 6858000"/>
              <a:gd name="connsiteX54" fmla="*/ 4282794 w 4417162"/>
              <a:gd name="connsiteY54" fmla="*/ 2471737 h 6858000"/>
              <a:gd name="connsiteX55" fmla="*/ 4264318 w 4417162"/>
              <a:gd name="connsiteY55" fmla="*/ 2513012 h 6858000"/>
              <a:gd name="connsiteX56" fmla="*/ 4249203 w 4417162"/>
              <a:gd name="connsiteY56" fmla="*/ 2560637 h 6858000"/>
              <a:gd name="connsiteX57" fmla="*/ 4239125 w 4417162"/>
              <a:gd name="connsiteY57" fmla="*/ 2613025 h 6858000"/>
              <a:gd name="connsiteX58" fmla="*/ 4229047 w 4417162"/>
              <a:gd name="connsiteY58" fmla="*/ 2671762 h 6858000"/>
              <a:gd name="connsiteX59" fmla="*/ 4227367 w 4417162"/>
              <a:gd name="connsiteY59" fmla="*/ 2741612 h 6858000"/>
              <a:gd name="connsiteX60" fmla="*/ 4229047 w 4417162"/>
              <a:gd name="connsiteY60" fmla="*/ 2809875 h 6858000"/>
              <a:gd name="connsiteX61" fmla="*/ 4239125 w 4417162"/>
              <a:gd name="connsiteY61" fmla="*/ 2868612 h 6858000"/>
              <a:gd name="connsiteX62" fmla="*/ 4249203 w 4417162"/>
              <a:gd name="connsiteY62" fmla="*/ 2922587 h 6858000"/>
              <a:gd name="connsiteX63" fmla="*/ 4264318 w 4417162"/>
              <a:gd name="connsiteY63" fmla="*/ 2967037 h 6858000"/>
              <a:gd name="connsiteX64" fmla="*/ 4282794 w 4417162"/>
              <a:gd name="connsiteY64" fmla="*/ 3009900 h 6858000"/>
              <a:gd name="connsiteX65" fmla="*/ 4301270 w 4417162"/>
              <a:gd name="connsiteY65" fmla="*/ 3046412 h 6858000"/>
              <a:gd name="connsiteX66" fmla="*/ 4321425 w 4417162"/>
              <a:gd name="connsiteY66" fmla="*/ 3084512 h 6858000"/>
              <a:gd name="connsiteX67" fmla="*/ 4341580 w 4417162"/>
              <a:gd name="connsiteY67" fmla="*/ 3121025 h 6858000"/>
              <a:gd name="connsiteX68" fmla="*/ 4361735 w 4417162"/>
              <a:gd name="connsiteY68" fmla="*/ 3160712 h 6858000"/>
              <a:gd name="connsiteX69" fmla="*/ 4378531 w 4417162"/>
              <a:gd name="connsiteY69" fmla="*/ 3201987 h 6858000"/>
              <a:gd name="connsiteX70" fmla="*/ 4393648 w 4417162"/>
              <a:gd name="connsiteY70" fmla="*/ 3248025 h 6858000"/>
              <a:gd name="connsiteX71" fmla="*/ 4405405 w 4417162"/>
              <a:gd name="connsiteY71" fmla="*/ 3300412 h 6858000"/>
              <a:gd name="connsiteX72" fmla="*/ 4413803 w 4417162"/>
              <a:gd name="connsiteY72" fmla="*/ 3360737 h 6858000"/>
              <a:gd name="connsiteX73" fmla="*/ 4417162 w 4417162"/>
              <a:gd name="connsiteY73" fmla="*/ 3427412 h 6858000"/>
              <a:gd name="connsiteX74" fmla="*/ 4413803 w 4417162"/>
              <a:gd name="connsiteY74" fmla="*/ 3497262 h 6858000"/>
              <a:gd name="connsiteX75" fmla="*/ 4405405 w 4417162"/>
              <a:gd name="connsiteY75" fmla="*/ 3557587 h 6858000"/>
              <a:gd name="connsiteX76" fmla="*/ 4393648 w 4417162"/>
              <a:gd name="connsiteY76" fmla="*/ 3609975 h 6858000"/>
              <a:gd name="connsiteX77" fmla="*/ 4378531 w 4417162"/>
              <a:gd name="connsiteY77" fmla="*/ 3656012 h 6858000"/>
              <a:gd name="connsiteX78" fmla="*/ 4361735 w 4417162"/>
              <a:gd name="connsiteY78" fmla="*/ 3697287 h 6858000"/>
              <a:gd name="connsiteX79" fmla="*/ 4341580 w 4417162"/>
              <a:gd name="connsiteY79" fmla="*/ 3736975 h 6858000"/>
              <a:gd name="connsiteX80" fmla="*/ 4301270 w 4417162"/>
              <a:gd name="connsiteY80" fmla="*/ 3811587 h 6858000"/>
              <a:gd name="connsiteX81" fmla="*/ 4282794 w 4417162"/>
              <a:gd name="connsiteY81" fmla="*/ 3848100 h 6858000"/>
              <a:gd name="connsiteX82" fmla="*/ 4264318 w 4417162"/>
              <a:gd name="connsiteY82" fmla="*/ 3890962 h 6858000"/>
              <a:gd name="connsiteX83" fmla="*/ 4249203 w 4417162"/>
              <a:gd name="connsiteY83" fmla="*/ 3935412 h 6858000"/>
              <a:gd name="connsiteX84" fmla="*/ 4239125 w 4417162"/>
              <a:gd name="connsiteY84" fmla="*/ 3987800 h 6858000"/>
              <a:gd name="connsiteX85" fmla="*/ 4229047 w 4417162"/>
              <a:gd name="connsiteY85" fmla="*/ 4048125 h 6858000"/>
              <a:gd name="connsiteX86" fmla="*/ 4227367 w 4417162"/>
              <a:gd name="connsiteY86" fmla="*/ 4116387 h 6858000"/>
              <a:gd name="connsiteX87" fmla="*/ 4229047 w 4417162"/>
              <a:gd name="connsiteY87" fmla="*/ 4186237 h 6858000"/>
              <a:gd name="connsiteX88" fmla="*/ 4239125 w 4417162"/>
              <a:gd name="connsiteY88" fmla="*/ 4244975 h 6858000"/>
              <a:gd name="connsiteX89" fmla="*/ 4249203 w 4417162"/>
              <a:gd name="connsiteY89" fmla="*/ 4297362 h 6858000"/>
              <a:gd name="connsiteX90" fmla="*/ 4264318 w 4417162"/>
              <a:gd name="connsiteY90" fmla="*/ 4343400 h 6858000"/>
              <a:gd name="connsiteX91" fmla="*/ 4282794 w 4417162"/>
              <a:gd name="connsiteY91" fmla="*/ 4386262 h 6858000"/>
              <a:gd name="connsiteX92" fmla="*/ 4301270 w 4417162"/>
              <a:gd name="connsiteY92" fmla="*/ 4424362 h 6858000"/>
              <a:gd name="connsiteX93" fmla="*/ 4341580 w 4417162"/>
              <a:gd name="connsiteY93" fmla="*/ 4498975 h 6858000"/>
              <a:gd name="connsiteX94" fmla="*/ 4361735 w 4417162"/>
              <a:gd name="connsiteY94" fmla="*/ 4537075 h 6858000"/>
              <a:gd name="connsiteX95" fmla="*/ 4378531 w 4417162"/>
              <a:gd name="connsiteY95" fmla="*/ 4579937 h 6858000"/>
              <a:gd name="connsiteX96" fmla="*/ 4393648 w 4417162"/>
              <a:gd name="connsiteY96" fmla="*/ 4625975 h 6858000"/>
              <a:gd name="connsiteX97" fmla="*/ 4405405 w 4417162"/>
              <a:gd name="connsiteY97" fmla="*/ 4678362 h 6858000"/>
              <a:gd name="connsiteX98" fmla="*/ 4413803 w 4417162"/>
              <a:gd name="connsiteY98" fmla="*/ 4738687 h 6858000"/>
              <a:gd name="connsiteX99" fmla="*/ 4417162 w 4417162"/>
              <a:gd name="connsiteY99" fmla="*/ 4806950 h 6858000"/>
              <a:gd name="connsiteX100" fmla="*/ 4413803 w 4417162"/>
              <a:gd name="connsiteY100" fmla="*/ 4875212 h 6858000"/>
              <a:gd name="connsiteX101" fmla="*/ 4405405 w 4417162"/>
              <a:gd name="connsiteY101" fmla="*/ 4935537 h 6858000"/>
              <a:gd name="connsiteX102" fmla="*/ 4393648 w 4417162"/>
              <a:gd name="connsiteY102" fmla="*/ 4987925 h 6858000"/>
              <a:gd name="connsiteX103" fmla="*/ 4378531 w 4417162"/>
              <a:gd name="connsiteY103" fmla="*/ 5033962 h 6858000"/>
              <a:gd name="connsiteX104" fmla="*/ 4361735 w 4417162"/>
              <a:gd name="connsiteY104" fmla="*/ 5075237 h 6858000"/>
              <a:gd name="connsiteX105" fmla="*/ 4341580 w 4417162"/>
              <a:gd name="connsiteY105" fmla="*/ 5114925 h 6858000"/>
              <a:gd name="connsiteX106" fmla="*/ 4321425 w 4417162"/>
              <a:gd name="connsiteY106" fmla="*/ 5149850 h 6858000"/>
              <a:gd name="connsiteX107" fmla="*/ 4301270 w 4417162"/>
              <a:gd name="connsiteY107" fmla="*/ 5186362 h 6858000"/>
              <a:gd name="connsiteX108" fmla="*/ 4282794 w 4417162"/>
              <a:gd name="connsiteY108" fmla="*/ 5226050 h 6858000"/>
              <a:gd name="connsiteX109" fmla="*/ 4264318 w 4417162"/>
              <a:gd name="connsiteY109" fmla="*/ 5268912 h 6858000"/>
              <a:gd name="connsiteX110" fmla="*/ 4249203 w 4417162"/>
              <a:gd name="connsiteY110" fmla="*/ 5313362 h 6858000"/>
              <a:gd name="connsiteX111" fmla="*/ 4239125 w 4417162"/>
              <a:gd name="connsiteY111" fmla="*/ 5365750 h 6858000"/>
              <a:gd name="connsiteX112" fmla="*/ 4229047 w 4417162"/>
              <a:gd name="connsiteY112" fmla="*/ 5426075 h 6858000"/>
              <a:gd name="connsiteX113" fmla="*/ 4227367 w 4417162"/>
              <a:gd name="connsiteY113" fmla="*/ 5494337 h 6858000"/>
              <a:gd name="connsiteX114" fmla="*/ 4229047 w 4417162"/>
              <a:gd name="connsiteY114" fmla="*/ 5562600 h 6858000"/>
              <a:gd name="connsiteX115" fmla="*/ 4239125 w 4417162"/>
              <a:gd name="connsiteY115" fmla="*/ 5622925 h 6858000"/>
              <a:gd name="connsiteX116" fmla="*/ 4249203 w 4417162"/>
              <a:gd name="connsiteY116" fmla="*/ 5675312 h 6858000"/>
              <a:gd name="connsiteX117" fmla="*/ 4264318 w 4417162"/>
              <a:gd name="connsiteY117" fmla="*/ 5721350 h 6858000"/>
              <a:gd name="connsiteX118" fmla="*/ 4282794 w 4417162"/>
              <a:gd name="connsiteY118" fmla="*/ 5762625 h 6858000"/>
              <a:gd name="connsiteX119" fmla="*/ 4301270 w 4417162"/>
              <a:gd name="connsiteY119" fmla="*/ 5802312 h 6858000"/>
              <a:gd name="connsiteX120" fmla="*/ 4321425 w 4417162"/>
              <a:gd name="connsiteY120" fmla="*/ 5840412 h 6858000"/>
              <a:gd name="connsiteX121" fmla="*/ 4341580 w 4417162"/>
              <a:gd name="connsiteY121" fmla="*/ 5876925 h 6858000"/>
              <a:gd name="connsiteX122" fmla="*/ 4361735 w 4417162"/>
              <a:gd name="connsiteY122" fmla="*/ 5915025 h 6858000"/>
              <a:gd name="connsiteX123" fmla="*/ 4378531 w 4417162"/>
              <a:gd name="connsiteY123" fmla="*/ 5956300 h 6858000"/>
              <a:gd name="connsiteX124" fmla="*/ 4393648 w 4417162"/>
              <a:gd name="connsiteY124" fmla="*/ 6003925 h 6858000"/>
              <a:gd name="connsiteX125" fmla="*/ 4405405 w 4417162"/>
              <a:gd name="connsiteY125" fmla="*/ 6056312 h 6858000"/>
              <a:gd name="connsiteX126" fmla="*/ 4413803 w 4417162"/>
              <a:gd name="connsiteY126" fmla="*/ 6113462 h 6858000"/>
              <a:gd name="connsiteX127" fmla="*/ 4417162 w 4417162"/>
              <a:gd name="connsiteY127" fmla="*/ 6183312 h 6858000"/>
              <a:gd name="connsiteX128" fmla="*/ 4413803 w 4417162"/>
              <a:gd name="connsiteY128" fmla="*/ 6251575 h 6858000"/>
              <a:gd name="connsiteX129" fmla="*/ 4405405 w 4417162"/>
              <a:gd name="connsiteY129" fmla="*/ 6311900 h 6858000"/>
              <a:gd name="connsiteX130" fmla="*/ 4393648 w 4417162"/>
              <a:gd name="connsiteY130" fmla="*/ 6361112 h 6858000"/>
              <a:gd name="connsiteX131" fmla="*/ 4378531 w 4417162"/>
              <a:gd name="connsiteY131" fmla="*/ 6407150 h 6858000"/>
              <a:gd name="connsiteX132" fmla="*/ 4361735 w 4417162"/>
              <a:gd name="connsiteY132" fmla="*/ 6448425 h 6858000"/>
              <a:gd name="connsiteX133" fmla="*/ 4343260 w 4417162"/>
              <a:gd name="connsiteY133" fmla="*/ 6488112 h 6858000"/>
              <a:gd name="connsiteX134" fmla="*/ 4324784 w 4417162"/>
              <a:gd name="connsiteY134" fmla="*/ 6523037 h 6858000"/>
              <a:gd name="connsiteX135" fmla="*/ 4304629 w 4417162"/>
              <a:gd name="connsiteY135" fmla="*/ 6561137 h 6858000"/>
              <a:gd name="connsiteX136" fmla="*/ 4284474 w 4417162"/>
              <a:gd name="connsiteY136" fmla="*/ 6597650 h 6858000"/>
              <a:gd name="connsiteX137" fmla="*/ 4267678 w 4417162"/>
              <a:gd name="connsiteY137" fmla="*/ 6640512 h 6858000"/>
              <a:gd name="connsiteX138" fmla="*/ 4250882 w 4417162"/>
              <a:gd name="connsiteY138" fmla="*/ 6683375 h 6858000"/>
              <a:gd name="connsiteX139" fmla="*/ 4240804 w 4417162"/>
              <a:gd name="connsiteY139" fmla="*/ 6735762 h 6858000"/>
              <a:gd name="connsiteX140" fmla="*/ 4232407 w 4417162"/>
              <a:gd name="connsiteY140" fmla="*/ 6791325 h 6858000"/>
              <a:gd name="connsiteX141" fmla="*/ 4227367 w 4417162"/>
              <a:gd name="connsiteY141" fmla="*/ 6858000 h 6858000"/>
              <a:gd name="connsiteX142" fmla="*/ 2310062 w 4417162"/>
              <a:gd name="connsiteY142" fmla="*/ 6858000 h 6858000"/>
              <a:gd name="connsiteX143" fmla="*/ 144378 w 4417162"/>
              <a:gd name="connsiteY143" fmla="*/ 6858000 h 6858000"/>
              <a:gd name="connsiteX144" fmla="*/ 0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0" y="0"/>
                </a:moveTo>
                <a:lnTo>
                  <a:pt x="144378" y="0"/>
                </a:lnTo>
                <a:lnTo>
                  <a:pt x="2310062" y="0"/>
                </a:lnTo>
                <a:lnTo>
                  <a:pt x="4227367" y="0"/>
                </a:lnTo>
                <a:lnTo>
                  <a:pt x="4232407" y="66675"/>
                </a:lnTo>
                <a:lnTo>
                  <a:pt x="4240804" y="122237"/>
                </a:lnTo>
                <a:lnTo>
                  <a:pt x="4250882" y="174625"/>
                </a:lnTo>
                <a:lnTo>
                  <a:pt x="4267678" y="217487"/>
                </a:lnTo>
                <a:lnTo>
                  <a:pt x="4284474" y="260350"/>
                </a:lnTo>
                <a:lnTo>
                  <a:pt x="4304629" y="296862"/>
                </a:lnTo>
                <a:lnTo>
                  <a:pt x="4324784" y="334962"/>
                </a:lnTo>
                <a:lnTo>
                  <a:pt x="4343260" y="369887"/>
                </a:lnTo>
                <a:lnTo>
                  <a:pt x="4361735" y="409575"/>
                </a:lnTo>
                <a:lnTo>
                  <a:pt x="4378531" y="450850"/>
                </a:lnTo>
                <a:lnTo>
                  <a:pt x="4393648" y="496887"/>
                </a:lnTo>
                <a:lnTo>
                  <a:pt x="4405405" y="546100"/>
                </a:lnTo>
                <a:lnTo>
                  <a:pt x="4413803" y="606425"/>
                </a:lnTo>
                <a:lnTo>
                  <a:pt x="4417162" y="673100"/>
                </a:lnTo>
                <a:lnTo>
                  <a:pt x="4413803" y="744537"/>
                </a:lnTo>
                <a:lnTo>
                  <a:pt x="4405405" y="801687"/>
                </a:lnTo>
                <a:lnTo>
                  <a:pt x="4393648" y="854075"/>
                </a:lnTo>
                <a:lnTo>
                  <a:pt x="4378531" y="901700"/>
                </a:lnTo>
                <a:lnTo>
                  <a:pt x="4361735" y="942975"/>
                </a:lnTo>
                <a:lnTo>
                  <a:pt x="4341580" y="981075"/>
                </a:lnTo>
                <a:lnTo>
                  <a:pt x="4321425" y="1017587"/>
                </a:lnTo>
                <a:lnTo>
                  <a:pt x="4301270" y="1055687"/>
                </a:lnTo>
                <a:lnTo>
                  <a:pt x="4282794" y="1095375"/>
                </a:lnTo>
                <a:lnTo>
                  <a:pt x="4264318" y="1136650"/>
                </a:lnTo>
                <a:lnTo>
                  <a:pt x="4249203" y="1182687"/>
                </a:lnTo>
                <a:lnTo>
                  <a:pt x="4239125" y="1235075"/>
                </a:lnTo>
                <a:lnTo>
                  <a:pt x="4229047" y="1295400"/>
                </a:lnTo>
                <a:lnTo>
                  <a:pt x="4227367" y="1363662"/>
                </a:lnTo>
                <a:lnTo>
                  <a:pt x="4229047" y="1431925"/>
                </a:lnTo>
                <a:lnTo>
                  <a:pt x="4239125" y="1492250"/>
                </a:lnTo>
                <a:lnTo>
                  <a:pt x="4249203" y="1544637"/>
                </a:lnTo>
                <a:lnTo>
                  <a:pt x="4264318" y="1589087"/>
                </a:lnTo>
                <a:lnTo>
                  <a:pt x="4282794" y="1631950"/>
                </a:lnTo>
                <a:lnTo>
                  <a:pt x="4301270" y="1671637"/>
                </a:lnTo>
                <a:lnTo>
                  <a:pt x="4321425" y="1708150"/>
                </a:lnTo>
                <a:lnTo>
                  <a:pt x="4341580" y="1743075"/>
                </a:lnTo>
                <a:lnTo>
                  <a:pt x="4361735" y="1782762"/>
                </a:lnTo>
                <a:lnTo>
                  <a:pt x="4378531" y="1824037"/>
                </a:lnTo>
                <a:lnTo>
                  <a:pt x="4393648" y="1870075"/>
                </a:lnTo>
                <a:lnTo>
                  <a:pt x="4405405" y="1922462"/>
                </a:lnTo>
                <a:lnTo>
                  <a:pt x="4413803" y="1982787"/>
                </a:lnTo>
                <a:lnTo>
                  <a:pt x="4417162" y="2051050"/>
                </a:lnTo>
                <a:lnTo>
                  <a:pt x="4413803" y="2119312"/>
                </a:lnTo>
                <a:lnTo>
                  <a:pt x="4405405" y="2179637"/>
                </a:lnTo>
                <a:lnTo>
                  <a:pt x="4393648" y="2232025"/>
                </a:lnTo>
                <a:lnTo>
                  <a:pt x="4378531" y="2278062"/>
                </a:lnTo>
                <a:lnTo>
                  <a:pt x="4361735" y="2319337"/>
                </a:lnTo>
                <a:lnTo>
                  <a:pt x="4341580" y="2359025"/>
                </a:lnTo>
                <a:lnTo>
                  <a:pt x="4321425" y="2395537"/>
                </a:lnTo>
                <a:lnTo>
                  <a:pt x="4301270" y="2433637"/>
                </a:lnTo>
                <a:lnTo>
                  <a:pt x="4282794" y="2471737"/>
                </a:lnTo>
                <a:lnTo>
                  <a:pt x="4264318" y="2513012"/>
                </a:lnTo>
                <a:lnTo>
                  <a:pt x="4249203" y="2560637"/>
                </a:lnTo>
                <a:lnTo>
                  <a:pt x="4239125" y="2613025"/>
                </a:lnTo>
                <a:lnTo>
                  <a:pt x="4229047" y="2671762"/>
                </a:lnTo>
                <a:lnTo>
                  <a:pt x="4227367" y="2741612"/>
                </a:lnTo>
                <a:lnTo>
                  <a:pt x="4229047" y="2809875"/>
                </a:lnTo>
                <a:lnTo>
                  <a:pt x="4239125" y="2868612"/>
                </a:lnTo>
                <a:lnTo>
                  <a:pt x="4249203" y="2922587"/>
                </a:lnTo>
                <a:lnTo>
                  <a:pt x="4264318" y="2967037"/>
                </a:lnTo>
                <a:lnTo>
                  <a:pt x="4282794" y="3009900"/>
                </a:lnTo>
                <a:lnTo>
                  <a:pt x="4301270" y="3046412"/>
                </a:lnTo>
                <a:lnTo>
                  <a:pt x="4321425" y="3084512"/>
                </a:lnTo>
                <a:lnTo>
                  <a:pt x="4341580" y="3121025"/>
                </a:lnTo>
                <a:lnTo>
                  <a:pt x="4361735" y="3160712"/>
                </a:lnTo>
                <a:lnTo>
                  <a:pt x="4378531" y="3201987"/>
                </a:lnTo>
                <a:lnTo>
                  <a:pt x="4393648" y="3248025"/>
                </a:lnTo>
                <a:lnTo>
                  <a:pt x="4405405" y="3300412"/>
                </a:lnTo>
                <a:lnTo>
                  <a:pt x="4413803" y="3360737"/>
                </a:lnTo>
                <a:lnTo>
                  <a:pt x="4417162" y="3427412"/>
                </a:lnTo>
                <a:lnTo>
                  <a:pt x="4413803" y="3497262"/>
                </a:lnTo>
                <a:lnTo>
                  <a:pt x="4405405" y="3557587"/>
                </a:lnTo>
                <a:lnTo>
                  <a:pt x="4393648" y="3609975"/>
                </a:lnTo>
                <a:lnTo>
                  <a:pt x="4378531" y="3656012"/>
                </a:lnTo>
                <a:lnTo>
                  <a:pt x="4361735" y="3697287"/>
                </a:lnTo>
                <a:lnTo>
                  <a:pt x="4341580" y="3736975"/>
                </a:lnTo>
                <a:lnTo>
                  <a:pt x="4301270" y="3811587"/>
                </a:lnTo>
                <a:lnTo>
                  <a:pt x="4282794" y="3848100"/>
                </a:lnTo>
                <a:lnTo>
                  <a:pt x="4264318" y="3890962"/>
                </a:lnTo>
                <a:lnTo>
                  <a:pt x="4249203" y="3935412"/>
                </a:lnTo>
                <a:lnTo>
                  <a:pt x="4239125" y="3987800"/>
                </a:lnTo>
                <a:lnTo>
                  <a:pt x="4229047" y="4048125"/>
                </a:lnTo>
                <a:lnTo>
                  <a:pt x="4227367" y="4116387"/>
                </a:lnTo>
                <a:lnTo>
                  <a:pt x="4229047" y="4186237"/>
                </a:lnTo>
                <a:lnTo>
                  <a:pt x="4239125" y="4244975"/>
                </a:lnTo>
                <a:lnTo>
                  <a:pt x="4249203" y="4297362"/>
                </a:lnTo>
                <a:lnTo>
                  <a:pt x="4264318" y="4343400"/>
                </a:lnTo>
                <a:lnTo>
                  <a:pt x="4282794" y="4386262"/>
                </a:lnTo>
                <a:lnTo>
                  <a:pt x="4301270" y="4424362"/>
                </a:lnTo>
                <a:lnTo>
                  <a:pt x="4341580" y="4498975"/>
                </a:lnTo>
                <a:lnTo>
                  <a:pt x="4361735" y="4537075"/>
                </a:lnTo>
                <a:lnTo>
                  <a:pt x="4378531" y="4579937"/>
                </a:lnTo>
                <a:lnTo>
                  <a:pt x="4393648" y="4625975"/>
                </a:lnTo>
                <a:lnTo>
                  <a:pt x="4405405" y="4678362"/>
                </a:lnTo>
                <a:lnTo>
                  <a:pt x="4413803" y="4738687"/>
                </a:lnTo>
                <a:lnTo>
                  <a:pt x="4417162" y="4806950"/>
                </a:lnTo>
                <a:lnTo>
                  <a:pt x="4413803" y="4875212"/>
                </a:lnTo>
                <a:lnTo>
                  <a:pt x="4405405" y="4935537"/>
                </a:lnTo>
                <a:lnTo>
                  <a:pt x="4393648" y="4987925"/>
                </a:lnTo>
                <a:lnTo>
                  <a:pt x="4378531" y="5033962"/>
                </a:lnTo>
                <a:lnTo>
                  <a:pt x="4361735" y="5075237"/>
                </a:lnTo>
                <a:lnTo>
                  <a:pt x="4341580" y="5114925"/>
                </a:lnTo>
                <a:lnTo>
                  <a:pt x="4321425" y="5149850"/>
                </a:lnTo>
                <a:lnTo>
                  <a:pt x="4301270" y="5186362"/>
                </a:lnTo>
                <a:lnTo>
                  <a:pt x="4282794" y="5226050"/>
                </a:lnTo>
                <a:lnTo>
                  <a:pt x="4264318" y="5268912"/>
                </a:lnTo>
                <a:lnTo>
                  <a:pt x="4249203" y="5313362"/>
                </a:lnTo>
                <a:lnTo>
                  <a:pt x="4239125" y="5365750"/>
                </a:lnTo>
                <a:lnTo>
                  <a:pt x="4229047" y="5426075"/>
                </a:lnTo>
                <a:lnTo>
                  <a:pt x="4227367" y="5494337"/>
                </a:lnTo>
                <a:lnTo>
                  <a:pt x="4229047" y="5562600"/>
                </a:lnTo>
                <a:lnTo>
                  <a:pt x="4239125" y="5622925"/>
                </a:lnTo>
                <a:lnTo>
                  <a:pt x="4249203" y="5675312"/>
                </a:lnTo>
                <a:lnTo>
                  <a:pt x="4264318" y="5721350"/>
                </a:lnTo>
                <a:lnTo>
                  <a:pt x="4282794" y="5762625"/>
                </a:lnTo>
                <a:lnTo>
                  <a:pt x="4301270" y="5802312"/>
                </a:lnTo>
                <a:lnTo>
                  <a:pt x="4321425" y="5840412"/>
                </a:lnTo>
                <a:lnTo>
                  <a:pt x="4341580" y="5876925"/>
                </a:lnTo>
                <a:lnTo>
                  <a:pt x="4361735" y="5915025"/>
                </a:lnTo>
                <a:lnTo>
                  <a:pt x="4378531" y="5956300"/>
                </a:lnTo>
                <a:lnTo>
                  <a:pt x="4393648" y="6003925"/>
                </a:lnTo>
                <a:lnTo>
                  <a:pt x="4405405" y="6056312"/>
                </a:lnTo>
                <a:lnTo>
                  <a:pt x="4413803" y="6113462"/>
                </a:lnTo>
                <a:lnTo>
                  <a:pt x="4417162" y="6183312"/>
                </a:lnTo>
                <a:lnTo>
                  <a:pt x="4413803" y="6251575"/>
                </a:lnTo>
                <a:lnTo>
                  <a:pt x="4405405" y="6311900"/>
                </a:lnTo>
                <a:lnTo>
                  <a:pt x="4393648" y="6361112"/>
                </a:lnTo>
                <a:lnTo>
                  <a:pt x="4378531" y="6407150"/>
                </a:lnTo>
                <a:lnTo>
                  <a:pt x="4361735" y="6448425"/>
                </a:lnTo>
                <a:lnTo>
                  <a:pt x="4343260" y="6488112"/>
                </a:lnTo>
                <a:lnTo>
                  <a:pt x="4324784" y="6523037"/>
                </a:lnTo>
                <a:lnTo>
                  <a:pt x="4304629" y="6561137"/>
                </a:lnTo>
                <a:lnTo>
                  <a:pt x="4284474" y="6597650"/>
                </a:lnTo>
                <a:lnTo>
                  <a:pt x="4267678" y="6640512"/>
                </a:lnTo>
                <a:lnTo>
                  <a:pt x="4250882" y="6683375"/>
                </a:lnTo>
                <a:lnTo>
                  <a:pt x="4240804" y="6735762"/>
                </a:lnTo>
                <a:lnTo>
                  <a:pt x="4232407" y="6791325"/>
                </a:lnTo>
                <a:lnTo>
                  <a:pt x="4227367" y="6858000"/>
                </a:lnTo>
                <a:lnTo>
                  <a:pt x="2310062" y="6858000"/>
                </a:lnTo>
                <a:lnTo>
                  <a:pt x="144378" y="6858000"/>
                </a:lnTo>
                <a:lnTo>
                  <a:pt x="0" y="6858000"/>
                </a:lnTo>
                <a:close/>
              </a:path>
            </a:pathLst>
          </a:custGeom>
          <a:solidFill>
            <a:srgbClr val="FFFFFF"/>
          </a:solidFill>
          <a:ln w="0">
            <a:noFill/>
            <a:prstDash val="solid"/>
            <a:round/>
            <a:headEnd/>
            <a:tailEnd/>
          </a:ln>
        </p:spPr>
        <p:txBody>
          <a:bodyPr/>
          <a:lstStyle/>
          <a:p>
            <a:endParaRPr lang="en-US"/>
          </a:p>
        </p:txBody>
      </p:sp>
      <p:sp useBgFill="1">
        <p:nvSpPr>
          <p:cNvPr id="15" name="Freeform: Shape 14">
            <a:extLst>
              <a:ext uri="{FF2B5EF4-FFF2-40B4-BE49-F238E27FC236}">
                <a16:creationId xmlns:a16="http://schemas.microsoft.com/office/drawing/2014/main" id="{A7A4B465-FBCC-4CD4-89A1-82992A7B47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272784" cy="6858000"/>
          </a:xfrm>
          <a:custGeom>
            <a:avLst/>
            <a:gdLst>
              <a:gd name="connsiteX0" fmla="*/ 0 w 4272784"/>
              <a:gd name="connsiteY0" fmla="*/ 0 h 6858000"/>
              <a:gd name="connsiteX1" fmla="*/ 4082989 w 4272784"/>
              <a:gd name="connsiteY1" fmla="*/ 0 h 6858000"/>
              <a:gd name="connsiteX2" fmla="*/ 4088029 w 4272784"/>
              <a:gd name="connsiteY2" fmla="*/ 66675 h 6858000"/>
              <a:gd name="connsiteX3" fmla="*/ 4096426 w 4272784"/>
              <a:gd name="connsiteY3" fmla="*/ 122237 h 6858000"/>
              <a:gd name="connsiteX4" fmla="*/ 4106504 w 4272784"/>
              <a:gd name="connsiteY4" fmla="*/ 174625 h 6858000"/>
              <a:gd name="connsiteX5" fmla="*/ 4123300 w 4272784"/>
              <a:gd name="connsiteY5" fmla="*/ 217487 h 6858000"/>
              <a:gd name="connsiteX6" fmla="*/ 4140096 w 4272784"/>
              <a:gd name="connsiteY6" fmla="*/ 260350 h 6858000"/>
              <a:gd name="connsiteX7" fmla="*/ 4160251 w 4272784"/>
              <a:gd name="connsiteY7" fmla="*/ 296862 h 6858000"/>
              <a:gd name="connsiteX8" fmla="*/ 4180406 w 4272784"/>
              <a:gd name="connsiteY8" fmla="*/ 334962 h 6858000"/>
              <a:gd name="connsiteX9" fmla="*/ 4198882 w 4272784"/>
              <a:gd name="connsiteY9" fmla="*/ 369887 h 6858000"/>
              <a:gd name="connsiteX10" fmla="*/ 4217357 w 4272784"/>
              <a:gd name="connsiteY10" fmla="*/ 409575 h 6858000"/>
              <a:gd name="connsiteX11" fmla="*/ 4234153 w 4272784"/>
              <a:gd name="connsiteY11" fmla="*/ 450850 h 6858000"/>
              <a:gd name="connsiteX12" fmla="*/ 4249270 w 4272784"/>
              <a:gd name="connsiteY12" fmla="*/ 496887 h 6858000"/>
              <a:gd name="connsiteX13" fmla="*/ 4261027 w 4272784"/>
              <a:gd name="connsiteY13" fmla="*/ 546100 h 6858000"/>
              <a:gd name="connsiteX14" fmla="*/ 4269425 w 4272784"/>
              <a:gd name="connsiteY14" fmla="*/ 606425 h 6858000"/>
              <a:gd name="connsiteX15" fmla="*/ 4272784 w 4272784"/>
              <a:gd name="connsiteY15" fmla="*/ 673100 h 6858000"/>
              <a:gd name="connsiteX16" fmla="*/ 4269425 w 4272784"/>
              <a:gd name="connsiteY16" fmla="*/ 744537 h 6858000"/>
              <a:gd name="connsiteX17" fmla="*/ 4261027 w 4272784"/>
              <a:gd name="connsiteY17" fmla="*/ 801687 h 6858000"/>
              <a:gd name="connsiteX18" fmla="*/ 4249270 w 4272784"/>
              <a:gd name="connsiteY18" fmla="*/ 854075 h 6858000"/>
              <a:gd name="connsiteX19" fmla="*/ 4234153 w 4272784"/>
              <a:gd name="connsiteY19" fmla="*/ 901700 h 6858000"/>
              <a:gd name="connsiteX20" fmla="*/ 4217357 w 4272784"/>
              <a:gd name="connsiteY20" fmla="*/ 942975 h 6858000"/>
              <a:gd name="connsiteX21" fmla="*/ 4197202 w 4272784"/>
              <a:gd name="connsiteY21" fmla="*/ 981075 h 6858000"/>
              <a:gd name="connsiteX22" fmla="*/ 4177047 w 4272784"/>
              <a:gd name="connsiteY22" fmla="*/ 1017587 h 6858000"/>
              <a:gd name="connsiteX23" fmla="*/ 4156892 w 4272784"/>
              <a:gd name="connsiteY23" fmla="*/ 1055687 h 6858000"/>
              <a:gd name="connsiteX24" fmla="*/ 4138416 w 4272784"/>
              <a:gd name="connsiteY24" fmla="*/ 1095375 h 6858000"/>
              <a:gd name="connsiteX25" fmla="*/ 4119940 w 4272784"/>
              <a:gd name="connsiteY25" fmla="*/ 1136650 h 6858000"/>
              <a:gd name="connsiteX26" fmla="*/ 4104825 w 4272784"/>
              <a:gd name="connsiteY26" fmla="*/ 1182687 h 6858000"/>
              <a:gd name="connsiteX27" fmla="*/ 4094747 w 4272784"/>
              <a:gd name="connsiteY27" fmla="*/ 1235075 h 6858000"/>
              <a:gd name="connsiteX28" fmla="*/ 4084669 w 4272784"/>
              <a:gd name="connsiteY28" fmla="*/ 1295400 h 6858000"/>
              <a:gd name="connsiteX29" fmla="*/ 4082989 w 4272784"/>
              <a:gd name="connsiteY29" fmla="*/ 1363662 h 6858000"/>
              <a:gd name="connsiteX30" fmla="*/ 4084669 w 4272784"/>
              <a:gd name="connsiteY30" fmla="*/ 1431925 h 6858000"/>
              <a:gd name="connsiteX31" fmla="*/ 4094747 w 4272784"/>
              <a:gd name="connsiteY31" fmla="*/ 1492250 h 6858000"/>
              <a:gd name="connsiteX32" fmla="*/ 4104825 w 4272784"/>
              <a:gd name="connsiteY32" fmla="*/ 1544637 h 6858000"/>
              <a:gd name="connsiteX33" fmla="*/ 4119940 w 4272784"/>
              <a:gd name="connsiteY33" fmla="*/ 1589087 h 6858000"/>
              <a:gd name="connsiteX34" fmla="*/ 4138416 w 4272784"/>
              <a:gd name="connsiteY34" fmla="*/ 1631950 h 6858000"/>
              <a:gd name="connsiteX35" fmla="*/ 4156892 w 4272784"/>
              <a:gd name="connsiteY35" fmla="*/ 1671637 h 6858000"/>
              <a:gd name="connsiteX36" fmla="*/ 4177047 w 4272784"/>
              <a:gd name="connsiteY36" fmla="*/ 1708150 h 6858000"/>
              <a:gd name="connsiteX37" fmla="*/ 4197202 w 4272784"/>
              <a:gd name="connsiteY37" fmla="*/ 1743075 h 6858000"/>
              <a:gd name="connsiteX38" fmla="*/ 4217357 w 4272784"/>
              <a:gd name="connsiteY38" fmla="*/ 1782762 h 6858000"/>
              <a:gd name="connsiteX39" fmla="*/ 4234153 w 4272784"/>
              <a:gd name="connsiteY39" fmla="*/ 1824037 h 6858000"/>
              <a:gd name="connsiteX40" fmla="*/ 4249270 w 4272784"/>
              <a:gd name="connsiteY40" fmla="*/ 1870075 h 6858000"/>
              <a:gd name="connsiteX41" fmla="*/ 4261027 w 4272784"/>
              <a:gd name="connsiteY41" fmla="*/ 1922462 h 6858000"/>
              <a:gd name="connsiteX42" fmla="*/ 4269425 w 4272784"/>
              <a:gd name="connsiteY42" fmla="*/ 1982787 h 6858000"/>
              <a:gd name="connsiteX43" fmla="*/ 4272784 w 4272784"/>
              <a:gd name="connsiteY43" fmla="*/ 2051050 h 6858000"/>
              <a:gd name="connsiteX44" fmla="*/ 4269425 w 4272784"/>
              <a:gd name="connsiteY44" fmla="*/ 2119312 h 6858000"/>
              <a:gd name="connsiteX45" fmla="*/ 4261027 w 4272784"/>
              <a:gd name="connsiteY45" fmla="*/ 2179637 h 6858000"/>
              <a:gd name="connsiteX46" fmla="*/ 4249270 w 4272784"/>
              <a:gd name="connsiteY46" fmla="*/ 2232025 h 6858000"/>
              <a:gd name="connsiteX47" fmla="*/ 4234153 w 4272784"/>
              <a:gd name="connsiteY47" fmla="*/ 2278062 h 6858000"/>
              <a:gd name="connsiteX48" fmla="*/ 4217357 w 4272784"/>
              <a:gd name="connsiteY48" fmla="*/ 2319337 h 6858000"/>
              <a:gd name="connsiteX49" fmla="*/ 4197202 w 4272784"/>
              <a:gd name="connsiteY49" fmla="*/ 2359025 h 6858000"/>
              <a:gd name="connsiteX50" fmla="*/ 4177047 w 4272784"/>
              <a:gd name="connsiteY50" fmla="*/ 2395537 h 6858000"/>
              <a:gd name="connsiteX51" fmla="*/ 4156892 w 4272784"/>
              <a:gd name="connsiteY51" fmla="*/ 2433637 h 6858000"/>
              <a:gd name="connsiteX52" fmla="*/ 4138416 w 4272784"/>
              <a:gd name="connsiteY52" fmla="*/ 2471737 h 6858000"/>
              <a:gd name="connsiteX53" fmla="*/ 4119940 w 4272784"/>
              <a:gd name="connsiteY53" fmla="*/ 2513012 h 6858000"/>
              <a:gd name="connsiteX54" fmla="*/ 4104825 w 4272784"/>
              <a:gd name="connsiteY54" fmla="*/ 2560637 h 6858000"/>
              <a:gd name="connsiteX55" fmla="*/ 4094747 w 4272784"/>
              <a:gd name="connsiteY55" fmla="*/ 2613025 h 6858000"/>
              <a:gd name="connsiteX56" fmla="*/ 4084669 w 4272784"/>
              <a:gd name="connsiteY56" fmla="*/ 2671762 h 6858000"/>
              <a:gd name="connsiteX57" fmla="*/ 4082989 w 4272784"/>
              <a:gd name="connsiteY57" fmla="*/ 2741612 h 6858000"/>
              <a:gd name="connsiteX58" fmla="*/ 4084669 w 4272784"/>
              <a:gd name="connsiteY58" fmla="*/ 2809875 h 6858000"/>
              <a:gd name="connsiteX59" fmla="*/ 4094747 w 4272784"/>
              <a:gd name="connsiteY59" fmla="*/ 2868612 h 6858000"/>
              <a:gd name="connsiteX60" fmla="*/ 4104825 w 4272784"/>
              <a:gd name="connsiteY60" fmla="*/ 2922587 h 6858000"/>
              <a:gd name="connsiteX61" fmla="*/ 4119940 w 4272784"/>
              <a:gd name="connsiteY61" fmla="*/ 2967037 h 6858000"/>
              <a:gd name="connsiteX62" fmla="*/ 4138416 w 4272784"/>
              <a:gd name="connsiteY62" fmla="*/ 3009900 h 6858000"/>
              <a:gd name="connsiteX63" fmla="*/ 4156892 w 4272784"/>
              <a:gd name="connsiteY63" fmla="*/ 3046412 h 6858000"/>
              <a:gd name="connsiteX64" fmla="*/ 4177047 w 4272784"/>
              <a:gd name="connsiteY64" fmla="*/ 3084512 h 6858000"/>
              <a:gd name="connsiteX65" fmla="*/ 4197202 w 4272784"/>
              <a:gd name="connsiteY65" fmla="*/ 3121025 h 6858000"/>
              <a:gd name="connsiteX66" fmla="*/ 4217357 w 4272784"/>
              <a:gd name="connsiteY66" fmla="*/ 3160712 h 6858000"/>
              <a:gd name="connsiteX67" fmla="*/ 4234153 w 4272784"/>
              <a:gd name="connsiteY67" fmla="*/ 3201987 h 6858000"/>
              <a:gd name="connsiteX68" fmla="*/ 4249270 w 4272784"/>
              <a:gd name="connsiteY68" fmla="*/ 3248025 h 6858000"/>
              <a:gd name="connsiteX69" fmla="*/ 4261027 w 4272784"/>
              <a:gd name="connsiteY69" fmla="*/ 3300412 h 6858000"/>
              <a:gd name="connsiteX70" fmla="*/ 4269425 w 4272784"/>
              <a:gd name="connsiteY70" fmla="*/ 3360737 h 6858000"/>
              <a:gd name="connsiteX71" fmla="*/ 4272784 w 4272784"/>
              <a:gd name="connsiteY71" fmla="*/ 3427412 h 6858000"/>
              <a:gd name="connsiteX72" fmla="*/ 4269425 w 4272784"/>
              <a:gd name="connsiteY72" fmla="*/ 3497262 h 6858000"/>
              <a:gd name="connsiteX73" fmla="*/ 4261027 w 4272784"/>
              <a:gd name="connsiteY73" fmla="*/ 3557587 h 6858000"/>
              <a:gd name="connsiteX74" fmla="*/ 4249270 w 4272784"/>
              <a:gd name="connsiteY74" fmla="*/ 3609975 h 6858000"/>
              <a:gd name="connsiteX75" fmla="*/ 4234153 w 4272784"/>
              <a:gd name="connsiteY75" fmla="*/ 3656012 h 6858000"/>
              <a:gd name="connsiteX76" fmla="*/ 4217357 w 4272784"/>
              <a:gd name="connsiteY76" fmla="*/ 3697287 h 6858000"/>
              <a:gd name="connsiteX77" fmla="*/ 4197202 w 4272784"/>
              <a:gd name="connsiteY77" fmla="*/ 3736975 h 6858000"/>
              <a:gd name="connsiteX78" fmla="*/ 4156892 w 4272784"/>
              <a:gd name="connsiteY78" fmla="*/ 3811587 h 6858000"/>
              <a:gd name="connsiteX79" fmla="*/ 4138416 w 4272784"/>
              <a:gd name="connsiteY79" fmla="*/ 3848100 h 6858000"/>
              <a:gd name="connsiteX80" fmla="*/ 4119940 w 4272784"/>
              <a:gd name="connsiteY80" fmla="*/ 3890962 h 6858000"/>
              <a:gd name="connsiteX81" fmla="*/ 4104825 w 4272784"/>
              <a:gd name="connsiteY81" fmla="*/ 3935412 h 6858000"/>
              <a:gd name="connsiteX82" fmla="*/ 4094747 w 4272784"/>
              <a:gd name="connsiteY82" fmla="*/ 3987800 h 6858000"/>
              <a:gd name="connsiteX83" fmla="*/ 4084669 w 4272784"/>
              <a:gd name="connsiteY83" fmla="*/ 4048125 h 6858000"/>
              <a:gd name="connsiteX84" fmla="*/ 4082989 w 4272784"/>
              <a:gd name="connsiteY84" fmla="*/ 4116387 h 6858000"/>
              <a:gd name="connsiteX85" fmla="*/ 4084669 w 4272784"/>
              <a:gd name="connsiteY85" fmla="*/ 4186237 h 6858000"/>
              <a:gd name="connsiteX86" fmla="*/ 4094747 w 4272784"/>
              <a:gd name="connsiteY86" fmla="*/ 4244975 h 6858000"/>
              <a:gd name="connsiteX87" fmla="*/ 4104825 w 4272784"/>
              <a:gd name="connsiteY87" fmla="*/ 4297362 h 6858000"/>
              <a:gd name="connsiteX88" fmla="*/ 4119940 w 4272784"/>
              <a:gd name="connsiteY88" fmla="*/ 4343400 h 6858000"/>
              <a:gd name="connsiteX89" fmla="*/ 4138416 w 4272784"/>
              <a:gd name="connsiteY89" fmla="*/ 4386262 h 6858000"/>
              <a:gd name="connsiteX90" fmla="*/ 4156892 w 4272784"/>
              <a:gd name="connsiteY90" fmla="*/ 4424362 h 6858000"/>
              <a:gd name="connsiteX91" fmla="*/ 4197202 w 4272784"/>
              <a:gd name="connsiteY91" fmla="*/ 4498975 h 6858000"/>
              <a:gd name="connsiteX92" fmla="*/ 4217357 w 4272784"/>
              <a:gd name="connsiteY92" fmla="*/ 4537075 h 6858000"/>
              <a:gd name="connsiteX93" fmla="*/ 4234153 w 4272784"/>
              <a:gd name="connsiteY93" fmla="*/ 4579937 h 6858000"/>
              <a:gd name="connsiteX94" fmla="*/ 4249270 w 4272784"/>
              <a:gd name="connsiteY94" fmla="*/ 4625975 h 6858000"/>
              <a:gd name="connsiteX95" fmla="*/ 4261027 w 4272784"/>
              <a:gd name="connsiteY95" fmla="*/ 4678362 h 6858000"/>
              <a:gd name="connsiteX96" fmla="*/ 4269425 w 4272784"/>
              <a:gd name="connsiteY96" fmla="*/ 4738687 h 6858000"/>
              <a:gd name="connsiteX97" fmla="*/ 4272784 w 4272784"/>
              <a:gd name="connsiteY97" fmla="*/ 4806950 h 6858000"/>
              <a:gd name="connsiteX98" fmla="*/ 4269425 w 4272784"/>
              <a:gd name="connsiteY98" fmla="*/ 4875212 h 6858000"/>
              <a:gd name="connsiteX99" fmla="*/ 4261027 w 4272784"/>
              <a:gd name="connsiteY99" fmla="*/ 4935537 h 6858000"/>
              <a:gd name="connsiteX100" fmla="*/ 4249270 w 4272784"/>
              <a:gd name="connsiteY100" fmla="*/ 4987925 h 6858000"/>
              <a:gd name="connsiteX101" fmla="*/ 4234153 w 4272784"/>
              <a:gd name="connsiteY101" fmla="*/ 5033962 h 6858000"/>
              <a:gd name="connsiteX102" fmla="*/ 4217357 w 4272784"/>
              <a:gd name="connsiteY102" fmla="*/ 5075237 h 6858000"/>
              <a:gd name="connsiteX103" fmla="*/ 4197202 w 4272784"/>
              <a:gd name="connsiteY103" fmla="*/ 5114925 h 6858000"/>
              <a:gd name="connsiteX104" fmla="*/ 4177047 w 4272784"/>
              <a:gd name="connsiteY104" fmla="*/ 5149850 h 6858000"/>
              <a:gd name="connsiteX105" fmla="*/ 4156892 w 4272784"/>
              <a:gd name="connsiteY105" fmla="*/ 5186362 h 6858000"/>
              <a:gd name="connsiteX106" fmla="*/ 4138416 w 4272784"/>
              <a:gd name="connsiteY106" fmla="*/ 5226050 h 6858000"/>
              <a:gd name="connsiteX107" fmla="*/ 4119940 w 4272784"/>
              <a:gd name="connsiteY107" fmla="*/ 5268912 h 6858000"/>
              <a:gd name="connsiteX108" fmla="*/ 4104825 w 4272784"/>
              <a:gd name="connsiteY108" fmla="*/ 5313362 h 6858000"/>
              <a:gd name="connsiteX109" fmla="*/ 4094747 w 4272784"/>
              <a:gd name="connsiteY109" fmla="*/ 5365750 h 6858000"/>
              <a:gd name="connsiteX110" fmla="*/ 4084669 w 4272784"/>
              <a:gd name="connsiteY110" fmla="*/ 5426075 h 6858000"/>
              <a:gd name="connsiteX111" fmla="*/ 4082989 w 4272784"/>
              <a:gd name="connsiteY111" fmla="*/ 5494337 h 6858000"/>
              <a:gd name="connsiteX112" fmla="*/ 4084669 w 4272784"/>
              <a:gd name="connsiteY112" fmla="*/ 5562600 h 6858000"/>
              <a:gd name="connsiteX113" fmla="*/ 4094747 w 4272784"/>
              <a:gd name="connsiteY113" fmla="*/ 5622925 h 6858000"/>
              <a:gd name="connsiteX114" fmla="*/ 4104825 w 4272784"/>
              <a:gd name="connsiteY114" fmla="*/ 5675312 h 6858000"/>
              <a:gd name="connsiteX115" fmla="*/ 4119940 w 4272784"/>
              <a:gd name="connsiteY115" fmla="*/ 5721350 h 6858000"/>
              <a:gd name="connsiteX116" fmla="*/ 4138416 w 4272784"/>
              <a:gd name="connsiteY116" fmla="*/ 5762625 h 6858000"/>
              <a:gd name="connsiteX117" fmla="*/ 4156892 w 4272784"/>
              <a:gd name="connsiteY117" fmla="*/ 5802312 h 6858000"/>
              <a:gd name="connsiteX118" fmla="*/ 4177047 w 4272784"/>
              <a:gd name="connsiteY118" fmla="*/ 5840412 h 6858000"/>
              <a:gd name="connsiteX119" fmla="*/ 4197202 w 4272784"/>
              <a:gd name="connsiteY119" fmla="*/ 5876925 h 6858000"/>
              <a:gd name="connsiteX120" fmla="*/ 4217357 w 4272784"/>
              <a:gd name="connsiteY120" fmla="*/ 5915025 h 6858000"/>
              <a:gd name="connsiteX121" fmla="*/ 4234153 w 4272784"/>
              <a:gd name="connsiteY121" fmla="*/ 5956300 h 6858000"/>
              <a:gd name="connsiteX122" fmla="*/ 4249270 w 4272784"/>
              <a:gd name="connsiteY122" fmla="*/ 6003925 h 6858000"/>
              <a:gd name="connsiteX123" fmla="*/ 4261027 w 4272784"/>
              <a:gd name="connsiteY123" fmla="*/ 6056312 h 6858000"/>
              <a:gd name="connsiteX124" fmla="*/ 4269425 w 4272784"/>
              <a:gd name="connsiteY124" fmla="*/ 6113462 h 6858000"/>
              <a:gd name="connsiteX125" fmla="*/ 4272784 w 4272784"/>
              <a:gd name="connsiteY125" fmla="*/ 6183312 h 6858000"/>
              <a:gd name="connsiteX126" fmla="*/ 4269425 w 4272784"/>
              <a:gd name="connsiteY126" fmla="*/ 6251575 h 6858000"/>
              <a:gd name="connsiteX127" fmla="*/ 4261027 w 4272784"/>
              <a:gd name="connsiteY127" fmla="*/ 6311900 h 6858000"/>
              <a:gd name="connsiteX128" fmla="*/ 4249270 w 4272784"/>
              <a:gd name="connsiteY128" fmla="*/ 6361112 h 6858000"/>
              <a:gd name="connsiteX129" fmla="*/ 4234153 w 4272784"/>
              <a:gd name="connsiteY129" fmla="*/ 6407150 h 6858000"/>
              <a:gd name="connsiteX130" fmla="*/ 4217357 w 4272784"/>
              <a:gd name="connsiteY130" fmla="*/ 6448425 h 6858000"/>
              <a:gd name="connsiteX131" fmla="*/ 4198882 w 4272784"/>
              <a:gd name="connsiteY131" fmla="*/ 6488112 h 6858000"/>
              <a:gd name="connsiteX132" fmla="*/ 4180406 w 4272784"/>
              <a:gd name="connsiteY132" fmla="*/ 6523037 h 6858000"/>
              <a:gd name="connsiteX133" fmla="*/ 4160251 w 4272784"/>
              <a:gd name="connsiteY133" fmla="*/ 6561137 h 6858000"/>
              <a:gd name="connsiteX134" fmla="*/ 4140096 w 4272784"/>
              <a:gd name="connsiteY134" fmla="*/ 6597650 h 6858000"/>
              <a:gd name="connsiteX135" fmla="*/ 4123300 w 4272784"/>
              <a:gd name="connsiteY135" fmla="*/ 6640512 h 6858000"/>
              <a:gd name="connsiteX136" fmla="*/ 4106504 w 4272784"/>
              <a:gd name="connsiteY136" fmla="*/ 6683375 h 6858000"/>
              <a:gd name="connsiteX137" fmla="*/ 4096426 w 4272784"/>
              <a:gd name="connsiteY137" fmla="*/ 6735762 h 6858000"/>
              <a:gd name="connsiteX138" fmla="*/ 4088029 w 4272784"/>
              <a:gd name="connsiteY138" fmla="*/ 6791325 h 6858000"/>
              <a:gd name="connsiteX139" fmla="*/ 4082989 w 4272784"/>
              <a:gd name="connsiteY139" fmla="*/ 6858000 h 6858000"/>
              <a:gd name="connsiteX140" fmla="*/ 0 w 4272784"/>
              <a:gd name="connsiteY140"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Lst>
            <a:rect l="l" t="t" r="r" b="b"/>
            <a:pathLst>
              <a:path w="4272784" h="6858000">
                <a:moveTo>
                  <a:pt x="0" y="0"/>
                </a:moveTo>
                <a:lnTo>
                  <a:pt x="4082989" y="0"/>
                </a:lnTo>
                <a:lnTo>
                  <a:pt x="4088029" y="66675"/>
                </a:lnTo>
                <a:lnTo>
                  <a:pt x="4096426" y="122237"/>
                </a:lnTo>
                <a:lnTo>
                  <a:pt x="4106504" y="174625"/>
                </a:lnTo>
                <a:lnTo>
                  <a:pt x="4123300" y="217487"/>
                </a:lnTo>
                <a:lnTo>
                  <a:pt x="4140096" y="260350"/>
                </a:lnTo>
                <a:lnTo>
                  <a:pt x="4160251" y="296862"/>
                </a:lnTo>
                <a:lnTo>
                  <a:pt x="4180406" y="334962"/>
                </a:lnTo>
                <a:lnTo>
                  <a:pt x="4198882" y="369887"/>
                </a:lnTo>
                <a:lnTo>
                  <a:pt x="4217357" y="409575"/>
                </a:lnTo>
                <a:lnTo>
                  <a:pt x="4234153" y="450850"/>
                </a:lnTo>
                <a:lnTo>
                  <a:pt x="4249270" y="496887"/>
                </a:lnTo>
                <a:lnTo>
                  <a:pt x="4261027" y="546100"/>
                </a:lnTo>
                <a:lnTo>
                  <a:pt x="4269425" y="606425"/>
                </a:lnTo>
                <a:lnTo>
                  <a:pt x="4272784" y="673100"/>
                </a:lnTo>
                <a:lnTo>
                  <a:pt x="4269425" y="744537"/>
                </a:lnTo>
                <a:lnTo>
                  <a:pt x="4261027" y="801687"/>
                </a:lnTo>
                <a:lnTo>
                  <a:pt x="4249270" y="854075"/>
                </a:lnTo>
                <a:lnTo>
                  <a:pt x="4234153" y="901700"/>
                </a:lnTo>
                <a:lnTo>
                  <a:pt x="4217357" y="942975"/>
                </a:lnTo>
                <a:lnTo>
                  <a:pt x="4197202" y="981075"/>
                </a:lnTo>
                <a:lnTo>
                  <a:pt x="4177047" y="1017587"/>
                </a:lnTo>
                <a:lnTo>
                  <a:pt x="4156892" y="1055687"/>
                </a:lnTo>
                <a:lnTo>
                  <a:pt x="4138416" y="1095375"/>
                </a:lnTo>
                <a:lnTo>
                  <a:pt x="4119940" y="1136650"/>
                </a:lnTo>
                <a:lnTo>
                  <a:pt x="4104825" y="1182687"/>
                </a:lnTo>
                <a:lnTo>
                  <a:pt x="4094747" y="1235075"/>
                </a:lnTo>
                <a:lnTo>
                  <a:pt x="4084669" y="1295400"/>
                </a:lnTo>
                <a:lnTo>
                  <a:pt x="4082989" y="1363662"/>
                </a:lnTo>
                <a:lnTo>
                  <a:pt x="4084669" y="1431925"/>
                </a:lnTo>
                <a:lnTo>
                  <a:pt x="4094747" y="1492250"/>
                </a:lnTo>
                <a:lnTo>
                  <a:pt x="4104825" y="1544637"/>
                </a:lnTo>
                <a:lnTo>
                  <a:pt x="4119940" y="1589087"/>
                </a:lnTo>
                <a:lnTo>
                  <a:pt x="4138416" y="1631950"/>
                </a:lnTo>
                <a:lnTo>
                  <a:pt x="4156892" y="1671637"/>
                </a:lnTo>
                <a:lnTo>
                  <a:pt x="4177047" y="1708150"/>
                </a:lnTo>
                <a:lnTo>
                  <a:pt x="4197202" y="1743075"/>
                </a:lnTo>
                <a:lnTo>
                  <a:pt x="4217357" y="1782762"/>
                </a:lnTo>
                <a:lnTo>
                  <a:pt x="4234153" y="1824037"/>
                </a:lnTo>
                <a:lnTo>
                  <a:pt x="4249270" y="1870075"/>
                </a:lnTo>
                <a:lnTo>
                  <a:pt x="4261027" y="1922462"/>
                </a:lnTo>
                <a:lnTo>
                  <a:pt x="4269425" y="1982787"/>
                </a:lnTo>
                <a:lnTo>
                  <a:pt x="4272784" y="2051050"/>
                </a:lnTo>
                <a:lnTo>
                  <a:pt x="4269425" y="2119312"/>
                </a:lnTo>
                <a:lnTo>
                  <a:pt x="4261027" y="2179637"/>
                </a:lnTo>
                <a:lnTo>
                  <a:pt x="4249270" y="2232025"/>
                </a:lnTo>
                <a:lnTo>
                  <a:pt x="4234153" y="2278062"/>
                </a:lnTo>
                <a:lnTo>
                  <a:pt x="4217357" y="2319337"/>
                </a:lnTo>
                <a:lnTo>
                  <a:pt x="4197202" y="2359025"/>
                </a:lnTo>
                <a:lnTo>
                  <a:pt x="4177047" y="2395537"/>
                </a:lnTo>
                <a:lnTo>
                  <a:pt x="4156892" y="2433637"/>
                </a:lnTo>
                <a:lnTo>
                  <a:pt x="4138416" y="2471737"/>
                </a:lnTo>
                <a:lnTo>
                  <a:pt x="4119940" y="2513012"/>
                </a:lnTo>
                <a:lnTo>
                  <a:pt x="4104825" y="2560637"/>
                </a:lnTo>
                <a:lnTo>
                  <a:pt x="4094747" y="2613025"/>
                </a:lnTo>
                <a:lnTo>
                  <a:pt x="4084669" y="2671762"/>
                </a:lnTo>
                <a:lnTo>
                  <a:pt x="4082989" y="2741612"/>
                </a:lnTo>
                <a:lnTo>
                  <a:pt x="4084669" y="2809875"/>
                </a:lnTo>
                <a:lnTo>
                  <a:pt x="4094747" y="2868612"/>
                </a:lnTo>
                <a:lnTo>
                  <a:pt x="4104825" y="2922587"/>
                </a:lnTo>
                <a:lnTo>
                  <a:pt x="4119940" y="2967037"/>
                </a:lnTo>
                <a:lnTo>
                  <a:pt x="4138416" y="3009900"/>
                </a:lnTo>
                <a:lnTo>
                  <a:pt x="4156892" y="3046412"/>
                </a:lnTo>
                <a:lnTo>
                  <a:pt x="4177047" y="3084512"/>
                </a:lnTo>
                <a:lnTo>
                  <a:pt x="4197202" y="3121025"/>
                </a:lnTo>
                <a:lnTo>
                  <a:pt x="4217357" y="3160712"/>
                </a:lnTo>
                <a:lnTo>
                  <a:pt x="4234153" y="3201987"/>
                </a:lnTo>
                <a:lnTo>
                  <a:pt x="4249270" y="3248025"/>
                </a:lnTo>
                <a:lnTo>
                  <a:pt x="4261027" y="3300412"/>
                </a:lnTo>
                <a:lnTo>
                  <a:pt x="4269425" y="3360737"/>
                </a:lnTo>
                <a:lnTo>
                  <a:pt x="4272784" y="3427412"/>
                </a:lnTo>
                <a:lnTo>
                  <a:pt x="4269425" y="3497262"/>
                </a:lnTo>
                <a:lnTo>
                  <a:pt x="4261027" y="3557587"/>
                </a:lnTo>
                <a:lnTo>
                  <a:pt x="4249270" y="3609975"/>
                </a:lnTo>
                <a:lnTo>
                  <a:pt x="4234153" y="3656012"/>
                </a:lnTo>
                <a:lnTo>
                  <a:pt x="4217357" y="3697287"/>
                </a:lnTo>
                <a:lnTo>
                  <a:pt x="4197202" y="3736975"/>
                </a:lnTo>
                <a:lnTo>
                  <a:pt x="4156892" y="3811587"/>
                </a:lnTo>
                <a:lnTo>
                  <a:pt x="4138416" y="3848100"/>
                </a:lnTo>
                <a:lnTo>
                  <a:pt x="4119940" y="3890962"/>
                </a:lnTo>
                <a:lnTo>
                  <a:pt x="4104825" y="3935412"/>
                </a:lnTo>
                <a:lnTo>
                  <a:pt x="4094747" y="3987800"/>
                </a:lnTo>
                <a:lnTo>
                  <a:pt x="4084669" y="4048125"/>
                </a:lnTo>
                <a:lnTo>
                  <a:pt x="4082989" y="4116387"/>
                </a:lnTo>
                <a:lnTo>
                  <a:pt x="4084669" y="4186237"/>
                </a:lnTo>
                <a:lnTo>
                  <a:pt x="4094747" y="4244975"/>
                </a:lnTo>
                <a:lnTo>
                  <a:pt x="4104825" y="4297362"/>
                </a:lnTo>
                <a:lnTo>
                  <a:pt x="4119940" y="4343400"/>
                </a:lnTo>
                <a:lnTo>
                  <a:pt x="4138416" y="4386262"/>
                </a:lnTo>
                <a:lnTo>
                  <a:pt x="4156892" y="4424362"/>
                </a:lnTo>
                <a:lnTo>
                  <a:pt x="4197202" y="4498975"/>
                </a:lnTo>
                <a:lnTo>
                  <a:pt x="4217357" y="4537075"/>
                </a:lnTo>
                <a:lnTo>
                  <a:pt x="4234153" y="4579937"/>
                </a:lnTo>
                <a:lnTo>
                  <a:pt x="4249270" y="4625975"/>
                </a:lnTo>
                <a:lnTo>
                  <a:pt x="4261027" y="4678362"/>
                </a:lnTo>
                <a:lnTo>
                  <a:pt x="4269425" y="4738687"/>
                </a:lnTo>
                <a:lnTo>
                  <a:pt x="4272784" y="4806950"/>
                </a:lnTo>
                <a:lnTo>
                  <a:pt x="4269425" y="4875212"/>
                </a:lnTo>
                <a:lnTo>
                  <a:pt x="4261027" y="4935537"/>
                </a:lnTo>
                <a:lnTo>
                  <a:pt x="4249270" y="4987925"/>
                </a:lnTo>
                <a:lnTo>
                  <a:pt x="4234153" y="5033962"/>
                </a:lnTo>
                <a:lnTo>
                  <a:pt x="4217357" y="5075237"/>
                </a:lnTo>
                <a:lnTo>
                  <a:pt x="4197202" y="5114925"/>
                </a:lnTo>
                <a:lnTo>
                  <a:pt x="4177047" y="5149850"/>
                </a:lnTo>
                <a:lnTo>
                  <a:pt x="4156892" y="5186362"/>
                </a:lnTo>
                <a:lnTo>
                  <a:pt x="4138416" y="5226050"/>
                </a:lnTo>
                <a:lnTo>
                  <a:pt x="4119940" y="5268912"/>
                </a:lnTo>
                <a:lnTo>
                  <a:pt x="4104825" y="5313362"/>
                </a:lnTo>
                <a:lnTo>
                  <a:pt x="4094747" y="5365750"/>
                </a:lnTo>
                <a:lnTo>
                  <a:pt x="4084669" y="5426075"/>
                </a:lnTo>
                <a:lnTo>
                  <a:pt x="4082989" y="5494337"/>
                </a:lnTo>
                <a:lnTo>
                  <a:pt x="4084669" y="5562600"/>
                </a:lnTo>
                <a:lnTo>
                  <a:pt x="4094747" y="5622925"/>
                </a:lnTo>
                <a:lnTo>
                  <a:pt x="4104825" y="5675312"/>
                </a:lnTo>
                <a:lnTo>
                  <a:pt x="4119940" y="5721350"/>
                </a:lnTo>
                <a:lnTo>
                  <a:pt x="4138416" y="5762625"/>
                </a:lnTo>
                <a:lnTo>
                  <a:pt x="4156892" y="5802312"/>
                </a:lnTo>
                <a:lnTo>
                  <a:pt x="4177047" y="5840412"/>
                </a:lnTo>
                <a:lnTo>
                  <a:pt x="4197202" y="5876925"/>
                </a:lnTo>
                <a:lnTo>
                  <a:pt x="4217357" y="5915025"/>
                </a:lnTo>
                <a:lnTo>
                  <a:pt x="4234153" y="5956300"/>
                </a:lnTo>
                <a:lnTo>
                  <a:pt x="4249270" y="6003925"/>
                </a:lnTo>
                <a:lnTo>
                  <a:pt x="4261027" y="6056312"/>
                </a:lnTo>
                <a:lnTo>
                  <a:pt x="4269425" y="6113462"/>
                </a:lnTo>
                <a:lnTo>
                  <a:pt x="4272784" y="6183312"/>
                </a:lnTo>
                <a:lnTo>
                  <a:pt x="4269425" y="6251575"/>
                </a:lnTo>
                <a:lnTo>
                  <a:pt x="4261027" y="6311900"/>
                </a:lnTo>
                <a:lnTo>
                  <a:pt x="4249270" y="6361112"/>
                </a:lnTo>
                <a:lnTo>
                  <a:pt x="4234153" y="6407150"/>
                </a:lnTo>
                <a:lnTo>
                  <a:pt x="4217357" y="6448425"/>
                </a:lnTo>
                <a:lnTo>
                  <a:pt x="4198882" y="6488112"/>
                </a:lnTo>
                <a:lnTo>
                  <a:pt x="4180406" y="6523037"/>
                </a:lnTo>
                <a:lnTo>
                  <a:pt x="4160251" y="6561137"/>
                </a:lnTo>
                <a:lnTo>
                  <a:pt x="4140096" y="6597650"/>
                </a:lnTo>
                <a:lnTo>
                  <a:pt x="4123300" y="6640512"/>
                </a:lnTo>
                <a:lnTo>
                  <a:pt x="4106504" y="6683375"/>
                </a:lnTo>
                <a:lnTo>
                  <a:pt x="4096426" y="6735762"/>
                </a:lnTo>
                <a:lnTo>
                  <a:pt x="4088029" y="6791325"/>
                </a:lnTo>
                <a:lnTo>
                  <a:pt x="4082989" y="6858000"/>
                </a:lnTo>
                <a:lnTo>
                  <a:pt x="0" y="6858000"/>
                </a:lnTo>
                <a:close/>
              </a:path>
            </a:pathLst>
          </a:custGeom>
          <a:ln w="0">
            <a:noFill/>
            <a:prstDash val="solid"/>
            <a:round/>
            <a:headEnd/>
            <a:tailEnd/>
          </a:ln>
        </p:spPr>
        <p:txBody>
          <a:bodyPr/>
          <a:lstStyle/>
          <a:p>
            <a:endParaRPr lang="en-US" dirty="0"/>
          </a:p>
        </p:txBody>
      </p:sp>
      <p:sp>
        <p:nvSpPr>
          <p:cNvPr id="17" name="Freeform: Shape 16">
            <a:extLst>
              <a:ext uri="{FF2B5EF4-FFF2-40B4-BE49-F238E27FC236}">
                <a16:creationId xmlns:a16="http://schemas.microsoft.com/office/drawing/2014/main" id="{909E572F-9CDC-4214-9D42-FF00176495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4417162" cy="6858000"/>
          </a:xfrm>
          <a:custGeom>
            <a:avLst/>
            <a:gdLst>
              <a:gd name="connsiteX0" fmla="*/ 4417162 w 4417162"/>
              <a:gd name="connsiteY0" fmla="*/ 0 h 6858000"/>
              <a:gd name="connsiteX1" fmla="*/ 334174 w 4417162"/>
              <a:gd name="connsiteY1" fmla="*/ 0 h 6858000"/>
              <a:gd name="connsiteX2" fmla="*/ 334173 w 4417162"/>
              <a:gd name="connsiteY2" fmla="*/ 0 h 6858000"/>
              <a:gd name="connsiteX3" fmla="*/ 189795 w 4417162"/>
              <a:gd name="connsiteY3" fmla="*/ 0 h 6858000"/>
              <a:gd name="connsiteX4" fmla="*/ 184756 w 4417162"/>
              <a:gd name="connsiteY4" fmla="*/ 66675 h 6858000"/>
              <a:gd name="connsiteX5" fmla="*/ 176358 w 4417162"/>
              <a:gd name="connsiteY5" fmla="*/ 122237 h 6858000"/>
              <a:gd name="connsiteX6" fmla="*/ 166281 w 4417162"/>
              <a:gd name="connsiteY6" fmla="*/ 174625 h 6858000"/>
              <a:gd name="connsiteX7" fmla="*/ 149485 w 4417162"/>
              <a:gd name="connsiteY7" fmla="*/ 217487 h 6858000"/>
              <a:gd name="connsiteX8" fmla="*/ 132689 w 4417162"/>
              <a:gd name="connsiteY8" fmla="*/ 260350 h 6858000"/>
              <a:gd name="connsiteX9" fmla="*/ 112534 w 4417162"/>
              <a:gd name="connsiteY9" fmla="*/ 296862 h 6858000"/>
              <a:gd name="connsiteX10" fmla="*/ 92379 w 4417162"/>
              <a:gd name="connsiteY10" fmla="*/ 334962 h 6858000"/>
              <a:gd name="connsiteX11" fmla="*/ 73903 w 4417162"/>
              <a:gd name="connsiteY11" fmla="*/ 369887 h 6858000"/>
              <a:gd name="connsiteX12" fmla="*/ 55427 w 4417162"/>
              <a:gd name="connsiteY12" fmla="*/ 409575 h 6858000"/>
              <a:gd name="connsiteX13" fmla="*/ 38632 w 4417162"/>
              <a:gd name="connsiteY13" fmla="*/ 450850 h 6858000"/>
              <a:gd name="connsiteX14" fmla="*/ 23515 w 4417162"/>
              <a:gd name="connsiteY14" fmla="*/ 496887 h 6858000"/>
              <a:gd name="connsiteX15" fmla="*/ 11758 w 4417162"/>
              <a:gd name="connsiteY15" fmla="*/ 546100 h 6858000"/>
              <a:gd name="connsiteX16" fmla="*/ 3359 w 4417162"/>
              <a:gd name="connsiteY16" fmla="*/ 606425 h 6858000"/>
              <a:gd name="connsiteX17" fmla="*/ 0 w 4417162"/>
              <a:gd name="connsiteY17" fmla="*/ 673100 h 6858000"/>
              <a:gd name="connsiteX18" fmla="*/ 3359 w 4417162"/>
              <a:gd name="connsiteY18" fmla="*/ 744537 h 6858000"/>
              <a:gd name="connsiteX19" fmla="*/ 11758 w 4417162"/>
              <a:gd name="connsiteY19" fmla="*/ 801687 h 6858000"/>
              <a:gd name="connsiteX20" fmla="*/ 23515 w 4417162"/>
              <a:gd name="connsiteY20" fmla="*/ 854075 h 6858000"/>
              <a:gd name="connsiteX21" fmla="*/ 38632 w 4417162"/>
              <a:gd name="connsiteY21" fmla="*/ 901700 h 6858000"/>
              <a:gd name="connsiteX22" fmla="*/ 55427 w 4417162"/>
              <a:gd name="connsiteY22" fmla="*/ 942975 h 6858000"/>
              <a:gd name="connsiteX23" fmla="*/ 75583 w 4417162"/>
              <a:gd name="connsiteY23" fmla="*/ 981075 h 6858000"/>
              <a:gd name="connsiteX24" fmla="*/ 95738 w 4417162"/>
              <a:gd name="connsiteY24" fmla="*/ 1017587 h 6858000"/>
              <a:gd name="connsiteX25" fmla="*/ 115893 w 4417162"/>
              <a:gd name="connsiteY25" fmla="*/ 1055687 h 6858000"/>
              <a:gd name="connsiteX26" fmla="*/ 134368 w 4417162"/>
              <a:gd name="connsiteY26" fmla="*/ 1095375 h 6858000"/>
              <a:gd name="connsiteX27" fmla="*/ 152844 w 4417162"/>
              <a:gd name="connsiteY27" fmla="*/ 1136650 h 6858000"/>
              <a:gd name="connsiteX28" fmla="*/ 167960 w 4417162"/>
              <a:gd name="connsiteY28" fmla="*/ 1182687 h 6858000"/>
              <a:gd name="connsiteX29" fmla="*/ 178038 w 4417162"/>
              <a:gd name="connsiteY29" fmla="*/ 1235075 h 6858000"/>
              <a:gd name="connsiteX30" fmla="*/ 188115 w 4417162"/>
              <a:gd name="connsiteY30" fmla="*/ 1295400 h 6858000"/>
              <a:gd name="connsiteX31" fmla="*/ 189795 w 4417162"/>
              <a:gd name="connsiteY31" fmla="*/ 1363662 h 6858000"/>
              <a:gd name="connsiteX32" fmla="*/ 188115 w 4417162"/>
              <a:gd name="connsiteY32" fmla="*/ 1431925 h 6858000"/>
              <a:gd name="connsiteX33" fmla="*/ 178038 w 4417162"/>
              <a:gd name="connsiteY33" fmla="*/ 1492250 h 6858000"/>
              <a:gd name="connsiteX34" fmla="*/ 167960 w 4417162"/>
              <a:gd name="connsiteY34" fmla="*/ 1544637 h 6858000"/>
              <a:gd name="connsiteX35" fmla="*/ 152844 w 4417162"/>
              <a:gd name="connsiteY35" fmla="*/ 1589087 h 6858000"/>
              <a:gd name="connsiteX36" fmla="*/ 134368 w 4417162"/>
              <a:gd name="connsiteY36" fmla="*/ 1631950 h 6858000"/>
              <a:gd name="connsiteX37" fmla="*/ 115893 w 4417162"/>
              <a:gd name="connsiteY37" fmla="*/ 1671637 h 6858000"/>
              <a:gd name="connsiteX38" fmla="*/ 95738 w 4417162"/>
              <a:gd name="connsiteY38" fmla="*/ 1708150 h 6858000"/>
              <a:gd name="connsiteX39" fmla="*/ 75583 w 4417162"/>
              <a:gd name="connsiteY39" fmla="*/ 1743075 h 6858000"/>
              <a:gd name="connsiteX40" fmla="*/ 55427 w 4417162"/>
              <a:gd name="connsiteY40" fmla="*/ 1782762 h 6858000"/>
              <a:gd name="connsiteX41" fmla="*/ 38632 w 4417162"/>
              <a:gd name="connsiteY41" fmla="*/ 1824037 h 6858000"/>
              <a:gd name="connsiteX42" fmla="*/ 23515 w 4417162"/>
              <a:gd name="connsiteY42" fmla="*/ 1870075 h 6858000"/>
              <a:gd name="connsiteX43" fmla="*/ 11758 w 4417162"/>
              <a:gd name="connsiteY43" fmla="*/ 1922462 h 6858000"/>
              <a:gd name="connsiteX44" fmla="*/ 3359 w 4417162"/>
              <a:gd name="connsiteY44" fmla="*/ 1982787 h 6858000"/>
              <a:gd name="connsiteX45" fmla="*/ 0 w 4417162"/>
              <a:gd name="connsiteY45" fmla="*/ 2051050 h 6858000"/>
              <a:gd name="connsiteX46" fmla="*/ 3359 w 4417162"/>
              <a:gd name="connsiteY46" fmla="*/ 2119312 h 6858000"/>
              <a:gd name="connsiteX47" fmla="*/ 11758 w 4417162"/>
              <a:gd name="connsiteY47" fmla="*/ 2179637 h 6858000"/>
              <a:gd name="connsiteX48" fmla="*/ 23515 w 4417162"/>
              <a:gd name="connsiteY48" fmla="*/ 2232025 h 6858000"/>
              <a:gd name="connsiteX49" fmla="*/ 38632 w 4417162"/>
              <a:gd name="connsiteY49" fmla="*/ 2278062 h 6858000"/>
              <a:gd name="connsiteX50" fmla="*/ 55427 w 4417162"/>
              <a:gd name="connsiteY50" fmla="*/ 2319337 h 6858000"/>
              <a:gd name="connsiteX51" fmla="*/ 75583 w 4417162"/>
              <a:gd name="connsiteY51" fmla="*/ 2359025 h 6858000"/>
              <a:gd name="connsiteX52" fmla="*/ 95738 w 4417162"/>
              <a:gd name="connsiteY52" fmla="*/ 2395537 h 6858000"/>
              <a:gd name="connsiteX53" fmla="*/ 115893 w 4417162"/>
              <a:gd name="connsiteY53" fmla="*/ 2433637 h 6858000"/>
              <a:gd name="connsiteX54" fmla="*/ 134368 w 4417162"/>
              <a:gd name="connsiteY54" fmla="*/ 2471737 h 6858000"/>
              <a:gd name="connsiteX55" fmla="*/ 152844 w 4417162"/>
              <a:gd name="connsiteY55" fmla="*/ 2513012 h 6858000"/>
              <a:gd name="connsiteX56" fmla="*/ 167960 w 4417162"/>
              <a:gd name="connsiteY56" fmla="*/ 2560637 h 6858000"/>
              <a:gd name="connsiteX57" fmla="*/ 178038 w 4417162"/>
              <a:gd name="connsiteY57" fmla="*/ 2613025 h 6858000"/>
              <a:gd name="connsiteX58" fmla="*/ 188115 w 4417162"/>
              <a:gd name="connsiteY58" fmla="*/ 2671762 h 6858000"/>
              <a:gd name="connsiteX59" fmla="*/ 189795 w 4417162"/>
              <a:gd name="connsiteY59" fmla="*/ 2741612 h 6858000"/>
              <a:gd name="connsiteX60" fmla="*/ 188115 w 4417162"/>
              <a:gd name="connsiteY60" fmla="*/ 2809875 h 6858000"/>
              <a:gd name="connsiteX61" fmla="*/ 178038 w 4417162"/>
              <a:gd name="connsiteY61" fmla="*/ 2868612 h 6858000"/>
              <a:gd name="connsiteX62" fmla="*/ 167960 w 4417162"/>
              <a:gd name="connsiteY62" fmla="*/ 2922587 h 6858000"/>
              <a:gd name="connsiteX63" fmla="*/ 152844 w 4417162"/>
              <a:gd name="connsiteY63" fmla="*/ 2967037 h 6858000"/>
              <a:gd name="connsiteX64" fmla="*/ 134368 w 4417162"/>
              <a:gd name="connsiteY64" fmla="*/ 3009900 h 6858000"/>
              <a:gd name="connsiteX65" fmla="*/ 115893 w 4417162"/>
              <a:gd name="connsiteY65" fmla="*/ 3046412 h 6858000"/>
              <a:gd name="connsiteX66" fmla="*/ 95738 w 4417162"/>
              <a:gd name="connsiteY66" fmla="*/ 3084512 h 6858000"/>
              <a:gd name="connsiteX67" fmla="*/ 75583 w 4417162"/>
              <a:gd name="connsiteY67" fmla="*/ 3121025 h 6858000"/>
              <a:gd name="connsiteX68" fmla="*/ 55427 w 4417162"/>
              <a:gd name="connsiteY68" fmla="*/ 3160712 h 6858000"/>
              <a:gd name="connsiteX69" fmla="*/ 38632 w 4417162"/>
              <a:gd name="connsiteY69" fmla="*/ 3201987 h 6858000"/>
              <a:gd name="connsiteX70" fmla="*/ 23515 w 4417162"/>
              <a:gd name="connsiteY70" fmla="*/ 3248025 h 6858000"/>
              <a:gd name="connsiteX71" fmla="*/ 11758 w 4417162"/>
              <a:gd name="connsiteY71" fmla="*/ 3300412 h 6858000"/>
              <a:gd name="connsiteX72" fmla="*/ 3359 w 4417162"/>
              <a:gd name="connsiteY72" fmla="*/ 3360737 h 6858000"/>
              <a:gd name="connsiteX73" fmla="*/ 0 w 4417162"/>
              <a:gd name="connsiteY73" fmla="*/ 3427412 h 6858000"/>
              <a:gd name="connsiteX74" fmla="*/ 3359 w 4417162"/>
              <a:gd name="connsiteY74" fmla="*/ 3497262 h 6858000"/>
              <a:gd name="connsiteX75" fmla="*/ 11758 w 4417162"/>
              <a:gd name="connsiteY75" fmla="*/ 3557587 h 6858000"/>
              <a:gd name="connsiteX76" fmla="*/ 23515 w 4417162"/>
              <a:gd name="connsiteY76" fmla="*/ 3609975 h 6858000"/>
              <a:gd name="connsiteX77" fmla="*/ 38632 w 4417162"/>
              <a:gd name="connsiteY77" fmla="*/ 3656012 h 6858000"/>
              <a:gd name="connsiteX78" fmla="*/ 55427 w 4417162"/>
              <a:gd name="connsiteY78" fmla="*/ 3697287 h 6858000"/>
              <a:gd name="connsiteX79" fmla="*/ 75583 w 4417162"/>
              <a:gd name="connsiteY79" fmla="*/ 3736975 h 6858000"/>
              <a:gd name="connsiteX80" fmla="*/ 115893 w 4417162"/>
              <a:gd name="connsiteY80" fmla="*/ 3811587 h 6858000"/>
              <a:gd name="connsiteX81" fmla="*/ 134368 w 4417162"/>
              <a:gd name="connsiteY81" fmla="*/ 3848100 h 6858000"/>
              <a:gd name="connsiteX82" fmla="*/ 152844 w 4417162"/>
              <a:gd name="connsiteY82" fmla="*/ 3890962 h 6858000"/>
              <a:gd name="connsiteX83" fmla="*/ 167960 w 4417162"/>
              <a:gd name="connsiteY83" fmla="*/ 3935412 h 6858000"/>
              <a:gd name="connsiteX84" fmla="*/ 178038 w 4417162"/>
              <a:gd name="connsiteY84" fmla="*/ 3987800 h 6858000"/>
              <a:gd name="connsiteX85" fmla="*/ 188115 w 4417162"/>
              <a:gd name="connsiteY85" fmla="*/ 4048125 h 6858000"/>
              <a:gd name="connsiteX86" fmla="*/ 189795 w 4417162"/>
              <a:gd name="connsiteY86" fmla="*/ 4116387 h 6858000"/>
              <a:gd name="connsiteX87" fmla="*/ 188115 w 4417162"/>
              <a:gd name="connsiteY87" fmla="*/ 4186237 h 6858000"/>
              <a:gd name="connsiteX88" fmla="*/ 178038 w 4417162"/>
              <a:gd name="connsiteY88" fmla="*/ 4244975 h 6858000"/>
              <a:gd name="connsiteX89" fmla="*/ 167960 w 4417162"/>
              <a:gd name="connsiteY89" fmla="*/ 4297362 h 6858000"/>
              <a:gd name="connsiteX90" fmla="*/ 152844 w 4417162"/>
              <a:gd name="connsiteY90" fmla="*/ 4343400 h 6858000"/>
              <a:gd name="connsiteX91" fmla="*/ 134368 w 4417162"/>
              <a:gd name="connsiteY91" fmla="*/ 4386262 h 6858000"/>
              <a:gd name="connsiteX92" fmla="*/ 115893 w 4417162"/>
              <a:gd name="connsiteY92" fmla="*/ 4424362 h 6858000"/>
              <a:gd name="connsiteX93" fmla="*/ 75583 w 4417162"/>
              <a:gd name="connsiteY93" fmla="*/ 4498975 h 6858000"/>
              <a:gd name="connsiteX94" fmla="*/ 55427 w 4417162"/>
              <a:gd name="connsiteY94" fmla="*/ 4537075 h 6858000"/>
              <a:gd name="connsiteX95" fmla="*/ 38632 w 4417162"/>
              <a:gd name="connsiteY95" fmla="*/ 4579937 h 6858000"/>
              <a:gd name="connsiteX96" fmla="*/ 23515 w 4417162"/>
              <a:gd name="connsiteY96" fmla="*/ 4625975 h 6858000"/>
              <a:gd name="connsiteX97" fmla="*/ 11758 w 4417162"/>
              <a:gd name="connsiteY97" fmla="*/ 4678362 h 6858000"/>
              <a:gd name="connsiteX98" fmla="*/ 3359 w 4417162"/>
              <a:gd name="connsiteY98" fmla="*/ 4738687 h 6858000"/>
              <a:gd name="connsiteX99" fmla="*/ 0 w 4417162"/>
              <a:gd name="connsiteY99" fmla="*/ 4806950 h 6858000"/>
              <a:gd name="connsiteX100" fmla="*/ 3359 w 4417162"/>
              <a:gd name="connsiteY100" fmla="*/ 4875212 h 6858000"/>
              <a:gd name="connsiteX101" fmla="*/ 11758 w 4417162"/>
              <a:gd name="connsiteY101" fmla="*/ 4935537 h 6858000"/>
              <a:gd name="connsiteX102" fmla="*/ 23515 w 4417162"/>
              <a:gd name="connsiteY102" fmla="*/ 4987925 h 6858000"/>
              <a:gd name="connsiteX103" fmla="*/ 38632 w 4417162"/>
              <a:gd name="connsiteY103" fmla="*/ 5033962 h 6858000"/>
              <a:gd name="connsiteX104" fmla="*/ 55427 w 4417162"/>
              <a:gd name="connsiteY104" fmla="*/ 5075237 h 6858000"/>
              <a:gd name="connsiteX105" fmla="*/ 75583 w 4417162"/>
              <a:gd name="connsiteY105" fmla="*/ 5114925 h 6858000"/>
              <a:gd name="connsiteX106" fmla="*/ 95738 w 4417162"/>
              <a:gd name="connsiteY106" fmla="*/ 5149850 h 6858000"/>
              <a:gd name="connsiteX107" fmla="*/ 115893 w 4417162"/>
              <a:gd name="connsiteY107" fmla="*/ 5186362 h 6858000"/>
              <a:gd name="connsiteX108" fmla="*/ 134368 w 4417162"/>
              <a:gd name="connsiteY108" fmla="*/ 5226050 h 6858000"/>
              <a:gd name="connsiteX109" fmla="*/ 152844 w 4417162"/>
              <a:gd name="connsiteY109" fmla="*/ 5268912 h 6858000"/>
              <a:gd name="connsiteX110" fmla="*/ 167960 w 4417162"/>
              <a:gd name="connsiteY110" fmla="*/ 5313362 h 6858000"/>
              <a:gd name="connsiteX111" fmla="*/ 178038 w 4417162"/>
              <a:gd name="connsiteY111" fmla="*/ 5365750 h 6858000"/>
              <a:gd name="connsiteX112" fmla="*/ 188115 w 4417162"/>
              <a:gd name="connsiteY112" fmla="*/ 5426075 h 6858000"/>
              <a:gd name="connsiteX113" fmla="*/ 189795 w 4417162"/>
              <a:gd name="connsiteY113" fmla="*/ 5494337 h 6858000"/>
              <a:gd name="connsiteX114" fmla="*/ 188115 w 4417162"/>
              <a:gd name="connsiteY114" fmla="*/ 5562600 h 6858000"/>
              <a:gd name="connsiteX115" fmla="*/ 178038 w 4417162"/>
              <a:gd name="connsiteY115" fmla="*/ 5622925 h 6858000"/>
              <a:gd name="connsiteX116" fmla="*/ 167960 w 4417162"/>
              <a:gd name="connsiteY116" fmla="*/ 5675312 h 6858000"/>
              <a:gd name="connsiteX117" fmla="*/ 152844 w 4417162"/>
              <a:gd name="connsiteY117" fmla="*/ 5721350 h 6858000"/>
              <a:gd name="connsiteX118" fmla="*/ 134368 w 4417162"/>
              <a:gd name="connsiteY118" fmla="*/ 5762625 h 6858000"/>
              <a:gd name="connsiteX119" fmla="*/ 115893 w 4417162"/>
              <a:gd name="connsiteY119" fmla="*/ 5802312 h 6858000"/>
              <a:gd name="connsiteX120" fmla="*/ 95738 w 4417162"/>
              <a:gd name="connsiteY120" fmla="*/ 5840412 h 6858000"/>
              <a:gd name="connsiteX121" fmla="*/ 75583 w 4417162"/>
              <a:gd name="connsiteY121" fmla="*/ 5876925 h 6858000"/>
              <a:gd name="connsiteX122" fmla="*/ 55427 w 4417162"/>
              <a:gd name="connsiteY122" fmla="*/ 5915025 h 6858000"/>
              <a:gd name="connsiteX123" fmla="*/ 38632 w 4417162"/>
              <a:gd name="connsiteY123" fmla="*/ 5956300 h 6858000"/>
              <a:gd name="connsiteX124" fmla="*/ 23515 w 4417162"/>
              <a:gd name="connsiteY124" fmla="*/ 6003925 h 6858000"/>
              <a:gd name="connsiteX125" fmla="*/ 11758 w 4417162"/>
              <a:gd name="connsiteY125" fmla="*/ 6056312 h 6858000"/>
              <a:gd name="connsiteX126" fmla="*/ 3359 w 4417162"/>
              <a:gd name="connsiteY126" fmla="*/ 6113462 h 6858000"/>
              <a:gd name="connsiteX127" fmla="*/ 0 w 4417162"/>
              <a:gd name="connsiteY127" fmla="*/ 6183312 h 6858000"/>
              <a:gd name="connsiteX128" fmla="*/ 3359 w 4417162"/>
              <a:gd name="connsiteY128" fmla="*/ 6251575 h 6858000"/>
              <a:gd name="connsiteX129" fmla="*/ 11758 w 4417162"/>
              <a:gd name="connsiteY129" fmla="*/ 6311900 h 6858000"/>
              <a:gd name="connsiteX130" fmla="*/ 23515 w 4417162"/>
              <a:gd name="connsiteY130" fmla="*/ 6361112 h 6858000"/>
              <a:gd name="connsiteX131" fmla="*/ 38632 w 4417162"/>
              <a:gd name="connsiteY131" fmla="*/ 6407150 h 6858000"/>
              <a:gd name="connsiteX132" fmla="*/ 55427 w 4417162"/>
              <a:gd name="connsiteY132" fmla="*/ 6448425 h 6858000"/>
              <a:gd name="connsiteX133" fmla="*/ 73903 w 4417162"/>
              <a:gd name="connsiteY133" fmla="*/ 6488112 h 6858000"/>
              <a:gd name="connsiteX134" fmla="*/ 92379 w 4417162"/>
              <a:gd name="connsiteY134" fmla="*/ 6523037 h 6858000"/>
              <a:gd name="connsiteX135" fmla="*/ 112534 w 4417162"/>
              <a:gd name="connsiteY135" fmla="*/ 6561137 h 6858000"/>
              <a:gd name="connsiteX136" fmla="*/ 132689 w 4417162"/>
              <a:gd name="connsiteY136" fmla="*/ 6597650 h 6858000"/>
              <a:gd name="connsiteX137" fmla="*/ 149485 w 4417162"/>
              <a:gd name="connsiteY137" fmla="*/ 6640512 h 6858000"/>
              <a:gd name="connsiteX138" fmla="*/ 166281 w 4417162"/>
              <a:gd name="connsiteY138" fmla="*/ 6683375 h 6858000"/>
              <a:gd name="connsiteX139" fmla="*/ 176358 w 4417162"/>
              <a:gd name="connsiteY139" fmla="*/ 6735762 h 6858000"/>
              <a:gd name="connsiteX140" fmla="*/ 184756 w 4417162"/>
              <a:gd name="connsiteY140" fmla="*/ 6791325 h 6858000"/>
              <a:gd name="connsiteX141" fmla="*/ 189795 w 4417162"/>
              <a:gd name="connsiteY141" fmla="*/ 6858000 h 6858000"/>
              <a:gd name="connsiteX142" fmla="*/ 334173 w 4417162"/>
              <a:gd name="connsiteY142" fmla="*/ 6858000 h 6858000"/>
              <a:gd name="connsiteX143" fmla="*/ 334174 w 4417162"/>
              <a:gd name="connsiteY143" fmla="*/ 6858000 h 6858000"/>
              <a:gd name="connsiteX144" fmla="*/ 4417162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4417162" y="0"/>
                </a:moveTo>
                <a:lnTo>
                  <a:pt x="334174" y="0"/>
                </a:lnTo>
                <a:lnTo>
                  <a:pt x="334173" y="0"/>
                </a:lnTo>
                <a:lnTo>
                  <a:pt x="189795" y="0"/>
                </a:lnTo>
                <a:lnTo>
                  <a:pt x="184756" y="66675"/>
                </a:lnTo>
                <a:lnTo>
                  <a:pt x="176358" y="122237"/>
                </a:lnTo>
                <a:lnTo>
                  <a:pt x="166281" y="174625"/>
                </a:lnTo>
                <a:lnTo>
                  <a:pt x="149485" y="217487"/>
                </a:lnTo>
                <a:lnTo>
                  <a:pt x="132689" y="260350"/>
                </a:lnTo>
                <a:lnTo>
                  <a:pt x="112534" y="296862"/>
                </a:lnTo>
                <a:lnTo>
                  <a:pt x="92379" y="334962"/>
                </a:lnTo>
                <a:lnTo>
                  <a:pt x="73903" y="369887"/>
                </a:lnTo>
                <a:lnTo>
                  <a:pt x="55427" y="409575"/>
                </a:lnTo>
                <a:lnTo>
                  <a:pt x="38632" y="450850"/>
                </a:lnTo>
                <a:lnTo>
                  <a:pt x="23515" y="496887"/>
                </a:lnTo>
                <a:lnTo>
                  <a:pt x="11758" y="546100"/>
                </a:lnTo>
                <a:lnTo>
                  <a:pt x="3359" y="606425"/>
                </a:lnTo>
                <a:lnTo>
                  <a:pt x="0" y="673100"/>
                </a:lnTo>
                <a:lnTo>
                  <a:pt x="3359" y="744537"/>
                </a:lnTo>
                <a:lnTo>
                  <a:pt x="11758" y="801687"/>
                </a:lnTo>
                <a:lnTo>
                  <a:pt x="23515" y="854075"/>
                </a:lnTo>
                <a:lnTo>
                  <a:pt x="38632" y="901700"/>
                </a:lnTo>
                <a:lnTo>
                  <a:pt x="55427" y="942975"/>
                </a:lnTo>
                <a:lnTo>
                  <a:pt x="75583" y="981075"/>
                </a:lnTo>
                <a:lnTo>
                  <a:pt x="95738" y="1017587"/>
                </a:lnTo>
                <a:lnTo>
                  <a:pt x="115893" y="1055687"/>
                </a:lnTo>
                <a:lnTo>
                  <a:pt x="134368" y="1095375"/>
                </a:lnTo>
                <a:lnTo>
                  <a:pt x="152844" y="1136650"/>
                </a:lnTo>
                <a:lnTo>
                  <a:pt x="167960" y="1182687"/>
                </a:lnTo>
                <a:lnTo>
                  <a:pt x="178038" y="1235075"/>
                </a:lnTo>
                <a:lnTo>
                  <a:pt x="188115" y="1295400"/>
                </a:lnTo>
                <a:lnTo>
                  <a:pt x="189795" y="1363662"/>
                </a:lnTo>
                <a:lnTo>
                  <a:pt x="188115" y="1431925"/>
                </a:lnTo>
                <a:lnTo>
                  <a:pt x="178038" y="1492250"/>
                </a:lnTo>
                <a:lnTo>
                  <a:pt x="167960" y="1544637"/>
                </a:lnTo>
                <a:lnTo>
                  <a:pt x="152844" y="1589087"/>
                </a:lnTo>
                <a:lnTo>
                  <a:pt x="134368" y="1631950"/>
                </a:lnTo>
                <a:lnTo>
                  <a:pt x="115893" y="1671637"/>
                </a:lnTo>
                <a:lnTo>
                  <a:pt x="95738" y="1708150"/>
                </a:lnTo>
                <a:lnTo>
                  <a:pt x="75583" y="1743075"/>
                </a:lnTo>
                <a:lnTo>
                  <a:pt x="55427" y="1782762"/>
                </a:lnTo>
                <a:lnTo>
                  <a:pt x="38632" y="1824037"/>
                </a:lnTo>
                <a:lnTo>
                  <a:pt x="23515" y="1870075"/>
                </a:lnTo>
                <a:lnTo>
                  <a:pt x="11758" y="1922462"/>
                </a:lnTo>
                <a:lnTo>
                  <a:pt x="3359" y="1982787"/>
                </a:lnTo>
                <a:lnTo>
                  <a:pt x="0" y="2051050"/>
                </a:lnTo>
                <a:lnTo>
                  <a:pt x="3359" y="2119312"/>
                </a:lnTo>
                <a:lnTo>
                  <a:pt x="11758" y="2179637"/>
                </a:lnTo>
                <a:lnTo>
                  <a:pt x="23515" y="2232025"/>
                </a:lnTo>
                <a:lnTo>
                  <a:pt x="38632" y="2278062"/>
                </a:lnTo>
                <a:lnTo>
                  <a:pt x="55427" y="2319337"/>
                </a:lnTo>
                <a:lnTo>
                  <a:pt x="75583" y="2359025"/>
                </a:lnTo>
                <a:lnTo>
                  <a:pt x="95738" y="2395537"/>
                </a:lnTo>
                <a:lnTo>
                  <a:pt x="115893" y="2433637"/>
                </a:lnTo>
                <a:lnTo>
                  <a:pt x="134368" y="2471737"/>
                </a:lnTo>
                <a:lnTo>
                  <a:pt x="152844" y="2513012"/>
                </a:lnTo>
                <a:lnTo>
                  <a:pt x="167960" y="2560637"/>
                </a:lnTo>
                <a:lnTo>
                  <a:pt x="178038" y="2613025"/>
                </a:lnTo>
                <a:lnTo>
                  <a:pt x="188115" y="2671762"/>
                </a:lnTo>
                <a:lnTo>
                  <a:pt x="189795" y="2741612"/>
                </a:lnTo>
                <a:lnTo>
                  <a:pt x="188115" y="2809875"/>
                </a:lnTo>
                <a:lnTo>
                  <a:pt x="178038" y="2868612"/>
                </a:lnTo>
                <a:lnTo>
                  <a:pt x="167960" y="2922587"/>
                </a:lnTo>
                <a:lnTo>
                  <a:pt x="152844" y="2967037"/>
                </a:lnTo>
                <a:lnTo>
                  <a:pt x="134368" y="3009900"/>
                </a:lnTo>
                <a:lnTo>
                  <a:pt x="115893" y="3046412"/>
                </a:lnTo>
                <a:lnTo>
                  <a:pt x="95738" y="3084512"/>
                </a:lnTo>
                <a:lnTo>
                  <a:pt x="75583" y="3121025"/>
                </a:lnTo>
                <a:lnTo>
                  <a:pt x="55427" y="3160712"/>
                </a:lnTo>
                <a:lnTo>
                  <a:pt x="38632" y="3201987"/>
                </a:lnTo>
                <a:lnTo>
                  <a:pt x="23515" y="3248025"/>
                </a:lnTo>
                <a:lnTo>
                  <a:pt x="11758" y="3300412"/>
                </a:lnTo>
                <a:lnTo>
                  <a:pt x="3359" y="3360737"/>
                </a:lnTo>
                <a:lnTo>
                  <a:pt x="0" y="3427412"/>
                </a:lnTo>
                <a:lnTo>
                  <a:pt x="3359" y="3497262"/>
                </a:lnTo>
                <a:lnTo>
                  <a:pt x="11758" y="3557587"/>
                </a:lnTo>
                <a:lnTo>
                  <a:pt x="23515" y="3609975"/>
                </a:lnTo>
                <a:lnTo>
                  <a:pt x="38632" y="3656012"/>
                </a:lnTo>
                <a:lnTo>
                  <a:pt x="55427" y="3697287"/>
                </a:lnTo>
                <a:lnTo>
                  <a:pt x="75583" y="3736975"/>
                </a:lnTo>
                <a:lnTo>
                  <a:pt x="115893" y="3811587"/>
                </a:lnTo>
                <a:lnTo>
                  <a:pt x="134368" y="3848100"/>
                </a:lnTo>
                <a:lnTo>
                  <a:pt x="152844" y="3890962"/>
                </a:lnTo>
                <a:lnTo>
                  <a:pt x="167960" y="3935412"/>
                </a:lnTo>
                <a:lnTo>
                  <a:pt x="178038" y="3987800"/>
                </a:lnTo>
                <a:lnTo>
                  <a:pt x="188115" y="4048125"/>
                </a:lnTo>
                <a:lnTo>
                  <a:pt x="189795" y="4116387"/>
                </a:lnTo>
                <a:lnTo>
                  <a:pt x="188115" y="4186237"/>
                </a:lnTo>
                <a:lnTo>
                  <a:pt x="178038" y="4244975"/>
                </a:lnTo>
                <a:lnTo>
                  <a:pt x="167960" y="4297362"/>
                </a:lnTo>
                <a:lnTo>
                  <a:pt x="152844" y="4343400"/>
                </a:lnTo>
                <a:lnTo>
                  <a:pt x="134368" y="4386262"/>
                </a:lnTo>
                <a:lnTo>
                  <a:pt x="115893" y="4424362"/>
                </a:lnTo>
                <a:lnTo>
                  <a:pt x="75583" y="4498975"/>
                </a:lnTo>
                <a:lnTo>
                  <a:pt x="55427" y="4537075"/>
                </a:lnTo>
                <a:lnTo>
                  <a:pt x="38632" y="4579937"/>
                </a:lnTo>
                <a:lnTo>
                  <a:pt x="23515" y="4625975"/>
                </a:lnTo>
                <a:lnTo>
                  <a:pt x="11758" y="4678362"/>
                </a:lnTo>
                <a:lnTo>
                  <a:pt x="3359" y="4738687"/>
                </a:lnTo>
                <a:lnTo>
                  <a:pt x="0" y="4806950"/>
                </a:lnTo>
                <a:lnTo>
                  <a:pt x="3359" y="4875212"/>
                </a:lnTo>
                <a:lnTo>
                  <a:pt x="11758" y="4935537"/>
                </a:lnTo>
                <a:lnTo>
                  <a:pt x="23515" y="4987925"/>
                </a:lnTo>
                <a:lnTo>
                  <a:pt x="38632" y="5033962"/>
                </a:lnTo>
                <a:lnTo>
                  <a:pt x="55427" y="5075237"/>
                </a:lnTo>
                <a:lnTo>
                  <a:pt x="75583" y="5114925"/>
                </a:lnTo>
                <a:lnTo>
                  <a:pt x="95738" y="5149850"/>
                </a:lnTo>
                <a:lnTo>
                  <a:pt x="115893" y="5186362"/>
                </a:lnTo>
                <a:lnTo>
                  <a:pt x="134368" y="5226050"/>
                </a:lnTo>
                <a:lnTo>
                  <a:pt x="152844" y="5268912"/>
                </a:lnTo>
                <a:lnTo>
                  <a:pt x="167960" y="5313362"/>
                </a:lnTo>
                <a:lnTo>
                  <a:pt x="178038" y="5365750"/>
                </a:lnTo>
                <a:lnTo>
                  <a:pt x="188115" y="5426075"/>
                </a:lnTo>
                <a:lnTo>
                  <a:pt x="189795" y="5494337"/>
                </a:lnTo>
                <a:lnTo>
                  <a:pt x="188115" y="5562600"/>
                </a:lnTo>
                <a:lnTo>
                  <a:pt x="178038" y="5622925"/>
                </a:lnTo>
                <a:lnTo>
                  <a:pt x="167960" y="5675312"/>
                </a:lnTo>
                <a:lnTo>
                  <a:pt x="152844" y="5721350"/>
                </a:lnTo>
                <a:lnTo>
                  <a:pt x="134368" y="5762625"/>
                </a:lnTo>
                <a:lnTo>
                  <a:pt x="115893" y="5802312"/>
                </a:lnTo>
                <a:lnTo>
                  <a:pt x="95738" y="5840412"/>
                </a:lnTo>
                <a:lnTo>
                  <a:pt x="75583" y="5876925"/>
                </a:lnTo>
                <a:lnTo>
                  <a:pt x="55427" y="5915025"/>
                </a:lnTo>
                <a:lnTo>
                  <a:pt x="38632" y="5956300"/>
                </a:lnTo>
                <a:lnTo>
                  <a:pt x="23515" y="6003925"/>
                </a:lnTo>
                <a:lnTo>
                  <a:pt x="11758" y="6056312"/>
                </a:lnTo>
                <a:lnTo>
                  <a:pt x="3359" y="6113462"/>
                </a:lnTo>
                <a:lnTo>
                  <a:pt x="0" y="6183312"/>
                </a:lnTo>
                <a:lnTo>
                  <a:pt x="3359" y="6251575"/>
                </a:lnTo>
                <a:lnTo>
                  <a:pt x="11758" y="6311900"/>
                </a:lnTo>
                <a:lnTo>
                  <a:pt x="23515" y="6361112"/>
                </a:lnTo>
                <a:lnTo>
                  <a:pt x="38632" y="6407150"/>
                </a:lnTo>
                <a:lnTo>
                  <a:pt x="55427" y="6448425"/>
                </a:lnTo>
                <a:lnTo>
                  <a:pt x="73903" y="6488112"/>
                </a:lnTo>
                <a:lnTo>
                  <a:pt x="92379" y="6523037"/>
                </a:lnTo>
                <a:lnTo>
                  <a:pt x="112534" y="6561137"/>
                </a:lnTo>
                <a:lnTo>
                  <a:pt x="132689" y="6597650"/>
                </a:lnTo>
                <a:lnTo>
                  <a:pt x="149485" y="6640512"/>
                </a:lnTo>
                <a:lnTo>
                  <a:pt x="166281" y="6683375"/>
                </a:lnTo>
                <a:lnTo>
                  <a:pt x="176358" y="6735762"/>
                </a:lnTo>
                <a:lnTo>
                  <a:pt x="184756" y="6791325"/>
                </a:lnTo>
                <a:lnTo>
                  <a:pt x="189795" y="6858000"/>
                </a:lnTo>
                <a:lnTo>
                  <a:pt x="334173" y="6858000"/>
                </a:lnTo>
                <a:lnTo>
                  <a:pt x="334174" y="6858000"/>
                </a:lnTo>
                <a:lnTo>
                  <a:pt x="4417162" y="6858000"/>
                </a:lnTo>
                <a:close/>
              </a:path>
            </a:pathLst>
          </a:custGeom>
          <a:solidFill>
            <a:schemeClr val="accent1">
              <a:lumMod val="50000"/>
              <a:alpha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4" name="Title 3">
            <a:extLst>
              <a:ext uri="{FF2B5EF4-FFF2-40B4-BE49-F238E27FC236}">
                <a16:creationId xmlns:a16="http://schemas.microsoft.com/office/drawing/2014/main" id="{90F4C2E6-807E-DBC0-AAA4-0F89D3D707E5}"/>
              </a:ext>
            </a:extLst>
          </p:cNvPr>
          <p:cNvSpPr>
            <a:spLocks noGrp="1"/>
          </p:cNvSpPr>
          <p:nvPr>
            <p:ph type="title"/>
          </p:nvPr>
        </p:nvSpPr>
        <p:spPr>
          <a:xfrm>
            <a:off x="457201" y="723406"/>
            <a:ext cx="3234018" cy="3826728"/>
          </a:xfrm>
          <a:prstGeom prst="ellipse">
            <a:avLst/>
          </a:prstGeom>
        </p:spPr>
        <p:txBody>
          <a:bodyPr vert="horz" lIns="91440" tIns="45720" rIns="91440" bIns="45720" rtlCol="0" anchor="b">
            <a:normAutofit/>
          </a:bodyPr>
          <a:lstStyle/>
          <a:p>
            <a:pPr algn="ctr"/>
            <a:r>
              <a:rPr lang="en-US" sz="3500" kern="1200">
                <a:solidFill>
                  <a:schemeClr val="tx1"/>
                </a:solidFill>
                <a:latin typeface="+mj-lt"/>
                <a:ea typeface="+mj-ea"/>
                <a:cs typeface="+mj-cs"/>
              </a:rPr>
              <a:t>Dashboard</a:t>
            </a:r>
          </a:p>
        </p:txBody>
      </p:sp>
      <p:pic>
        <p:nvPicPr>
          <p:cNvPr id="6" name="Content Placeholder 5">
            <a:extLst>
              <a:ext uri="{FF2B5EF4-FFF2-40B4-BE49-F238E27FC236}">
                <a16:creationId xmlns:a16="http://schemas.microsoft.com/office/drawing/2014/main" id="{53BEDCEF-E904-0518-16CE-5741AB2E124C}"/>
              </a:ext>
            </a:extLst>
          </p:cNvPr>
          <p:cNvPicPr>
            <a:picLocks noGrp="1" noChangeAspect="1"/>
          </p:cNvPicPr>
          <p:nvPr>
            <p:ph idx="1"/>
          </p:nvPr>
        </p:nvPicPr>
        <p:blipFill>
          <a:blip r:embed="rId4">
            <a:extLst>
              <a:ext uri="{28A0092B-C50C-407E-A947-70E740481C1C}">
                <a14:useLocalDpi xmlns:a14="http://schemas.microsoft.com/office/drawing/2010/main" val="0"/>
              </a:ext>
            </a:extLst>
          </a:blip>
          <a:srcRect/>
          <a:stretch/>
        </p:blipFill>
        <p:spPr>
          <a:xfrm>
            <a:off x="6927403" y="643469"/>
            <a:ext cx="2609037" cy="5571062"/>
          </a:xfrm>
          <a:prstGeom prst="rect">
            <a:avLst/>
          </a:prstGeom>
        </p:spPr>
      </p:pic>
    </p:spTree>
    <p:extLst>
      <p:ext uri="{BB962C8B-B14F-4D97-AF65-F5344CB8AC3E}">
        <p14:creationId xmlns:p14="http://schemas.microsoft.com/office/powerpoint/2010/main" val="3773224600"/>
      </p:ext>
    </p:extLst>
  </p:cSld>
  <p:clrMapOvr>
    <a:masterClrMapping/>
  </p:clrMapOvr>
  <p:extLst>
    <p:ext uri="{6950BFC3-D8DA-4A85-94F7-54DA5524770B}">
      <p188:commentRel xmlns:p188="http://schemas.microsoft.com/office/powerpoint/2018/8/main" r:id="rId3"/>
    </p:ext>
  </p:extLst>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0F4C2E6-807E-DBC0-AAA4-0F89D3D707E5}"/>
              </a:ext>
            </a:extLst>
          </p:cNvPr>
          <p:cNvSpPr>
            <a:spLocks noGrp="1"/>
          </p:cNvSpPr>
          <p:nvPr>
            <p:ph type="title"/>
          </p:nvPr>
        </p:nvSpPr>
        <p:spPr>
          <a:xfrm>
            <a:off x="552450" y="-24781"/>
            <a:ext cx="3333750" cy="2371148"/>
          </a:xfrm>
          <a:prstGeom prst="ellipse">
            <a:avLst/>
          </a:prstGeom>
        </p:spPr>
        <p:txBody>
          <a:bodyPr vert="horz" lIns="91440" tIns="45720" rIns="91440" bIns="45720" rtlCol="0" anchor="ctr">
            <a:normAutofit/>
          </a:bodyPr>
          <a:lstStyle/>
          <a:p>
            <a:r>
              <a:rPr lang="en-US" sz="3200" kern="1200" dirty="0">
                <a:latin typeface="+mj-lt"/>
                <a:ea typeface="+mj-ea"/>
                <a:cs typeface="+mj-cs"/>
              </a:rPr>
              <a:t>Mood Rating</a:t>
            </a:r>
          </a:p>
        </p:txBody>
      </p:sp>
      <p:pic>
        <p:nvPicPr>
          <p:cNvPr id="9" name="Picture 8">
            <a:extLst>
              <a:ext uri="{FF2B5EF4-FFF2-40B4-BE49-F238E27FC236}">
                <a16:creationId xmlns:a16="http://schemas.microsoft.com/office/drawing/2014/main" id="{78D4A2F5-EBC9-1A60-33CE-629742330EA9}"/>
              </a:ext>
            </a:extLst>
          </p:cNvPr>
          <p:cNvPicPr>
            <a:picLocks noChangeAspect="1"/>
          </p:cNvPicPr>
          <p:nvPr/>
        </p:nvPicPr>
        <p:blipFill>
          <a:blip r:embed="rId3"/>
          <a:stretch>
            <a:fillRect/>
          </a:stretch>
        </p:blipFill>
        <p:spPr>
          <a:xfrm>
            <a:off x="4854793" y="445069"/>
            <a:ext cx="6953780" cy="5910713"/>
          </a:xfrm>
          <a:prstGeom prst="rect">
            <a:avLst/>
          </a:prstGeom>
        </p:spPr>
      </p:pic>
      <p:pic>
        <p:nvPicPr>
          <p:cNvPr id="1026" name="Picture 2" descr="Mood rating illustration 5083257 Vector Art at Vecteezy">
            <a:extLst>
              <a:ext uri="{FF2B5EF4-FFF2-40B4-BE49-F238E27FC236}">
                <a16:creationId xmlns:a16="http://schemas.microsoft.com/office/drawing/2014/main" id="{11D3B59A-F046-173C-13FC-7CA970CDBAFD}"/>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3418" t="18940" r="13827" b="18670"/>
          <a:stretch/>
        </p:blipFill>
        <p:spPr bwMode="auto">
          <a:xfrm>
            <a:off x="2430887" y="5320181"/>
            <a:ext cx="2314576" cy="1190913"/>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Mood tracking is a chore. Here's why I do it anyway · Exist">
            <a:extLst>
              <a:ext uri="{FF2B5EF4-FFF2-40B4-BE49-F238E27FC236}">
                <a16:creationId xmlns:a16="http://schemas.microsoft.com/office/drawing/2014/main" id="{9FB99A15-5958-1E36-67BE-2CBCEE3AB46A}"/>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2456" t="25278" r="18467" b="64031"/>
          <a:stretch/>
        </p:blipFill>
        <p:spPr bwMode="auto">
          <a:xfrm>
            <a:off x="7566124" y="2674764"/>
            <a:ext cx="4073426" cy="485776"/>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Rate, rating, mood icon - Download on Iconfinder">
            <a:extLst>
              <a:ext uri="{FF2B5EF4-FFF2-40B4-BE49-F238E27FC236}">
                <a16:creationId xmlns:a16="http://schemas.microsoft.com/office/drawing/2014/main" id="{110DFD48-0BD2-924A-D7BA-33BAD92BFD51}"/>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97817" y="4663098"/>
            <a:ext cx="2023740" cy="202374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descr="Emotion Rating Scales - Minute Meeting Tool by School Counseling Spot">
            <a:extLst>
              <a:ext uri="{FF2B5EF4-FFF2-40B4-BE49-F238E27FC236}">
                <a16:creationId xmlns:a16="http://schemas.microsoft.com/office/drawing/2014/main" id="{F46956DA-EFAF-F067-9877-27DD432FD294}"/>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52450" y="1956990"/>
            <a:ext cx="3333750" cy="250507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649800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213D52-17A6-27B3-2C58-650D25069EE9}"/>
              </a:ext>
            </a:extLst>
          </p:cNvPr>
          <p:cNvSpPr>
            <a:spLocks noGrp="1"/>
          </p:cNvSpPr>
          <p:nvPr>
            <p:ph type="title"/>
          </p:nvPr>
        </p:nvSpPr>
        <p:spPr>
          <a:xfrm>
            <a:off x="556532" y="643467"/>
            <a:ext cx="11210925" cy="744836"/>
          </a:xfrm>
        </p:spPr>
        <p:txBody>
          <a:bodyPr vert="horz" lIns="91440" tIns="45720" rIns="91440" bIns="45720" rtlCol="0" anchor="ctr">
            <a:normAutofit/>
          </a:bodyPr>
          <a:lstStyle/>
          <a:p>
            <a:pPr algn="ctr"/>
            <a:r>
              <a:rPr lang="en-US" sz="3200" kern="1200">
                <a:latin typeface="+mj-lt"/>
                <a:ea typeface="+mj-ea"/>
                <a:cs typeface="+mj-cs"/>
              </a:rPr>
              <a:t>Mood Tracking</a:t>
            </a:r>
          </a:p>
        </p:txBody>
      </p:sp>
      <p:pic>
        <p:nvPicPr>
          <p:cNvPr id="5" name="Content Placeholder 4">
            <a:extLst>
              <a:ext uri="{FF2B5EF4-FFF2-40B4-BE49-F238E27FC236}">
                <a16:creationId xmlns:a16="http://schemas.microsoft.com/office/drawing/2014/main" id="{CB8B0D00-4A52-96D5-A36C-FF24884A223C}"/>
              </a:ext>
            </a:extLst>
          </p:cNvPr>
          <p:cNvPicPr>
            <a:picLocks noGrp="1" noChangeAspect="1"/>
          </p:cNvPicPr>
          <p:nvPr>
            <p:ph idx="1"/>
          </p:nvPr>
        </p:nvPicPr>
        <p:blipFill rotWithShape="1">
          <a:blip r:embed="rId3"/>
          <a:srcRect t="4475" b="8432"/>
          <a:stretch/>
        </p:blipFill>
        <p:spPr>
          <a:xfrm>
            <a:off x="643467" y="2231571"/>
            <a:ext cx="10905066" cy="3178629"/>
          </a:xfrm>
          <a:prstGeom prst="rect">
            <a:avLst/>
          </a:prstGeom>
        </p:spPr>
      </p:pic>
    </p:spTree>
    <p:extLst>
      <p:ext uri="{BB962C8B-B14F-4D97-AF65-F5344CB8AC3E}">
        <p14:creationId xmlns:p14="http://schemas.microsoft.com/office/powerpoint/2010/main" val="7127154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1825AC39-5F85-4CAA-8A81-A1287086B2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FFFFFF"/>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Freeform: Shape 11">
            <a:extLst>
              <a:ext uri="{FF2B5EF4-FFF2-40B4-BE49-F238E27FC236}">
                <a16:creationId xmlns:a16="http://schemas.microsoft.com/office/drawing/2014/main" id="{95DA4D23-37FC-4B90-8188-F0377C5FF4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417162" cy="6858000"/>
          </a:xfrm>
          <a:custGeom>
            <a:avLst/>
            <a:gdLst>
              <a:gd name="connsiteX0" fmla="*/ 0 w 4417162"/>
              <a:gd name="connsiteY0" fmla="*/ 0 h 6858000"/>
              <a:gd name="connsiteX1" fmla="*/ 144378 w 4417162"/>
              <a:gd name="connsiteY1" fmla="*/ 0 h 6858000"/>
              <a:gd name="connsiteX2" fmla="*/ 2310062 w 4417162"/>
              <a:gd name="connsiteY2" fmla="*/ 0 h 6858000"/>
              <a:gd name="connsiteX3" fmla="*/ 4227367 w 4417162"/>
              <a:gd name="connsiteY3" fmla="*/ 0 h 6858000"/>
              <a:gd name="connsiteX4" fmla="*/ 4232407 w 4417162"/>
              <a:gd name="connsiteY4" fmla="*/ 66675 h 6858000"/>
              <a:gd name="connsiteX5" fmla="*/ 4240804 w 4417162"/>
              <a:gd name="connsiteY5" fmla="*/ 122237 h 6858000"/>
              <a:gd name="connsiteX6" fmla="*/ 4250882 w 4417162"/>
              <a:gd name="connsiteY6" fmla="*/ 174625 h 6858000"/>
              <a:gd name="connsiteX7" fmla="*/ 4267678 w 4417162"/>
              <a:gd name="connsiteY7" fmla="*/ 217487 h 6858000"/>
              <a:gd name="connsiteX8" fmla="*/ 4284474 w 4417162"/>
              <a:gd name="connsiteY8" fmla="*/ 260350 h 6858000"/>
              <a:gd name="connsiteX9" fmla="*/ 4304629 w 4417162"/>
              <a:gd name="connsiteY9" fmla="*/ 296862 h 6858000"/>
              <a:gd name="connsiteX10" fmla="*/ 4324784 w 4417162"/>
              <a:gd name="connsiteY10" fmla="*/ 334962 h 6858000"/>
              <a:gd name="connsiteX11" fmla="*/ 4343260 w 4417162"/>
              <a:gd name="connsiteY11" fmla="*/ 369887 h 6858000"/>
              <a:gd name="connsiteX12" fmla="*/ 4361735 w 4417162"/>
              <a:gd name="connsiteY12" fmla="*/ 409575 h 6858000"/>
              <a:gd name="connsiteX13" fmla="*/ 4378531 w 4417162"/>
              <a:gd name="connsiteY13" fmla="*/ 450850 h 6858000"/>
              <a:gd name="connsiteX14" fmla="*/ 4393648 w 4417162"/>
              <a:gd name="connsiteY14" fmla="*/ 496887 h 6858000"/>
              <a:gd name="connsiteX15" fmla="*/ 4405405 w 4417162"/>
              <a:gd name="connsiteY15" fmla="*/ 546100 h 6858000"/>
              <a:gd name="connsiteX16" fmla="*/ 4413803 w 4417162"/>
              <a:gd name="connsiteY16" fmla="*/ 606425 h 6858000"/>
              <a:gd name="connsiteX17" fmla="*/ 4417162 w 4417162"/>
              <a:gd name="connsiteY17" fmla="*/ 673100 h 6858000"/>
              <a:gd name="connsiteX18" fmla="*/ 4413803 w 4417162"/>
              <a:gd name="connsiteY18" fmla="*/ 744537 h 6858000"/>
              <a:gd name="connsiteX19" fmla="*/ 4405405 w 4417162"/>
              <a:gd name="connsiteY19" fmla="*/ 801687 h 6858000"/>
              <a:gd name="connsiteX20" fmla="*/ 4393648 w 4417162"/>
              <a:gd name="connsiteY20" fmla="*/ 854075 h 6858000"/>
              <a:gd name="connsiteX21" fmla="*/ 4378531 w 4417162"/>
              <a:gd name="connsiteY21" fmla="*/ 901700 h 6858000"/>
              <a:gd name="connsiteX22" fmla="*/ 4361735 w 4417162"/>
              <a:gd name="connsiteY22" fmla="*/ 942975 h 6858000"/>
              <a:gd name="connsiteX23" fmla="*/ 4341580 w 4417162"/>
              <a:gd name="connsiteY23" fmla="*/ 981075 h 6858000"/>
              <a:gd name="connsiteX24" fmla="*/ 4321425 w 4417162"/>
              <a:gd name="connsiteY24" fmla="*/ 1017587 h 6858000"/>
              <a:gd name="connsiteX25" fmla="*/ 4301270 w 4417162"/>
              <a:gd name="connsiteY25" fmla="*/ 1055687 h 6858000"/>
              <a:gd name="connsiteX26" fmla="*/ 4282794 w 4417162"/>
              <a:gd name="connsiteY26" fmla="*/ 1095375 h 6858000"/>
              <a:gd name="connsiteX27" fmla="*/ 4264318 w 4417162"/>
              <a:gd name="connsiteY27" fmla="*/ 1136650 h 6858000"/>
              <a:gd name="connsiteX28" fmla="*/ 4249203 w 4417162"/>
              <a:gd name="connsiteY28" fmla="*/ 1182687 h 6858000"/>
              <a:gd name="connsiteX29" fmla="*/ 4239125 w 4417162"/>
              <a:gd name="connsiteY29" fmla="*/ 1235075 h 6858000"/>
              <a:gd name="connsiteX30" fmla="*/ 4229047 w 4417162"/>
              <a:gd name="connsiteY30" fmla="*/ 1295400 h 6858000"/>
              <a:gd name="connsiteX31" fmla="*/ 4227367 w 4417162"/>
              <a:gd name="connsiteY31" fmla="*/ 1363662 h 6858000"/>
              <a:gd name="connsiteX32" fmla="*/ 4229047 w 4417162"/>
              <a:gd name="connsiteY32" fmla="*/ 1431925 h 6858000"/>
              <a:gd name="connsiteX33" fmla="*/ 4239125 w 4417162"/>
              <a:gd name="connsiteY33" fmla="*/ 1492250 h 6858000"/>
              <a:gd name="connsiteX34" fmla="*/ 4249203 w 4417162"/>
              <a:gd name="connsiteY34" fmla="*/ 1544637 h 6858000"/>
              <a:gd name="connsiteX35" fmla="*/ 4264318 w 4417162"/>
              <a:gd name="connsiteY35" fmla="*/ 1589087 h 6858000"/>
              <a:gd name="connsiteX36" fmla="*/ 4282794 w 4417162"/>
              <a:gd name="connsiteY36" fmla="*/ 1631950 h 6858000"/>
              <a:gd name="connsiteX37" fmla="*/ 4301270 w 4417162"/>
              <a:gd name="connsiteY37" fmla="*/ 1671637 h 6858000"/>
              <a:gd name="connsiteX38" fmla="*/ 4321425 w 4417162"/>
              <a:gd name="connsiteY38" fmla="*/ 1708150 h 6858000"/>
              <a:gd name="connsiteX39" fmla="*/ 4341580 w 4417162"/>
              <a:gd name="connsiteY39" fmla="*/ 1743075 h 6858000"/>
              <a:gd name="connsiteX40" fmla="*/ 4361735 w 4417162"/>
              <a:gd name="connsiteY40" fmla="*/ 1782762 h 6858000"/>
              <a:gd name="connsiteX41" fmla="*/ 4378531 w 4417162"/>
              <a:gd name="connsiteY41" fmla="*/ 1824037 h 6858000"/>
              <a:gd name="connsiteX42" fmla="*/ 4393648 w 4417162"/>
              <a:gd name="connsiteY42" fmla="*/ 1870075 h 6858000"/>
              <a:gd name="connsiteX43" fmla="*/ 4405405 w 4417162"/>
              <a:gd name="connsiteY43" fmla="*/ 1922462 h 6858000"/>
              <a:gd name="connsiteX44" fmla="*/ 4413803 w 4417162"/>
              <a:gd name="connsiteY44" fmla="*/ 1982787 h 6858000"/>
              <a:gd name="connsiteX45" fmla="*/ 4417162 w 4417162"/>
              <a:gd name="connsiteY45" fmla="*/ 2051050 h 6858000"/>
              <a:gd name="connsiteX46" fmla="*/ 4413803 w 4417162"/>
              <a:gd name="connsiteY46" fmla="*/ 2119312 h 6858000"/>
              <a:gd name="connsiteX47" fmla="*/ 4405405 w 4417162"/>
              <a:gd name="connsiteY47" fmla="*/ 2179637 h 6858000"/>
              <a:gd name="connsiteX48" fmla="*/ 4393648 w 4417162"/>
              <a:gd name="connsiteY48" fmla="*/ 2232025 h 6858000"/>
              <a:gd name="connsiteX49" fmla="*/ 4378531 w 4417162"/>
              <a:gd name="connsiteY49" fmla="*/ 2278062 h 6858000"/>
              <a:gd name="connsiteX50" fmla="*/ 4361735 w 4417162"/>
              <a:gd name="connsiteY50" fmla="*/ 2319337 h 6858000"/>
              <a:gd name="connsiteX51" fmla="*/ 4341580 w 4417162"/>
              <a:gd name="connsiteY51" fmla="*/ 2359025 h 6858000"/>
              <a:gd name="connsiteX52" fmla="*/ 4321425 w 4417162"/>
              <a:gd name="connsiteY52" fmla="*/ 2395537 h 6858000"/>
              <a:gd name="connsiteX53" fmla="*/ 4301270 w 4417162"/>
              <a:gd name="connsiteY53" fmla="*/ 2433637 h 6858000"/>
              <a:gd name="connsiteX54" fmla="*/ 4282794 w 4417162"/>
              <a:gd name="connsiteY54" fmla="*/ 2471737 h 6858000"/>
              <a:gd name="connsiteX55" fmla="*/ 4264318 w 4417162"/>
              <a:gd name="connsiteY55" fmla="*/ 2513012 h 6858000"/>
              <a:gd name="connsiteX56" fmla="*/ 4249203 w 4417162"/>
              <a:gd name="connsiteY56" fmla="*/ 2560637 h 6858000"/>
              <a:gd name="connsiteX57" fmla="*/ 4239125 w 4417162"/>
              <a:gd name="connsiteY57" fmla="*/ 2613025 h 6858000"/>
              <a:gd name="connsiteX58" fmla="*/ 4229047 w 4417162"/>
              <a:gd name="connsiteY58" fmla="*/ 2671762 h 6858000"/>
              <a:gd name="connsiteX59" fmla="*/ 4227367 w 4417162"/>
              <a:gd name="connsiteY59" fmla="*/ 2741612 h 6858000"/>
              <a:gd name="connsiteX60" fmla="*/ 4229047 w 4417162"/>
              <a:gd name="connsiteY60" fmla="*/ 2809875 h 6858000"/>
              <a:gd name="connsiteX61" fmla="*/ 4239125 w 4417162"/>
              <a:gd name="connsiteY61" fmla="*/ 2868612 h 6858000"/>
              <a:gd name="connsiteX62" fmla="*/ 4249203 w 4417162"/>
              <a:gd name="connsiteY62" fmla="*/ 2922587 h 6858000"/>
              <a:gd name="connsiteX63" fmla="*/ 4264318 w 4417162"/>
              <a:gd name="connsiteY63" fmla="*/ 2967037 h 6858000"/>
              <a:gd name="connsiteX64" fmla="*/ 4282794 w 4417162"/>
              <a:gd name="connsiteY64" fmla="*/ 3009900 h 6858000"/>
              <a:gd name="connsiteX65" fmla="*/ 4301270 w 4417162"/>
              <a:gd name="connsiteY65" fmla="*/ 3046412 h 6858000"/>
              <a:gd name="connsiteX66" fmla="*/ 4321425 w 4417162"/>
              <a:gd name="connsiteY66" fmla="*/ 3084512 h 6858000"/>
              <a:gd name="connsiteX67" fmla="*/ 4341580 w 4417162"/>
              <a:gd name="connsiteY67" fmla="*/ 3121025 h 6858000"/>
              <a:gd name="connsiteX68" fmla="*/ 4361735 w 4417162"/>
              <a:gd name="connsiteY68" fmla="*/ 3160712 h 6858000"/>
              <a:gd name="connsiteX69" fmla="*/ 4378531 w 4417162"/>
              <a:gd name="connsiteY69" fmla="*/ 3201987 h 6858000"/>
              <a:gd name="connsiteX70" fmla="*/ 4393648 w 4417162"/>
              <a:gd name="connsiteY70" fmla="*/ 3248025 h 6858000"/>
              <a:gd name="connsiteX71" fmla="*/ 4405405 w 4417162"/>
              <a:gd name="connsiteY71" fmla="*/ 3300412 h 6858000"/>
              <a:gd name="connsiteX72" fmla="*/ 4413803 w 4417162"/>
              <a:gd name="connsiteY72" fmla="*/ 3360737 h 6858000"/>
              <a:gd name="connsiteX73" fmla="*/ 4417162 w 4417162"/>
              <a:gd name="connsiteY73" fmla="*/ 3427412 h 6858000"/>
              <a:gd name="connsiteX74" fmla="*/ 4413803 w 4417162"/>
              <a:gd name="connsiteY74" fmla="*/ 3497262 h 6858000"/>
              <a:gd name="connsiteX75" fmla="*/ 4405405 w 4417162"/>
              <a:gd name="connsiteY75" fmla="*/ 3557587 h 6858000"/>
              <a:gd name="connsiteX76" fmla="*/ 4393648 w 4417162"/>
              <a:gd name="connsiteY76" fmla="*/ 3609975 h 6858000"/>
              <a:gd name="connsiteX77" fmla="*/ 4378531 w 4417162"/>
              <a:gd name="connsiteY77" fmla="*/ 3656012 h 6858000"/>
              <a:gd name="connsiteX78" fmla="*/ 4361735 w 4417162"/>
              <a:gd name="connsiteY78" fmla="*/ 3697287 h 6858000"/>
              <a:gd name="connsiteX79" fmla="*/ 4341580 w 4417162"/>
              <a:gd name="connsiteY79" fmla="*/ 3736975 h 6858000"/>
              <a:gd name="connsiteX80" fmla="*/ 4301270 w 4417162"/>
              <a:gd name="connsiteY80" fmla="*/ 3811587 h 6858000"/>
              <a:gd name="connsiteX81" fmla="*/ 4282794 w 4417162"/>
              <a:gd name="connsiteY81" fmla="*/ 3848100 h 6858000"/>
              <a:gd name="connsiteX82" fmla="*/ 4264318 w 4417162"/>
              <a:gd name="connsiteY82" fmla="*/ 3890962 h 6858000"/>
              <a:gd name="connsiteX83" fmla="*/ 4249203 w 4417162"/>
              <a:gd name="connsiteY83" fmla="*/ 3935412 h 6858000"/>
              <a:gd name="connsiteX84" fmla="*/ 4239125 w 4417162"/>
              <a:gd name="connsiteY84" fmla="*/ 3987800 h 6858000"/>
              <a:gd name="connsiteX85" fmla="*/ 4229047 w 4417162"/>
              <a:gd name="connsiteY85" fmla="*/ 4048125 h 6858000"/>
              <a:gd name="connsiteX86" fmla="*/ 4227367 w 4417162"/>
              <a:gd name="connsiteY86" fmla="*/ 4116387 h 6858000"/>
              <a:gd name="connsiteX87" fmla="*/ 4229047 w 4417162"/>
              <a:gd name="connsiteY87" fmla="*/ 4186237 h 6858000"/>
              <a:gd name="connsiteX88" fmla="*/ 4239125 w 4417162"/>
              <a:gd name="connsiteY88" fmla="*/ 4244975 h 6858000"/>
              <a:gd name="connsiteX89" fmla="*/ 4249203 w 4417162"/>
              <a:gd name="connsiteY89" fmla="*/ 4297362 h 6858000"/>
              <a:gd name="connsiteX90" fmla="*/ 4264318 w 4417162"/>
              <a:gd name="connsiteY90" fmla="*/ 4343400 h 6858000"/>
              <a:gd name="connsiteX91" fmla="*/ 4282794 w 4417162"/>
              <a:gd name="connsiteY91" fmla="*/ 4386262 h 6858000"/>
              <a:gd name="connsiteX92" fmla="*/ 4301270 w 4417162"/>
              <a:gd name="connsiteY92" fmla="*/ 4424362 h 6858000"/>
              <a:gd name="connsiteX93" fmla="*/ 4341580 w 4417162"/>
              <a:gd name="connsiteY93" fmla="*/ 4498975 h 6858000"/>
              <a:gd name="connsiteX94" fmla="*/ 4361735 w 4417162"/>
              <a:gd name="connsiteY94" fmla="*/ 4537075 h 6858000"/>
              <a:gd name="connsiteX95" fmla="*/ 4378531 w 4417162"/>
              <a:gd name="connsiteY95" fmla="*/ 4579937 h 6858000"/>
              <a:gd name="connsiteX96" fmla="*/ 4393648 w 4417162"/>
              <a:gd name="connsiteY96" fmla="*/ 4625975 h 6858000"/>
              <a:gd name="connsiteX97" fmla="*/ 4405405 w 4417162"/>
              <a:gd name="connsiteY97" fmla="*/ 4678362 h 6858000"/>
              <a:gd name="connsiteX98" fmla="*/ 4413803 w 4417162"/>
              <a:gd name="connsiteY98" fmla="*/ 4738687 h 6858000"/>
              <a:gd name="connsiteX99" fmla="*/ 4417162 w 4417162"/>
              <a:gd name="connsiteY99" fmla="*/ 4806950 h 6858000"/>
              <a:gd name="connsiteX100" fmla="*/ 4413803 w 4417162"/>
              <a:gd name="connsiteY100" fmla="*/ 4875212 h 6858000"/>
              <a:gd name="connsiteX101" fmla="*/ 4405405 w 4417162"/>
              <a:gd name="connsiteY101" fmla="*/ 4935537 h 6858000"/>
              <a:gd name="connsiteX102" fmla="*/ 4393648 w 4417162"/>
              <a:gd name="connsiteY102" fmla="*/ 4987925 h 6858000"/>
              <a:gd name="connsiteX103" fmla="*/ 4378531 w 4417162"/>
              <a:gd name="connsiteY103" fmla="*/ 5033962 h 6858000"/>
              <a:gd name="connsiteX104" fmla="*/ 4361735 w 4417162"/>
              <a:gd name="connsiteY104" fmla="*/ 5075237 h 6858000"/>
              <a:gd name="connsiteX105" fmla="*/ 4341580 w 4417162"/>
              <a:gd name="connsiteY105" fmla="*/ 5114925 h 6858000"/>
              <a:gd name="connsiteX106" fmla="*/ 4321425 w 4417162"/>
              <a:gd name="connsiteY106" fmla="*/ 5149850 h 6858000"/>
              <a:gd name="connsiteX107" fmla="*/ 4301270 w 4417162"/>
              <a:gd name="connsiteY107" fmla="*/ 5186362 h 6858000"/>
              <a:gd name="connsiteX108" fmla="*/ 4282794 w 4417162"/>
              <a:gd name="connsiteY108" fmla="*/ 5226050 h 6858000"/>
              <a:gd name="connsiteX109" fmla="*/ 4264318 w 4417162"/>
              <a:gd name="connsiteY109" fmla="*/ 5268912 h 6858000"/>
              <a:gd name="connsiteX110" fmla="*/ 4249203 w 4417162"/>
              <a:gd name="connsiteY110" fmla="*/ 5313362 h 6858000"/>
              <a:gd name="connsiteX111" fmla="*/ 4239125 w 4417162"/>
              <a:gd name="connsiteY111" fmla="*/ 5365750 h 6858000"/>
              <a:gd name="connsiteX112" fmla="*/ 4229047 w 4417162"/>
              <a:gd name="connsiteY112" fmla="*/ 5426075 h 6858000"/>
              <a:gd name="connsiteX113" fmla="*/ 4227367 w 4417162"/>
              <a:gd name="connsiteY113" fmla="*/ 5494337 h 6858000"/>
              <a:gd name="connsiteX114" fmla="*/ 4229047 w 4417162"/>
              <a:gd name="connsiteY114" fmla="*/ 5562600 h 6858000"/>
              <a:gd name="connsiteX115" fmla="*/ 4239125 w 4417162"/>
              <a:gd name="connsiteY115" fmla="*/ 5622925 h 6858000"/>
              <a:gd name="connsiteX116" fmla="*/ 4249203 w 4417162"/>
              <a:gd name="connsiteY116" fmla="*/ 5675312 h 6858000"/>
              <a:gd name="connsiteX117" fmla="*/ 4264318 w 4417162"/>
              <a:gd name="connsiteY117" fmla="*/ 5721350 h 6858000"/>
              <a:gd name="connsiteX118" fmla="*/ 4282794 w 4417162"/>
              <a:gd name="connsiteY118" fmla="*/ 5762625 h 6858000"/>
              <a:gd name="connsiteX119" fmla="*/ 4301270 w 4417162"/>
              <a:gd name="connsiteY119" fmla="*/ 5802312 h 6858000"/>
              <a:gd name="connsiteX120" fmla="*/ 4321425 w 4417162"/>
              <a:gd name="connsiteY120" fmla="*/ 5840412 h 6858000"/>
              <a:gd name="connsiteX121" fmla="*/ 4341580 w 4417162"/>
              <a:gd name="connsiteY121" fmla="*/ 5876925 h 6858000"/>
              <a:gd name="connsiteX122" fmla="*/ 4361735 w 4417162"/>
              <a:gd name="connsiteY122" fmla="*/ 5915025 h 6858000"/>
              <a:gd name="connsiteX123" fmla="*/ 4378531 w 4417162"/>
              <a:gd name="connsiteY123" fmla="*/ 5956300 h 6858000"/>
              <a:gd name="connsiteX124" fmla="*/ 4393648 w 4417162"/>
              <a:gd name="connsiteY124" fmla="*/ 6003925 h 6858000"/>
              <a:gd name="connsiteX125" fmla="*/ 4405405 w 4417162"/>
              <a:gd name="connsiteY125" fmla="*/ 6056312 h 6858000"/>
              <a:gd name="connsiteX126" fmla="*/ 4413803 w 4417162"/>
              <a:gd name="connsiteY126" fmla="*/ 6113462 h 6858000"/>
              <a:gd name="connsiteX127" fmla="*/ 4417162 w 4417162"/>
              <a:gd name="connsiteY127" fmla="*/ 6183312 h 6858000"/>
              <a:gd name="connsiteX128" fmla="*/ 4413803 w 4417162"/>
              <a:gd name="connsiteY128" fmla="*/ 6251575 h 6858000"/>
              <a:gd name="connsiteX129" fmla="*/ 4405405 w 4417162"/>
              <a:gd name="connsiteY129" fmla="*/ 6311900 h 6858000"/>
              <a:gd name="connsiteX130" fmla="*/ 4393648 w 4417162"/>
              <a:gd name="connsiteY130" fmla="*/ 6361112 h 6858000"/>
              <a:gd name="connsiteX131" fmla="*/ 4378531 w 4417162"/>
              <a:gd name="connsiteY131" fmla="*/ 6407150 h 6858000"/>
              <a:gd name="connsiteX132" fmla="*/ 4361735 w 4417162"/>
              <a:gd name="connsiteY132" fmla="*/ 6448425 h 6858000"/>
              <a:gd name="connsiteX133" fmla="*/ 4343260 w 4417162"/>
              <a:gd name="connsiteY133" fmla="*/ 6488112 h 6858000"/>
              <a:gd name="connsiteX134" fmla="*/ 4324784 w 4417162"/>
              <a:gd name="connsiteY134" fmla="*/ 6523037 h 6858000"/>
              <a:gd name="connsiteX135" fmla="*/ 4304629 w 4417162"/>
              <a:gd name="connsiteY135" fmla="*/ 6561137 h 6858000"/>
              <a:gd name="connsiteX136" fmla="*/ 4284474 w 4417162"/>
              <a:gd name="connsiteY136" fmla="*/ 6597650 h 6858000"/>
              <a:gd name="connsiteX137" fmla="*/ 4267678 w 4417162"/>
              <a:gd name="connsiteY137" fmla="*/ 6640512 h 6858000"/>
              <a:gd name="connsiteX138" fmla="*/ 4250882 w 4417162"/>
              <a:gd name="connsiteY138" fmla="*/ 6683375 h 6858000"/>
              <a:gd name="connsiteX139" fmla="*/ 4240804 w 4417162"/>
              <a:gd name="connsiteY139" fmla="*/ 6735762 h 6858000"/>
              <a:gd name="connsiteX140" fmla="*/ 4232407 w 4417162"/>
              <a:gd name="connsiteY140" fmla="*/ 6791325 h 6858000"/>
              <a:gd name="connsiteX141" fmla="*/ 4227367 w 4417162"/>
              <a:gd name="connsiteY141" fmla="*/ 6858000 h 6858000"/>
              <a:gd name="connsiteX142" fmla="*/ 2310062 w 4417162"/>
              <a:gd name="connsiteY142" fmla="*/ 6858000 h 6858000"/>
              <a:gd name="connsiteX143" fmla="*/ 144378 w 4417162"/>
              <a:gd name="connsiteY143" fmla="*/ 6858000 h 6858000"/>
              <a:gd name="connsiteX144" fmla="*/ 0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0" y="0"/>
                </a:moveTo>
                <a:lnTo>
                  <a:pt x="144378" y="0"/>
                </a:lnTo>
                <a:lnTo>
                  <a:pt x="2310062" y="0"/>
                </a:lnTo>
                <a:lnTo>
                  <a:pt x="4227367" y="0"/>
                </a:lnTo>
                <a:lnTo>
                  <a:pt x="4232407" y="66675"/>
                </a:lnTo>
                <a:lnTo>
                  <a:pt x="4240804" y="122237"/>
                </a:lnTo>
                <a:lnTo>
                  <a:pt x="4250882" y="174625"/>
                </a:lnTo>
                <a:lnTo>
                  <a:pt x="4267678" y="217487"/>
                </a:lnTo>
                <a:lnTo>
                  <a:pt x="4284474" y="260350"/>
                </a:lnTo>
                <a:lnTo>
                  <a:pt x="4304629" y="296862"/>
                </a:lnTo>
                <a:lnTo>
                  <a:pt x="4324784" y="334962"/>
                </a:lnTo>
                <a:lnTo>
                  <a:pt x="4343260" y="369887"/>
                </a:lnTo>
                <a:lnTo>
                  <a:pt x="4361735" y="409575"/>
                </a:lnTo>
                <a:lnTo>
                  <a:pt x="4378531" y="450850"/>
                </a:lnTo>
                <a:lnTo>
                  <a:pt x="4393648" y="496887"/>
                </a:lnTo>
                <a:lnTo>
                  <a:pt x="4405405" y="546100"/>
                </a:lnTo>
                <a:lnTo>
                  <a:pt x="4413803" y="606425"/>
                </a:lnTo>
                <a:lnTo>
                  <a:pt x="4417162" y="673100"/>
                </a:lnTo>
                <a:lnTo>
                  <a:pt x="4413803" y="744537"/>
                </a:lnTo>
                <a:lnTo>
                  <a:pt x="4405405" y="801687"/>
                </a:lnTo>
                <a:lnTo>
                  <a:pt x="4393648" y="854075"/>
                </a:lnTo>
                <a:lnTo>
                  <a:pt x="4378531" y="901700"/>
                </a:lnTo>
                <a:lnTo>
                  <a:pt x="4361735" y="942975"/>
                </a:lnTo>
                <a:lnTo>
                  <a:pt x="4341580" y="981075"/>
                </a:lnTo>
                <a:lnTo>
                  <a:pt x="4321425" y="1017587"/>
                </a:lnTo>
                <a:lnTo>
                  <a:pt x="4301270" y="1055687"/>
                </a:lnTo>
                <a:lnTo>
                  <a:pt x="4282794" y="1095375"/>
                </a:lnTo>
                <a:lnTo>
                  <a:pt x="4264318" y="1136650"/>
                </a:lnTo>
                <a:lnTo>
                  <a:pt x="4249203" y="1182687"/>
                </a:lnTo>
                <a:lnTo>
                  <a:pt x="4239125" y="1235075"/>
                </a:lnTo>
                <a:lnTo>
                  <a:pt x="4229047" y="1295400"/>
                </a:lnTo>
                <a:lnTo>
                  <a:pt x="4227367" y="1363662"/>
                </a:lnTo>
                <a:lnTo>
                  <a:pt x="4229047" y="1431925"/>
                </a:lnTo>
                <a:lnTo>
                  <a:pt x="4239125" y="1492250"/>
                </a:lnTo>
                <a:lnTo>
                  <a:pt x="4249203" y="1544637"/>
                </a:lnTo>
                <a:lnTo>
                  <a:pt x="4264318" y="1589087"/>
                </a:lnTo>
                <a:lnTo>
                  <a:pt x="4282794" y="1631950"/>
                </a:lnTo>
                <a:lnTo>
                  <a:pt x="4301270" y="1671637"/>
                </a:lnTo>
                <a:lnTo>
                  <a:pt x="4321425" y="1708150"/>
                </a:lnTo>
                <a:lnTo>
                  <a:pt x="4341580" y="1743075"/>
                </a:lnTo>
                <a:lnTo>
                  <a:pt x="4361735" y="1782762"/>
                </a:lnTo>
                <a:lnTo>
                  <a:pt x="4378531" y="1824037"/>
                </a:lnTo>
                <a:lnTo>
                  <a:pt x="4393648" y="1870075"/>
                </a:lnTo>
                <a:lnTo>
                  <a:pt x="4405405" y="1922462"/>
                </a:lnTo>
                <a:lnTo>
                  <a:pt x="4413803" y="1982787"/>
                </a:lnTo>
                <a:lnTo>
                  <a:pt x="4417162" y="2051050"/>
                </a:lnTo>
                <a:lnTo>
                  <a:pt x="4413803" y="2119312"/>
                </a:lnTo>
                <a:lnTo>
                  <a:pt x="4405405" y="2179637"/>
                </a:lnTo>
                <a:lnTo>
                  <a:pt x="4393648" y="2232025"/>
                </a:lnTo>
                <a:lnTo>
                  <a:pt x="4378531" y="2278062"/>
                </a:lnTo>
                <a:lnTo>
                  <a:pt x="4361735" y="2319337"/>
                </a:lnTo>
                <a:lnTo>
                  <a:pt x="4341580" y="2359025"/>
                </a:lnTo>
                <a:lnTo>
                  <a:pt x="4321425" y="2395537"/>
                </a:lnTo>
                <a:lnTo>
                  <a:pt x="4301270" y="2433637"/>
                </a:lnTo>
                <a:lnTo>
                  <a:pt x="4282794" y="2471737"/>
                </a:lnTo>
                <a:lnTo>
                  <a:pt x="4264318" y="2513012"/>
                </a:lnTo>
                <a:lnTo>
                  <a:pt x="4249203" y="2560637"/>
                </a:lnTo>
                <a:lnTo>
                  <a:pt x="4239125" y="2613025"/>
                </a:lnTo>
                <a:lnTo>
                  <a:pt x="4229047" y="2671762"/>
                </a:lnTo>
                <a:lnTo>
                  <a:pt x="4227367" y="2741612"/>
                </a:lnTo>
                <a:lnTo>
                  <a:pt x="4229047" y="2809875"/>
                </a:lnTo>
                <a:lnTo>
                  <a:pt x="4239125" y="2868612"/>
                </a:lnTo>
                <a:lnTo>
                  <a:pt x="4249203" y="2922587"/>
                </a:lnTo>
                <a:lnTo>
                  <a:pt x="4264318" y="2967037"/>
                </a:lnTo>
                <a:lnTo>
                  <a:pt x="4282794" y="3009900"/>
                </a:lnTo>
                <a:lnTo>
                  <a:pt x="4301270" y="3046412"/>
                </a:lnTo>
                <a:lnTo>
                  <a:pt x="4321425" y="3084512"/>
                </a:lnTo>
                <a:lnTo>
                  <a:pt x="4341580" y="3121025"/>
                </a:lnTo>
                <a:lnTo>
                  <a:pt x="4361735" y="3160712"/>
                </a:lnTo>
                <a:lnTo>
                  <a:pt x="4378531" y="3201987"/>
                </a:lnTo>
                <a:lnTo>
                  <a:pt x="4393648" y="3248025"/>
                </a:lnTo>
                <a:lnTo>
                  <a:pt x="4405405" y="3300412"/>
                </a:lnTo>
                <a:lnTo>
                  <a:pt x="4413803" y="3360737"/>
                </a:lnTo>
                <a:lnTo>
                  <a:pt x="4417162" y="3427412"/>
                </a:lnTo>
                <a:lnTo>
                  <a:pt x="4413803" y="3497262"/>
                </a:lnTo>
                <a:lnTo>
                  <a:pt x="4405405" y="3557587"/>
                </a:lnTo>
                <a:lnTo>
                  <a:pt x="4393648" y="3609975"/>
                </a:lnTo>
                <a:lnTo>
                  <a:pt x="4378531" y="3656012"/>
                </a:lnTo>
                <a:lnTo>
                  <a:pt x="4361735" y="3697287"/>
                </a:lnTo>
                <a:lnTo>
                  <a:pt x="4341580" y="3736975"/>
                </a:lnTo>
                <a:lnTo>
                  <a:pt x="4301270" y="3811587"/>
                </a:lnTo>
                <a:lnTo>
                  <a:pt x="4282794" y="3848100"/>
                </a:lnTo>
                <a:lnTo>
                  <a:pt x="4264318" y="3890962"/>
                </a:lnTo>
                <a:lnTo>
                  <a:pt x="4249203" y="3935412"/>
                </a:lnTo>
                <a:lnTo>
                  <a:pt x="4239125" y="3987800"/>
                </a:lnTo>
                <a:lnTo>
                  <a:pt x="4229047" y="4048125"/>
                </a:lnTo>
                <a:lnTo>
                  <a:pt x="4227367" y="4116387"/>
                </a:lnTo>
                <a:lnTo>
                  <a:pt x="4229047" y="4186237"/>
                </a:lnTo>
                <a:lnTo>
                  <a:pt x="4239125" y="4244975"/>
                </a:lnTo>
                <a:lnTo>
                  <a:pt x="4249203" y="4297362"/>
                </a:lnTo>
                <a:lnTo>
                  <a:pt x="4264318" y="4343400"/>
                </a:lnTo>
                <a:lnTo>
                  <a:pt x="4282794" y="4386262"/>
                </a:lnTo>
                <a:lnTo>
                  <a:pt x="4301270" y="4424362"/>
                </a:lnTo>
                <a:lnTo>
                  <a:pt x="4341580" y="4498975"/>
                </a:lnTo>
                <a:lnTo>
                  <a:pt x="4361735" y="4537075"/>
                </a:lnTo>
                <a:lnTo>
                  <a:pt x="4378531" y="4579937"/>
                </a:lnTo>
                <a:lnTo>
                  <a:pt x="4393648" y="4625975"/>
                </a:lnTo>
                <a:lnTo>
                  <a:pt x="4405405" y="4678362"/>
                </a:lnTo>
                <a:lnTo>
                  <a:pt x="4413803" y="4738687"/>
                </a:lnTo>
                <a:lnTo>
                  <a:pt x="4417162" y="4806950"/>
                </a:lnTo>
                <a:lnTo>
                  <a:pt x="4413803" y="4875212"/>
                </a:lnTo>
                <a:lnTo>
                  <a:pt x="4405405" y="4935537"/>
                </a:lnTo>
                <a:lnTo>
                  <a:pt x="4393648" y="4987925"/>
                </a:lnTo>
                <a:lnTo>
                  <a:pt x="4378531" y="5033962"/>
                </a:lnTo>
                <a:lnTo>
                  <a:pt x="4361735" y="5075237"/>
                </a:lnTo>
                <a:lnTo>
                  <a:pt x="4341580" y="5114925"/>
                </a:lnTo>
                <a:lnTo>
                  <a:pt x="4321425" y="5149850"/>
                </a:lnTo>
                <a:lnTo>
                  <a:pt x="4301270" y="5186362"/>
                </a:lnTo>
                <a:lnTo>
                  <a:pt x="4282794" y="5226050"/>
                </a:lnTo>
                <a:lnTo>
                  <a:pt x="4264318" y="5268912"/>
                </a:lnTo>
                <a:lnTo>
                  <a:pt x="4249203" y="5313362"/>
                </a:lnTo>
                <a:lnTo>
                  <a:pt x="4239125" y="5365750"/>
                </a:lnTo>
                <a:lnTo>
                  <a:pt x="4229047" y="5426075"/>
                </a:lnTo>
                <a:lnTo>
                  <a:pt x="4227367" y="5494337"/>
                </a:lnTo>
                <a:lnTo>
                  <a:pt x="4229047" y="5562600"/>
                </a:lnTo>
                <a:lnTo>
                  <a:pt x="4239125" y="5622925"/>
                </a:lnTo>
                <a:lnTo>
                  <a:pt x="4249203" y="5675312"/>
                </a:lnTo>
                <a:lnTo>
                  <a:pt x="4264318" y="5721350"/>
                </a:lnTo>
                <a:lnTo>
                  <a:pt x="4282794" y="5762625"/>
                </a:lnTo>
                <a:lnTo>
                  <a:pt x="4301270" y="5802312"/>
                </a:lnTo>
                <a:lnTo>
                  <a:pt x="4321425" y="5840412"/>
                </a:lnTo>
                <a:lnTo>
                  <a:pt x="4341580" y="5876925"/>
                </a:lnTo>
                <a:lnTo>
                  <a:pt x="4361735" y="5915025"/>
                </a:lnTo>
                <a:lnTo>
                  <a:pt x="4378531" y="5956300"/>
                </a:lnTo>
                <a:lnTo>
                  <a:pt x="4393648" y="6003925"/>
                </a:lnTo>
                <a:lnTo>
                  <a:pt x="4405405" y="6056312"/>
                </a:lnTo>
                <a:lnTo>
                  <a:pt x="4413803" y="6113462"/>
                </a:lnTo>
                <a:lnTo>
                  <a:pt x="4417162" y="6183312"/>
                </a:lnTo>
                <a:lnTo>
                  <a:pt x="4413803" y="6251575"/>
                </a:lnTo>
                <a:lnTo>
                  <a:pt x="4405405" y="6311900"/>
                </a:lnTo>
                <a:lnTo>
                  <a:pt x="4393648" y="6361112"/>
                </a:lnTo>
                <a:lnTo>
                  <a:pt x="4378531" y="6407150"/>
                </a:lnTo>
                <a:lnTo>
                  <a:pt x="4361735" y="6448425"/>
                </a:lnTo>
                <a:lnTo>
                  <a:pt x="4343260" y="6488112"/>
                </a:lnTo>
                <a:lnTo>
                  <a:pt x="4324784" y="6523037"/>
                </a:lnTo>
                <a:lnTo>
                  <a:pt x="4304629" y="6561137"/>
                </a:lnTo>
                <a:lnTo>
                  <a:pt x="4284474" y="6597650"/>
                </a:lnTo>
                <a:lnTo>
                  <a:pt x="4267678" y="6640512"/>
                </a:lnTo>
                <a:lnTo>
                  <a:pt x="4250882" y="6683375"/>
                </a:lnTo>
                <a:lnTo>
                  <a:pt x="4240804" y="6735762"/>
                </a:lnTo>
                <a:lnTo>
                  <a:pt x="4232407" y="6791325"/>
                </a:lnTo>
                <a:lnTo>
                  <a:pt x="4227367" y="6858000"/>
                </a:lnTo>
                <a:lnTo>
                  <a:pt x="2310062" y="6858000"/>
                </a:lnTo>
                <a:lnTo>
                  <a:pt x="144378" y="6858000"/>
                </a:lnTo>
                <a:lnTo>
                  <a:pt x="0" y="6858000"/>
                </a:lnTo>
                <a:close/>
              </a:path>
            </a:pathLst>
          </a:custGeom>
          <a:solidFill>
            <a:srgbClr val="FFFFFF"/>
          </a:solidFill>
          <a:ln w="0">
            <a:noFill/>
            <a:prstDash val="solid"/>
            <a:round/>
            <a:headEnd/>
            <a:tailEnd/>
          </a:ln>
        </p:spPr>
        <p:txBody>
          <a:bodyPr/>
          <a:lstStyle/>
          <a:p>
            <a:endParaRPr lang="en-US"/>
          </a:p>
        </p:txBody>
      </p:sp>
      <p:sp useBgFill="1">
        <p:nvSpPr>
          <p:cNvPr id="14" name="Freeform: Shape 13">
            <a:extLst>
              <a:ext uri="{FF2B5EF4-FFF2-40B4-BE49-F238E27FC236}">
                <a16:creationId xmlns:a16="http://schemas.microsoft.com/office/drawing/2014/main" id="{A7A4B465-FBCC-4CD4-89A1-82992A7B47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272784" cy="6858000"/>
          </a:xfrm>
          <a:custGeom>
            <a:avLst/>
            <a:gdLst>
              <a:gd name="connsiteX0" fmla="*/ 0 w 4272784"/>
              <a:gd name="connsiteY0" fmla="*/ 0 h 6858000"/>
              <a:gd name="connsiteX1" fmla="*/ 4082989 w 4272784"/>
              <a:gd name="connsiteY1" fmla="*/ 0 h 6858000"/>
              <a:gd name="connsiteX2" fmla="*/ 4088029 w 4272784"/>
              <a:gd name="connsiteY2" fmla="*/ 66675 h 6858000"/>
              <a:gd name="connsiteX3" fmla="*/ 4096426 w 4272784"/>
              <a:gd name="connsiteY3" fmla="*/ 122237 h 6858000"/>
              <a:gd name="connsiteX4" fmla="*/ 4106504 w 4272784"/>
              <a:gd name="connsiteY4" fmla="*/ 174625 h 6858000"/>
              <a:gd name="connsiteX5" fmla="*/ 4123300 w 4272784"/>
              <a:gd name="connsiteY5" fmla="*/ 217487 h 6858000"/>
              <a:gd name="connsiteX6" fmla="*/ 4140096 w 4272784"/>
              <a:gd name="connsiteY6" fmla="*/ 260350 h 6858000"/>
              <a:gd name="connsiteX7" fmla="*/ 4160251 w 4272784"/>
              <a:gd name="connsiteY7" fmla="*/ 296862 h 6858000"/>
              <a:gd name="connsiteX8" fmla="*/ 4180406 w 4272784"/>
              <a:gd name="connsiteY8" fmla="*/ 334962 h 6858000"/>
              <a:gd name="connsiteX9" fmla="*/ 4198882 w 4272784"/>
              <a:gd name="connsiteY9" fmla="*/ 369887 h 6858000"/>
              <a:gd name="connsiteX10" fmla="*/ 4217357 w 4272784"/>
              <a:gd name="connsiteY10" fmla="*/ 409575 h 6858000"/>
              <a:gd name="connsiteX11" fmla="*/ 4234153 w 4272784"/>
              <a:gd name="connsiteY11" fmla="*/ 450850 h 6858000"/>
              <a:gd name="connsiteX12" fmla="*/ 4249270 w 4272784"/>
              <a:gd name="connsiteY12" fmla="*/ 496887 h 6858000"/>
              <a:gd name="connsiteX13" fmla="*/ 4261027 w 4272784"/>
              <a:gd name="connsiteY13" fmla="*/ 546100 h 6858000"/>
              <a:gd name="connsiteX14" fmla="*/ 4269425 w 4272784"/>
              <a:gd name="connsiteY14" fmla="*/ 606425 h 6858000"/>
              <a:gd name="connsiteX15" fmla="*/ 4272784 w 4272784"/>
              <a:gd name="connsiteY15" fmla="*/ 673100 h 6858000"/>
              <a:gd name="connsiteX16" fmla="*/ 4269425 w 4272784"/>
              <a:gd name="connsiteY16" fmla="*/ 744537 h 6858000"/>
              <a:gd name="connsiteX17" fmla="*/ 4261027 w 4272784"/>
              <a:gd name="connsiteY17" fmla="*/ 801687 h 6858000"/>
              <a:gd name="connsiteX18" fmla="*/ 4249270 w 4272784"/>
              <a:gd name="connsiteY18" fmla="*/ 854075 h 6858000"/>
              <a:gd name="connsiteX19" fmla="*/ 4234153 w 4272784"/>
              <a:gd name="connsiteY19" fmla="*/ 901700 h 6858000"/>
              <a:gd name="connsiteX20" fmla="*/ 4217357 w 4272784"/>
              <a:gd name="connsiteY20" fmla="*/ 942975 h 6858000"/>
              <a:gd name="connsiteX21" fmla="*/ 4197202 w 4272784"/>
              <a:gd name="connsiteY21" fmla="*/ 981075 h 6858000"/>
              <a:gd name="connsiteX22" fmla="*/ 4177047 w 4272784"/>
              <a:gd name="connsiteY22" fmla="*/ 1017587 h 6858000"/>
              <a:gd name="connsiteX23" fmla="*/ 4156892 w 4272784"/>
              <a:gd name="connsiteY23" fmla="*/ 1055687 h 6858000"/>
              <a:gd name="connsiteX24" fmla="*/ 4138416 w 4272784"/>
              <a:gd name="connsiteY24" fmla="*/ 1095375 h 6858000"/>
              <a:gd name="connsiteX25" fmla="*/ 4119940 w 4272784"/>
              <a:gd name="connsiteY25" fmla="*/ 1136650 h 6858000"/>
              <a:gd name="connsiteX26" fmla="*/ 4104825 w 4272784"/>
              <a:gd name="connsiteY26" fmla="*/ 1182687 h 6858000"/>
              <a:gd name="connsiteX27" fmla="*/ 4094747 w 4272784"/>
              <a:gd name="connsiteY27" fmla="*/ 1235075 h 6858000"/>
              <a:gd name="connsiteX28" fmla="*/ 4084669 w 4272784"/>
              <a:gd name="connsiteY28" fmla="*/ 1295400 h 6858000"/>
              <a:gd name="connsiteX29" fmla="*/ 4082989 w 4272784"/>
              <a:gd name="connsiteY29" fmla="*/ 1363662 h 6858000"/>
              <a:gd name="connsiteX30" fmla="*/ 4084669 w 4272784"/>
              <a:gd name="connsiteY30" fmla="*/ 1431925 h 6858000"/>
              <a:gd name="connsiteX31" fmla="*/ 4094747 w 4272784"/>
              <a:gd name="connsiteY31" fmla="*/ 1492250 h 6858000"/>
              <a:gd name="connsiteX32" fmla="*/ 4104825 w 4272784"/>
              <a:gd name="connsiteY32" fmla="*/ 1544637 h 6858000"/>
              <a:gd name="connsiteX33" fmla="*/ 4119940 w 4272784"/>
              <a:gd name="connsiteY33" fmla="*/ 1589087 h 6858000"/>
              <a:gd name="connsiteX34" fmla="*/ 4138416 w 4272784"/>
              <a:gd name="connsiteY34" fmla="*/ 1631950 h 6858000"/>
              <a:gd name="connsiteX35" fmla="*/ 4156892 w 4272784"/>
              <a:gd name="connsiteY35" fmla="*/ 1671637 h 6858000"/>
              <a:gd name="connsiteX36" fmla="*/ 4177047 w 4272784"/>
              <a:gd name="connsiteY36" fmla="*/ 1708150 h 6858000"/>
              <a:gd name="connsiteX37" fmla="*/ 4197202 w 4272784"/>
              <a:gd name="connsiteY37" fmla="*/ 1743075 h 6858000"/>
              <a:gd name="connsiteX38" fmla="*/ 4217357 w 4272784"/>
              <a:gd name="connsiteY38" fmla="*/ 1782762 h 6858000"/>
              <a:gd name="connsiteX39" fmla="*/ 4234153 w 4272784"/>
              <a:gd name="connsiteY39" fmla="*/ 1824037 h 6858000"/>
              <a:gd name="connsiteX40" fmla="*/ 4249270 w 4272784"/>
              <a:gd name="connsiteY40" fmla="*/ 1870075 h 6858000"/>
              <a:gd name="connsiteX41" fmla="*/ 4261027 w 4272784"/>
              <a:gd name="connsiteY41" fmla="*/ 1922462 h 6858000"/>
              <a:gd name="connsiteX42" fmla="*/ 4269425 w 4272784"/>
              <a:gd name="connsiteY42" fmla="*/ 1982787 h 6858000"/>
              <a:gd name="connsiteX43" fmla="*/ 4272784 w 4272784"/>
              <a:gd name="connsiteY43" fmla="*/ 2051050 h 6858000"/>
              <a:gd name="connsiteX44" fmla="*/ 4269425 w 4272784"/>
              <a:gd name="connsiteY44" fmla="*/ 2119312 h 6858000"/>
              <a:gd name="connsiteX45" fmla="*/ 4261027 w 4272784"/>
              <a:gd name="connsiteY45" fmla="*/ 2179637 h 6858000"/>
              <a:gd name="connsiteX46" fmla="*/ 4249270 w 4272784"/>
              <a:gd name="connsiteY46" fmla="*/ 2232025 h 6858000"/>
              <a:gd name="connsiteX47" fmla="*/ 4234153 w 4272784"/>
              <a:gd name="connsiteY47" fmla="*/ 2278062 h 6858000"/>
              <a:gd name="connsiteX48" fmla="*/ 4217357 w 4272784"/>
              <a:gd name="connsiteY48" fmla="*/ 2319337 h 6858000"/>
              <a:gd name="connsiteX49" fmla="*/ 4197202 w 4272784"/>
              <a:gd name="connsiteY49" fmla="*/ 2359025 h 6858000"/>
              <a:gd name="connsiteX50" fmla="*/ 4177047 w 4272784"/>
              <a:gd name="connsiteY50" fmla="*/ 2395537 h 6858000"/>
              <a:gd name="connsiteX51" fmla="*/ 4156892 w 4272784"/>
              <a:gd name="connsiteY51" fmla="*/ 2433637 h 6858000"/>
              <a:gd name="connsiteX52" fmla="*/ 4138416 w 4272784"/>
              <a:gd name="connsiteY52" fmla="*/ 2471737 h 6858000"/>
              <a:gd name="connsiteX53" fmla="*/ 4119940 w 4272784"/>
              <a:gd name="connsiteY53" fmla="*/ 2513012 h 6858000"/>
              <a:gd name="connsiteX54" fmla="*/ 4104825 w 4272784"/>
              <a:gd name="connsiteY54" fmla="*/ 2560637 h 6858000"/>
              <a:gd name="connsiteX55" fmla="*/ 4094747 w 4272784"/>
              <a:gd name="connsiteY55" fmla="*/ 2613025 h 6858000"/>
              <a:gd name="connsiteX56" fmla="*/ 4084669 w 4272784"/>
              <a:gd name="connsiteY56" fmla="*/ 2671762 h 6858000"/>
              <a:gd name="connsiteX57" fmla="*/ 4082989 w 4272784"/>
              <a:gd name="connsiteY57" fmla="*/ 2741612 h 6858000"/>
              <a:gd name="connsiteX58" fmla="*/ 4084669 w 4272784"/>
              <a:gd name="connsiteY58" fmla="*/ 2809875 h 6858000"/>
              <a:gd name="connsiteX59" fmla="*/ 4094747 w 4272784"/>
              <a:gd name="connsiteY59" fmla="*/ 2868612 h 6858000"/>
              <a:gd name="connsiteX60" fmla="*/ 4104825 w 4272784"/>
              <a:gd name="connsiteY60" fmla="*/ 2922587 h 6858000"/>
              <a:gd name="connsiteX61" fmla="*/ 4119940 w 4272784"/>
              <a:gd name="connsiteY61" fmla="*/ 2967037 h 6858000"/>
              <a:gd name="connsiteX62" fmla="*/ 4138416 w 4272784"/>
              <a:gd name="connsiteY62" fmla="*/ 3009900 h 6858000"/>
              <a:gd name="connsiteX63" fmla="*/ 4156892 w 4272784"/>
              <a:gd name="connsiteY63" fmla="*/ 3046412 h 6858000"/>
              <a:gd name="connsiteX64" fmla="*/ 4177047 w 4272784"/>
              <a:gd name="connsiteY64" fmla="*/ 3084512 h 6858000"/>
              <a:gd name="connsiteX65" fmla="*/ 4197202 w 4272784"/>
              <a:gd name="connsiteY65" fmla="*/ 3121025 h 6858000"/>
              <a:gd name="connsiteX66" fmla="*/ 4217357 w 4272784"/>
              <a:gd name="connsiteY66" fmla="*/ 3160712 h 6858000"/>
              <a:gd name="connsiteX67" fmla="*/ 4234153 w 4272784"/>
              <a:gd name="connsiteY67" fmla="*/ 3201987 h 6858000"/>
              <a:gd name="connsiteX68" fmla="*/ 4249270 w 4272784"/>
              <a:gd name="connsiteY68" fmla="*/ 3248025 h 6858000"/>
              <a:gd name="connsiteX69" fmla="*/ 4261027 w 4272784"/>
              <a:gd name="connsiteY69" fmla="*/ 3300412 h 6858000"/>
              <a:gd name="connsiteX70" fmla="*/ 4269425 w 4272784"/>
              <a:gd name="connsiteY70" fmla="*/ 3360737 h 6858000"/>
              <a:gd name="connsiteX71" fmla="*/ 4272784 w 4272784"/>
              <a:gd name="connsiteY71" fmla="*/ 3427412 h 6858000"/>
              <a:gd name="connsiteX72" fmla="*/ 4269425 w 4272784"/>
              <a:gd name="connsiteY72" fmla="*/ 3497262 h 6858000"/>
              <a:gd name="connsiteX73" fmla="*/ 4261027 w 4272784"/>
              <a:gd name="connsiteY73" fmla="*/ 3557587 h 6858000"/>
              <a:gd name="connsiteX74" fmla="*/ 4249270 w 4272784"/>
              <a:gd name="connsiteY74" fmla="*/ 3609975 h 6858000"/>
              <a:gd name="connsiteX75" fmla="*/ 4234153 w 4272784"/>
              <a:gd name="connsiteY75" fmla="*/ 3656012 h 6858000"/>
              <a:gd name="connsiteX76" fmla="*/ 4217357 w 4272784"/>
              <a:gd name="connsiteY76" fmla="*/ 3697287 h 6858000"/>
              <a:gd name="connsiteX77" fmla="*/ 4197202 w 4272784"/>
              <a:gd name="connsiteY77" fmla="*/ 3736975 h 6858000"/>
              <a:gd name="connsiteX78" fmla="*/ 4156892 w 4272784"/>
              <a:gd name="connsiteY78" fmla="*/ 3811587 h 6858000"/>
              <a:gd name="connsiteX79" fmla="*/ 4138416 w 4272784"/>
              <a:gd name="connsiteY79" fmla="*/ 3848100 h 6858000"/>
              <a:gd name="connsiteX80" fmla="*/ 4119940 w 4272784"/>
              <a:gd name="connsiteY80" fmla="*/ 3890962 h 6858000"/>
              <a:gd name="connsiteX81" fmla="*/ 4104825 w 4272784"/>
              <a:gd name="connsiteY81" fmla="*/ 3935412 h 6858000"/>
              <a:gd name="connsiteX82" fmla="*/ 4094747 w 4272784"/>
              <a:gd name="connsiteY82" fmla="*/ 3987800 h 6858000"/>
              <a:gd name="connsiteX83" fmla="*/ 4084669 w 4272784"/>
              <a:gd name="connsiteY83" fmla="*/ 4048125 h 6858000"/>
              <a:gd name="connsiteX84" fmla="*/ 4082989 w 4272784"/>
              <a:gd name="connsiteY84" fmla="*/ 4116387 h 6858000"/>
              <a:gd name="connsiteX85" fmla="*/ 4084669 w 4272784"/>
              <a:gd name="connsiteY85" fmla="*/ 4186237 h 6858000"/>
              <a:gd name="connsiteX86" fmla="*/ 4094747 w 4272784"/>
              <a:gd name="connsiteY86" fmla="*/ 4244975 h 6858000"/>
              <a:gd name="connsiteX87" fmla="*/ 4104825 w 4272784"/>
              <a:gd name="connsiteY87" fmla="*/ 4297362 h 6858000"/>
              <a:gd name="connsiteX88" fmla="*/ 4119940 w 4272784"/>
              <a:gd name="connsiteY88" fmla="*/ 4343400 h 6858000"/>
              <a:gd name="connsiteX89" fmla="*/ 4138416 w 4272784"/>
              <a:gd name="connsiteY89" fmla="*/ 4386262 h 6858000"/>
              <a:gd name="connsiteX90" fmla="*/ 4156892 w 4272784"/>
              <a:gd name="connsiteY90" fmla="*/ 4424362 h 6858000"/>
              <a:gd name="connsiteX91" fmla="*/ 4197202 w 4272784"/>
              <a:gd name="connsiteY91" fmla="*/ 4498975 h 6858000"/>
              <a:gd name="connsiteX92" fmla="*/ 4217357 w 4272784"/>
              <a:gd name="connsiteY92" fmla="*/ 4537075 h 6858000"/>
              <a:gd name="connsiteX93" fmla="*/ 4234153 w 4272784"/>
              <a:gd name="connsiteY93" fmla="*/ 4579937 h 6858000"/>
              <a:gd name="connsiteX94" fmla="*/ 4249270 w 4272784"/>
              <a:gd name="connsiteY94" fmla="*/ 4625975 h 6858000"/>
              <a:gd name="connsiteX95" fmla="*/ 4261027 w 4272784"/>
              <a:gd name="connsiteY95" fmla="*/ 4678362 h 6858000"/>
              <a:gd name="connsiteX96" fmla="*/ 4269425 w 4272784"/>
              <a:gd name="connsiteY96" fmla="*/ 4738687 h 6858000"/>
              <a:gd name="connsiteX97" fmla="*/ 4272784 w 4272784"/>
              <a:gd name="connsiteY97" fmla="*/ 4806950 h 6858000"/>
              <a:gd name="connsiteX98" fmla="*/ 4269425 w 4272784"/>
              <a:gd name="connsiteY98" fmla="*/ 4875212 h 6858000"/>
              <a:gd name="connsiteX99" fmla="*/ 4261027 w 4272784"/>
              <a:gd name="connsiteY99" fmla="*/ 4935537 h 6858000"/>
              <a:gd name="connsiteX100" fmla="*/ 4249270 w 4272784"/>
              <a:gd name="connsiteY100" fmla="*/ 4987925 h 6858000"/>
              <a:gd name="connsiteX101" fmla="*/ 4234153 w 4272784"/>
              <a:gd name="connsiteY101" fmla="*/ 5033962 h 6858000"/>
              <a:gd name="connsiteX102" fmla="*/ 4217357 w 4272784"/>
              <a:gd name="connsiteY102" fmla="*/ 5075237 h 6858000"/>
              <a:gd name="connsiteX103" fmla="*/ 4197202 w 4272784"/>
              <a:gd name="connsiteY103" fmla="*/ 5114925 h 6858000"/>
              <a:gd name="connsiteX104" fmla="*/ 4177047 w 4272784"/>
              <a:gd name="connsiteY104" fmla="*/ 5149850 h 6858000"/>
              <a:gd name="connsiteX105" fmla="*/ 4156892 w 4272784"/>
              <a:gd name="connsiteY105" fmla="*/ 5186362 h 6858000"/>
              <a:gd name="connsiteX106" fmla="*/ 4138416 w 4272784"/>
              <a:gd name="connsiteY106" fmla="*/ 5226050 h 6858000"/>
              <a:gd name="connsiteX107" fmla="*/ 4119940 w 4272784"/>
              <a:gd name="connsiteY107" fmla="*/ 5268912 h 6858000"/>
              <a:gd name="connsiteX108" fmla="*/ 4104825 w 4272784"/>
              <a:gd name="connsiteY108" fmla="*/ 5313362 h 6858000"/>
              <a:gd name="connsiteX109" fmla="*/ 4094747 w 4272784"/>
              <a:gd name="connsiteY109" fmla="*/ 5365750 h 6858000"/>
              <a:gd name="connsiteX110" fmla="*/ 4084669 w 4272784"/>
              <a:gd name="connsiteY110" fmla="*/ 5426075 h 6858000"/>
              <a:gd name="connsiteX111" fmla="*/ 4082989 w 4272784"/>
              <a:gd name="connsiteY111" fmla="*/ 5494337 h 6858000"/>
              <a:gd name="connsiteX112" fmla="*/ 4084669 w 4272784"/>
              <a:gd name="connsiteY112" fmla="*/ 5562600 h 6858000"/>
              <a:gd name="connsiteX113" fmla="*/ 4094747 w 4272784"/>
              <a:gd name="connsiteY113" fmla="*/ 5622925 h 6858000"/>
              <a:gd name="connsiteX114" fmla="*/ 4104825 w 4272784"/>
              <a:gd name="connsiteY114" fmla="*/ 5675312 h 6858000"/>
              <a:gd name="connsiteX115" fmla="*/ 4119940 w 4272784"/>
              <a:gd name="connsiteY115" fmla="*/ 5721350 h 6858000"/>
              <a:gd name="connsiteX116" fmla="*/ 4138416 w 4272784"/>
              <a:gd name="connsiteY116" fmla="*/ 5762625 h 6858000"/>
              <a:gd name="connsiteX117" fmla="*/ 4156892 w 4272784"/>
              <a:gd name="connsiteY117" fmla="*/ 5802312 h 6858000"/>
              <a:gd name="connsiteX118" fmla="*/ 4177047 w 4272784"/>
              <a:gd name="connsiteY118" fmla="*/ 5840412 h 6858000"/>
              <a:gd name="connsiteX119" fmla="*/ 4197202 w 4272784"/>
              <a:gd name="connsiteY119" fmla="*/ 5876925 h 6858000"/>
              <a:gd name="connsiteX120" fmla="*/ 4217357 w 4272784"/>
              <a:gd name="connsiteY120" fmla="*/ 5915025 h 6858000"/>
              <a:gd name="connsiteX121" fmla="*/ 4234153 w 4272784"/>
              <a:gd name="connsiteY121" fmla="*/ 5956300 h 6858000"/>
              <a:gd name="connsiteX122" fmla="*/ 4249270 w 4272784"/>
              <a:gd name="connsiteY122" fmla="*/ 6003925 h 6858000"/>
              <a:gd name="connsiteX123" fmla="*/ 4261027 w 4272784"/>
              <a:gd name="connsiteY123" fmla="*/ 6056312 h 6858000"/>
              <a:gd name="connsiteX124" fmla="*/ 4269425 w 4272784"/>
              <a:gd name="connsiteY124" fmla="*/ 6113462 h 6858000"/>
              <a:gd name="connsiteX125" fmla="*/ 4272784 w 4272784"/>
              <a:gd name="connsiteY125" fmla="*/ 6183312 h 6858000"/>
              <a:gd name="connsiteX126" fmla="*/ 4269425 w 4272784"/>
              <a:gd name="connsiteY126" fmla="*/ 6251575 h 6858000"/>
              <a:gd name="connsiteX127" fmla="*/ 4261027 w 4272784"/>
              <a:gd name="connsiteY127" fmla="*/ 6311900 h 6858000"/>
              <a:gd name="connsiteX128" fmla="*/ 4249270 w 4272784"/>
              <a:gd name="connsiteY128" fmla="*/ 6361112 h 6858000"/>
              <a:gd name="connsiteX129" fmla="*/ 4234153 w 4272784"/>
              <a:gd name="connsiteY129" fmla="*/ 6407150 h 6858000"/>
              <a:gd name="connsiteX130" fmla="*/ 4217357 w 4272784"/>
              <a:gd name="connsiteY130" fmla="*/ 6448425 h 6858000"/>
              <a:gd name="connsiteX131" fmla="*/ 4198882 w 4272784"/>
              <a:gd name="connsiteY131" fmla="*/ 6488112 h 6858000"/>
              <a:gd name="connsiteX132" fmla="*/ 4180406 w 4272784"/>
              <a:gd name="connsiteY132" fmla="*/ 6523037 h 6858000"/>
              <a:gd name="connsiteX133" fmla="*/ 4160251 w 4272784"/>
              <a:gd name="connsiteY133" fmla="*/ 6561137 h 6858000"/>
              <a:gd name="connsiteX134" fmla="*/ 4140096 w 4272784"/>
              <a:gd name="connsiteY134" fmla="*/ 6597650 h 6858000"/>
              <a:gd name="connsiteX135" fmla="*/ 4123300 w 4272784"/>
              <a:gd name="connsiteY135" fmla="*/ 6640512 h 6858000"/>
              <a:gd name="connsiteX136" fmla="*/ 4106504 w 4272784"/>
              <a:gd name="connsiteY136" fmla="*/ 6683375 h 6858000"/>
              <a:gd name="connsiteX137" fmla="*/ 4096426 w 4272784"/>
              <a:gd name="connsiteY137" fmla="*/ 6735762 h 6858000"/>
              <a:gd name="connsiteX138" fmla="*/ 4088029 w 4272784"/>
              <a:gd name="connsiteY138" fmla="*/ 6791325 h 6858000"/>
              <a:gd name="connsiteX139" fmla="*/ 4082989 w 4272784"/>
              <a:gd name="connsiteY139" fmla="*/ 6858000 h 6858000"/>
              <a:gd name="connsiteX140" fmla="*/ 0 w 4272784"/>
              <a:gd name="connsiteY140"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Lst>
            <a:rect l="l" t="t" r="r" b="b"/>
            <a:pathLst>
              <a:path w="4272784" h="6858000">
                <a:moveTo>
                  <a:pt x="0" y="0"/>
                </a:moveTo>
                <a:lnTo>
                  <a:pt x="4082989" y="0"/>
                </a:lnTo>
                <a:lnTo>
                  <a:pt x="4088029" y="66675"/>
                </a:lnTo>
                <a:lnTo>
                  <a:pt x="4096426" y="122237"/>
                </a:lnTo>
                <a:lnTo>
                  <a:pt x="4106504" y="174625"/>
                </a:lnTo>
                <a:lnTo>
                  <a:pt x="4123300" y="217487"/>
                </a:lnTo>
                <a:lnTo>
                  <a:pt x="4140096" y="260350"/>
                </a:lnTo>
                <a:lnTo>
                  <a:pt x="4160251" y="296862"/>
                </a:lnTo>
                <a:lnTo>
                  <a:pt x="4180406" y="334962"/>
                </a:lnTo>
                <a:lnTo>
                  <a:pt x="4198882" y="369887"/>
                </a:lnTo>
                <a:lnTo>
                  <a:pt x="4217357" y="409575"/>
                </a:lnTo>
                <a:lnTo>
                  <a:pt x="4234153" y="450850"/>
                </a:lnTo>
                <a:lnTo>
                  <a:pt x="4249270" y="496887"/>
                </a:lnTo>
                <a:lnTo>
                  <a:pt x="4261027" y="546100"/>
                </a:lnTo>
                <a:lnTo>
                  <a:pt x="4269425" y="606425"/>
                </a:lnTo>
                <a:lnTo>
                  <a:pt x="4272784" y="673100"/>
                </a:lnTo>
                <a:lnTo>
                  <a:pt x="4269425" y="744537"/>
                </a:lnTo>
                <a:lnTo>
                  <a:pt x="4261027" y="801687"/>
                </a:lnTo>
                <a:lnTo>
                  <a:pt x="4249270" y="854075"/>
                </a:lnTo>
                <a:lnTo>
                  <a:pt x="4234153" y="901700"/>
                </a:lnTo>
                <a:lnTo>
                  <a:pt x="4217357" y="942975"/>
                </a:lnTo>
                <a:lnTo>
                  <a:pt x="4197202" y="981075"/>
                </a:lnTo>
                <a:lnTo>
                  <a:pt x="4177047" y="1017587"/>
                </a:lnTo>
                <a:lnTo>
                  <a:pt x="4156892" y="1055687"/>
                </a:lnTo>
                <a:lnTo>
                  <a:pt x="4138416" y="1095375"/>
                </a:lnTo>
                <a:lnTo>
                  <a:pt x="4119940" y="1136650"/>
                </a:lnTo>
                <a:lnTo>
                  <a:pt x="4104825" y="1182687"/>
                </a:lnTo>
                <a:lnTo>
                  <a:pt x="4094747" y="1235075"/>
                </a:lnTo>
                <a:lnTo>
                  <a:pt x="4084669" y="1295400"/>
                </a:lnTo>
                <a:lnTo>
                  <a:pt x="4082989" y="1363662"/>
                </a:lnTo>
                <a:lnTo>
                  <a:pt x="4084669" y="1431925"/>
                </a:lnTo>
                <a:lnTo>
                  <a:pt x="4094747" y="1492250"/>
                </a:lnTo>
                <a:lnTo>
                  <a:pt x="4104825" y="1544637"/>
                </a:lnTo>
                <a:lnTo>
                  <a:pt x="4119940" y="1589087"/>
                </a:lnTo>
                <a:lnTo>
                  <a:pt x="4138416" y="1631950"/>
                </a:lnTo>
                <a:lnTo>
                  <a:pt x="4156892" y="1671637"/>
                </a:lnTo>
                <a:lnTo>
                  <a:pt x="4177047" y="1708150"/>
                </a:lnTo>
                <a:lnTo>
                  <a:pt x="4197202" y="1743075"/>
                </a:lnTo>
                <a:lnTo>
                  <a:pt x="4217357" y="1782762"/>
                </a:lnTo>
                <a:lnTo>
                  <a:pt x="4234153" y="1824037"/>
                </a:lnTo>
                <a:lnTo>
                  <a:pt x="4249270" y="1870075"/>
                </a:lnTo>
                <a:lnTo>
                  <a:pt x="4261027" y="1922462"/>
                </a:lnTo>
                <a:lnTo>
                  <a:pt x="4269425" y="1982787"/>
                </a:lnTo>
                <a:lnTo>
                  <a:pt x="4272784" y="2051050"/>
                </a:lnTo>
                <a:lnTo>
                  <a:pt x="4269425" y="2119312"/>
                </a:lnTo>
                <a:lnTo>
                  <a:pt x="4261027" y="2179637"/>
                </a:lnTo>
                <a:lnTo>
                  <a:pt x="4249270" y="2232025"/>
                </a:lnTo>
                <a:lnTo>
                  <a:pt x="4234153" y="2278062"/>
                </a:lnTo>
                <a:lnTo>
                  <a:pt x="4217357" y="2319337"/>
                </a:lnTo>
                <a:lnTo>
                  <a:pt x="4197202" y="2359025"/>
                </a:lnTo>
                <a:lnTo>
                  <a:pt x="4177047" y="2395537"/>
                </a:lnTo>
                <a:lnTo>
                  <a:pt x="4156892" y="2433637"/>
                </a:lnTo>
                <a:lnTo>
                  <a:pt x="4138416" y="2471737"/>
                </a:lnTo>
                <a:lnTo>
                  <a:pt x="4119940" y="2513012"/>
                </a:lnTo>
                <a:lnTo>
                  <a:pt x="4104825" y="2560637"/>
                </a:lnTo>
                <a:lnTo>
                  <a:pt x="4094747" y="2613025"/>
                </a:lnTo>
                <a:lnTo>
                  <a:pt x="4084669" y="2671762"/>
                </a:lnTo>
                <a:lnTo>
                  <a:pt x="4082989" y="2741612"/>
                </a:lnTo>
                <a:lnTo>
                  <a:pt x="4084669" y="2809875"/>
                </a:lnTo>
                <a:lnTo>
                  <a:pt x="4094747" y="2868612"/>
                </a:lnTo>
                <a:lnTo>
                  <a:pt x="4104825" y="2922587"/>
                </a:lnTo>
                <a:lnTo>
                  <a:pt x="4119940" y="2967037"/>
                </a:lnTo>
                <a:lnTo>
                  <a:pt x="4138416" y="3009900"/>
                </a:lnTo>
                <a:lnTo>
                  <a:pt x="4156892" y="3046412"/>
                </a:lnTo>
                <a:lnTo>
                  <a:pt x="4177047" y="3084512"/>
                </a:lnTo>
                <a:lnTo>
                  <a:pt x="4197202" y="3121025"/>
                </a:lnTo>
                <a:lnTo>
                  <a:pt x="4217357" y="3160712"/>
                </a:lnTo>
                <a:lnTo>
                  <a:pt x="4234153" y="3201987"/>
                </a:lnTo>
                <a:lnTo>
                  <a:pt x="4249270" y="3248025"/>
                </a:lnTo>
                <a:lnTo>
                  <a:pt x="4261027" y="3300412"/>
                </a:lnTo>
                <a:lnTo>
                  <a:pt x="4269425" y="3360737"/>
                </a:lnTo>
                <a:lnTo>
                  <a:pt x="4272784" y="3427412"/>
                </a:lnTo>
                <a:lnTo>
                  <a:pt x="4269425" y="3497262"/>
                </a:lnTo>
                <a:lnTo>
                  <a:pt x="4261027" y="3557587"/>
                </a:lnTo>
                <a:lnTo>
                  <a:pt x="4249270" y="3609975"/>
                </a:lnTo>
                <a:lnTo>
                  <a:pt x="4234153" y="3656012"/>
                </a:lnTo>
                <a:lnTo>
                  <a:pt x="4217357" y="3697287"/>
                </a:lnTo>
                <a:lnTo>
                  <a:pt x="4197202" y="3736975"/>
                </a:lnTo>
                <a:lnTo>
                  <a:pt x="4156892" y="3811587"/>
                </a:lnTo>
                <a:lnTo>
                  <a:pt x="4138416" y="3848100"/>
                </a:lnTo>
                <a:lnTo>
                  <a:pt x="4119940" y="3890962"/>
                </a:lnTo>
                <a:lnTo>
                  <a:pt x="4104825" y="3935412"/>
                </a:lnTo>
                <a:lnTo>
                  <a:pt x="4094747" y="3987800"/>
                </a:lnTo>
                <a:lnTo>
                  <a:pt x="4084669" y="4048125"/>
                </a:lnTo>
                <a:lnTo>
                  <a:pt x="4082989" y="4116387"/>
                </a:lnTo>
                <a:lnTo>
                  <a:pt x="4084669" y="4186237"/>
                </a:lnTo>
                <a:lnTo>
                  <a:pt x="4094747" y="4244975"/>
                </a:lnTo>
                <a:lnTo>
                  <a:pt x="4104825" y="4297362"/>
                </a:lnTo>
                <a:lnTo>
                  <a:pt x="4119940" y="4343400"/>
                </a:lnTo>
                <a:lnTo>
                  <a:pt x="4138416" y="4386262"/>
                </a:lnTo>
                <a:lnTo>
                  <a:pt x="4156892" y="4424362"/>
                </a:lnTo>
                <a:lnTo>
                  <a:pt x="4197202" y="4498975"/>
                </a:lnTo>
                <a:lnTo>
                  <a:pt x="4217357" y="4537075"/>
                </a:lnTo>
                <a:lnTo>
                  <a:pt x="4234153" y="4579937"/>
                </a:lnTo>
                <a:lnTo>
                  <a:pt x="4249270" y="4625975"/>
                </a:lnTo>
                <a:lnTo>
                  <a:pt x="4261027" y="4678362"/>
                </a:lnTo>
                <a:lnTo>
                  <a:pt x="4269425" y="4738687"/>
                </a:lnTo>
                <a:lnTo>
                  <a:pt x="4272784" y="4806950"/>
                </a:lnTo>
                <a:lnTo>
                  <a:pt x="4269425" y="4875212"/>
                </a:lnTo>
                <a:lnTo>
                  <a:pt x="4261027" y="4935537"/>
                </a:lnTo>
                <a:lnTo>
                  <a:pt x="4249270" y="4987925"/>
                </a:lnTo>
                <a:lnTo>
                  <a:pt x="4234153" y="5033962"/>
                </a:lnTo>
                <a:lnTo>
                  <a:pt x="4217357" y="5075237"/>
                </a:lnTo>
                <a:lnTo>
                  <a:pt x="4197202" y="5114925"/>
                </a:lnTo>
                <a:lnTo>
                  <a:pt x="4177047" y="5149850"/>
                </a:lnTo>
                <a:lnTo>
                  <a:pt x="4156892" y="5186362"/>
                </a:lnTo>
                <a:lnTo>
                  <a:pt x="4138416" y="5226050"/>
                </a:lnTo>
                <a:lnTo>
                  <a:pt x="4119940" y="5268912"/>
                </a:lnTo>
                <a:lnTo>
                  <a:pt x="4104825" y="5313362"/>
                </a:lnTo>
                <a:lnTo>
                  <a:pt x="4094747" y="5365750"/>
                </a:lnTo>
                <a:lnTo>
                  <a:pt x="4084669" y="5426075"/>
                </a:lnTo>
                <a:lnTo>
                  <a:pt x="4082989" y="5494337"/>
                </a:lnTo>
                <a:lnTo>
                  <a:pt x="4084669" y="5562600"/>
                </a:lnTo>
                <a:lnTo>
                  <a:pt x="4094747" y="5622925"/>
                </a:lnTo>
                <a:lnTo>
                  <a:pt x="4104825" y="5675312"/>
                </a:lnTo>
                <a:lnTo>
                  <a:pt x="4119940" y="5721350"/>
                </a:lnTo>
                <a:lnTo>
                  <a:pt x="4138416" y="5762625"/>
                </a:lnTo>
                <a:lnTo>
                  <a:pt x="4156892" y="5802312"/>
                </a:lnTo>
                <a:lnTo>
                  <a:pt x="4177047" y="5840412"/>
                </a:lnTo>
                <a:lnTo>
                  <a:pt x="4197202" y="5876925"/>
                </a:lnTo>
                <a:lnTo>
                  <a:pt x="4217357" y="5915025"/>
                </a:lnTo>
                <a:lnTo>
                  <a:pt x="4234153" y="5956300"/>
                </a:lnTo>
                <a:lnTo>
                  <a:pt x="4249270" y="6003925"/>
                </a:lnTo>
                <a:lnTo>
                  <a:pt x="4261027" y="6056312"/>
                </a:lnTo>
                <a:lnTo>
                  <a:pt x="4269425" y="6113462"/>
                </a:lnTo>
                <a:lnTo>
                  <a:pt x="4272784" y="6183312"/>
                </a:lnTo>
                <a:lnTo>
                  <a:pt x="4269425" y="6251575"/>
                </a:lnTo>
                <a:lnTo>
                  <a:pt x="4261027" y="6311900"/>
                </a:lnTo>
                <a:lnTo>
                  <a:pt x="4249270" y="6361112"/>
                </a:lnTo>
                <a:lnTo>
                  <a:pt x="4234153" y="6407150"/>
                </a:lnTo>
                <a:lnTo>
                  <a:pt x="4217357" y="6448425"/>
                </a:lnTo>
                <a:lnTo>
                  <a:pt x="4198882" y="6488112"/>
                </a:lnTo>
                <a:lnTo>
                  <a:pt x="4180406" y="6523037"/>
                </a:lnTo>
                <a:lnTo>
                  <a:pt x="4160251" y="6561137"/>
                </a:lnTo>
                <a:lnTo>
                  <a:pt x="4140096" y="6597650"/>
                </a:lnTo>
                <a:lnTo>
                  <a:pt x="4123300" y="6640512"/>
                </a:lnTo>
                <a:lnTo>
                  <a:pt x="4106504" y="6683375"/>
                </a:lnTo>
                <a:lnTo>
                  <a:pt x="4096426" y="6735762"/>
                </a:lnTo>
                <a:lnTo>
                  <a:pt x="4088029" y="6791325"/>
                </a:lnTo>
                <a:lnTo>
                  <a:pt x="4082989" y="6858000"/>
                </a:lnTo>
                <a:lnTo>
                  <a:pt x="0" y="6858000"/>
                </a:lnTo>
                <a:close/>
              </a:path>
            </a:pathLst>
          </a:custGeom>
          <a:ln w="0">
            <a:noFill/>
            <a:prstDash val="solid"/>
            <a:round/>
            <a:headEnd/>
            <a:tailEnd/>
          </a:ln>
        </p:spPr>
        <p:txBody>
          <a:bodyPr/>
          <a:lstStyle/>
          <a:p>
            <a:endParaRPr lang="en-US" dirty="0"/>
          </a:p>
        </p:txBody>
      </p:sp>
      <p:sp>
        <p:nvSpPr>
          <p:cNvPr id="16" name="Freeform: Shape 15">
            <a:extLst>
              <a:ext uri="{FF2B5EF4-FFF2-40B4-BE49-F238E27FC236}">
                <a16:creationId xmlns:a16="http://schemas.microsoft.com/office/drawing/2014/main" id="{909E572F-9CDC-4214-9D42-FF00176495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4417162" cy="6858000"/>
          </a:xfrm>
          <a:custGeom>
            <a:avLst/>
            <a:gdLst>
              <a:gd name="connsiteX0" fmla="*/ 4417162 w 4417162"/>
              <a:gd name="connsiteY0" fmla="*/ 0 h 6858000"/>
              <a:gd name="connsiteX1" fmla="*/ 334174 w 4417162"/>
              <a:gd name="connsiteY1" fmla="*/ 0 h 6858000"/>
              <a:gd name="connsiteX2" fmla="*/ 334173 w 4417162"/>
              <a:gd name="connsiteY2" fmla="*/ 0 h 6858000"/>
              <a:gd name="connsiteX3" fmla="*/ 189795 w 4417162"/>
              <a:gd name="connsiteY3" fmla="*/ 0 h 6858000"/>
              <a:gd name="connsiteX4" fmla="*/ 184756 w 4417162"/>
              <a:gd name="connsiteY4" fmla="*/ 66675 h 6858000"/>
              <a:gd name="connsiteX5" fmla="*/ 176358 w 4417162"/>
              <a:gd name="connsiteY5" fmla="*/ 122237 h 6858000"/>
              <a:gd name="connsiteX6" fmla="*/ 166281 w 4417162"/>
              <a:gd name="connsiteY6" fmla="*/ 174625 h 6858000"/>
              <a:gd name="connsiteX7" fmla="*/ 149485 w 4417162"/>
              <a:gd name="connsiteY7" fmla="*/ 217487 h 6858000"/>
              <a:gd name="connsiteX8" fmla="*/ 132689 w 4417162"/>
              <a:gd name="connsiteY8" fmla="*/ 260350 h 6858000"/>
              <a:gd name="connsiteX9" fmla="*/ 112534 w 4417162"/>
              <a:gd name="connsiteY9" fmla="*/ 296862 h 6858000"/>
              <a:gd name="connsiteX10" fmla="*/ 92379 w 4417162"/>
              <a:gd name="connsiteY10" fmla="*/ 334962 h 6858000"/>
              <a:gd name="connsiteX11" fmla="*/ 73903 w 4417162"/>
              <a:gd name="connsiteY11" fmla="*/ 369887 h 6858000"/>
              <a:gd name="connsiteX12" fmla="*/ 55427 w 4417162"/>
              <a:gd name="connsiteY12" fmla="*/ 409575 h 6858000"/>
              <a:gd name="connsiteX13" fmla="*/ 38632 w 4417162"/>
              <a:gd name="connsiteY13" fmla="*/ 450850 h 6858000"/>
              <a:gd name="connsiteX14" fmla="*/ 23515 w 4417162"/>
              <a:gd name="connsiteY14" fmla="*/ 496887 h 6858000"/>
              <a:gd name="connsiteX15" fmla="*/ 11758 w 4417162"/>
              <a:gd name="connsiteY15" fmla="*/ 546100 h 6858000"/>
              <a:gd name="connsiteX16" fmla="*/ 3359 w 4417162"/>
              <a:gd name="connsiteY16" fmla="*/ 606425 h 6858000"/>
              <a:gd name="connsiteX17" fmla="*/ 0 w 4417162"/>
              <a:gd name="connsiteY17" fmla="*/ 673100 h 6858000"/>
              <a:gd name="connsiteX18" fmla="*/ 3359 w 4417162"/>
              <a:gd name="connsiteY18" fmla="*/ 744537 h 6858000"/>
              <a:gd name="connsiteX19" fmla="*/ 11758 w 4417162"/>
              <a:gd name="connsiteY19" fmla="*/ 801687 h 6858000"/>
              <a:gd name="connsiteX20" fmla="*/ 23515 w 4417162"/>
              <a:gd name="connsiteY20" fmla="*/ 854075 h 6858000"/>
              <a:gd name="connsiteX21" fmla="*/ 38632 w 4417162"/>
              <a:gd name="connsiteY21" fmla="*/ 901700 h 6858000"/>
              <a:gd name="connsiteX22" fmla="*/ 55427 w 4417162"/>
              <a:gd name="connsiteY22" fmla="*/ 942975 h 6858000"/>
              <a:gd name="connsiteX23" fmla="*/ 75583 w 4417162"/>
              <a:gd name="connsiteY23" fmla="*/ 981075 h 6858000"/>
              <a:gd name="connsiteX24" fmla="*/ 95738 w 4417162"/>
              <a:gd name="connsiteY24" fmla="*/ 1017587 h 6858000"/>
              <a:gd name="connsiteX25" fmla="*/ 115893 w 4417162"/>
              <a:gd name="connsiteY25" fmla="*/ 1055687 h 6858000"/>
              <a:gd name="connsiteX26" fmla="*/ 134368 w 4417162"/>
              <a:gd name="connsiteY26" fmla="*/ 1095375 h 6858000"/>
              <a:gd name="connsiteX27" fmla="*/ 152844 w 4417162"/>
              <a:gd name="connsiteY27" fmla="*/ 1136650 h 6858000"/>
              <a:gd name="connsiteX28" fmla="*/ 167960 w 4417162"/>
              <a:gd name="connsiteY28" fmla="*/ 1182687 h 6858000"/>
              <a:gd name="connsiteX29" fmla="*/ 178038 w 4417162"/>
              <a:gd name="connsiteY29" fmla="*/ 1235075 h 6858000"/>
              <a:gd name="connsiteX30" fmla="*/ 188115 w 4417162"/>
              <a:gd name="connsiteY30" fmla="*/ 1295400 h 6858000"/>
              <a:gd name="connsiteX31" fmla="*/ 189795 w 4417162"/>
              <a:gd name="connsiteY31" fmla="*/ 1363662 h 6858000"/>
              <a:gd name="connsiteX32" fmla="*/ 188115 w 4417162"/>
              <a:gd name="connsiteY32" fmla="*/ 1431925 h 6858000"/>
              <a:gd name="connsiteX33" fmla="*/ 178038 w 4417162"/>
              <a:gd name="connsiteY33" fmla="*/ 1492250 h 6858000"/>
              <a:gd name="connsiteX34" fmla="*/ 167960 w 4417162"/>
              <a:gd name="connsiteY34" fmla="*/ 1544637 h 6858000"/>
              <a:gd name="connsiteX35" fmla="*/ 152844 w 4417162"/>
              <a:gd name="connsiteY35" fmla="*/ 1589087 h 6858000"/>
              <a:gd name="connsiteX36" fmla="*/ 134368 w 4417162"/>
              <a:gd name="connsiteY36" fmla="*/ 1631950 h 6858000"/>
              <a:gd name="connsiteX37" fmla="*/ 115893 w 4417162"/>
              <a:gd name="connsiteY37" fmla="*/ 1671637 h 6858000"/>
              <a:gd name="connsiteX38" fmla="*/ 95738 w 4417162"/>
              <a:gd name="connsiteY38" fmla="*/ 1708150 h 6858000"/>
              <a:gd name="connsiteX39" fmla="*/ 75583 w 4417162"/>
              <a:gd name="connsiteY39" fmla="*/ 1743075 h 6858000"/>
              <a:gd name="connsiteX40" fmla="*/ 55427 w 4417162"/>
              <a:gd name="connsiteY40" fmla="*/ 1782762 h 6858000"/>
              <a:gd name="connsiteX41" fmla="*/ 38632 w 4417162"/>
              <a:gd name="connsiteY41" fmla="*/ 1824037 h 6858000"/>
              <a:gd name="connsiteX42" fmla="*/ 23515 w 4417162"/>
              <a:gd name="connsiteY42" fmla="*/ 1870075 h 6858000"/>
              <a:gd name="connsiteX43" fmla="*/ 11758 w 4417162"/>
              <a:gd name="connsiteY43" fmla="*/ 1922462 h 6858000"/>
              <a:gd name="connsiteX44" fmla="*/ 3359 w 4417162"/>
              <a:gd name="connsiteY44" fmla="*/ 1982787 h 6858000"/>
              <a:gd name="connsiteX45" fmla="*/ 0 w 4417162"/>
              <a:gd name="connsiteY45" fmla="*/ 2051050 h 6858000"/>
              <a:gd name="connsiteX46" fmla="*/ 3359 w 4417162"/>
              <a:gd name="connsiteY46" fmla="*/ 2119312 h 6858000"/>
              <a:gd name="connsiteX47" fmla="*/ 11758 w 4417162"/>
              <a:gd name="connsiteY47" fmla="*/ 2179637 h 6858000"/>
              <a:gd name="connsiteX48" fmla="*/ 23515 w 4417162"/>
              <a:gd name="connsiteY48" fmla="*/ 2232025 h 6858000"/>
              <a:gd name="connsiteX49" fmla="*/ 38632 w 4417162"/>
              <a:gd name="connsiteY49" fmla="*/ 2278062 h 6858000"/>
              <a:gd name="connsiteX50" fmla="*/ 55427 w 4417162"/>
              <a:gd name="connsiteY50" fmla="*/ 2319337 h 6858000"/>
              <a:gd name="connsiteX51" fmla="*/ 75583 w 4417162"/>
              <a:gd name="connsiteY51" fmla="*/ 2359025 h 6858000"/>
              <a:gd name="connsiteX52" fmla="*/ 95738 w 4417162"/>
              <a:gd name="connsiteY52" fmla="*/ 2395537 h 6858000"/>
              <a:gd name="connsiteX53" fmla="*/ 115893 w 4417162"/>
              <a:gd name="connsiteY53" fmla="*/ 2433637 h 6858000"/>
              <a:gd name="connsiteX54" fmla="*/ 134368 w 4417162"/>
              <a:gd name="connsiteY54" fmla="*/ 2471737 h 6858000"/>
              <a:gd name="connsiteX55" fmla="*/ 152844 w 4417162"/>
              <a:gd name="connsiteY55" fmla="*/ 2513012 h 6858000"/>
              <a:gd name="connsiteX56" fmla="*/ 167960 w 4417162"/>
              <a:gd name="connsiteY56" fmla="*/ 2560637 h 6858000"/>
              <a:gd name="connsiteX57" fmla="*/ 178038 w 4417162"/>
              <a:gd name="connsiteY57" fmla="*/ 2613025 h 6858000"/>
              <a:gd name="connsiteX58" fmla="*/ 188115 w 4417162"/>
              <a:gd name="connsiteY58" fmla="*/ 2671762 h 6858000"/>
              <a:gd name="connsiteX59" fmla="*/ 189795 w 4417162"/>
              <a:gd name="connsiteY59" fmla="*/ 2741612 h 6858000"/>
              <a:gd name="connsiteX60" fmla="*/ 188115 w 4417162"/>
              <a:gd name="connsiteY60" fmla="*/ 2809875 h 6858000"/>
              <a:gd name="connsiteX61" fmla="*/ 178038 w 4417162"/>
              <a:gd name="connsiteY61" fmla="*/ 2868612 h 6858000"/>
              <a:gd name="connsiteX62" fmla="*/ 167960 w 4417162"/>
              <a:gd name="connsiteY62" fmla="*/ 2922587 h 6858000"/>
              <a:gd name="connsiteX63" fmla="*/ 152844 w 4417162"/>
              <a:gd name="connsiteY63" fmla="*/ 2967037 h 6858000"/>
              <a:gd name="connsiteX64" fmla="*/ 134368 w 4417162"/>
              <a:gd name="connsiteY64" fmla="*/ 3009900 h 6858000"/>
              <a:gd name="connsiteX65" fmla="*/ 115893 w 4417162"/>
              <a:gd name="connsiteY65" fmla="*/ 3046412 h 6858000"/>
              <a:gd name="connsiteX66" fmla="*/ 95738 w 4417162"/>
              <a:gd name="connsiteY66" fmla="*/ 3084512 h 6858000"/>
              <a:gd name="connsiteX67" fmla="*/ 75583 w 4417162"/>
              <a:gd name="connsiteY67" fmla="*/ 3121025 h 6858000"/>
              <a:gd name="connsiteX68" fmla="*/ 55427 w 4417162"/>
              <a:gd name="connsiteY68" fmla="*/ 3160712 h 6858000"/>
              <a:gd name="connsiteX69" fmla="*/ 38632 w 4417162"/>
              <a:gd name="connsiteY69" fmla="*/ 3201987 h 6858000"/>
              <a:gd name="connsiteX70" fmla="*/ 23515 w 4417162"/>
              <a:gd name="connsiteY70" fmla="*/ 3248025 h 6858000"/>
              <a:gd name="connsiteX71" fmla="*/ 11758 w 4417162"/>
              <a:gd name="connsiteY71" fmla="*/ 3300412 h 6858000"/>
              <a:gd name="connsiteX72" fmla="*/ 3359 w 4417162"/>
              <a:gd name="connsiteY72" fmla="*/ 3360737 h 6858000"/>
              <a:gd name="connsiteX73" fmla="*/ 0 w 4417162"/>
              <a:gd name="connsiteY73" fmla="*/ 3427412 h 6858000"/>
              <a:gd name="connsiteX74" fmla="*/ 3359 w 4417162"/>
              <a:gd name="connsiteY74" fmla="*/ 3497262 h 6858000"/>
              <a:gd name="connsiteX75" fmla="*/ 11758 w 4417162"/>
              <a:gd name="connsiteY75" fmla="*/ 3557587 h 6858000"/>
              <a:gd name="connsiteX76" fmla="*/ 23515 w 4417162"/>
              <a:gd name="connsiteY76" fmla="*/ 3609975 h 6858000"/>
              <a:gd name="connsiteX77" fmla="*/ 38632 w 4417162"/>
              <a:gd name="connsiteY77" fmla="*/ 3656012 h 6858000"/>
              <a:gd name="connsiteX78" fmla="*/ 55427 w 4417162"/>
              <a:gd name="connsiteY78" fmla="*/ 3697287 h 6858000"/>
              <a:gd name="connsiteX79" fmla="*/ 75583 w 4417162"/>
              <a:gd name="connsiteY79" fmla="*/ 3736975 h 6858000"/>
              <a:gd name="connsiteX80" fmla="*/ 115893 w 4417162"/>
              <a:gd name="connsiteY80" fmla="*/ 3811587 h 6858000"/>
              <a:gd name="connsiteX81" fmla="*/ 134368 w 4417162"/>
              <a:gd name="connsiteY81" fmla="*/ 3848100 h 6858000"/>
              <a:gd name="connsiteX82" fmla="*/ 152844 w 4417162"/>
              <a:gd name="connsiteY82" fmla="*/ 3890962 h 6858000"/>
              <a:gd name="connsiteX83" fmla="*/ 167960 w 4417162"/>
              <a:gd name="connsiteY83" fmla="*/ 3935412 h 6858000"/>
              <a:gd name="connsiteX84" fmla="*/ 178038 w 4417162"/>
              <a:gd name="connsiteY84" fmla="*/ 3987800 h 6858000"/>
              <a:gd name="connsiteX85" fmla="*/ 188115 w 4417162"/>
              <a:gd name="connsiteY85" fmla="*/ 4048125 h 6858000"/>
              <a:gd name="connsiteX86" fmla="*/ 189795 w 4417162"/>
              <a:gd name="connsiteY86" fmla="*/ 4116387 h 6858000"/>
              <a:gd name="connsiteX87" fmla="*/ 188115 w 4417162"/>
              <a:gd name="connsiteY87" fmla="*/ 4186237 h 6858000"/>
              <a:gd name="connsiteX88" fmla="*/ 178038 w 4417162"/>
              <a:gd name="connsiteY88" fmla="*/ 4244975 h 6858000"/>
              <a:gd name="connsiteX89" fmla="*/ 167960 w 4417162"/>
              <a:gd name="connsiteY89" fmla="*/ 4297362 h 6858000"/>
              <a:gd name="connsiteX90" fmla="*/ 152844 w 4417162"/>
              <a:gd name="connsiteY90" fmla="*/ 4343400 h 6858000"/>
              <a:gd name="connsiteX91" fmla="*/ 134368 w 4417162"/>
              <a:gd name="connsiteY91" fmla="*/ 4386262 h 6858000"/>
              <a:gd name="connsiteX92" fmla="*/ 115893 w 4417162"/>
              <a:gd name="connsiteY92" fmla="*/ 4424362 h 6858000"/>
              <a:gd name="connsiteX93" fmla="*/ 75583 w 4417162"/>
              <a:gd name="connsiteY93" fmla="*/ 4498975 h 6858000"/>
              <a:gd name="connsiteX94" fmla="*/ 55427 w 4417162"/>
              <a:gd name="connsiteY94" fmla="*/ 4537075 h 6858000"/>
              <a:gd name="connsiteX95" fmla="*/ 38632 w 4417162"/>
              <a:gd name="connsiteY95" fmla="*/ 4579937 h 6858000"/>
              <a:gd name="connsiteX96" fmla="*/ 23515 w 4417162"/>
              <a:gd name="connsiteY96" fmla="*/ 4625975 h 6858000"/>
              <a:gd name="connsiteX97" fmla="*/ 11758 w 4417162"/>
              <a:gd name="connsiteY97" fmla="*/ 4678362 h 6858000"/>
              <a:gd name="connsiteX98" fmla="*/ 3359 w 4417162"/>
              <a:gd name="connsiteY98" fmla="*/ 4738687 h 6858000"/>
              <a:gd name="connsiteX99" fmla="*/ 0 w 4417162"/>
              <a:gd name="connsiteY99" fmla="*/ 4806950 h 6858000"/>
              <a:gd name="connsiteX100" fmla="*/ 3359 w 4417162"/>
              <a:gd name="connsiteY100" fmla="*/ 4875212 h 6858000"/>
              <a:gd name="connsiteX101" fmla="*/ 11758 w 4417162"/>
              <a:gd name="connsiteY101" fmla="*/ 4935537 h 6858000"/>
              <a:gd name="connsiteX102" fmla="*/ 23515 w 4417162"/>
              <a:gd name="connsiteY102" fmla="*/ 4987925 h 6858000"/>
              <a:gd name="connsiteX103" fmla="*/ 38632 w 4417162"/>
              <a:gd name="connsiteY103" fmla="*/ 5033962 h 6858000"/>
              <a:gd name="connsiteX104" fmla="*/ 55427 w 4417162"/>
              <a:gd name="connsiteY104" fmla="*/ 5075237 h 6858000"/>
              <a:gd name="connsiteX105" fmla="*/ 75583 w 4417162"/>
              <a:gd name="connsiteY105" fmla="*/ 5114925 h 6858000"/>
              <a:gd name="connsiteX106" fmla="*/ 95738 w 4417162"/>
              <a:gd name="connsiteY106" fmla="*/ 5149850 h 6858000"/>
              <a:gd name="connsiteX107" fmla="*/ 115893 w 4417162"/>
              <a:gd name="connsiteY107" fmla="*/ 5186362 h 6858000"/>
              <a:gd name="connsiteX108" fmla="*/ 134368 w 4417162"/>
              <a:gd name="connsiteY108" fmla="*/ 5226050 h 6858000"/>
              <a:gd name="connsiteX109" fmla="*/ 152844 w 4417162"/>
              <a:gd name="connsiteY109" fmla="*/ 5268912 h 6858000"/>
              <a:gd name="connsiteX110" fmla="*/ 167960 w 4417162"/>
              <a:gd name="connsiteY110" fmla="*/ 5313362 h 6858000"/>
              <a:gd name="connsiteX111" fmla="*/ 178038 w 4417162"/>
              <a:gd name="connsiteY111" fmla="*/ 5365750 h 6858000"/>
              <a:gd name="connsiteX112" fmla="*/ 188115 w 4417162"/>
              <a:gd name="connsiteY112" fmla="*/ 5426075 h 6858000"/>
              <a:gd name="connsiteX113" fmla="*/ 189795 w 4417162"/>
              <a:gd name="connsiteY113" fmla="*/ 5494337 h 6858000"/>
              <a:gd name="connsiteX114" fmla="*/ 188115 w 4417162"/>
              <a:gd name="connsiteY114" fmla="*/ 5562600 h 6858000"/>
              <a:gd name="connsiteX115" fmla="*/ 178038 w 4417162"/>
              <a:gd name="connsiteY115" fmla="*/ 5622925 h 6858000"/>
              <a:gd name="connsiteX116" fmla="*/ 167960 w 4417162"/>
              <a:gd name="connsiteY116" fmla="*/ 5675312 h 6858000"/>
              <a:gd name="connsiteX117" fmla="*/ 152844 w 4417162"/>
              <a:gd name="connsiteY117" fmla="*/ 5721350 h 6858000"/>
              <a:gd name="connsiteX118" fmla="*/ 134368 w 4417162"/>
              <a:gd name="connsiteY118" fmla="*/ 5762625 h 6858000"/>
              <a:gd name="connsiteX119" fmla="*/ 115893 w 4417162"/>
              <a:gd name="connsiteY119" fmla="*/ 5802312 h 6858000"/>
              <a:gd name="connsiteX120" fmla="*/ 95738 w 4417162"/>
              <a:gd name="connsiteY120" fmla="*/ 5840412 h 6858000"/>
              <a:gd name="connsiteX121" fmla="*/ 75583 w 4417162"/>
              <a:gd name="connsiteY121" fmla="*/ 5876925 h 6858000"/>
              <a:gd name="connsiteX122" fmla="*/ 55427 w 4417162"/>
              <a:gd name="connsiteY122" fmla="*/ 5915025 h 6858000"/>
              <a:gd name="connsiteX123" fmla="*/ 38632 w 4417162"/>
              <a:gd name="connsiteY123" fmla="*/ 5956300 h 6858000"/>
              <a:gd name="connsiteX124" fmla="*/ 23515 w 4417162"/>
              <a:gd name="connsiteY124" fmla="*/ 6003925 h 6858000"/>
              <a:gd name="connsiteX125" fmla="*/ 11758 w 4417162"/>
              <a:gd name="connsiteY125" fmla="*/ 6056312 h 6858000"/>
              <a:gd name="connsiteX126" fmla="*/ 3359 w 4417162"/>
              <a:gd name="connsiteY126" fmla="*/ 6113462 h 6858000"/>
              <a:gd name="connsiteX127" fmla="*/ 0 w 4417162"/>
              <a:gd name="connsiteY127" fmla="*/ 6183312 h 6858000"/>
              <a:gd name="connsiteX128" fmla="*/ 3359 w 4417162"/>
              <a:gd name="connsiteY128" fmla="*/ 6251575 h 6858000"/>
              <a:gd name="connsiteX129" fmla="*/ 11758 w 4417162"/>
              <a:gd name="connsiteY129" fmla="*/ 6311900 h 6858000"/>
              <a:gd name="connsiteX130" fmla="*/ 23515 w 4417162"/>
              <a:gd name="connsiteY130" fmla="*/ 6361112 h 6858000"/>
              <a:gd name="connsiteX131" fmla="*/ 38632 w 4417162"/>
              <a:gd name="connsiteY131" fmla="*/ 6407150 h 6858000"/>
              <a:gd name="connsiteX132" fmla="*/ 55427 w 4417162"/>
              <a:gd name="connsiteY132" fmla="*/ 6448425 h 6858000"/>
              <a:gd name="connsiteX133" fmla="*/ 73903 w 4417162"/>
              <a:gd name="connsiteY133" fmla="*/ 6488112 h 6858000"/>
              <a:gd name="connsiteX134" fmla="*/ 92379 w 4417162"/>
              <a:gd name="connsiteY134" fmla="*/ 6523037 h 6858000"/>
              <a:gd name="connsiteX135" fmla="*/ 112534 w 4417162"/>
              <a:gd name="connsiteY135" fmla="*/ 6561137 h 6858000"/>
              <a:gd name="connsiteX136" fmla="*/ 132689 w 4417162"/>
              <a:gd name="connsiteY136" fmla="*/ 6597650 h 6858000"/>
              <a:gd name="connsiteX137" fmla="*/ 149485 w 4417162"/>
              <a:gd name="connsiteY137" fmla="*/ 6640512 h 6858000"/>
              <a:gd name="connsiteX138" fmla="*/ 166281 w 4417162"/>
              <a:gd name="connsiteY138" fmla="*/ 6683375 h 6858000"/>
              <a:gd name="connsiteX139" fmla="*/ 176358 w 4417162"/>
              <a:gd name="connsiteY139" fmla="*/ 6735762 h 6858000"/>
              <a:gd name="connsiteX140" fmla="*/ 184756 w 4417162"/>
              <a:gd name="connsiteY140" fmla="*/ 6791325 h 6858000"/>
              <a:gd name="connsiteX141" fmla="*/ 189795 w 4417162"/>
              <a:gd name="connsiteY141" fmla="*/ 6858000 h 6858000"/>
              <a:gd name="connsiteX142" fmla="*/ 334173 w 4417162"/>
              <a:gd name="connsiteY142" fmla="*/ 6858000 h 6858000"/>
              <a:gd name="connsiteX143" fmla="*/ 334174 w 4417162"/>
              <a:gd name="connsiteY143" fmla="*/ 6858000 h 6858000"/>
              <a:gd name="connsiteX144" fmla="*/ 4417162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4417162" y="0"/>
                </a:moveTo>
                <a:lnTo>
                  <a:pt x="334174" y="0"/>
                </a:lnTo>
                <a:lnTo>
                  <a:pt x="334173" y="0"/>
                </a:lnTo>
                <a:lnTo>
                  <a:pt x="189795" y="0"/>
                </a:lnTo>
                <a:lnTo>
                  <a:pt x="184756" y="66675"/>
                </a:lnTo>
                <a:lnTo>
                  <a:pt x="176358" y="122237"/>
                </a:lnTo>
                <a:lnTo>
                  <a:pt x="166281" y="174625"/>
                </a:lnTo>
                <a:lnTo>
                  <a:pt x="149485" y="217487"/>
                </a:lnTo>
                <a:lnTo>
                  <a:pt x="132689" y="260350"/>
                </a:lnTo>
                <a:lnTo>
                  <a:pt x="112534" y="296862"/>
                </a:lnTo>
                <a:lnTo>
                  <a:pt x="92379" y="334962"/>
                </a:lnTo>
                <a:lnTo>
                  <a:pt x="73903" y="369887"/>
                </a:lnTo>
                <a:lnTo>
                  <a:pt x="55427" y="409575"/>
                </a:lnTo>
                <a:lnTo>
                  <a:pt x="38632" y="450850"/>
                </a:lnTo>
                <a:lnTo>
                  <a:pt x="23515" y="496887"/>
                </a:lnTo>
                <a:lnTo>
                  <a:pt x="11758" y="546100"/>
                </a:lnTo>
                <a:lnTo>
                  <a:pt x="3359" y="606425"/>
                </a:lnTo>
                <a:lnTo>
                  <a:pt x="0" y="673100"/>
                </a:lnTo>
                <a:lnTo>
                  <a:pt x="3359" y="744537"/>
                </a:lnTo>
                <a:lnTo>
                  <a:pt x="11758" y="801687"/>
                </a:lnTo>
                <a:lnTo>
                  <a:pt x="23515" y="854075"/>
                </a:lnTo>
                <a:lnTo>
                  <a:pt x="38632" y="901700"/>
                </a:lnTo>
                <a:lnTo>
                  <a:pt x="55427" y="942975"/>
                </a:lnTo>
                <a:lnTo>
                  <a:pt x="75583" y="981075"/>
                </a:lnTo>
                <a:lnTo>
                  <a:pt x="95738" y="1017587"/>
                </a:lnTo>
                <a:lnTo>
                  <a:pt x="115893" y="1055687"/>
                </a:lnTo>
                <a:lnTo>
                  <a:pt x="134368" y="1095375"/>
                </a:lnTo>
                <a:lnTo>
                  <a:pt x="152844" y="1136650"/>
                </a:lnTo>
                <a:lnTo>
                  <a:pt x="167960" y="1182687"/>
                </a:lnTo>
                <a:lnTo>
                  <a:pt x="178038" y="1235075"/>
                </a:lnTo>
                <a:lnTo>
                  <a:pt x="188115" y="1295400"/>
                </a:lnTo>
                <a:lnTo>
                  <a:pt x="189795" y="1363662"/>
                </a:lnTo>
                <a:lnTo>
                  <a:pt x="188115" y="1431925"/>
                </a:lnTo>
                <a:lnTo>
                  <a:pt x="178038" y="1492250"/>
                </a:lnTo>
                <a:lnTo>
                  <a:pt x="167960" y="1544637"/>
                </a:lnTo>
                <a:lnTo>
                  <a:pt x="152844" y="1589087"/>
                </a:lnTo>
                <a:lnTo>
                  <a:pt x="134368" y="1631950"/>
                </a:lnTo>
                <a:lnTo>
                  <a:pt x="115893" y="1671637"/>
                </a:lnTo>
                <a:lnTo>
                  <a:pt x="95738" y="1708150"/>
                </a:lnTo>
                <a:lnTo>
                  <a:pt x="75583" y="1743075"/>
                </a:lnTo>
                <a:lnTo>
                  <a:pt x="55427" y="1782762"/>
                </a:lnTo>
                <a:lnTo>
                  <a:pt x="38632" y="1824037"/>
                </a:lnTo>
                <a:lnTo>
                  <a:pt x="23515" y="1870075"/>
                </a:lnTo>
                <a:lnTo>
                  <a:pt x="11758" y="1922462"/>
                </a:lnTo>
                <a:lnTo>
                  <a:pt x="3359" y="1982787"/>
                </a:lnTo>
                <a:lnTo>
                  <a:pt x="0" y="2051050"/>
                </a:lnTo>
                <a:lnTo>
                  <a:pt x="3359" y="2119312"/>
                </a:lnTo>
                <a:lnTo>
                  <a:pt x="11758" y="2179637"/>
                </a:lnTo>
                <a:lnTo>
                  <a:pt x="23515" y="2232025"/>
                </a:lnTo>
                <a:lnTo>
                  <a:pt x="38632" y="2278062"/>
                </a:lnTo>
                <a:lnTo>
                  <a:pt x="55427" y="2319337"/>
                </a:lnTo>
                <a:lnTo>
                  <a:pt x="75583" y="2359025"/>
                </a:lnTo>
                <a:lnTo>
                  <a:pt x="95738" y="2395537"/>
                </a:lnTo>
                <a:lnTo>
                  <a:pt x="115893" y="2433637"/>
                </a:lnTo>
                <a:lnTo>
                  <a:pt x="134368" y="2471737"/>
                </a:lnTo>
                <a:lnTo>
                  <a:pt x="152844" y="2513012"/>
                </a:lnTo>
                <a:lnTo>
                  <a:pt x="167960" y="2560637"/>
                </a:lnTo>
                <a:lnTo>
                  <a:pt x="178038" y="2613025"/>
                </a:lnTo>
                <a:lnTo>
                  <a:pt x="188115" y="2671762"/>
                </a:lnTo>
                <a:lnTo>
                  <a:pt x="189795" y="2741612"/>
                </a:lnTo>
                <a:lnTo>
                  <a:pt x="188115" y="2809875"/>
                </a:lnTo>
                <a:lnTo>
                  <a:pt x="178038" y="2868612"/>
                </a:lnTo>
                <a:lnTo>
                  <a:pt x="167960" y="2922587"/>
                </a:lnTo>
                <a:lnTo>
                  <a:pt x="152844" y="2967037"/>
                </a:lnTo>
                <a:lnTo>
                  <a:pt x="134368" y="3009900"/>
                </a:lnTo>
                <a:lnTo>
                  <a:pt x="115893" y="3046412"/>
                </a:lnTo>
                <a:lnTo>
                  <a:pt x="95738" y="3084512"/>
                </a:lnTo>
                <a:lnTo>
                  <a:pt x="75583" y="3121025"/>
                </a:lnTo>
                <a:lnTo>
                  <a:pt x="55427" y="3160712"/>
                </a:lnTo>
                <a:lnTo>
                  <a:pt x="38632" y="3201987"/>
                </a:lnTo>
                <a:lnTo>
                  <a:pt x="23515" y="3248025"/>
                </a:lnTo>
                <a:lnTo>
                  <a:pt x="11758" y="3300412"/>
                </a:lnTo>
                <a:lnTo>
                  <a:pt x="3359" y="3360737"/>
                </a:lnTo>
                <a:lnTo>
                  <a:pt x="0" y="3427412"/>
                </a:lnTo>
                <a:lnTo>
                  <a:pt x="3359" y="3497262"/>
                </a:lnTo>
                <a:lnTo>
                  <a:pt x="11758" y="3557587"/>
                </a:lnTo>
                <a:lnTo>
                  <a:pt x="23515" y="3609975"/>
                </a:lnTo>
                <a:lnTo>
                  <a:pt x="38632" y="3656012"/>
                </a:lnTo>
                <a:lnTo>
                  <a:pt x="55427" y="3697287"/>
                </a:lnTo>
                <a:lnTo>
                  <a:pt x="75583" y="3736975"/>
                </a:lnTo>
                <a:lnTo>
                  <a:pt x="115893" y="3811587"/>
                </a:lnTo>
                <a:lnTo>
                  <a:pt x="134368" y="3848100"/>
                </a:lnTo>
                <a:lnTo>
                  <a:pt x="152844" y="3890962"/>
                </a:lnTo>
                <a:lnTo>
                  <a:pt x="167960" y="3935412"/>
                </a:lnTo>
                <a:lnTo>
                  <a:pt x="178038" y="3987800"/>
                </a:lnTo>
                <a:lnTo>
                  <a:pt x="188115" y="4048125"/>
                </a:lnTo>
                <a:lnTo>
                  <a:pt x="189795" y="4116387"/>
                </a:lnTo>
                <a:lnTo>
                  <a:pt x="188115" y="4186237"/>
                </a:lnTo>
                <a:lnTo>
                  <a:pt x="178038" y="4244975"/>
                </a:lnTo>
                <a:lnTo>
                  <a:pt x="167960" y="4297362"/>
                </a:lnTo>
                <a:lnTo>
                  <a:pt x="152844" y="4343400"/>
                </a:lnTo>
                <a:lnTo>
                  <a:pt x="134368" y="4386262"/>
                </a:lnTo>
                <a:lnTo>
                  <a:pt x="115893" y="4424362"/>
                </a:lnTo>
                <a:lnTo>
                  <a:pt x="75583" y="4498975"/>
                </a:lnTo>
                <a:lnTo>
                  <a:pt x="55427" y="4537075"/>
                </a:lnTo>
                <a:lnTo>
                  <a:pt x="38632" y="4579937"/>
                </a:lnTo>
                <a:lnTo>
                  <a:pt x="23515" y="4625975"/>
                </a:lnTo>
                <a:lnTo>
                  <a:pt x="11758" y="4678362"/>
                </a:lnTo>
                <a:lnTo>
                  <a:pt x="3359" y="4738687"/>
                </a:lnTo>
                <a:lnTo>
                  <a:pt x="0" y="4806950"/>
                </a:lnTo>
                <a:lnTo>
                  <a:pt x="3359" y="4875212"/>
                </a:lnTo>
                <a:lnTo>
                  <a:pt x="11758" y="4935537"/>
                </a:lnTo>
                <a:lnTo>
                  <a:pt x="23515" y="4987925"/>
                </a:lnTo>
                <a:lnTo>
                  <a:pt x="38632" y="5033962"/>
                </a:lnTo>
                <a:lnTo>
                  <a:pt x="55427" y="5075237"/>
                </a:lnTo>
                <a:lnTo>
                  <a:pt x="75583" y="5114925"/>
                </a:lnTo>
                <a:lnTo>
                  <a:pt x="95738" y="5149850"/>
                </a:lnTo>
                <a:lnTo>
                  <a:pt x="115893" y="5186362"/>
                </a:lnTo>
                <a:lnTo>
                  <a:pt x="134368" y="5226050"/>
                </a:lnTo>
                <a:lnTo>
                  <a:pt x="152844" y="5268912"/>
                </a:lnTo>
                <a:lnTo>
                  <a:pt x="167960" y="5313362"/>
                </a:lnTo>
                <a:lnTo>
                  <a:pt x="178038" y="5365750"/>
                </a:lnTo>
                <a:lnTo>
                  <a:pt x="188115" y="5426075"/>
                </a:lnTo>
                <a:lnTo>
                  <a:pt x="189795" y="5494337"/>
                </a:lnTo>
                <a:lnTo>
                  <a:pt x="188115" y="5562600"/>
                </a:lnTo>
                <a:lnTo>
                  <a:pt x="178038" y="5622925"/>
                </a:lnTo>
                <a:lnTo>
                  <a:pt x="167960" y="5675312"/>
                </a:lnTo>
                <a:lnTo>
                  <a:pt x="152844" y="5721350"/>
                </a:lnTo>
                <a:lnTo>
                  <a:pt x="134368" y="5762625"/>
                </a:lnTo>
                <a:lnTo>
                  <a:pt x="115893" y="5802312"/>
                </a:lnTo>
                <a:lnTo>
                  <a:pt x="95738" y="5840412"/>
                </a:lnTo>
                <a:lnTo>
                  <a:pt x="75583" y="5876925"/>
                </a:lnTo>
                <a:lnTo>
                  <a:pt x="55427" y="5915025"/>
                </a:lnTo>
                <a:lnTo>
                  <a:pt x="38632" y="5956300"/>
                </a:lnTo>
                <a:lnTo>
                  <a:pt x="23515" y="6003925"/>
                </a:lnTo>
                <a:lnTo>
                  <a:pt x="11758" y="6056312"/>
                </a:lnTo>
                <a:lnTo>
                  <a:pt x="3359" y="6113462"/>
                </a:lnTo>
                <a:lnTo>
                  <a:pt x="0" y="6183312"/>
                </a:lnTo>
                <a:lnTo>
                  <a:pt x="3359" y="6251575"/>
                </a:lnTo>
                <a:lnTo>
                  <a:pt x="11758" y="6311900"/>
                </a:lnTo>
                <a:lnTo>
                  <a:pt x="23515" y="6361112"/>
                </a:lnTo>
                <a:lnTo>
                  <a:pt x="38632" y="6407150"/>
                </a:lnTo>
                <a:lnTo>
                  <a:pt x="55427" y="6448425"/>
                </a:lnTo>
                <a:lnTo>
                  <a:pt x="73903" y="6488112"/>
                </a:lnTo>
                <a:lnTo>
                  <a:pt x="92379" y="6523037"/>
                </a:lnTo>
                <a:lnTo>
                  <a:pt x="112534" y="6561137"/>
                </a:lnTo>
                <a:lnTo>
                  <a:pt x="132689" y="6597650"/>
                </a:lnTo>
                <a:lnTo>
                  <a:pt x="149485" y="6640512"/>
                </a:lnTo>
                <a:lnTo>
                  <a:pt x="166281" y="6683375"/>
                </a:lnTo>
                <a:lnTo>
                  <a:pt x="176358" y="6735762"/>
                </a:lnTo>
                <a:lnTo>
                  <a:pt x="184756" y="6791325"/>
                </a:lnTo>
                <a:lnTo>
                  <a:pt x="189795" y="6858000"/>
                </a:lnTo>
                <a:lnTo>
                  <a:pt x="334173" y="6858000"/>
                </a:lnTo>
                <a:lnTo>
                  <a:pt x="334174" y="6858000"/>
                </a:lnTo>
                <a:lnTo>
                  <a:pt x="4417162" y="6858000"/>
                </a:lnTo>
                <a:close/>
              </a:path>
            </a:pathLst>
          </a:custGeom>
          <a:solidFill>
            <a:schemeClr val="accent1">
              <a:lumMod val="50000"/>
              <a:alpha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4" name="Title 3">
            <a:extLst>
              <a:ext uri="{FF2B5EF4-FFF2-40B4-BE49-F238E27FC236}">
                <a16:creationId xmlns:a16="http://schemas.microsoft.com/office/drawing/2014/main" id="{90F4C2E6-807E-DBC0-AAA4-0F89D3D707E5}"/>
              </a:ext>
            </a:extLst>
          </p:cNvPr>
          <p:cNvSpPr>
            <a:spLocks noGrp="1"/>
          </p:cNvSpPr>
          <p:nvPr>
            <p:ph type="title"/>
          </p:nvPr>
        </p:nvSpPr>
        <p:spPr>
          <a:xfrm>
            <a:off x="457201" y="723406"/>
            <a:ext cx="3234018" cy="3826728"/>
          </a:xfrm>
          <a:prstGeom prst="ellipse">
            <a:avLst/>
          </a:prstGeom>
        </p:spPr>
        <p:txBody>
          <a:bodyPr vert="horz" lIns="91440" tIns="45720" rIns="91440" bIns="45720" rtlCol="0" anchor="b">
            <a:normAutofit/>
          </a:bodyPr>
          <a:lstStyle/>
          <a:p>
            <a:pPr algn="ctr"/>
            <a:r>
              <a:rPr lang="en-US" sz="6400" kern="1200">
                <a:solidFill>
                  <a:schemeClr val="tx1"/>
                </a:solidFill>
                <a:latin typeface="+mj-lt"/>
                <a:ea typeface="+mj-ea"/>
                <a:cs typeface="+mj-cs"/>
              </a:rPr>
              <a:t>Learn</a:t>
            </a:r>
          </a:p>
        </p:txBody>
      </p:sp>
      <p:pic>
        <p:nvPicPr>
          <p:cNvPr id="5" name="Content Placeholder 4">
            <a:extLst>
              <a:ext uri="{FF2B5EF4-FFF2-40B4-BE49-F238E27FC236}">
                <a16:creationId xmlns:a16="http://schemas.microsoft.com/office/drawing/2014/main" id="{E7DA6AE5-B23B-09E9-1F15-3FB902095D24}"/>
              </a:ext>
            </a:extLst>
          </p:cNvPr>
          <p:cNvPicPr>
            <a:picLocks noGrp="1" noChangeAspect="1"/>
          </p:cNvPicPr>
          <p:nvPr>
            <p:ph idx="1"/>
          </p:nvPr>
        </p:nvPicPr>
        <p:blipFill>
          <a:blip r:embed="rId4"/>
          <a:stretch>
            <a:fillRect/>
          </a:stretch>
        </p:blipFill>
        <p:spPr>
          <a:xfrm>
            <a:off x="6908794" y="643469"/>
            <a:ext cx="2646254" cy="5571062"/>
          </a:xfrm>
          <a:prstGeom prst="rect">
            <a:avLst/>
          </a:prstGeom>
        </p:spPr>
      </p:pic>
    </p:spTree>
    <p:extLst>
      <p:ext uri="{BB962C8B-B14F-4D97-AF65-F5344CB8AC3E}">
        <p14:creationId xmlns:p14="http://schemas.microsoft.com/office/powerpoint/2010/main" val="2706356740"/>
      </p:ext>
    </p:extLst>
  </p:cSld>
  <p:clrMapOvr>
    <a:masterClrMapping/>
  </p:clrMapOvr>
  <p:extLst>
    <p:ext uri="{6950BFC3-D8DA-4A85-94F7-54DA5524770B}">
      <p188:commentRel xmlns:p188="http://schemas.microsoft.com/office/powerpoint/2018/8/main" r:id="rId3"/>
    </p:ext>
  </p:extLst>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A095B8D-2EEE-A358-B643-B3FFCA6F9F22}"/>
              </a:ext>
            </a:extLst>
          </p:cNvPr>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3600" kern="1200">
                <a:solidFill>
                  <a:srgbClr val="FFFFFF"/>
                </a:solidFill>
                <a:latin typeface="+mj-lt"/>
                <a:ea typeface="+mj-ea"/>
                <a:cs typeface="+mj-cs"/>
              </a:rPr>
              <a:t>Module Example: Doing &amp; Feeling</a:t>
            </a:r>
          </a:p>
        </p:txBody>
      </p:sp>
      <p:pic>
        <p:nvPicPr>
          <p:cNvPr id="4" name="Content Placeholder 3">
            <a:extLst>
              <a:ext uri="{FF2B5EF4-FFF2-40B4-BE49-F238E27FC236}">
                <a16:creationId xmlns:a16="http://schemas.microsoft.com/office/drawing/2014/main" id="{AB4950CD-1522-0358-6631-DD0DE9C5C6A7}"/>
              </a:ext>
            </a:extLst>
          </p:cNvPr>
          <p:cNvPicPr>
            <a:picLocks noGrp="1" noChangeAspect="1"/>
          </p:cNvPicPr>
          <p:nvPr>
            <p:ph idx="1"/>
          </p:nvPr>
        </p:nvPicPr>
        <p:blipFill>
          <a:blip r:embed="rId4"/>
          <a:stretch>
            <a:fillRect/>
          </a:stretch>
        </p:blipFill>
        <p:spPr>
          <a:xfrm>
            <a:off x="5358169" y="567266"/>
            <a:ext cx="2617307" cy="5568739"/>
          </a:xfrm>
          <a:prstGeom prst="rect">
            <a:avLst/>
          </a:prstGeom>
        </p:spPr>
      </p:pic>
      <p:pic>
        <p:nvPicPr>
          <p:cNvPr id="5" name="Picture 4">
            <a:extLst>
              <a:ext uri="{FF2B5EF4-FFF2-40B4-BE49-F238E27FC236}">
                <a16:creationId xmlns:a16="http://schemas.microsoft.com/office/drawing/2014/main" id="{CACCB89F-166F-1824-EE58-BC08B80378BE}"/>
              </a:ext>
            </a:extLst>
          </p:cNvPr>
          <p:cNvPicPr>
            <a:picLocks noChangeAspect="1"/>
          </p:cNvPicPr>
          <p:nvPr/>
        </p:nvPicPr>
        <p:blipFill>
          <a:blip r:embed="rId5"/>
          <a:stretch>
            <a:fillRect/>
          </a:stretch>
        </p:blipFill>
        <p:spPr>
          <a:xfrm>
            <a:off x="8854896" y="567265"/>
            <a:ext cx="2619682" cy="5568739"/>
          </a:xfrm>
          <a:prstGeom prst="rect">
            <a:avLst/>
          </a:prstGeom>
        </p:spPr>
      </p:pic>
      <p:cxnSp>
        <p:nvCxnSpPr>
          <p:cNvPr id="7" name="Straight Arrow Connector 6">
            <a:extLst>
              <a:ext uri="{FF2B5EF4-FFF2-40B4-BE49-F238E27FC236}">
                <a16:creationId xmlns:a16="http://schemas.microsoft.com/office/drawing/2014/main" id="{4DD33F29-B891-983F-E541-18E64C3F8B7D}"/>
              </a:ext>
            </a:extLst>
          </p:cNvPr>
          <p:cNvCxnSpPr>
            <a:stCxn id="4" idx="3"/>
            <a:endCxn id="5" idx="1"/>
          </p:cNvCxnSpPr>
          <p:nvPr/>
        </p:nvCxnSpPr>
        <p:spPr>
          <a:xfrm flipV="1">
            <a:off x="7975476" y="3351635"/>
            <a:ext cx="879420"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487110609"/>
      </p:ext>
    </p:extLst>
  </p:cSld>
  <p:clrMapOvr>
    <a:masterClrMapping/>
  </p:clrMapOvr>
  <p:extLst>
    <p:ext uri="{6950BFC3-D8DA-4A85-94F7-54DA5524770B}">
      <p188:commentRel xmlns:p188="http://schemas.microsoft.com/office/powerpoint/2018/8/main" r:id="rId3"/>
    </p:ext>
  </p:extLst>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8">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7CD2E64-CB69-FBE9-38F0-2E3142294725}"/>
              </a:ext>
            </a:extLst>
          </p:cNvPr>
          <p:cNvSpPr>
            <a:spLocks noGrp="1"/>
          </p:cNvSpPr>
          <p:nvPr>
            <p:ph type="title"/>
          </p:nvPr>
        </p:nvSpPr>
        <p:spPr>
          <a:xfrm>
            <a:off x="838200" y="557188"/>
            <a:ext cx="10515600" cy="1133499"/>
          </a:xfrm>
        </p:spPr>
        <p:txBody>
          <a:bodyPr>
            <a:normAutofit/>
          </a:bodyPr>
          <a:lstStyle/>
          <a:p>
            <a:pPr algn="ctr"/>
            <a:r>
              <a:rPr lang="en-US" sz="4800"/>
              <a:t>Session Example: Intro to Doing &amp; Feeling</a:t>
            </a:r>
          </a:p>
        </p:txBody>
      </p:sp>
      <p:graphicFrame>
        <p:nvGraphicFramePr>
          <p:cNvPr id="4" name="Content Placeholder 3">
            <a:extLst>
              <a:ext uri="{FF2B5EF4-FFF2-40B4-BE49-F238E27FC236}">
                <a16:creationId xmlns:a16="http://schemas.microsoft.com/office/drawing/2014/main" id="{C2A8970E-15A0-9401-E9A0-093AAE4EC5FA}"/>
              </a:ext>
            </a:extLst>
          </p:cNvPr>
          <p:cNvGraphicFramePr>
            <a:graphicFrameLocks noGrp="1"/>
          </p:cNvGraphicFramePr>
          <p:nvPr>
            <p:ph idx="1"/>
            <p:extLst>
              <p:ext uri="{D42A27DB-BD31-4B8C-83A1-F6EECF244321}">
                <p14:modId xmlns:p14="http://schemas.microsoft.com/office/powerpoint/2010/main" val="4012929208"/>
              </p:ext>
            </p:extLst>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935074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 name="Rectangle 35">
            <a:extLst>
              <a:ext uri="{FF2B5EF4-FFF2-40B4-BE49-F238E27FC236}">
                <a16:creationId xmlns:a16="http://schemas.microsoft.com/office/drawing/2014/main" id="{A96817CF-C3CD-4D61-B837-5AA969D695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12191996" cy="6858000"/>
          </a:xfrm>
          <a:prstGeom prst="rect">
            <a:avLst/>
          </a:prstGeom>
          <a:solidFill>
            <a:srgbClr val="FFFFFF"/>
          </a:solidFill>
          <a:ln w="0">
            <a:noFill/>
            <a:prstDash val="solid"/>
            <a:round/>
            <a:headEnd/>
            <a:tailEnd/>
          </a:ln>
        </p:spPr>
        <p:txBody>
          <a:bodyPr rtlCol="0" anchor="ctr"/>
          <a:lstStyle/>
          <a:p>
            <a:pPr algn="ctr" defTabSz="457200"/>
            <a:endParaRPr lang="en-US">
              <a:solidFill>
                <a:schemeClr val="tx1"/>
              </a:solidFill>
            </a:endParaRPr>
          </a:p>
        </p:txBody>
      </p:sp>
      <p:sp useBgFill="1">
        <p:nvSpPr>
          <p:cNvPr id="34" name="Rectangle 37">
            <a:extLst>
              <a:ext uri="{FF2B5EF4-FFF2-40B4-BE49-F238E27FC236}">
                <a16:creationId xmlns:a16="http://schemas.microsoft.com/office/drawing/2014/main" id="{B9EC6CC4-13EB-4749-BB55-C377E4F6F4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7699494" cy="6858000"/>
          </a:xfrm>
          <a:prstGeom prst="rect">
            <a:avLst/>
          </a:prstGeom>
          <a:ln w="0">
            <a:noFill/>
            <a:prstDash val="solid"/>
            <a:round/>
            <a:headEnd/>
            <a:tailEnd/>
          </a:ln>
        </p:spPr>
        <p:txBody>
          <a:bodyPr rtlCol="0" anchor="ctr"/>
          <a:lstStyle/>
          <a:p>
            <a:pPr algn="ctr" defTabSz="457200"/>
            <a:endParaRPr lang="en-US" dirty="0">
              <a:solidFill>
                <a:schemeClr val="tx1"/>
              </a:solidFill>
            </a:endParaRPr>
          </a:p>
        </p:txBody>
      </p:sp>
      <p:sp>
        <p:nvSpPr>
          <p:cNvPr id="40" name="Rectangle 39">
            <a:extLst>
              <a:ext uri="{FF2B5EF4-FFF2-40B4-BE49-F238E27FC236}">
                <a16:creationId xmlns:a16="http://schemas.microsoft.com/office/drawing/2014/main" id="{488597D4-F59F-437D-9049-E852DF6896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7699494" cy="6858000"/>
          </a:xfrm>
          <a:prstGeom prst="rect">
            <a:avLst/>
          </a:prstGeom>
          <a:solidFill>
            <a:schemeClr val="accent1">
              <a:lumMod val="50000"/>
              <a:alpha val="25000"/>
            </a:schemeClr>
          </a:solidFill>
          <a:ln w="0">
            <a:noFill/>
            <a:prstDash val="solid"/>
            <a:round/>
            <a:headEnd/>
            <a:tailEnd/>
          </a:ln>
        </p:spPr>
        <p:txBody>
          <a:bodyPr rtlCol="0" anchor="ctr"/>
          <a:lstStyle/>
          <a:p>
            <a:pPr algn="ctr" defTabSz="457200"/>
            <a:endParaRPr lang="en-US" dirty="0">
              <a:solidFill>
                <a:schemeClr val="tx1"/>
              </a:solidFill>
            </a:endParaRPr>
          </a:p>
        </p:txBody>
      </p:sp>
      <p:sp>
        <p:nvSpPr>
          <p:cNvPr id="2" name="Title 1">
            <a:extLst>
              <a:ext uri="{FF2B5EF4-FFF2-40B4-BE49-F238E27FC236}">
                <a16:creationId xmlns:a16="http://schemas.microsoft.com/office/drawing/2014/main" id="{9EAF3BD6-ACD3-8B0F-3765-FBD3649D0D1C}"/>
              </a:ext>
            </a:extLst>
          </p:cNvPr>
          <p:cNvSpPr>
            <a:spLocks noGrp="1"/>
          </p:cNvSpPr>
          <p:nvPr>
            <p:ph type="title"/>
          </p:nvPr>
        </p:nvSpPr>
        <p:spPr>
          <a:xfrm>
            <a:off x="1252800" y="662399"/>
            <a:ext cx="5995987" cy="1494000"/>
          </a:xfrm>
        </p:spPr>
        <p:txBody>
          <a:bodyPr vert="horz" lIns="91440" tIns="45720" rIns="91440" bIns="45720" rtlCol="0" anchor="t">
            <a:normAutofit/>
          </a:bodyPr>
          <a:lstStyle/>
          <a:p>
            <a:r>
              <a:rPr lang="en-US" kern="1200">
                <a:solidFill>
                  <a:schemeClr val="tx1"/>
                </a:solidFill>
                <a:latin typeface="+mj-lt"/>
                <a:ea typeface="+mj-ea"/>
                <a:cs typeface="+mj-cs"/>
              </a:rPr>
              <a:t>Education Example</a:t>
            </a:r>
          </a:p>
        </p:txBody>
      </p:sp>
      <p:grpSp>
        <p:nvGrpSpPr>
          <p:cNvPr id="42" name="Group 41">
            <a:extLst>
              <a:ext uri="{FF2B5EF4-FFF2-40B4-BE49-F238E27FC236}">
                <a16:creationId xmlns:a16="http://schemas.microsoft.com/office/drawing/2014/main" id="{3248E2E5-FC33-4EDF-9119-E1D8A6179B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885825" cy="6858000"/>
            <a:chOff x="-13043" y="0"/>
            <a:chExt cx="885825" cy="6858000"/>
          </a:xfrm>
        </p:grpSpPr>
        <p:sp>
          <p:nvSpPr>
            <p:cNvPr id="43" name="Freeform 6">
              <a:extLst>
                <a:ext uri="{FF2B5EF4-FFF2-40B4-BE49-F238E27FC236}">
                  <a16:creationId xmlns:a16="http://schemas.microsoft.com/office/drawing/2014/main" id="{E96175EA-5A58-462A-B6AF-5F575F91844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043"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tx1"/>
            </a:solidFill>
            <a:ln w="0">
              <a:noFill/>
              <a:prstDash val="solid"/>
              <a:round/>
              <a:headEnd/>
              <a:tailEnd/>
            </a:ln>
          </p:spPr>
          <p:txBody>
            <a:bodyPr/>
            <a:lstStyle/>
            <a:p>
              <a:endParaRPr lang="en-US"/>
            </a:p>
          </p:txBody>
        </p:sp>
        <p:sp>
          <p:nvSpPr>
            <p:cNvPr id="44" name="Freeform 6">
              <a:extLst>
                <a:ext uri="{FF2B5EF4-FFF2-40B4-BE49-F238E27FC236}">
                  <a16:creationId xmlns:a16="http://schemas.microsoft.com/office/drawing/2014/main" id="{DE22DF26-7486-4229-BBD6-5A95765C84A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043"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accent1">
                <a:lumMod val="50000"/>
                <a:alpha val="25000"/>
              </a:schemeClr>
            </a:solidFill>
            <a:ln w="0">
              <a:noFill/>
              <a:prstDash val="solid"/>
              <a:round/>
              <a:headEnd/>
              <a:tailEnd/>
            </a:ln>
          </p:spPr>
          <p:txBody>
            <a:bodyPr/>
            <a:lstStyle/>
            <a:p>
              <a:endParaRPr lang="en-US"/>
            </a:p>
          </p:txBody>
        </p:sp>
      </p:grpSp>
      <p:sp>
        <p:nvSpPr>
          <p:cNvPr id="30" name="Content Placeholder 29">
            <a:extLst>
              <a:ext uri="{FF2B5EF4-FFF2-40B4-BE49-F238E27FC236}">
                <a16:creationId xmlns:a16="http://schemas.microsoft.com/office/drawing/2014/main" id="{5D87E23D-CCFC-5F45-63A4-3B4B0FCCC212}"/>
              </a:ext>
            </a:extLst>
          </p:cNvPr>
          <p:cNvSpPr>
            <a:spLocks noGrp="1"/>
          </p:cNvSpPr>
          <p:nvPr>
            <p:ph sz="half" idx="2"/>
          </p:nvPr>
        </p:nvSpPr>
        <p:spPr>
          <a:xfrm>
            <a:off x="1251677" y="2286000"/>
            <a:ext cx="5968273" cy="3844800"/>
          </a:xfrm>
        </p:spPr>
        <p:txBody>
          <a:bodyPr vert="horz" lIns="91440" tIns="45720" rIns="91440" bIns="45720" rtlCol="0">
            <a:normAutofit/>
          </a:bodyPr>
          <a:lstStyle/>
          <a:p>
            <a:pPr marL="0" marR="0" indent="0">
              <a:spcBef>
                <a:spcPts val="0"/>
              </a:spcBef>
              <a:spcAft>
                <a:spcPts val="800"/>
              </a:spcAft>
              <a:buNone/>
            </a:pPr>
            <a:r>
              <a:rPr lang="en-US" sz="1700" dirty="0">
                <a:solidFill>
                  <a:schemeClr val="tx1">
                    <a:alpha val="60000"/>
                  </a:schemeClr>
                </a:solidFill>
                <a:effectLst/>
              </a:rPr>
              <a:t>Have you ever noticed that certain things you do affect how you feel? You might feel more energized after taking a walk, or down after watching a sad movie. This module is all about recognizing the ways in which our behaviors affect how we feel and learning to use it to our advantage. At first, this might seem counterintuitive – often times, we wait to feel better or more motivated before doing something. But that’s not always the best course of action!</a:t>
            </a:r>
          </a:p>
          <a:p>
            <a:pPr marL="0" marR="0" indent="0">
              <a:spcBef>
                <a:spcPts val="0"/>
              </a:spcBef>
              <a:spcAft>
                <a:spcPts val="800"/>
              </a:spcAft>
              <a:buNone/>
            </a:pPr>
            <a:r>
              <a:rPr lang="en-US" sz="1700" dirty="0">
                <a:solidFill>
                  <a:schemeClr val="tx1">
                    <a:alpha val="60000"/>
                  </a:schemeClr>
                </a:solidFill>
                <a:effectLst/>
              </a:rPr>
              <a:t>When it comes to feeling down or depressed, there is often a difficult or stressful situation that leads to some initial negative emotions. These emotions often lead to changes in behavior, such as avoidance or isolation. This can make us feel even more depressed, so then we avoid and isolate more, and it becomes a downward spiral – avoidance, inactivity, and depression work together to pull each other down.</a:t>
            </a:r>
          </a:p>
          <a:p>
            <a:endParaRPr lang="en-US" sz="1700" dirty="0">
              <a:solidFill>
                <a:schemeClr val="tx1">
                  <a:alpha val="60000"/>
                </a:schemeClr>
              </a:solidFill>
            </a:endParaRPr>
          </a:p>
        </p:txBody>
      </p:sp>
      <p:pic>
        <p:nvPicPr>
          <p:cNvPr id="31" name="Content Placeholder 30">
            <a:extLst>
              <a:ext uri="{FF2B5EF4-FFF2-40B4-BE49-F238E27FC236}">
                <a16:creationId xmlns:a16="http://schemas.microsoft.com/office/drawing/2014/main" id="{E895CFD9-984A-FBB4-EE1E-3ACFD3C04D11}"/>
              </a:ext>
            </a:extLst>
          </p:cNvPr>
          <p:cNvPicPr>
            <a:picLocks noGrp="1" noChangeAspect="1"/>
          </p:cNvPicPr>
          <p:nvPr>
            <p:ph sz="half" idx="1"/>
          </p:nvPr>
        </p:nvPicPr>
        <p:blipFill>
          <a:blip r:embed="rId4"/>
          <a:stretch>
            <a:fillRect/>
          </a:stretch>
        </p:blipFill>
        <p:spPr>
          <a:xfrm>
            <a:off x="8629583" y="643469"/>
            <a:ext cx="2632326" cy="5571062"/>
          </a:xfrm>
          <a:prstGeom prst="rect">
            <a:avLst/>
          </a:prstGeom>
        </p:spPr>
      </p:pic>
    </p:spTree>
    <p:extLst>
      <p:ext uri="{BB962C8B-B14F-4D97-AF65-F5344CB8AC3E}">
        <p14:creationId xmlns:p14="http://schemas.microsoft.com/office/powerpoint/2010/main" val="6678768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31"/>
                                        </p:tgtEl>
                                        <p:attrNameLst>
                                          <p:attrName>style.visibility</p:attrName>
                                        </p:attrNameLst>
                                      </p:cBhvr>
                                      <p:to>
                                        <p:strVal val="visible"/>
                                      </p:to>
                                    </p:set>
                                    <p:animEffect transition="in" filter="fade">
                                      <p:cBhvr>
                                        <p:cTn id="7" dur="1000"/>
                                        <p:tgtEl>
                                          <p:spTgt spid="31"/>
                                        </p:tgtEl>
                                      </p:cBhvr>
                                    </p:animEffect>
                                    <p:anim calcmode="lin" valueType="num">
                                      <p:cBhvr>
                                        <p:cTn id="8" dur="1000" fill="hold"/>
                                        <p:tgtEl>
                                          <p:spTgt spid="31"/>
                                        </p:tgtEl>
                                        <p:attrNameLst>
                                          <p:attrName>ppt_x</p:attrName>
                                        </p:attrNameLst>
                                      </p:cBhvr>
                                      <p:tavLst>
                                        <p:tav tm="0">
                                          <p:val>
                                            <p:strVal val="#ppt_x"/>
                                          </p:val>
                                        </p:tav>
                                        <p:tav tm="100000">
                                          <p:val>
                                            <p:strVal val="#ppt_x"/>
                                          </p:val>
                                        </p:tav>
                                      </p:tavLst>
                                    </p:anim>
                                    <p:anim calcmode="lin" valueType="num">
                                      <p:cBhvr>
                                        <p:cTn id="9" dur="1000" fill="hold"/>
                                        <p:tgtEl>
                                          <p:spTgt spid="31"/>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extLst>
    <p:ext uri="{6950BFC3-D8DA-4A85-94F7-54DA5524770B}">
      <p188:commentRel xmlns:p188="http://schemas.microsoft.com/office/powerpoint/2018/8/main" r:id="rId3"/>
    </p:ext>
  </p:extLst>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Rectangle 21">
            <a:extLst>
              <a:ext uri="{FF2B5EF4-FFF2-40B4-BE49-F238E27FC236}">
                <a16:creationId xmlns:a16="http://schemas.microsoft.com/office/drawing/2014/main" id="{A96817CF-C3CD-4D61-B837-5AA969D695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12191996" cy="6858000"/>
          </a:xfrm>
          <a:prstGeom prst="rect">
            <a:avLst/>
          </a:prstGeom>
          <a:solidFill>
            <a:srgbClr val="FFFFFF"/>
          </a:solidFill>
          <a:ln w="0">
            <a:noFill/>
            <a:prstDash val="solid"/>
            <a:round/>
            <a:headEnd/>
            <a:tailEnd/>
          </a:ln>
        </p:spPr>
        <p:txBody>
          <a:bodyPr rtlCol="0" anchor="ctr"/>
          <a:lstStyle/>
          <a:p>
            <a:pPr algn="ctr" defTabSz="457200"/>
            <a:endParaRPr lang="en-US">
              <a:solidFill>
                <a:schemeClr val="tx1"/>
              </a:solidFill>
            </a:endParaRPr>
          </a:p>
        </p:txBody>
      </p:sp>
      <p:sp useBgFill="1">
        <p:nvSpPr>
          <p:cNvPr id="21" name="Rectangle 23">
            <a:extLst>
              <a:ext uri="{FF2B5EF4-FFF2-40B4-BE49-F238E27FC236}">
                <a16:creationId xmlns:a16="http://schemas.microsoft.com/office/drawing/2014/main" id="{B9EC6CC4-13EB-4749-BB55-C377E4F6F4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7699494" cy="6858000"/>
          </a:xfrm>
          <a:prstGeom prst="rect">
            <a:avLst/>
          </a:prstGeom>
          <a:ln w="0">
            <a:noFill/>
            <a:prstDash val="solid"/>
            <a:round/>
            <a:headEnd/>
            <a:tailEnd/>
          </a:ln>
        </p:spPr>
        <p:txBody>
          <a:bodyPr rtlCol="0" anchor="ctr"/>
          <a:lstStyle/>
          <a:p>
            <a:pPr algn="ctr" defTabSz="457200"/>
            <a:endParaRPr lang="en-US" dirty="0">
              <a:solidFill>
                <a:schemeClr val="tx1"/>
              </a:solidFill>
            </a:endParaRPr>
          </a:p>
        </p:txBody>
      </p:sp>
      <p:sp>
        <p:nvSpPr>
          <p:cNvPr id="26" name="Rectangle 25">
            <a:extLst>
              <a:ext uri="{FF2B5EF4-FFF2-40B4-BE49-F238E27FC236}">
                <a16:creationId xmlns:a16="http://schemas.microsoft.com/office/drawing/2014/main" id="{488597D4-F59F-437D-9049-E852DF6896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1" y="0"/>
            <a:ext cx="7699494" cy="6858000"/>
          </a:xfrm>
          <a:prstGeom prst="rect">
            <a:avLst/>
          </a:prstGeom>
          <a:solidFill>
            <a:schemeClr val="accent1">
              <a:lumMod val="50000"/>
              <a:alpha val="25000"/>
            </a:schemeClr>
          </a:solidFill>
          <a:ln w="0">
            <a:noFill/>
            <a:prstDash val="solid"/>
            <a:round/>
            <a:headEnd/>
            <a:tailEnd/>
          </a:ln>
        </p:spPr>
        <p:txBody>
          <a:bodyPr rtlCol="0" anchor="ctr"/>
          <a:lstStyle/>
          <a:p>
            <a:pPr algn="ctr" defTabSz="457200"/>
            <a:endParaRPr lang="en-US" dirty="0">
              <a:solidFill>
                <a:schemeClr val="tx1"/>
              </a:solidFill>
            </a:endParaRPr>
          </a:p>
        </p:txBody>
      </p:sp>
      <p:sp>
        <p:nvSpPr>
          <p:cNvPr id="2" name="Title 1">
            <a:extLst>
              <a:ext uri="{FF2B5EF4-FFF2-40B4-BE49-F238E27FC236}">
                <a16:creationId xmlns:a16="http://schemas.microsoft.com/office/drawing/2014/main" id="{9EAF3BD6-ACD3-8B0F-3765-FBD3649D0D1C}"/>
              </a:ext>
            </a:extLst>
          </p:cNvPr>
          <p:cNvSpPr>
            <a:spLocks noGrp="1"/>
          </p:cNvSpPr>
          <p:nvPr>
            <p:ph type="title"/>
          </p:nvPr>
        </p:nvSpPr>
        <p:spPr>
          <a:xfrm>
            <a:off x="1252800" y="662399"/>
            <a:ext cx="5995987" cy="1494000"/>
          </a:xfrm>
        </p:spPr>
        <p:txBody>
          <a:bodyPr vert="horz" lIns="91440" tIns="45720" rIns="91440" bIns="45720" rtlCol="0" anchor="t">
            <a:normAutofit/>
          </a:bodyPr>
          <a:lstStyle/>
          <a:p>
            <a:r>
              <a:rPr lang="en-US" kern="1200" dirty="0">
                <a:solidFill>
                  <a:schemeClr val="tx1"/>
                </a:solidFill>
                <a:latin typeface="+mj-lt"/>
                <a:ea typeface="+mj-ea"/>
                <a:cs typeface="+mj-cs"/>
              </a:rPr>
              <a:t>AYA Story Example</a:t>
            </a:r>
          </a:p>
        </p:txBody>
      </p:sp>
      <p:grpSp>
        <p:nvGrpSpPr>
          <p:cNvPr id="28" name="Group 27">
            <a:extLst>
              <a:ext uri="{FF2B5EF4-FFF2-40B4-BE49-F238E27FC236}">
                <a16:creationId xmlns:a16="http://schemas.microsoft.com/office/drawing/2014/main" id="{3248E2E5-FC33-4EDF-9119-E1D8A6179B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885825" cy="6858000"/>
            <a:chOff x="-13043" y="0"/>
            <a:chExt cx="885825" cy="6858000"/>
          </a:xfrm>
        </p:grpSpPr>
        <p:sp>
          <p:nvSpPr>
            <p:cNvPr id="29" name="Freeform 6">
              <a:extLst>
                <a:ext uri="{FF2B5EF4-FFF2-40B4-BE49-F238E27FC236}">
                  <a16:creationId xmlns:a16="http://schemas.microsoft.com/office/drawing/2014/main" id="{E96175EA-5A58-462A-B6AF-5F575F91844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043"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tx1"/>
            </a:solidFill>
            <a:ln w="0">
              <a:noFill/>
              <a:prstDash val="solid"/>
              <a:round/>
              <a:headEnd/>
              <a:tailEnd/>
            </a:ln>
          </p:spPr>
          <p:txBody>
            <a:bodyPr/>
            <a:lstStyle/>
            <a:p>
              <a:endParaRPr lang="en-US"/>
            </a:p>
          </p:txBody>
        </p:sp>
        <p:sp>
          <p:nvSpPr>
            <p:cNvPr id="30" name="Freeform 6">
              <a:extLst>
                <a:ext uri="{FF2B5EF4-FFF2-40B4-BE49-F238E27FC236}">
                  <a16:creationId xmlns:a16="http://schemas.microsoft.com/office/drawing/2014/main" id="{DE22DF26-7486-4229-BBD6-5A95765C84A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043"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accent1">
                <a:lumMod val="50000"/>
                <a:alpha val="25000"/>
              </a:schemeClr>
            </a:solidFill>
            <a:ln w="0">
              <a:noFill/>
              <a:prstDash val="solid"/>
              <a:round/>
              <a:headEnd/>
              <a:tailEnd/>
            </a:ln>
          </p:spPr>
          <p:txBody>
            <a:bodyPr/>
            <a:lstStyle/>
            <a:p>
              <a:endParaRPr lang="en-US"/>
            </a:p>
          </p:txBody>
        </p:sp>
      </p:grpSp>
      <p:sp>
        <p:nvSpPr>
          <p:cNvPr id="17" name="Content Placeholder 16">
            <a:extLst>
              <a:ext uri="{FF2B5EF4-FFF2-40B4-BE49-F238E27FC236}">
                <a16:creationId xmlns:a16="http://schemas.microsoft.com/office/drawing/2014/main" id="{5D151E56-9B33-0A57-07A3-7004C5B3E59A}"/>
              </a:ext>
            </a:extLst>
          </p:cNvPr>
          <p:cNvSpPr>
            <a:spLocks noGrp="1"/>
          </p:cNvSpPr>
          <p:nvPr>
            <p:ph sz="half" idx="1"/>
          </p:nvPr>
        </p:nvSpPr>
        <p:spPr>
          <a:xfrm>
            <a:off x="1251677" y="2286000"/>
            <a:ext cx="5968273" cy="3844800"/>
          </a:xfrm>
        </p:spPr>
        <p:txBody>
          <a:bodyPr vert="horz" lIns="91440" tIns="45720" rIns="91440" bIns="45720" rtlCol="0">
            <a:normAutofit/>
          </a:bodyPr>
          <a:lstStyle/>
          <a:p>
            <a:pPr marL="0" marR="0" indent="0">
              <a:spcBef>
                <a:spcPts val="0"/>
              </a:spcBef>
              <a:spcAft>
                <a:spcPts val="800"/>
              </a:spcAft>
              <a:buNone/>
            </a:pPr>
            <a:r>
              <a:rPr lang="en-US" sz="1900" dirty="0">
                <a:solidFill>
                  <a:schemeClr val="tx1">
                    <a:alpha val="60000"/>
                  </a:schemeClr>
                </a:solidFill>
                <a:effectLst/>
              </a:rPr>
              <a:t>I'm Ally and I am 23 years old. I was diagnosed with non-</a:t>
            </a:r>
            <a:r>
              <a:rPr lang="en-US" sz="1900" dirty="0" err="1">
                <a:solidFill>
                  <a:schemeClr val="tx1">
                    <a:alpha val="60000"/>
                  </a:schemeClr>
                </a:solidFill>
                <a:effectLst/>
              </a:rPr>
              <a:t>Hodgkins</a:t>
            </a:r>
            <a:r>
              <a:rPr lang="en-US" sz="1900" dirty="0">
                <a:solidFill>
                  <a:schemeClr val="tx1">
                    <a:alpha val="60000"/>
                  </a:schemeClr>
                </a:solidFill>
                <a:effectLst/>
              </a:rPr>
              <a:t> lymphoma at 21 and finished up my treatment a few months ago. When I found out my cancer was in remission, I was so relieved. I thought that everything would go back to normal – I could go back to school, hang out with my friends, start working out again…but it just wasn’t that way.  I tried to hang out with my old friends but they didn’t get what I’ve gone through. I felt awkward when I was with them so I stopped responding to their invites. But then I felt more lonely than ever, and guilty for ignoring them.  It was a really tough time, and I started to feel depressed.</a:t>
            </a:r>
          </a:p>
          <a:p>
            <a:pPr marL="0" marR="0" indent="0">
              <a:spcBef>
                <a:spcPts val="0"/>
              </a:spcBef>
              <a:spcAft>
                <a:spcPts val="800"/>
              </a:spcAft>
              <a:buNone/>
            </a:pPr>
            <a:r>
              <a:rPr lang="en-US" sz="1900" i="1" dirty="0">
                <a:solidFill>
                  <a:schemeClr val="tx1">
                    <a:alpha val="60000"/>
                  </a:schemeClr>
                </a:solidFill>
                <a:effectLst/>
              </a:rPr>
              <a:t>We’ll come back to Ally’s story in a bit, but first let’s figure out what her downward spiral was.</a:t>
            </a:r>
          </a:p>
        </p:txBody>
      </p:sp>
      <p:pic>
        <p:nvPicPr>
          <p:cNvPr id="7" name="Content Placeholder 6">
            <a:extLst>
              <a:ext uri="{FF2B5EF4-FFF2-40B4-BE49-F238E27FC236}">
                <a16:creationId xmlns:a16="http://schemas.microsoft.com/office/drawing/2014/main" id="{34107736-8E1D-4F62-0AC6-A6D0C0FE20DA}"/>
              </a:ext>
            </a:extLst>
          </p:cNvPr>
          <p:cNvPicPr>
            <a:picLocks noGrp="1" noChangeAspect="1"/>
          </p:cNvPicPr>
          <p:nvPr>
            <p:ph sz="half" idx="2"/>
          </p:nvPr>
        </p:nvPicPr>
        <p:blipFill>
          <a:blip r:embed="rId4"/>
          <a:stretch>
            <a:fillRect/>
          </a:stretch>
        </p:blipFill>
        <p:spPr>
          <a:xfrm>
            <a:off x="8636546" y="643469"/>
            <a:ext cx="2618399" cy="5571062"/>
          </a:xfrm>
          <a:prstGeom prst="rect">
            <a:avLst/>
          </a:prstGeom>
        </p:spPr>
      </p:pic>
    </p:spTree>
    <p:extLst>
      <p:ext uri="{BB962C8B-B14F-4D97-AF65-F5344CB8AC3E}">
        <p14:creationId xmlns:p14="http://schemas.microsoft.com/office/powerpoint/2010/main" val="34636533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1000"/>
                                        <p:tgtEl>
                                          <p:spTgt spid="7"/>
                                        </p:tgtEl>
                                      </p:cBhvr>
                                    </p:animEffect>
                                    <p:anim calcmode="lin" valueType="num">
                                      <p:cBhvr>
                                        <p:cTn id="8" dur="1000" fill="hold"/>
                                        <p:tgtEl>
                                          <p:spTgt spid="7"/>
                                        </p:tgtEl>
                                        <p:attrNameLst>
                                          <p:attrName>ppt_x</p:attrName>
                                        </p:attrNameLst>
                                      </p:cBhvr>
                                      <p:tavLst>
                                        <p:tav tm="0">
                                          <p:val>
                                            <p:strVal val="#ppt_x"/>
                                          </p:val>
                                        </p:tav>
                                        <p:tav tm="100000">
                                          <p:val>
                                            <p:strVal val="#ppt_x"/>
                                          </p:val>
                                        </p:tav>
                                      </p:tavLst>
                                    </p:anim>
                                    <p:anim calcmode="lin" valueType="num">
                                      <p:cBhvr>
                                        <p:cTn id="9" dur="1000" fill="hold"/>
                                        <p:tgtEl>
                                          <p:spTgt spid="7"/>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extLst>
    <p:ext uri="{6950BFC3-D8DA-4A85-94F7-54DA5524770B}">
      <p188:commentRel xmlns:p188="http://schemas.microsoft.com/office/powerpoint/2018/8/main" r:id="rId3"/>
    </p:ext>
  </p:extLs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850A7996F154E4FA7785DDB182B98E3" ma:contentTypeVersion="15" ma:contentTypeDescription="Create a new document." ma:contentTypeScope="" ma:versionID="46cd5e81fe8b89db6854a313a15e1049">
  <xsd:schema xmlns:xsd="http://www.w3.org/2001/XMLSchema" xmlns:xs="http://www.w3.org/2001/XMLSchema" xmlns:p="http://schemas.microsoft.com/office/2006/metadata/properties" xmlns:ns2="ae82414a-0e8c-430a-a40a-968ff9054b21" xmlns:ns3="90947a30-aed6-487d-a00c-ffcd5d748952" targetNamespace="http://schemas.microsoft.com/office/2006/metadata/properties" ma:root="true" ma:fieldsID="3fae32e7894a58c685b8a9c8b4ab84dd" ns2:_="" ns3:_="">
    <xsd:import namespace="ae82414a-0e8c-430a-a40a-968ff9054b21"/>
    <xsd:import namespace="90947a30-aed6-487d-a00c-ffcd5d748952"/>
    <xsd:element name="properties">
      <xsd:complexType>
        <xsd:sequence>
          <xsd:element name="documentManagement">
            <xsd:complexType>
              <xsd:all>
                <xsd:element ref="ns2:MediaServiceMetadata" minOccurs="0"/>
                <xsd:element ref="ns2:MediaServiceFastMetadata"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element ref="ns2:lcf76f155ced4ddcb4097134ff3c332f" minOccurs="0"/>
                <xsd:element ref="ns3:TaxCatchAll" minOccurs="0"/>
                <xsd:element ref="ns2:MediaServiceOCR" minOccurs="0"/>
                <xsd:element ref="ns3:SharedWithUsers" minOccurs="0"/>
                <xsd:element ref="ns3:SharedWithDetails" minOccurs="0"/>
                <xsd:element ref="ns2:MediaServiceSearchProperties" minOccurs="0"/>
                <xsd:element ref="ns2: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e82414a-0e8c-430a-a40a-968ff9054b2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MediaServiceDateTaken" ma:index="11" nillable="true" ma:displayName="MediaServiceDateTaken" ma:hidden="true" ma:indexed="true" ma:internalName="MediaServiceDateTaken"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LengthInSeconds" ma:index="14" nillable="true" ma:displayName="MediaLengthInSeconds" ma:hidden="true" ma:internalName="MediaLengthInSeconds" ma:readOnly="true">
      <xsd:simpleType>
        <xsd:restriction base="dms:Unknown"/>
      </xsd:simpleType>
    </xsd:element>
    <xsd:element name="lcf76f155ced4ddcb4097134ff3c332f" ma:index="16" nillable="true" ma:taxonomy="true" ma:internalName="lcf76f155ced4ddcb4097134ff3c332f" ma:taxonomyFieldName="MediaServiceImageTags" ma:displayName="Image Tags" ma:readOnly="false" ma:fieldId="{5cf76f15-5ced-4ddc-b409-7134ff3c332f}" ma:taxonomyMulti="true" ma:sspId="da0cd38b-47d1-479b-a863-216ca283e7c1" ma:termSetId="09814cd3-568e-fe90-9814-8d621ff8fb84" ma:anchorId="fba54fb3-c3e1-fe81-a776-ca4b69148c4d" ma:open="true" ma:isKeyword="false">
      <xsd:complexType>
        <xsd:sequence>
          <xsd:element ref="pc:Terms" minOccurs="0" maxOccurs="1"/>
        </xsd:sequence>
      </xsd:complexType>
    </xsd:element>
    <xsd:element name="MediaServiceOCR" ma:index="18" nillable="true" ma:displayName="Extracted Text" ma:internalName="MediaServiceOCR" ma:readOnly="true">
      <xsd:simpleType>
        <xsd:restriction base="dms:Note">
          <xsd:maxLength value="255"/>
        </xsd:restriction>
      </xsd:simpleType>
    </xsd:element>
    <xsd:element name="MediaServiceSearchProperties" ma:index="21" nillable="true" ma:displayName="MediaServiceSearchProperties" ma:hidden="true" ma:internalName="MediaServiceSearchProperties" ma:readOnly="true">
      <xsd:simpleType>
        <xsd:restriction base="dms:Note"/>
      </xsd:simpleType>
    </xsd:element>
    <xsd:element name="MediaServiceLocation" ma:index="22" nillable="true" ma:displayName="Location" ma:indexed="true"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0947a30-aed6-487d-a00c-ffcd5d748952" elementFormDefault="qualified">
    <xsd:import namespace="http://schemas.microsoft.com/office/2006/documentManagement/types"/>
    <xsd:import namespace="http://schemas.microsoft.com/office/infopath/2007/PartnerControls"/>
    <xsd:element name="TaxCatchAll" ma:index="17" nillable="true" ma:displayName="Taxonomy Catch All Column" ma:hidden="true" ma:list="{0fcf107d-73f3-4176-ac55-37f5319deb37}" ma:internalName="TaxCatchAll" ma:showField="CatchAllData" ma:web="90947a30-aed6-487d-a00c-ffcd5d748952">
      <xsd:complexType>
        <xsd:complexContent>
          <xsd:extension base="dms:MultiChoiceLookup">
            <xsd:sequence>
              <xsd:element name="Value" type="dms:Lookup" maxOccurs="unbounded" minOccurs="0" nillable="true"/>
            </xsd:sequence>
          </xsd:extension>
        </xsd:complexContent>
      </xsd:complexType>
    </xsd:element>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ae82414a-0e8c-430a-a40a-968ff9054b21">
      <Terms xmlns="http://schemas.microsoft.com/office/infopath/2007/PartnerControls"/>
    </lcf76f155ced4ddcb4097134ff3c332f>
    <TaxCatchAll xmlns="90947a30-aed6-487d-a00c-ffcd5d748952" xsi:nil="true"/>
    <SharedWithUsers xmlns="90947a30-aed6-487d-a00c-ffcd5d748952">
      <UserInfo>
        <DisplayName/>
        <AccountId xsi:nil="true"/>
        <AccountType/>
      </UserInfo>
    </SharedWithUsers>
    <MediaLengthInSeconds xmlns="ae82414a-0e8c-430a-a40a-968ff9054b21"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47437EA-A02E-4F2D-9B77-C75ADF0D8CA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e82414a-0e8c-430a-a40a-968ff9054b21"/>
    <ds:schemaRef ds:uri="90947a30-aed6-487d-a00c-ffcd5d74895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D39E6E99-97B3-4906-98A4-6FDA99E7DE6C}">
  <ds:schemaRefs>
    <ds:schemaRef ds:uri="http://schemas.microsoft.com/office/2006/metadata/properties"/>
    <ds:schemaRef ds:uri="http://schemas.microsoft.com/office/infopath/2007/PartnerControls"/>
    <ds:schemaRef ds:uri="ae82414a-0e8c-430a-a40a-968ff9054b21"/>
    <ds:schemaRef ds:uri="90947a30-aed6-487d-a00c-ffcd5d748952"/>
  </ds:schemaRefs>
</ds:datastoreItem>
</file>

<file path=customXml/itemProps3.xml><?xml version="1.0" encoding="utf-8"?>
<ds:datastoreItem xmlns:ds="http://schemas.openxmlformats.org/officeDocument/2006/customXml" ds:itemID="{F36EBE9C-44E1-46A3-BF0A-3D905D49AF1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4513</TotalTime>
  <Words>2083</Words>
  <Application>Microsoft Office PowerPoint</Application>
  <PresentationFormat>Widescreen</PresentationFormat>
  <Paragraphs>134</Paragraphs>
  <Slides>16</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 Theme</vt:lpstr>
      <vt:lpstr>Intro</vt:lpstr>
      <vt:lpstr>Dashboard</vt:lpstr>
      <vt:lpstr>Mood Rating</vt:lpstr>
      <vt:lpstr>Mood Tracking</vt:lpstr>
      <vt:lpstr>Learn</vt:lpstr>
      <vt:lpstr>Module Example: Doing &amp; Feeling</vt:lpstr>
      <vt:lpstr>Session Example: Intro to Doing &amp; Feeling</vt:lpstr>
      <vt:lpstr>Education Example</vt:lpstr>
      <vt:lpstr>AYA Story Example</vt:lpstr>
      <vt:lpstr>Activity Example: Intro to Doing &amp; Feeling</vt:lpstr>
      <vt:lpstr>Activity Example: Intro to Doing &amp; Feeling</vt:lpstr>
      <vt:lpstr>Activity Example: Intro to Doing &amp; Feeling</vt:lpstr>
      <vt:lpstr>Session Example: Intro to Doing &amp; Feeling</vt:lpstr>
      <vt:lpstr>Practice Example: Being &amp; Feeling</vt:lpstr>
      <vt:lpstr>Discussion Boards</vt:lpstr>
      <vt:lpstr>Wrap-up Questions</vt:lpstr>
    </vt:vector>
  </TitlesOfParts>
  <Company>Wake Forest Baptist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arly M. Murphy</dc:creator>
  <cp:lastModifiedBy>Murphy, Karly</cp:lastModifiedBy>
  <cp:revision>3</cp:revision>
  <dcterms:created xsi:type="dcterms:W3CDTF">2023-01-05T20:09:47Z</dcterms:created>
  <dcterms:modified xsi:type="dcterms:W3CDTF">2025-05-23T13:52: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850A7996F154E4FA7785DDB182B98E3</vt:lpwstr>
  </property>
  <property fmtid="{D5CDD505-2E9C-101B-9397-08002B2CF9AE}" pid="3" name="Order">
    <vt:r8>185600</vt:r8>
  </property>
  <property fmtid="{D5CDD505-2E9C-101B-9397-08002B2CF9AE}" pid="4" name="ComplianceAssetId">
    <vt:lpwstr/>
  </property>
  <property fmtid="{D5CDD505-2E9C-101B-9397-08002B2CF9AE}" pid="5" name="_ExtendedDescription">
    <vt:lpwstr/>
  </property>
  <property fmtid="{D5CDD505-2E9C-101B-9397-08002B2CF9AE}" pid="6" name="TriggerFlowInfo">
    <vt:lpwstr/>
  </property>
  <property fmtid="{D5CDD505-2E9C-101B-9397-08002B2CF9AE}" pid="7" name="MediaServiceImageTags">
    <vt:lpwstr/>
  </property>
</Properties>
</file>